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55"/>
  </p:normalViewPr>
  <p:slideViewPr>
    <p:cSldViewPr snapToGrid="0" snapToObjects="1">
      <p:cViewPr varScale="1">
        <p:scale>
          <a:sx n="147" d="100"/>
          <a:sy n="147" d="100"/>
        </p:scale>
        <p:origin x="3224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913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6675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838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2972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8587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768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24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9971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17364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172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2114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78659A-8756-0E4C-830F-574E2EA0BBEB}" type="datetimeFigureOut">
              <a:rPr lang="en-GB" smtClean="0"/>
              <a:t>09/11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823C35-3C85-DC4B-B62C-562199B424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1292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7" name="Group 46"/>
          <p:cNvGrpSpPr/>
          <p:nvPr/>
        </p:nvGrpSpPr>
        <p:grpSpPr>
          <a:xfrm>
            <a:off x="1534435" y="5632739"/>
            <a:ext cx="3352842" cy="2317225"/>
            <a:chOff x="353418" y="408937"/>
            <a:chExt cx="5588068" cy="3862043"/>
          </a:xfrm>
        </p:grpSpPr>
        <p:cxnSp>
          <p:nvCxnSpPr>
            <p:cNvPr id="48" name="Straight Connector 47"/>
            <p:cNvCxnSpPr/>
            <p:nvPr/>
          </p:nvCxnSpPr>
          <p:spPr>
            <a:xfrm>
              <a:off x="1545570" y="1872839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 flipV="1">
              <a:off x="1407672" y="1997782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/>
          </p:nvCxnSpPr>
          <p:spPr>
            <a:xfrm flipV="1">
              <a:off x="1419687" y="1414877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/>
            <p:nvPr/>
          </p:nvCxnSpPr>
          <p:spPr>
            <a:xfrm flipV="1">
              <a:off x="1516772" y="1548368"/>
              <a:ext cx="206264" cy="25853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 flipH="1" flipV="1">
              <a:off x="1123246" y="1539062"/>
              <a:ext cx="195891" cy="24566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3" name="Group 52"/>
            <p:cNvGrpSpPr/>
            <p:nvPr/>
          </p:nvGrpSpPr>
          <p:grpSpPr>
            <a:xfrm>
              <a:off x="1974389" y="2239590"/>
              <a:ext cx="716758" cy="695647"/>
              <a:chOff x="2723345" y="2222218"/>
              <a:chExt cx="499833" cy="485111"/>
            </a:xfrm>
          </p:grpSpPr>
          <p:sp>
            <p:nvSpPr>
              <p:cNvPr id="174" name="Oval 173"/>
              <p:cNvSpPr/>
              <p:nvPr/>
            </p:nvSpPr>
            <p:spPr>
              <a:xfrm>
                <a:off x="2724348" y="2222218"/>
                <a:ext cx="489575" cy="459805"/>
              </a:xfrm>
              <a:prstGeom prst="ellipse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accent6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3" dirty="0"/>
              </a:p>
            </p:txBody>
          </p:sp>
          <p:sp>
            <p:nvSpPr>
              <p:cNvPr id="175" name="Pie 174"/>
              <p:cNvSpPr/>
              <p:nvPr/>
            </p:nvSpPr>
            <p:spPr>
              <a:xfrm>
                <a:off x="2723345" y="2222379"/>
                <a:ext cx="499833" cy="484950"/>
              </a:xfrm>
              <a:prstGeom prst="pie">
                <a:avLst>
                  <a:gd name="adj1" fmla="val 17166843"/>
                  <a:gd name="adj2" fmla="val 16200000"/>
                </a:avLst>
              </a:prstGeom>
              <a:solidFill>
                <a:srgbClr val="00B050"/>
              </a:solidFill>
              <a:ln>
                <a:solidFill>
                  <a:srgbClr val="00B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3" dirty="0">
                  <a:solidFill>
                    <a:schemeClr val="tx1"/>
                  </a:solidFill>
                </a:endParaRPr>
              </a:p>
            </p:txBody>
          </p:sp>
        </p:grpSp>
        <p:cxnSp>
          <p:nvCxnSpPr>
            <p:cNvPr id="54" name="Straight Connector 53"/>
            <p:cNvCxnSpPr/>
            <p:nvPr/>
          </p:nvCxnSpPr>
          <p:spPr>
            <a:xfrm flipV="1">
              <a:off x="2338799" y="2927850"/>
              <a:ext cx="2685" cy="36739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Oval 54"/>
            <p:cNvSpPr/>
            <p:nvPr/>
          </p:nvSpPr>
          <p:spPr>
            <a:xfrm>
              <a:off x="2236619" y="3295240"/>
              <a:ext cx="204359" cy="189360"/>
            </a:xfrm>
            <a:prstGeom prst="ellips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234797" y="1858406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57" name="Oval 56"/>
            <p:cNvSpPr/>
            <p:nvPr/>
          </p:nvSpPr>
          <p:spPr>
            <a:xfrm>
              <a:off x="2281877" y="1326830"/>
              <a:ext cx="204291" cy="206731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58" name="Straight Connector 57"/>
            <p:cNvCxnSpPr/>
            <p:nvPr/>
          </p:nvCxnSpPr>
          <p:spPr>
            <a:xfrm flipH="1">
              <a:off x="2582295" y="1372308"/>
              <a:ext cx="919374" cy="96290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 flipH="1">
              <a:off x="2712324" y="1498884"/>
              <a:ext cx="583628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69</a:t>
              </a:r>
            </a:p>
            <a:p>
              <a:endParaRPr lang="en-US" sz="1000" dirty="0"/>
            </a:p>
          </p:txBody>
        </p:sp>
        <p:sp>
          <p:nvSpPr>
            <p:cNvPr id="60" name="Oval 59"/>
            <p:cNvSpPr/>
            <p:nvPr/>
          </p:nvSpPr>
          <p:spPr>
            <a:xfrm>
              <a:off x="1258568" y="1735038"/>
              <a:ext cx="302636" cy="28129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61" name="Oval 60"/>
            <p:cNvSpPr/>
            <p:nvPr/>
          </p:nvSpPr>
          <p:spPr>
            <a:xfrm>
              <a:off x="1686575" y="1367416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62" name="Oval 61"/>
            <p:cNvSpPr/>
            <p:nvPr/>
          </p:nvSpPr>
          <p:spPr>
            <a:xfrm>
              <a:off x="1309628" y="1196672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63" name="Oval 62"/>
            <p:cNvSpPr/>
            <p:nvPr/>
          </p:nvSpPr>
          <p:spPr>
            <a:xfrm>
              <a:off x="473918" y="1415028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64" name="Straight Connector 63"/>
            <p:cNvCxnSpPr/>
            <p:nvPr/>
          </p:nvCxnSpPr>
          <p:spPr>
            <a:xfrm flipV="1">
              <a:off x="1105817" y="1985020"/>
              <a:ext cx="206264" cy="25853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Oval 64"/>
            <p:cNvSpPr/>
            <p:nvPr/>
          </p:nvSpPr>
          <p:spPr>
            <a:xfrm>
              <a:off x="853047" y="2194566"/>
              <a:ext cx="302636" cy="28129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66" name="Straight Connector 65"/>
            <p:cNvCxnSpPr/>
            <p:nvPr/>
          </p:nvCxnSpPr>
          <p:spPr>
            <a:xfrm>
              <a:off x="871002" y="1869445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Oval 66"/>
            <p:cNvSpPr/>
            <p:nvPr/>
          </p:nvSpPr>
          <p:spPr>
            <a:xfrm>
              <a:off x="642205" y="1771240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 flipV="1">
              <a:off x="1503990" y="1970276"/>
              <a:ext cx="224256" cy="23273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Oval 68"/>
            <p:cNvSpPr/>
            <p:nvPr/>
          </p:nvSpPr>
          <p:spPr>
            <a:xfrm>
              <a:off x="1694972" y="2166783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70" name="Oval 69"/>
            <p:cNvSpPr/>
            <p:nvPr/>
          </p:nvSpPr>
          <p:spPr>
            <a:xfrm flipH="1" flipV="1">
              <a:off x="1086345" y="1496218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71" name="Straight Connector 70"/>
            <p:cNvCxnSpPr/>
            <p:nvPr/>
          </p:nvCxnSpPr>
          <p:spPr>
            <a:xfrm>
              <a:off x="702482" y="1521892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Oval 71"/>
            <p:cNvSpPr/>
            <p:nvPr/>
          </p:nvSpPr>
          <p:spPr>
            <a:xfrm>
              <a:off x="1282112" y="2316861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73" name="Straight Connector 72"/>
            <p:cNvCxnSpPr/>
            <p:nvPr/>
          </p:nvCxnSpPr>
          <p:spPr>
            <a:xfrm flipV="1">
              <a:off x="2365530" y="1903194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Oval 73"/>
            <p:cNvSpPr/>
            <p:nvPr/>
          </p:nvSpPr>
          <p:spPr>
            <a:xfrm flipH="1" flipV="1">
              <a:off x="2347665" y="1849542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75" name="Oval 74"/>
            <p:cNvSpPr/>
            <p:nvPr/>
          </p:nvSpPr>
          <p:spPr>
            <a:xfrm flipH="1" flipV="1">
              <a:off x="1926105" y="1850653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76" name="Straight Connector 75"/>
            <p:cNvCxnSpPr/>
            <p:nvPr/>
          </p:nvCxnSpPr>
          <p:spPr>
            <a:xfrm>
              <a:off x="1976958" y="1875688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/>
            <p:cNvCxnSpPr/>
            <p:nvPr/>
          </p:nvCxnSpPr>
          <p:spPr>
            <a:xfrm flipV="1">
              <a:off x="2378004" y="1537143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 flipH="1" flipV="1">
              <a:off x="947088" y="1142019"/>
              <a:ext cx="155173" cy="36428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Oval 78"/>
            <p:cNvSpPr/>
            <p:nvPr/>
          </p:nvSpPr>
          <p:spPr>
            <a:xfrm flipH="1" flipV="1">
              <a:off x="927013" y="1107608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80" name="Oval 79"/>
            <p:cNvSpPr/>
            <p:nvPr/>
          </p:nvSpPr>
          <p:spPr>
            <a:xfrm>
              <a:off x="353418" y="1136202"/>
              <a:ext cx="228564" cy="212449"/>
            </a:xfrm>
            <a:prstGeom prst="ellipse">
              <a:avLst/>
            </a:prstGeom>
            <a:pattFill prst="dkDnDiag">
              <a:fgClr>
                <a:schemeClr val="bg2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bg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81" name="Straight Connector 80"/>
            <p:cNvCxnSpPr/>
            <p:nvPr/>
          </p:nvCxnSpPr>
          <p:spPr>
            <a:xfrm flipV="1">
              <a:off x="581982" y="1132643"/>
              <a:ext cx="346566" cy="10978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910499" y="1088689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cxnSp>
          <p:nvCxnSpPr>
            <p:cNvPr id="83" name="Straight Connector 82"/>
            <p:cNvCxnSpPr/>
            <p:nvPr/>
          </p:nvCxnSpPr>
          <p:spPr>
            <a:xfrm flipH="1" flipV="1">
              <a:off x="556027" y="991017"/>
              <a:ext cx="385807" cy="12157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Oval 83"/>
            <p:cNvSpPr/>
            <p:nvPr/>
          </p:nvSpPr>
          <p:spPr>
            <a:xfrm>
              <a:off x="360935" y="809680"/>
              <a:ext cx="228564" cy="212449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5" name="Oval 84"/>
            <p:cNvSpPr/>
            <p:nvPr/>
          </p:nvSpPr>
          <p:spPr>
            <a:xfrm>
              <a:off x="537703" y="468286"/>
              <a:ext cx="356710" cy="331561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86" name="Oval 85"/>
            <p:cNvSpPr/>
            <p:nvPr/>
          </p:nvSpPr>
          <p:spPr>
            <a:xfrm>
              <a:off x="1289729" y="660031"/>
              <a:ext cx="508570" cy="47271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87" name="Oval 86"/>
            <p:cNvSpPr/>
            <p:nvPr/>
          </p:nvSpPr>
          <p:spPr>
            <a:xfrm>
              <a:off x="984591" y="469862"/>
              <a:ext cx="334545" cy="31095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88" name="Straight Connector 87"/>
            <p:cNvCxnSpPr/>
            <p:nvPr/>
          </p:nvCxnSpPr>
          <p:spPr>
            <a:xfrm flipH="1" flipV="1">
              <a:off x="795675" y="792065"/>
              <a:ext cx="149023" cy="32052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 flipV="1">
              <a:off x="963875" y="777766"/>
              <a:ext cx="129277" cy="32984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/>
            <p:nvPr/>
          </p:nvCxnSpPr>
          <p:spPr>
            <a:xfrm flipV="1">
              <a:off x="972286" y="969429"/>
              <a:ext cx="327248" cy="15855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Oval 90"/>
            <p:cNvSpPr/>
            <p:nvPr/>
          </p:nvSpPr>
          <p:spPr>
            <a:xfrm flipH="1" flipV="1">
              <a:off x="3494156" y="1329571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92" name="Straight Connector 91"/>
            <p:cNvCxnSpPr/>
            <p:nvPr/>
          </p:nvCxnSpPr>
          <p:spPr>
            <a:xfrm flipV="1">
              <a:off x="3515583" y="598296"/>
              <a:ext cx="14938" cy="73127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Pie 92"/>
            <p:cNvSpPr/>
            <p:nvPr/>
          </p:nvSpPr>
          <p:spPr>
            <a:xfrm>
              <a:off x="3430593" y="408937"/>
              <a:ext cx="199855" cy="189359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0070C0"/>
            </a:solidFill>
            <a:ln>
              <a:solidFill>
                <a:schemeClr val="accent1">
                  <a:shade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94" name="Straight Connector 93"/>
            <p:cNvCxnSpPr/>
            <p:nvPr/>
          </p:nvCxnSpPr>
          <p:spPr>
            <a:xfrm>
              <a:off x="3543221" y="1355144"/>
              <a:ext cx="69904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Oval 94"/>
            <p:cNvSpPr/>
            <p:nvPr/>
          </p:nvSpPr>
          <p:spPr>
            <a:xfrm flipH="1" flipV="1">
              <a:off x="4246884" y="1329571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96" name="TextBox 95"/>
            <p:cNvSpPr txBox="1"/>
            <p:nvPr/>
          </p:nvSpPr>
          <p:spPr>
            <a:xfrm flipH="1">
              <a:off x="3415075" y="741364"/>
              <a:ext cx="65817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19</a:t>
              </a:r>
            </a:p>
            <a:p>
              <a:endParaRPr lang="en-US" sz="1000" dirty="0"/>
            </a:p>
          </p:txBody>
        </p:sp>
        <p:sp>
          <p:nvSpPr>
            <p:cNvPr id="97" name="TextBox 96"/>
            <p:cNvSpPr txBox="1"/>
            <p:nvPr/>
          </p:nvSpPr>
          <p:spPr>
            <a:xfrm flipH="1">
              <a:off x="3640393" y="1048210"/>
              <a:ext cx="719686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2</a:t>
              </a:r>
            </a:p>
            <a:p>
              <a:endParaRPr lang="en-US" sz="1000" dirty="0"/>
            </a:p>
          </p:txBody>
        </p:sp>
        <p:sp>
          <p:nvSpPr>
            <p:cNvPr id="98" name="Oval 97"/>
            <p:cNvSpPr/>
            <p:nvPr/>
          </p:nvSpPr>
          <p:spPr>
            <a:xfrm>
              <a:off x="4172398" y="832247"/>
              <a:ext cx="204359" cy="189359"/>
            </a:xfrm>
            <a:prstGeom prst="ellipse">
              <a:avLst/>
            </a:prstGeom>
            <a:pattFill prst="dk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99" name="Straight Connector 98"/>
            <p:cNvCxnSpPr/>
            <p:nvPr/>
          </p:nvCxnSpPr>
          <p:spPr>
            <a:xfrm flipV="1">
              <a:off x="4265841" y="1019572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4151230" y="974360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</a:t>
              </a:r>
            </a:p>
            <a:p>
              <a:endParaRPr lang="en-US" sz="1000" dirty="0"/>
            </a:p>
          </p:txBody>
        </p:sp>
        <p:sp>
          <p:nvSpPr>
            <p:cNvPr id="101" name="Oval 100"/>
            <p:cNvSpPr/>
            <p:nvPr/>
          </p:nvSpPr>
          <p:spPr>
            <a:xfrm flipH="1" flipV="1">
              <a:off x="4227348" y="1698390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02" name="Straight Connector 101"/>
            <p:cNvCxnSpPr/>
            <p:nvPr/>
          </p:nvCxnSpPr>
          <p:spPr>
            <a:xfrm flipV="1">
              <a:off x="4257687" y="1385991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Straight Connector 102"/>
            <p:cNvCxnSpPr/>
            <p:nvPr/>
          </p:nvCxnSpPr>
          <p:spPr>
            <a:xfrm>
              <a:off x="4274287" y="1723425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Pie 103"/>
            <p:cNvSpPr/>
            <p:nvPr/>
          </p:nvSpPr>
          <p:spPr>
            <a:xfrm>
              <a:off x="4652537" y="1618151"/>
              <a:ext cx="204358" cy="184744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282785" y="1415450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</a:t>
              </a:r>
            </a:p>
            <a:p>
              <a:endParaRPr lang="en-US" sz="1000" dirty="0"/>
            </a:p>
          </p:txBody>
        </p:sp>
        <p:cxnSp>
          <p:nvCxnSpPr>
            <p:cNvPr id="106" name="Straight Connector 105"/>
            <p:cNvCxnSpPr/>
            <p:nvPr/>
          </p:nvCxnSpPr>
          <p:spPr>
            <a:xfrm>
              <a:off x="4856895" y="1723425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4845023" y="1421005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108" name="Pie 107"/>
            <p:cNvSpPr/>
            <p:nvPr/>
          </p:nvSpPr>
          <p:spPr>
            <a:xfrm>
              <a:off x="5240758" y="1627476"/>
              <a:ext cx="204358" cy="195479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09" name="Oval 108"/>
            <p:cNvSpPr/>
            <p:nvPr/>
          </p:nvSpPr>
          <p:spPr>
            <a:xfrm flipH="1" flipV="1">
              <a:off x="4229241" y="2048320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10" name="Straight Connector 109"/>
            <p:cNvCxnSpPr/>
            <p:nvPr/>
          </p:nvCxnSpPr>
          <p:spPr>
            <a:xfrm flipV="1">
              <a:off x="4248198" y="1738321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/>
            <p:cNvCxnSpPr/>
            <p:nvPr/>
          </p:nvCxnSpPr>
          <p:spPr>
            <a:xfrm>
              <a:off x="3838732" y="2076516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12" name="Group 111"/>
            <p:cNvGrpSpPr/>
            <p:nvPr/>
          </p:nvGrpSpPr>
          <p:grpSpPr>
            <a:xfrm>
              <a:off x="3203250" y="1784728"/>
              <a:ext cx="629407" cy="616719"/>
              <a:chOff x="2723345" y="2222379"/>
              <a:chExt cx="499833" cy="484950"/>
            </a:xfrm>
          </p:grpSpPr>
          <p:sp>
            <p:nvSpPr>
              <p:cNvPr id="172" name="Oval 171"/>
              <p:cNvSpPr/>
              <p:nvPr/>
            </p:nvSpPr>
            <p:spPr>
              <a:xfrm>
                <a:off x="2724348" y="2224432"/>
                <a:ext cx="489575" cy="459805"/>
              </a:xfrm>
              <a:prstGeom prst="ellipse">
                <a:avLst/>
              </a:prstGeom>
              <a:pattFill prst="ltUpDiag">
                <a:fgClr>
                  <a:srgbClr val="B283FD"/>
                </a:fgClr>
                <a:bgClr>
                  <a:schemeClr val="bg1"/>
                </a:bgClr>
              </a:pattFill>
              <a:ln>
                <a:solidFill>
                  <a:srgbClr val="B283FD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3" dirty="0"/>
              </a:p>
            </p:txBody>
          </p:sp>
          <p:sp>
            <p:nvSpPr>
              <p:cNvPr id="173" name="Pie 172"/>
              <p:cNvSpPr/>
              <p:nvPr/>
            </p:nvSpPr>
            <p:spPr>
              <a:xfrm>
                <a:off x="2723345" y="2222379"/>
                <a:ext cx="499833" cy="484950"/>
              </a:xfrm>
              <a:prstGeom prst="pie">
                <a:avLst>
                  <a:gd name="adj1" fmla="val 17166843"/>
                  <a:gd name="adj2" fmla="val 16200000"/>
                </a:avLst>
              </a:prstGeom>
              <a:solidFill>
                <a:schemeClr val="accent2"/>
              </a:solidFill>
              <a:ln>
                <a:solidFill>
                  <a:schemeClr val="accent2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803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13" name="Oval 112"/>
            <p:cNvSpPr/>
            <p:nvPr/>
          </p:nvSpPr>
          <p:spPr>
            <a:xfrm>
              <a:off x="2913080" y="2531651"/>
              <a:ext cx="196628" cy="198977"/>
            </a:xfrm>
            <a:prstGeom prst="ellipse">
              <a:avLst/>
            </a:prstGeom>
            <a:pattFill prst="dkDnDiag">
              <a:fgClr>
                <a:srgbClr val="B283FD"/>
              </a:fgClr>
              <a:bgClr>
                <a:schemeClr val="bg1"/>
              </a:bgClr>
            </a:pattFill>
            <a:ln>
              <a:solidFill>
                <a:srgbClr val="B283F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14" name="Straight Connector 113"/>
            <p:cNvCxnSpPr/>
            <p:nvPr/>
          </p:nvCxnSpPr>
          <p:spPr>
            <a:xfrm flipV="1">
              <a:off x="3086846" y="2306579"/>
              <a:ext cx="206264" cy="25853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Oval 114"/>
            <p:cNvSpPr/>
            <p:nvPr/>
          </p:nvSpPr>
          <p:spPr>
            <a:xfrm>
              <a:off x="3428648" y="2720164"/>
              <a:ext cx="201800" cy="189361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16" name="Straight Connector 115"/>
            <p:cNvCxnSpPr/>
            <p:nvPr/>
          </p:nvCxnSpPr>
          <p:spPr>
            <a:xfrm flipH="1" flipV="1">
              <a:off x="3517954" y="2401447"/>
              <a:ext cx="12566" cy="32632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Oval 116"/>
            <p:cNvSpPr/>
            <p:nvPr/>
          </p:nvSpPr>
          <p:spPr>
            <a:xfrm>
              <a:off x="4025967" y="2703145"/>
              <a:ext cx="196628" cy="198977"/>
            </a:xfrm>
            <a:prstGeom prst="ellipse">
              <a:avLst/>
            </a:prstGeom>
            <a:pattFill prst="dkDnDiag">
              <a:fgClr>
                <a:srgbClr val="B283FD"/>
              </a:fgClr>
              <a:bgClr>
                <a:schemeClr val="bg1"/>
              </a:bgClr>
            </a:pattFill>
            <a:ln>
              <a:solidFill>
                <a:srgbClr val="B283F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18" name="Straight Connector 117"/>
            <p:cNvCxnSpPr/>
            <p:nvPr/>
          </p:nvCxnSpPr>
          <p:spPr>
            <a:xfrm>
              <a:off x="3635424" y="2814844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/>
            <p:cNvSpPr txBox="1"/>
            <p:nvPr/>
          </p:nvSpPr>
          <p:spPr>
            <a:xfrm>
              <a:off x="3655623" y="2489356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3</a:t>
              </a:r>
            </a:p>
            <a:p>
              <a:endParaRPr lang="en-US" sz="1000" dirty="0"/>
            </a:p>
          </p:txBody>
        </p:sp>
        <p:cxnSp>
          <p:nvCxnSpPr>
            <p:cNvPr id="120" name="Straight Connector 119"/>
            <p:cNvCxnSpPr/>
            <p:nvPr/>
          </p:nvCxnSpPr>
          <p:spPr>
            <a:xfrm>
              <a:off x="4229183" y="2802633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Connector 120"/>
            <p:cNvCxnSpPr/>
            <p:nvPr/>
          </p:nvCxnSpPr>
          <p:spPr>
            <a:xfrm flipH="1" flipV="1">
              <a:off x="4437329" y="2517707"/>
              <a:ext cx="220885" cy="18630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/>
            <p:cNvSpPr txBox="1"/>
            <p:nvPr/>
          </p:nvSpPr>
          <p:spPr>
            <a:xfrm>
              <a:off x="4413198" y="2318594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123" name="Oval 122"/>
            <p:cNvSpPr/>
            <p:nvPr/>
          </p:nvSpPr>
          <p:spPr>
            <a:xfrm>
              <a:off x="4290532" y="2347831"/>
              <a:ext cx="196628" cy="198977"/>
            </a:xfrm>
            <a:prstGeom prst="ellipse">
              <a:avLst/>
            </a:prstGeom>
            <a:pattFill prst="dk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24" name="Straight Connector 123"/>
            <p:cNvCxnSpPr/>
            <p:nvPr/>
          </p:nvCxnSpPr>
          <p:spPr>
            <a:xfrm flipV="1">
              <a:off x="4751725" y="2344454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5" name="TextBox 124"/>
            <p:cNvSpPr txBox="1"/>
            <p:nvPr/>
          </p:nvSpPr>
          <p:spPr>
            <a:xfrm>
              <a:off x="4689151" y="2292156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cxnSp>
          <p:nvCxnSpPr>
            <p:cNvPr id="126" name="Straight Connector 125"/>
            <p:cNvCxnSpPr/>
            <p:nvPr/>
          </p:nvCxnSpPr>
          <p:spPr>
            <a:xfrm>
              <a:off x="4888201" y="2206616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4905036" y="1892177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8</a:t>
              </a:r>
            </a:p>
            <a:p>
              <a:endParaRPr lang="en-US" sz="1000" dirty="0"/>
            </a:p>
          </p:txBody>
        </p:sp>
        <p:sp>
          <p:nvSpPr>
            <p:cNvPr id="128" name="Pie 127"/>
            <p:cNvSpPr/>
            <p:nvPr/>
          </p:nvSpPr>
          <p:spPr>
            <a:xfrm>
              <a:off x="5279102" y="2112492"/>
              <a:ext cx="199855" cy="189359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0070C0"/>
            </a:solidFill>
            <a:ln>
              <a:solidFill>
                <a:schemeClr val="accent1">
                  <a:shade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129" name="Straight Connector 128"/>
            <p:cNvCxnSpPr/>
            <p:nvPr/>
          </p:nvCxnSpPr>
          <p:spPr>
            <a:xfrm>
              <a:off x="4873480" y="2802633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0" name="Oval 129"/>
            <p:cNvSpPr/>
            <p:nvPr/>
          </p:nvSpPr>
          <p:spPr>
            <a:xfrm>
              <a:off x="5262817" y="2706022"/>
              <a:ext cx="197984" cy="189360"/>
            </a:xfrm>
            <a:prstGeom prst="ellipse">
              <a:avLst/>
            </a:prstGeom>
            <a:pattFill prst="dk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4905036" y="2491082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132" name="Oval 131"/>
            <p:cNvSpPr/>
            <p:nvPr/>
          </p:nvSpPr>
          <p:spPr>
            <a:xfrm flipH="1" flipV="1">
              <a:off x="4709281" y="3240249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33" name="Straight Connector 132"/>
            <p:cNvCxnSpPr/>
            <p:nvPr/>
          </p:nvCxnSpPr>
          <p:spPr>
            <a:xfrm flipV="1">
              <a:off x="4739620" y="2927850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4" name="Straight Connector 133"/>
            <p:cNvCxnSpPr/>
            <p:nvPr/>
          </p:nvCxnSpPr>
          <p:spPr>
            <a:xfrm>
              <a:off x="4326601" y="3265284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Pie 134"/>
            <p:cNvSpPr/>
            <p:nvPr/>
          </p:nvSpPr>
          <p:spPr>
            <a:xfrm flipH="1">
              <a:off x="4617446" y="2085722"/>
              <a:ext cx="267236" cy="257819"/>
            </a:xfrm>
            <a:prstGeom prst="pie">
              <a:avLst>
                <a:gd name="adj1" fmla="val 5352730"/>
                <a:gd name="adj2" fmla="val 16200000"/>
              </a:avLst>
            </a:prstGeom>
            <a:pattFill prst="dkDnDiag">
              <a:fgClr>
                <a:srgbClr val="B283FD"/>
              </a:fgClr>
              <a:bgClr>
                <a:schemeClr val="bg1"/>
              </a:bgClr>
            </a:pattFill>
            <a:ln>
              <a:solidFill>
                <a:srgbClr val="B283F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36" name="Pie 135"/>
            <p:cNvSpPr/>
            <p:nvPr/>
          </p:nvSpPr>
          <p:spPr>
            <a:xfrm rot="228972" flipH="1">
              <a:off x="4609088" y="2086641"/>
              <a:ext cx="267236" cy="257819"/>
            </a:xfrm>
            <a:prstGeom prst="pie">
              <a:avLst>
                <a:gd name="adj1" fmla="val 16350609"/>
                <a:gd name="adj2" fmla="val 5639097"/>
              </a:avLst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37" name="Pie 136"/>
            <p:cNvSpPr/>
            <p:nvPr/>
          </p:nvSpPr>
          <p:spPr>
            <a:xfrm flipH="1">
              <a:off x="4614976" y="2667891"/>
              <a:ext cx="267236" cy="257819"/>
            </a:xfrm>
            <a:prstGeom prst="pie">
              <a:avLst>
                <a:gd name="adj1" fmla="val 5352730"/>
                <a:gd name="adj2" fmla="val 16200000"/>
              </a:avLst>
            </a:prstGeom>
            <a:solidFill>
              <a:srgbClr val="FF55F8"/>
            </a:solidFill>
            <a:ln>
              <a:solidFill>
                <a:srgbClr val="FF55F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38" name="Pie 137"/>
            <p:cNvSpPr/>
            <p:nvPr/>
          </p:nvSpPr>
          <p:spPr>
            <a:xfrm rot="228972" flipH="1">
              <a:off x="4606618" y="2668810"/>
              <a:ext cx="267236" cy="257819"/>
            </a:xfrm>
            <a:prstGeom prst="pie">
              <a:avLst>
                <a:gd name="adj1" fmla="val 16350609"/>
                <a:gd name="adj2" fmla="val 5639097"/>
              </a:avLst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39" name="Pie 138"/>
            <p:cNvSpPr/>
            <p:nvPr/>
          </p:nvSpPr>
          <p:spPr>
            <a:xfrm>
              <a:off x="4019287" y="3120765"/>
              <a:ext cx="307850" cy="307850"/>
            </a:xfrm>
            <a:prstGeom prst="pie">
              <a:avLst>
                <a:gd name="adj1" fmla="val 18209484"/>
                <a:gd name="adj2" fmla="val 12841068"/>
              </a:avLst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>
                <a:solidFill>
                  <a:schemeClr val="tx1"/>
                </a:solidFill>
              </a:endParaRPr>
            </a:p>
          </p:txBody>
        </p:sp>
        <p:sp>
          <p:nvSpPr>
            <p:cNvPr id="140" name="Pie 139"/>
            <p:cNvSpPr/>
            <p:nvPr/>
          </p:nvSpPr>
          <p:spPr>
            <a:xfrm>
              <a:off x="4018366" y="3120110"/>
              <a:ext cx="312965" cy="307850"/>
            </a:xfrm>
            <a:prstGeom prst="pie">
              <a:avLst>
                <a:gd name="adj1" fmla="val 13044943"/>
                <a:gd name="adj2" fmla="val 18403478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141" name="Straight Connector 140"/>
            <p:cNvCxnSpPr/>
            <p:nvPr/>
          </p:nvCxnSpPr>
          <p:spPr>
            <a:xfrm flipV="1">
              <a:off x="4458981" y="3287162"/>
              <a:ext cx="257197" cy="25463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2" name="Oval 141"/>
            <p:cNvSpPr/>
            <p:nvPr/>
          </p:nvSpPr>
          <p:spPr>
            <a:xfrm>
              <a:off x="4282801" y="3512941"/>
              <a:ext cx="204359" cy="189360"/>
            </a:xfrm>
            <a:prstGeom prst="ellipse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/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4295308" y="3164471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cxnSp>
          <p:nvCxnSpPr>
            <p:cNvPr id="144" name="Straight Connector 143"/>
            <p:cNvCxnSpPr/>
            <p:nvPr/>
          </p:nvCxnSpPr>
          <p:spPr>
            <a:xfrm flipH="1" flipV="1">
              <a:off x="4501279" y="3070182"/>
              <a:ext cx="220885" cy="18630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Pie 144"/>
            <p:cNvSpPr/>
            <p:nvPr/>
          </p:nvSpPr>
          <p:spPr>
            <a:xfrm>
              <a:off x="4326601" y="2914448"/>
              <a:ext cx="199855" cy="189359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146" name="Straight Connector 145"/>
            <p:cNvCxnSpPr/>
            <p:nvPr/>
          </p:nvCxnSpPr>
          <p:spPr>
            <a:xfrm>
              <a:off x="4757799" y="3264684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/>
            <p:nvPr/>
          </p:nvCxnSpPr>
          <p:spPr>
            <a:xfrm>
              <a:off x="5337070" y="3256486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8" name="Oval 147"/>
            <p:cNvSpPr/>
            <p:nvPr/>
          </p:nvSpPr>
          <p:spPr>
            <a:xfrm>
              <a:off x="5138578" y="3161806"/>
              <a:ext cx="204359" cy="189360"/>
            </a:xfrm>
            <a:prstGeom prst="ellipse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/>
            </a:p>
          </p:txBody>
        </p:sp>
        <p:sp>
          <p:nvSpPr>
            <p:cNvPr id="149" name="Oval 148"/>
            <p:cNvSpPr/>
            <p:nvPr/>
          </p:nvSpPr>
          <p:spPr>
            <a:xfrm>
              <a:off x="5717849" y="3153608"/>
              <a:ext cx="204359" cy="189360"/>
            </a:xfrm>
            <a:prstGeom prst="ellipse">
              <a:avLst/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5352515" y="2952799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4</a:t>
              </a:r>
            </a:p>
            <a:p>
              <a:endParaRPr lang="en-US" sz="1000" dirty="0"/>
            </a:p>
          </p:txBody>
        </p:sp>
        <p:cxnSp>
          <p:nvCxnSpPr>
            <p:cNvPr id="151" name="Straight Connector 150"/>
            <p:cNvCxnSpPr/>
            <p:nvPr/>
          </p:nvCxnSpPr>
          <p:spPr>
            <a:xfrm flipV="1">
              <a:off x="4728255" y="3293171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2" name="Oval 151"/>
            <p:cNvSpPr/>
            <p:nvPr/>
          </p:nvSpPr>
          <p:spPr>
            <a:xfrm>
              <a:off x="4613046" y="4017495"/>
              <a:ext cx="201800" cy="189361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53" name="Oval 152"/>
            <p:cNvSpPr/>
            <p:nvPr/>
          </p:nvSpPr>
          <p:spPr>
            <a:xfrm flipH="1" flipV="1">
              <a:off x="4702137" y="3623491"/>
              <a:ext cx="51301" cy="5007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54" name="Straight Connector 153"/>
            <p:cNvCxnSpPr/>
            <p:nvPr/>
          </p:nvCxnSpPr>
          <p:spPr>
            <a:xfrm flipV="1">
              <a:off x="4717539" y="3676413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 flipV="1">
              <a:off x="4487160" y="3668049"/>
              <a:ext cx="216723" cy="19899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Pie 155"/>
            <p:cNvSpPr/>
            <p:nvPr/>
          </p:nvSpPr>
          <p:spPr>
            <a:xfrm>
              <a:off x="4326601" y="3850838"/>
              <a:ext cx="199855" cy="189359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157" name="Straight Connector 156"/>
            <p:cNvCxnSpPr/>
            <p:nvPr/>
          </p:nvCxnSpPr>
          <p:spPr>
            <a:xfrm flipH="1" flipV="1">
              <a:off x="4749890" y="3290498"/>
              <a:ext cx="220885" cy="18630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Pie 157"/>
            <p:cNvSpPr/>
            <p:nvPr/>
          </p:nvSpPr>
          <p:spPr>
            <a:xfrm>
              <a:off x="4942930" y="3423802"/>
              <a:ext cx="307850" cy="307850"/>
            </a:xfrm>
            <a:prstGeom prst="pie">
              <a:avLst>
                <a:gd name="adj1" fmla="val 18209484"/>
                <a:gd name="adj2" fmla="val 12841068"/>
              </a:avLst>
            </a:prstGeom>
            <a:pattFill prst="ltUpDiag">
              <a:fgClr>
                <a:srgbClr val="B283FD"/>
              </a:fgClr>
              <a:bgClr>
                <a:schemeClr val="bg1"/>
              </a:bgClr>
            </a:pattFill>
            <a:ln>
              <a:solidFill>
                <a:srgbClr val="B283F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 dirty="0">
                <a:solidFill>
                  <a:schemeClr val="tx1"/>
                </a:solidFill>
              </a:endParaRPr>
            </a:p>
          </p:txBody>
        </p:sp>
        <p:sp>
          <p:nvSpPr>
            <p:cNvPr id="159" name="Pie 158"/>
            <p:cNvSpPr/>
            <p:nvPr/>
          </p:nvSpPr>
          <p:spPr>
            <a:xfrm>
              <a:off x="4938437" y="3426719"/>
              <a:ext cx="312965" cy="307850"/>
            </a:xfrm>
            <a:prstGeom prst="pie">
              <a:avLst>
                <a:gd name="adj1" fmla="val 13044943"/>
                <a:gd name="adj2" fmla="val 18403478"/>
              </a:avLst>
            </a:prstGeom>
            <a:pattFill prst="ltUp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60" name="Oval 159"/>
            <p:cNvSpPr/>
            <p:nvPr/>
          </p:nvSpPr>
          <p:spPr>
            <a:xfrm>
              <a:off x="4996605" y="4072003"/>
              <a:ext cx="196628" cy="198977"/>
            </a:xfrm>
            <a:prstGeom prst="ellipse">
              <a:avLst/>
            </a:prstGeom>
            <a:pattFill prst="dk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rgbClr val="00B0F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61" name="Straight Connector 160"/>
            <p:cNvCxnSpPr/>
            <p:nvPr/>
          </p:nvCxnSpPr>
          <p:spPr>
            <a:xfrm flipV="1">
              <a:off x="5094919" y="3734569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Pie 161"/>
            <p:cNvSpPr/>
            <p:nvPr/>
          </p:nvSpPr>
          <p:spPr>
            <a:xfrm>
              <a:off x="5633967" y="3435852"/>
              <a:ext cx="194496" cy="201894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55F8"/>
            </a:solidFill>
            <a:ln>
              <a:solidFill>
                <a:srgbClr val="FF55F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cxnSp>
          <p:nvCxnSpPr>
            <p:cNvPr id="163" name="Straight Connector 162"/>
            <p:cNvCxnSpPr/>
            <p:nvPr/>
          </p:nvCxnSpPr>
          <p:spPr>
            <a:xfrm>
              <a:off x="5253184" y="3576527"/>
              <a:ext cx="38386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5243170" y="3273316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165" name="Oval 164"/>
            <p:cNvSpPr/>
            <p:nvPr/>
          </p:nvSpPr>
          <p:spPr>
            <a:xfrm>
              <a:off x="5618093" y="3975180"/>
              <a:ext cx="199511" cy="201894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66" name="Straight Connector 165"/>
            <p:cNvCxnSpPr/>
            <p:nvPr/>
          </p:nvCxnSpPr>
          <p:spPr>
            <a:xfrm flipV="1">
              <a:off x="5726056" y="3637746"/>
              <a:ext cx="8446" cy="33743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66"/>
            <p:cNvSpPr txBox="1"/>
            <p:nvPr/>
          </p:nvSpPr>
          <p:spPr>
            <a:xfrm>
              <a:off x="5610733" y="3601523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2907592" y="2141054"/>
              <a:ext cx="330753" cy="6668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/>
                <a:t>2</a:t>
              </a:r>
            </a:p>
            <a:p>
              <a:endParaRPr lang="en-US" sz="1000" dirty="0"/>
            </a:p>
          </p:txBody>
        </p:sp>
        <p:cxnSp>
          <p:nvCxnSpPr>
            <p:cNvPr id="169" name="Straight Connector 168"/>
            <p:cNvCxnSpPr/>
            <p:nvPr/>
          </p:nvCxnSpPr>
          <p:spPr>
            <a:xfrm flipV="1">
              <a:off x="4847554" y="2462826"/>
              <a:ext cx="217857" cy="2343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Pie 169"/>
            <p:cNvSpPr/>
            <p:nvPr/>
          </p:nvSpPr>
          <p:spPr>
            <a:xfrm flipH="1">
              <a:off x="5067562" y="2301980"/>
              <a:ext cx="267236" cy="257819"/>
            </a:xfrm>
            <a:prstGeom prst="pie">
              <a:avLst>
                <a:gd name="adj1" fmla="val 5352730"/>
                <a:gd name="adj2" fmla="val 16200000"/>
              </a:avLst>
            </a:prstGeom>
            <a:solidFill>
              <a:srgbClr val="00FDFF"/>
            </a:solidFill>
            <a:ln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171" name="Pie 170"/>
            <p:cNvSpPr/>
            <p:nvPr/>
          </p:nvSpPr>
          <p:spPr>
            <a:xfrm rot="228972" flipH="1">
              <a:off x="5059204" y="2302899"/>
              <a:ext cx="267236" cy="257819"/>
            </a:xfrm>
            <a:prstGeom prst="pie">
              <a:avLst>
                <a:gd name="adj1" fmla="val 16350609"/>
                <a:gd name="adj2" fmla="val 5639097"/>
              </a:avLst>
            </a:prstGeom>
            <a:solidFill>
              <a:srgbClr val="0070C0"/>
            </a:solidFill>
            <a:ln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</p:grpSp>
      <p:grpSp>
        <p:nvGrpSpPr>
          <p:cNvPr id="178" name="Group 177"/>
          <p:cNvGrpSpPr/>
          <p:nvPr/>
        </p:nvGrpSpPr>
        <p:grpSpPr>
          <a:xfrm>
            <a:off x="1391501" y="1220467"/>
            <a:ext cx="4101564" cy="3026653"/>
            <a:chOff x="200431" y="5640915"/>
            <a:chExt cx="4103706" cy="3531206"/>
          </a:xfrm>
        </p:grpSpPr>
        <p:sp>
          <p:nvSpPr>
            <p:cNvPr id="179" name="TextBox 178"/>
            <p:cNvSpPr txBox="1"/>
            <p:nvPr/>
          </p:nvSpPr>
          <p:spPr>
            <a:xfrm>
              <a:off x="2733243" y="7579472"/>
              <a:ext cx="667518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/>
                <a:t>Chelmsford</a:t>
              </a:r>
              <a:endParaRPr lang="en-US" sz="802" dirty="0"/>
            </a:p>
          </p:txBody>
        </p:sp>
        <p:sp>
          <p:nvSpPr>
            <p:cNvPr id="180" name="Freeform 179"/>
            <p:cNvSpPr/>
            <p:nvPr/>
          </p:nvSpPr>
          <p:spPr>
            <a:xfrm>
              <a:off x="200431" y="5701703"/>
              <a:ext cx="3689136" cy="3470418"/>
            </a:xfrm>
            <a:custGeom>
              <a:avLst/>
              <a:gdLst>
                <a:gd name="connsiteX0" fmla="*/ 14140 w 5649501"/>
                <a:gd name="connsiteY0" fmla="*/ 0 h 5236589"/>
                <a:gd name="connsiteX1" fmla="*/ 9427 w 5649501"/>
                <a:gd name="connsiteY1" fmla="*/ 23567 h 5236589"/>
                <a:gd name="connsiteX2" fmla="*/ 4714 w 5649501"/>
                <a:gd name="connsiteY2" fmla="*/ 37707 h 5236589"/>
                <a:gd name="connsiteX3" fmla="*/ 0 w 5649501"/>
                <a:gd name="connsiteY3" fmla="*/ 56560 h 5236589"/>
                <a:gd name="connsiteX4" fmla="*/ 9427 w 5649501"/>
                <a:gd name="connsiteY4" fmla="*/ 141402 h 5236589"/>
                <a:gd name="connsiteX5" fmla="*/ 14140 w 5649501"/>
                <a:gd name="connsiteY5" fmla="*/ 179109 h 5236589"/>
                <a:gd name="connsiteX6" fmla="*/ 28281 w 5649501"/>
                <a:gd name="connsiteY6" fmla="*/ 212103 h 5236589"/>
                <a:gd name="connsiteX7" fmla="*/ 37707 w 5649501"/>
                <a:gd name="connsiteY7" fmla="*/ 226243 h 5236589"/>
                <a:gd name="connsiteX8" fmla="*/ 42421 w 5649501"/>
                <a:gd name="connsiteY8" fmla="*/ 240383 h 5236589"/>
                <a:gd name="connsiteX9" fmla="*/ 51848 w 5649501"/>
                <a:gd name="connsiteY9" fmla="*/ 254523 h 5236589"/>
                <a:gd name="connsiteX10" fmla="*/ 61275 w 5649501"/>
                <a:gd name="connsiteY10" fmla="*/ 273377 h 5236589"/>
                <a:gd name="connsiteX11" fmla="*/ 70701 w 5649501"/>
                <a:gd name="connsiteY11" fmla="*/ 287517 h 5236589"/>
                <a:gd name="connsiteX12" fmla="*/ 84842 w 5649501"/>
                <a:gd name="connsiteY12" fmla="*/ 315798 h 5236589"/>
                <a:gd name="connsiteX13" fmla="*/ 113122 w 5649501"/>
                <a:gd name="connsiteY13" fmla="*/ 372358 h 5236589"/>
                <a:gd name="connsiteX14" fmla="*/ 127262 w 5649501"/>
                <a:gd name="connsiteY14" fmla="*/ 381785 h 5236589"/>
                <a:gd name="connsiteX15" fmla="*/ 150829 w 5649501"/>
                <a:gd name="connsiteY15" fmla="*/ 410066 h 5236589"/>
                <a:gd name="connsiteX16" fmla="*/ 169683 w 5649501"/>
                <a:gd name="connsiteY16" fmla="*/ 438346 h 5236589"/>
                <a:gd name="connsiteX17" fmla="*/ 207390 w 5649501"/>
                <a:gd name="connsiteY17" fmla="*/ 457200 h 5236589"/>
                <a:gd name="connsiteX18" fmla="*/ 221530 w 5649501"/>
                <a:gd name="connsiteY18" fmla="*/ 490193 h 5236589"/>
                <a:gd name="connsiteX19" fmla="*/ 226244 w 5649501"/>
                <a:gd name="connsiteY19" fmla="*/ 504334 h 5236589"/>
                <a:gd name="connsiteX20" fmla="*/ 240384 w 5649501"/>
                <a:gd name="connsiteY20" fmla="*/ 513760 h 5236589"/>
                <a:gd name="connsiteX21" fmla="*/ 249811 w 5649501"/>
                <a:gd name="connsiteY21" fmla="*/ 542041 h 5236589"/>
                <a:gd name="connsiteX22" fmla="*/ 254524 w 5649501"/>
                <a:gd name="connsiteY22" fmla="*/ 575035 h 5236589"/>
                <a:gd name="connsiteX23" fmla="*/ 273378 w 5649501"/>
                <a:gd name="connsiteY23" fmla="*/ 593888 h 5236589"/>
                <a:gd name="connsiteX24" fmla="*/ 292231 w 5649501"/>
                <a:gd name="connsiteY24" fmla="*/ 622169 h 5236589"/>
                <a:gd name="connsiteX25" fmla="*/ 296945 w 5649501"/>
                <a:gd name="connsiteY25" fmla="*/ 641022 h 5236589"/>
                <a:gd name="connsiteX26" fmla="*/ 306371 w 5649501"/>
                <a:gd name="connsiteY26" fmla="*/ 688156 h 5236589"/>
                <a:gd name="connsiteX27" fmla="*/ 311085 w 5649501"/>
                <a:gd name="connsiteY27" fmla="*/ 702297 h 5236589"/>
                <a:gd name="connsiteX28" fmla="*/ 325225 w 5649501"/>
                <a:gd name="connsiteY28" fmla="*/ 711723 h 5236589"/>
                <a:gd name="connsiteX29" fmla="*/ 339365 w 5649501"/>
                <a:gd name="connsiteY29" fmla="*/ 730577 h 5236589"/>
                <a:gd name="connsiteX30" fmla="*/ 353505 w 5649501"/>
                <a:gd name="connsiteY30" fmla="*/ 735290 h 5236589"/>
                <a:gd name="connsiteX31" fmla="*/ 372359 w 5649501"/>
                <a:gd name="connsiteY31" fmla="*/ 768284 h 5236589"/>
                <a:gd name="connsiteX32" fmla="*/ 386499 w 5649501"/>
                <a:gd name="connsiteY32" fmla="*/ 834272 h 5236589"/>
                <a:gd name="connsiteX33" fmla="*/ 391213 w 5649501"/>
                <a:gd name="connsiteY33" fmla="*/ 848412 h 5236589"/>
                <a:gd name="connsiteX34" fmla="*/ 400639 w 5649501"/>
                <a:gd name="connsiteY34" fmla="*/ 862552 h 5236589"/>
                <a:gd name="connsiteX35" fmla="*/ 414780 w 5649501"/>
                <a:gd name="connsiteY35" fmla="*/ 890833 h 5236589"/>
                <a:gd name="connsiteX36" fmla="*/ 419493 w 5649501"/>
                <a:gd name="connsiteY36" fmla="*/ 909686 h 5236589"/>
                <a:gd name="connsiteX37" fmla="*/ 438347 w 5649501"/>
                <a:gd name="connsiteY37" fmla="*/ 937967 h 5236589"/>
                <a:gd name="connsiteX38" fmla="*/ 443060 w 5649501"/>
                <a:gd name="connsiteY38" fmla="*/ 952107 h 5236589"/>
                <a:gd name="connsiteX39" fmla="*/ 461914 w 5649501"/>
                <a:gd name="connsiteY39" fmla="*/ 980387 h 5236589"/>
                <a:gd name="connsiteX40" fmla="*/ 480767 w 5649501"/>
                <a:gd name="connsiteY40" fmla="*/ 999241 h 5236589"/>
                <a:gd name="connsiteX41" fmla="*/ 490194 w 5649501"/>
                <a:gd name="connsiteY41" fmla="*/ 1013381 h 5236589"/>
                <a:gd name="connsiteX42" fmla="*/ 504334 w 5649501"/>
                <a:gd name="connsiteY42" fmla="*/ 1084082 h 5236589"/>
                <a:gd name="connsiteX43" fmla="*/ 513761 w 5649501"/>
                <a:gd name="connsiteY43" fmla="*/ 1131216 h 5236589"/>
                <a:gd name="connsiteX44" fmla="*/ 532615 w 5649501"/>
                <a:gd name="connsiteY44" fmla="*/ 1159497 h 5236589"/>
                <a:gd name="connsiteX45" fmla="*/ 542042 w 5649501"/>
                <a:gd name="connsiteY45" fmla="*/ 1173637 h 5236589"/>
                <a:gd name="connsiteX46" fmla="*/ 551468 w 5649501"/>
                <a:gd name="connsiteY46" fmla="*/ 1187777 h 5236589"/>
                <a:gd name="connsiteX47" fmla="*/ 565609 w 5649501"/>
                <a:gd name="connsiteY47" fmla="*/ 1201917 h 5236589"/>
                <a:gd name="connsiteX48" fmla="*/ 570322 w 5649501"/>
                <a:gd name="connsiteY48" fmla="*/ 1216057 h 5236589"/>
                <a:gd name="connsiteX49" fmla="*/ 598602 w 5649501"/>
                <a:gd name="connsiteY49" fmla="*/ 1249051 h 5236589"/>
                <a:gd name="connsiteX50" fmla="*/ 617456 w 5649501"/>
                <a:gd name="connsiteY50" fmla="*/ 1277332 h 5236589"/>
                <a:gd name="connsiteX51" fmla="*/ 626883 w 5649501"/>
                <a:gd name="connsiteY51" fmla="*/ 1291472 h 5236589"/>
                <a:gd name="connsiteX52" fmla="*/ 650450 w 5649501"/>
                <a:gd name="connsiteY52" fmla="*/ 1324466 h 5236589"/>
                <a:gd name="connsiteX53" fmla="*/ 664590 w 5649501"/>
                <a:gd name="connsiteY53" fmla="*/ 1329179 h 5236589"/>
                <a:gd name="connsiteX54" fmla="*/ 683444 w 5649501"/>
                <a:gd name="connsiteY54" fmla="*/ 1357459 h 5236589"/>
                <a:gd name="connsiteX55" fmla="*/ 688157 w 5649501"/>
                <a:gd name="connsiteY55" fmla="*/ 1371600 h 5236589"/>
                <a:gd name="connsiteX56" fmla="*/ 707011 w 5649501"/>
                <a:gd name="connsiteY56" fmla="*/ 1404593 h 5236589"/>
                <a:gd name="connsiteX57" fmla="*/ 721151 w 5649501"/>
                <a:gd name="connsiteY57" fmla="*/ 1437587 h 5236589"/>
                <a:gd name="connsiteX58" fmla="*/ 735291 w 5649501"/>
                <a:gd name="connsiteY58" fmla="*/ 1465868 h 5236589"/>
                <a:gd name="connsiteX59" fmla="*/ 740004 w 5649501"/>
                <a:gd name="connsiteY59" fmla="*/ 1484721 h 5236589"/>
                <a:gd name="connsiteX60" fmla="*/ 754145 w 5649501"/>
                <a:gd name="connsiteY60" fmla="*/ 1489435 h 5236589"/>
                <a:gd name="connsiteX61" fmla="*/ 749431 w 5649501"/>
                <a:gd name="connsiteY61" fmla="*/ 1545996 h 5236589"/>
                <a:gd name="connsiteX62" fmla="*/ 754145 w 5649501"/>
                <a:gd name="connsiteY62" fmla="*/ 1593130 h 5236589"/>
                <a:gd name="connsiteX63" fmla="*/ 758858 w 5649501"/>
                <a:gd name="connsiteY63" fmla="*/ 1621410 h 5236589"/>
                <a:gd name="connsiteX64" fmla="*/ 744718 w 5649501"/>
                <a:gd name="connsiteY64" fmla="*/ 1701538 h 5236589"/>
                <a:gd name="connsiteX65" fmla="*/ 735291 w 5649501"/>
                <a:gd name="connsiteY65" fmla="*/ 1729818 h 5236589"/>
                <a:gd name="connsiteX66" fmla="*/ 725864 w 5649501"/>
                <a:gd name="connsiteY66" fmla="*/ 1748672 h 5236589"/>
                <a:gd name="connsiteX67" fmla="*/ 735291 w 5649501"/>
                <a:gd name="connsiteY67" fmla="*/ 1984342 h 5236589"/>
                <a:gd name="connsiteX68" fmla="*/ 744718 w 5649501"/>
                <a:gd name="connsiteY68" fmla="*/ 2022049 h 5236589"/>
                <a:gd name="connsiteX69" fmla="*/ 758858 w 5649501"/>
                <a:gd name="connsiteY69" fmla="*/ 2031476 h 5236589"/>
                <a:gd name="connsiteX70" fmla="*/ 772998 w 5649501"/>
                <a:gd name="connsiteY70" fmla="*/ 2069183 h 5236589"/>
                <a:gd name="connsiteX71" fmla="*/ 791852 w 5649501"/>
                <a:gd name="connsiteY71" fmla="*/ 2097464 h 5236589"/>
                <a:gd name="connsiteX72" fmla="*/ 801279 w 5649501"/>
                <a:gd name="connsiteY72" fmla="*/ 2125744 h 5236589"/>
                <a:gd name="connsiteX73" fmla="*/ 805992 w 5649501"/>
                <a:gd name="connsiteY73" fmla="*/ 2139884 h 5236589"/>
                <a:gd name="connsiteX74" fmla="*/ 815419 w 5649501"/>
                <a:gd name="connsiteY74" fmla="*/ 2177591 h 5236589"/>
                <a:gd name="connsiteX75" fmla="*/ 820132 w 5649501"/>
                <a:gd name="connsiteY75" fmla="*/ 2191732 h 5236589"/>
                <a:gd name="connsiteX76" fmla="*/ 829559 w 5649501"/>
                <a:gd name="connsiteY76" fmla="*/ 2205872 h 5236589"/>
                <a:gd name="connsiteX77" fmla="*/ 829559 w 5649501"/>
                <a:gd name="connsiteY77" fmla="*/ 2286000 h 5236589"/>
                <a:gd name="connsiteX78" fmla="*/ 834272 w 5649501"/>
                <a:gd name="connsiteY78" fmla="*/ 2351987 h 5236589"/>
                <a:gd name="connsiteX79" fmla="*/ 838986 w 5649501"/>
                <a:gd name="connsiteY79" fmla="*/ 2375554 h 5236589"/>
                <a:gd name="connsiteX80" fmla="*/ 843699 w 5649501"/>
                <a:gd name="connsiteY80" fmla="*/ 2403835 h 5236589"/>
                <a:gd name="connsiteX81" fmla="*/ 848413 w 5649501"/>
                <a:gd name="connsiteY81" fmla="*/ 2441542 h 5236589"/>
                <a:gd name="connsiteX82" fmla="*/ 853126 w 5649501"/>
                <a:gd name="connsiteY82" fmla="*/ 2474536 h 5236589"/>
                <a:gd name="connsiteX83" fmla="*/ 857839 w 5649501"/>
                <a:gd name="connsiteY83" fmla="*/ 2535810 h 5236589"/>
                <a:gd name="connsiteX84" fmla="*/ 867266 w 5649501"/>
                <a:gd name="connsiteY84" fmla="*/ 2559377 h 5236589"/>
                <a:gd name="connsiteX85" fmla="*/ 871980 w 5649501"/>
                <a:gd name="connsiteY85" fmla="*/ 2578231 h 5236589"/>
                <a:gd name="connsiteX86" fmla="*/ 890833 w 5649501"/>
                <a:gd name="connsiteY86" fmla="*/ 2606511 h 5236589"/>
                <a:gd name="connsiteX87" fmla="*/ 904973 w 5649501"/>
                <a:gd name="connsiteY87" fmla="*/ 2634791 h 5236589"/>
                <a:gd name="connsiteX88" fmla="*/ 909687 w 5649501"/>
                <a:gd name="connsiteY88" fmla="*/ 2733773 h 5236589"/>
                <a:gd name="connsiteX89" fmla="*/ 928540 w 5649501"/>
                <a:gd name="connsiteY89" fmla="*/ 2762053 h 5236589"/>
                <a:gd name="connsiteX90" fmla="*/ 937967 w 5649501"/>
                <a:gd name="connsiteY90" fmla="*/ 2790334 h 5236589"/>
                <a:gd name="connsiteX91" fmla="*/ 947394 w 5649501"/>
                <a:gd name="connsiteY91" fmla="*/ 2856321 h 5236589"/>
                <a:gd name="connsiteX92" fmla="*/ 956821 w 5649501"/>
                <a:gd name="connsiteY92" fmla="*/ 2889315 h 5236589"/>
                <a:gd name="connsiteX93" fmla="*/ 966248 w 5649501"/>
                <a:gd name="connsiteY93" fmla="*/ 2917596 h 5236589"/>
                <a:gd name="connsiteX94" fmla="*/ 975675 w 5649501"/>
                <a:gd name="connsiteY94" fmla="*/ 2950589 h 5236589"/>
                <a:gd name="connsiteX95" fmla="*/ 980388 w 5649501"/>
                <a:gd name="connsiteY95" fmla="*/ 2964730 h 5236589"/>
                <a:gd name="connsiteX96" fmla="*/ 994528 w 5649501"/>
                <a:gd name="connsiteY96" fmla="*/ 2978870 h 5236589"/>
                <a:gd name="connsiteX97" fmla="*/ 1008668 w 5649501"/>
                <a:gd name="connsiteY97" fmla="*/ 3030717 h 5236589"/>
                <a:gd name="connsiteX98" fmla="*/ 1027522 w 5649501"/>
                <a:gd name="connsiteY98" fmla="*/ 3058998 h 5236589"/>
                <a:gd name="connsiteX99" fmla="*/ 1046376 w 5649501"/>
                <a:gd name="connsiteY99" fmla="*/ 3091991 h 5236589"/>
                <a:gd name="connsiteX100" fmla="*/ 1079369 w 5649501"/>
                <a:gd name="connsiteY100" fmla="*/ 3134412 h 5236589"/>
                <a:gd name="connsiteX101" fmla="*/ 1107650 w 5649501"/>
                <a:gd name="connsiteY101" fmla="*/ 3143839 h 5236589"/>
                <a:gd name="connsiteX102" fmla="*/ 1140644 w 5649501"/>
                <a:gd name="connsiteY102" fmla="*/ 3186259 h 5236589"/>
                <a:gd name="connsiteX103" fmla="*/ 1154784 w 5649501"/>
                <a:gd name="connsiteY103" fmla="*/ 3214540 h 5236589"/>
                <a:gd name="connsiteX104" fmla="*/ 1168924 w 5649501"/>
                <a:gd name="connsiteY104" fmla="*/ 3223967 h 5236589"/>
                <a:gd name="connsiteX105" fmla="*/ 1187778 w 5649501"/>
                <a:gd name="connsiteY105" fmla="*/ 3242820 h 5236589"/>
                <a:gd name="connsiteX106" fmla="*/ 1192491 w 5649501"/>
                <a:gd name="connsiteY106" fmla="*/ 3256960 h 5236589"/>
                <a:gd name="connsiteX107" fmla="*/ 1220771 w 5649501"/>
                <a:gd name="connsiteY107" fmla="*/ 3275814 h 5236589"/>
                <a:gd name="connsiteX108" fmla="*/ 1258479 w 5649501"/>
                <a:gd name="connsiteY108" fmla="*/ 3294668 h 5236589"/>
                <a:gd name="connsiteX109" fmla="*/ 1277332 w 5649501"/>
                <a:gd name="connsiteY109" fmla="*/ 3313521 h 5236589"/>
                <a:gd name="connsiteX110" fmla="*/ 1291472 w 5649501"/>
                <a:gd name="connsiteY110" fmla="*/ 3322948 h 5236589"/>
                <a:gd name="connsiteX111" fmla="*/ 1300899 w 5649501"/>
                <a:gd name="connsiteY111" fmla="*/ 3341802 h 5236589"/>
                <a:gd name="connsiteX112" fmla="*/ 1305613 w 5649501"/>
                <a:gd name="connsiteY112" fmla="*/ 3360655 h 5236589"/>
                <a:gd name="connsiteX113" fmla="*/ 1319753 w 5649501"/>
                <a:gd name="connsiteY113" fmla="*/ 3374796 h 5236589"/>
                <a:gd name="connsiteX114" fmla="*/ 1329180 w 5649501"/>
                <a:gd name="connsiteY114" fmla="*/ 3388936 h 5236589"/>
                <a:gd name="connsiteX115" fmla="*/ 1338606 w 5649501"/>
                <a:gd name="connsiteY115" fmla="*/ 3421930 h 5236589"/>
                <a:gd name="connsiteX116" fmla="*/ 1343320 w 5649501"/>
                <a:gd name="connsiteY116" fmla="*/ 3436070 h 5236589"/>
                <a:gd name="connsiteX117" fmla="*/ 1348033 w 5649501"/>
                <a:gd name="connsiteY117" fmla="*/ 3454923 h 5236589"/>
                <a:gd name="connsiteX118" fmla="*/ 1357460 w 5649501"/>
                <a:gd name="connsiteY118" fmla="*/ 3469064 h 5236589"/>
                <a:gd name="connsiteX119" fmla="*/ 1366887 w 5649501"/>
                <a:gd name="connsiteY119" fmla="*/ 3497344 h 5236589"/>
                <a:gd name="connsiteX120" fmla="*/ 1371600 w 5649501"/>
                <a:gd name="connsiteY120" fmla="*/ 3516198 h 5236589"/>
                <a:gd name="connsiteX121" fmla="*/ 1385740 w 5649501"/>
                <a:gd name="connsiteY121" fmla="*/ 3535051 h 5236589"/>
                <a:gd name="connsiteX122" fmla="*/ 1395167 w 5649501"/>
                <a:gd name="connsiteY122" fmla="*/ 3549191 h 5236589"/>
                <a:gd name="connsiteX123" fmla="*/ 1399881 w 5649501"/>
                <a:gd name="connsiteY123" fmla="*/ 3568045 h 5236589"/>
                <a:gd name="connsiteX124" fmla="*/ 1414021 w 5649501"/>
                <a:gd name="connsiteY124" fmla="*/ 3577472 h 5236589"/>
                <a:gd name="connsiteX125" fmla="*/ 1423448 w 5649501"/>
                <a:gd name="connsiteY125" fmla="*/ 3605752 h 5236589"/>
                <a:gd name="connsiteX126" fmla="*/ 1432875 w 5649501"/>
                <a:gd name="connsiteY126" fmla="*/ 3619892 h 5236589"/>
                <a:gd name="connsiteX127" fmla="*/ 1437588 w 5649501"/>
                <a:gd name="connsiteY127" fmla="*/ 3634033 h 5236589"/>
                <a:gd name="connsiteX128" fmla="*/ 1442301 w 5649501"/>
                <a:gd name="connsiteY128" fmla="*/ 3676453 h 5236589"/>
                <a:gd name="connsiteX129" fmla="*/ 1451728 w 5649501"/>
                <a:gd name="connsiteY129" fmla="*/ 3690593 h 5236589"/>
                <a:gd name="connsiteX130" fmla="*/ 1461155 w 5649501"/>
                <a:gd name="connsiteY130" fmla="*/ 3728301 h 5236589"/>
                <a:gd name="connsiteX131" fmla="*/ 1465868 w 5649501"/>
                <a:gd name="connsiteY131" fmla="*/ 3756581 h 5236589"/>
                <a:gd name="connsiteX132" fmla="*/ 1470582 w 5649501"/>
                <a:gd name="connsiteY132" fmla="*/ 3770721 h 5236589"/>
                <a:gd name="connsiteX133" fmla="*/ 1484722 w 5649501"/>
                <a:gd name="connsiteY133" fmla="*/ 3775435 h 5236589"/>
                <a:gd name="connsiteX134" fmla="*/ 1494149 w 5649501"/>
                <a:gd name="connsiteY134" fmla="*/ 3831996 h 5236589"/>
                <a:gd name="connsiteX135" fmla="*/ 1498862 w 5649501"/>
                <a:gd name="connsiteY135" fmla="*/ 3855563 h 5236589"/>
                <a:gd name="connsiteX136" fmla="*/ 1503576 w 5649501"/>
                <a:gd name="connsiteY136" fmla="*/ 3883843 h 5236589"/>
                <a:gd name="connsiteX137" fmla="*/ 1508289 w 5649501"/>
                <a:gd name="connsiteY137" fmla="*/ 3897983 h 5236589"/>
                <a:gd name="connsiteX138" fmla="*/ 1517716 w 5649501"/>
                <a:gd name="connsiteY138" fmla="*/ 3930977 h 5236589"/>
                <a:gd name="connsiteX139" fmla="*/ 1527143 w 5649501"/>
                <a:gd name="connsiteY139" fmla="*/ 3945117 h 5236589"/>
                <a:gd name="connsiteX140" fmla="*/ 1541283 w 5649501"/>
                <a:gd name="connsiteY140" fmla="*/ 3949831 h 5236589"/>
                <a:gd name="connsiteX141" fmla="*/ 1560136 w 5649501"/>
                <a:gd name="connsiteY141" fmla="*/ 3973398 h 5236589"/>
                <a:gd name="connsiteX142" fmla="*/ 1574277 w 5649501"/>
                <a:gd name="connsiteY142" fmla="*/ 3992251 h 5236589"/>
                <a:gd name="connsiteX143" fmla="*/ 1602557 w 5649501"/>
                <a:gd name="connsiteY143" fmla="*/ 4020532 h 5236589"/>
                <a:gd name="connsiteX144" fmla="*/ 1621411 w 5649501"/>
                <a:gd name="connsiteY144" fmla="*/ 4062952 h 5236589"/>
                <a:gd name="connsiteX145" fmla="*/ 1630837 w 5649501"/>
                <a:gd name="connsiteY145" fmla="*/ 4077092 h 5236589"/>
                <a:gd name="connsiteX146" fmla="*/ 1640264 w 5649501"/>
                <a:gd name="connsiteY146" fmla="*/ 4095946 h 5236589"/>
                <a:gd name="connsiteX147" fmla="*/ 1644978 w 5649501"/>
                <a:gd name="connsiteY147" fmla="*/ 4110086 h 5236589"/>
                <a:gd name="connsiteX148" fmla="*/ 1654404 w 5649501"/>
                <a:gd name="connsiteY148" fmla="*/ 4124226 h 5236589"/>
                <a:gd name="connsiteX149" fmla="*/ 1659118 w 5649501"/>
                <a:gd name="connsiteY149" fmla="*/ 4138367 h 5236589"/>
                <a:gd name="connsiteX150" fmla="*/ 1687398 w 5649501"/>
                <a:gd name="connsiteY150" fmla="*/ 4157220 h 5236589"/>
                <a:gd name="connsiteX151" fmla="*/ 1701538 w 5649501"/>
                <a:gd name="connsiteY151" fmla="*/ 4185501 h 5236589"/>
                <a:gd name="connsiteX152" fmla="*/ 1710965 w 5649501"/>
                <a:gd name="connsiteY152" fmla="*/ 4223208 h 5236589"/>
                <a:gd name="connsiteX153" fmla="*/ 1720392 w 5649501"/>
                <a:gd name="connsiteY153" fmla="*/ 4279769 h 5236589"/>
                <a:gd name="connsiteX154" fmla="*/ 1729819 w 5649501"/>
                <a:gd name="connsiteY154" fmla="*/ 4312763 h 5236589"/>
                <a:gd name="connsiteX155" fmla="*/ 1739246 w 5649501"/>
                <a:gd name="connsiteY155" fmla="*/ 4331616 h 5236589"/>
                <a:gd name="connsiteX156" fmla="*/ 1758099 w 5649501"/>
                <a:gd name="connsiteY156" fmla="*/ 4359897 h 5236589"/>
                <a:gd name="connsiteX157" fmla="*/ 1762813 w 5649501"/>
                <a:gd name="connsiteY157" fmla="*/ 4378750 h 5236589"/>
                <a:gd name="connsiteX158" fmla="*/ 1772239 w 5649501"/>
                <a:gd name="connsiteY158" fmla="*/ 4407031 h 5236589"/>
                <a:gd name="connsiteX159" fmla="*/ 1767526 w 5649501"/>
                <a:gd name="connsiteY159" fmla="*/ 4482445 h 5236589"/>
                <a:gd name="connsiteX160" fmla="*/ 1758099 w 5649501"/>
                <a:gd name="connsiteY160" fmla="*/ 4496585 h 5236589"/>
                <a:gd name="connsiteX161" fmla="*/ 1739246 w 5649501"/>
                <a:gd name="connsiteY161" fmla="*/ 4515439 h 5236589"/>
                <a:gd name="connsiteX162" fmla="*/ 1729819 w 5649501"/>
                <a:gd name="connsiteY162" fmla="*/ 4529579 h 5236589"/>
                <a:gd name="connsiteX163" fmla="*/ 1715679 w 5649501"/>
                <a:gd name="connsiteY163" fmla="*/ 4539006 h 5236589"/>
                <a:gd name="connsiteX164" fmla="*/ 1692112 w 5649501"/>
                <a:gd name="connsiteY164" fmla="*/ 4562573 h 5236589"/>
                <a:gd name="connsiteX165" fmla="*/ 1682685 w 5649501"/>
                <a:gd name="connsiteY165" fmla="*/ 4548433 h 5236589"/>
                <a:gd name="connsiteX166" fmla="*/ 1668545 w 5649501"/>
                <a:gd name="connsiteY166" fmla="*/ 4543719 h 5236589"/>
                <a:gd name="connsiteX167" fmla="*/ 1654404 w 5649501"/>
                <a:gd name="connsiteY167" fmla="*/ 4534292 h 5236589"/>
                <a:gd name="connsiteX168" fmla="*/ 1649691 w 5649501"/>
                <a:gd name="connsiteY168" fmla="*/ 4548433 h 5236589"/>
                <a:gd name="connsiteX169" fmla="*/ 1640264 w 5649501"/>
                <a:gd name="connsiteY169" fmla="*/ 4562573 h 5236589"/>
                <a:gd name="connsiteX170" fmla="*/ 1649691 w 5649501"/>
                <a:gd name="connsiteY170" fmla="*/ 4652127 h 5236589"/>
                <a:gd name="connsiteX171" fmla="*/ 1654404 w 5649501"/>
                <a:gd name="connsiteY171" fmla="*/ 4666268 h 5236589"/>
                <a:gd name="connsiteX172" fmla="*/ 1668545 w 5649501"/>
                <a:gd name="connsiteY172" fmla="*/ 4670981 h 5236589"/>
                <a:gd name="connsiteX173" fmla="*/ 1682685 w 5649501"/>
                <a:gd name="connsiteY173" fmla="*/ 4656841 h 5236589"/>
                <a:gd name="connsiteX174" fmla="*/ 1696825 w 5649501"/>
                <a:gd name="connsiteY174" fmla="*/ 4661554 h 5236589"/>
                <a:gd name="connsiteX175" fmla="*/ 1710965 w 5649501"/>
                <a:gd name="connsiteY175" fmla="*/ 4736969 h 5236589"/>
                <a:gd name="connsiteX176" fmla="*/ 1753386 w 5649501"/>
                <a:gd name="connsiteY176" fmla="*/ 4769963 h 5236589"/>
                <a:gd name="connsiteX177" fmla="*/ 1772239 w 5649501"/>
                <a:gd name="connsiteY177" fmla="*/ 4793530 h 5236589"/>
                <a:gd name="connsiteX178" fmla="*/ 1786380 w 5649501"/>
                <a:gd name="connsiteY178" fmla="*/ 4821810 h 5236589"/>
                <a:gd name="connsiteX179" fmla="*/ 1800520 w 5649501"/>
                <a:gd name="connsiteY179" fmla="*/ 4835950 h 5236589"/>
                <a:gd name="connsiteX180" fmla="*/ 1800520 w 5649501"/>
                <a:gd name="connsiteY180" fmla="*/ 4887798 h 5236589"/>
                <a:gd name="connsiteX181" fmla="*/ 1795806 w 5649501"/>
                <a:gd name="connsiteY181" fmla="*/ 4901938 h 5236589"/>
                <a:gd name="connsiteX182" fmla="*/ 1781666 w 5649501"/>
                <a:gd name="connsiteY182" fmla="*/ 4916078 h 5236589"/>
                <a:gd name="connsiteX183" fmla="*/ 1776953 w 5649501"/>
                <a:gd name="connsiteY183" fmla="*/ 4930218 h 5236589"/>
                <a:gd name="connsiteX184" fmla="*/ 1767526 w 5649501"/>
                <a:gd name="connsiteY184" fmla="*/ 4953785 h 5236589"/>
                <a:gd name="connsiteX185" fmla="*/ 1776953 w 5649501"/>
                <a:gd name="connsiteY185" fmla="*/ 5052767 h 5236589"/>
                <a:gd name="connsiteX186" fmla="*/ 1781666 w 5649501"/>
                <a:gd name="connsiteY186" fmla="*/ 5066907 h 5236589"/>
                <a:gd name="connsiteX187" fmla="*/ 1795806 w 5649501"/>
                <a:gd name="connsiteY187" fmla="*/ 5076334 h 5236589"/>
                <a:gd name="connsiteX188" fmla="*/ 1809947 w 5649501"/>
                <a:gd name="connsiteY188" fmla="*/ 5071620 h 5236589"/>
                <a:gd name="connsiteX189" fmla="*/ 1819373 w 5649501"/>
                <a:gd name="connsiteY189" fmla="*/ 5057480 h 5236589"/>
                <a:gd name="connsiteX190" fmla="*/ 1828800 w 5649501"/>
                <a:gd name="connsiteY190" fmla="*/ 4996206 h 5236589"/>
                <a:gd name="connsiteX191" fmla="*/ 1847654 w 5649501"/>
                <a:gd name="connsiteY191" fmla="*/ 4967925 h 5236589"/>
                <a:gd name="connsiteX192" fmla="*/ 1861794 w 5649501"/>
                <a:gd name="connsiteY192" fmla="*/ 4972639 h 5236589"/>
                <a:gd name="connsiteX193" fmla="*/ 1890075 w 5649501"/>
                <a:gd name="connsiteY193" fmla="*/ 4991492 h 5236589"/>
                <a:gd name="connsiteX194" fmla="*/ 1899501 w 5649501"/>
                <a:gd name="connsiteY194" fmla="*/ 5052767 h 5236589"/>
                <a:gd name="connsiteX195" fmla="*/ 1904215 w 5649501"/>
                <a:gd name="connsiteY195" fmla="*/ 5066907 h 5236589"/>
                <a:gd name="connsiteX196" fmla="*/ 1941922 w 5649501"/>
                <a:gd name="connsiteY196" fmla="*/ 5071620 h 5236589"/>
                <a:gd name="connsiteX197" fmla="*/ 1956062 w 5649501"/>
                <a:gd name="connsiteY197" fmla="*/ 5076334 h 5236589"/>
                <a:gd name="connsiteX198" fmla="*/ 1974916 w 5649501"/>
                <a:gd name="connsiteY198" fmla="*/ 5071620 h 5236589"/>
                <a:gd name="connsiteX199" fmla="*/ 1979629 w 5649501"/>
                <a:gd name="connsiteY199" fmla="*/ 5090474 h 5236589"/>
                <a:gd name="connsiteX200" fmla="*/ 2026763 w 5649501"/>
                <a:gd name="connsiteY200" fmla="*/ 5109327 h 5236589"/>
                <a:gd name="connsiteX201" fmla="*/ 2045617 w 5649501"/>
                <a:gd name="connsiteY201" fmla="*/ 5151748 h 5236589"/>
                <a:gd name="connsiteX202" fmla="*/ 2059757 w 5649501"/>
                <a:gd name="connsiteY202" fmla="*/ 5156462 h 5236589"/>
                <a:gd name="connsiteX203" fmla="*/ 2073897 w 5649501"/>
                <a:gd name="connsiteY203" fmla="*/ 5165888 h 5236589"/>
                <a:gd name="connsiteX204" fmla="*/ 2083324 w 5649501"/>
                <a:gd name="connsiteY204" fmla="*/ 5180029 h 5236589"/>
                <a:gd name="connsiteX205" fmla="*/ 2111604 w 5649501"/>
                <a:gd name="connsiteY205" fmla="*/ 5203596 h 5236589"/>
                <a:gd name="connsiteX206" fmla="*/ 2149312 w 5649501"/>
                <a:gd name="connsiteY206" fmla="*/ 5213022 h 5236589"/>
                <a:gd name="connsiteX207" fmla="*/ 2172879 w 5649501"/>
                <a:gd name="connsiteY207" fmla="*/ 5222449 h 5236589"/>
                <a:gd name="connsiteX208" fmla="*/ 2224726 w 5649501"/>
                <a:gd name="connsiteY208" fmla="*/ 5236589 h 5236589"/>
                <a:gd name="connsiteX209" fmla="*/ 2243580 w 5649501"/>
                <a:gd name="connsiteY209" fmla="*/ 5227163 h 5236589"/>
                <a:gd name="connsiteX210" fmla="*/ 2257720 w 5649501"/>
                <a:gd name="connsiteY210" fmla="*/ 5222449 h 5236589"/>
                <a:gd name="connsiteX211" fmla="*/ 2262433 w 5649501"/>
                <a:gd name="connsiteY211" fmla="*/ 5198882 h 5236589"/>
                <a:gd name="connsiteX212" fmla="*/ 2276573 w 5649501"/>
                <a:gd name="connsiteY212" fmla="*/ 5165888 h 5236589"/>
                <a:gd name="connsiteX213" fmla="*/ 2323707 w 5649501"/>
                <a:gd name="connsiteY213" fmla="*/ 5137608 h 5236589"/>
                <a:gd name="connsiteX214" fmla="*/ 2337848 w 5649501"/>
                <a:gd name="connsiteY214" fmla="*/ 5128181 h 5236589"/>
                <a:gd name="connsiteX215" fmla="*/ 2342561 w 5649501"/>
                <a:gd name="connsiteY215" fmla="*/ 5114041 h 5236589"/>
                <a:gd name="connsiteX216" fmla="*/ 2356701 w 5649501"/>
                <a:gd name="connsiteY216" fmla="*/ 5109327 h 5236589"/>
                <a:gd name="connsiteX217" fmla="*/ 2408549 w 5649501"/>
                <a:gd name="connsiteY217" fmla="*/ 5114041 h 5236589"/>
                <a:gd name="connsiteX218" fmla="*/ 2441543 w 5649501"/>
                <a:gd name="connsiteY218" fmla="*/ 5109327 h 5236589"/>
                <a:gd name="connsiteX219" fmla="*/ 2446256 w 5649501"/>
                <a:gd name="connsiteY219" fmla="*/ 5095187 h 5236589"/>
                <a:gd name="connsiteX220" fmla="*/ 2450969 w 5649501"/>
                <a:gd name="connsiteY220" fmla="*/ 5076334 h 5236589"/>
                <a:gd name="connsiteX221" fmla="*/ 2545237 w 5649501"/>
                <a:gd name="connsiteY221" fmla="*/ 5081047 h 5236589"/>
                <a:gd name="connsiteX222" fmla="*/ 2549951 w 5649501"/>
                <a:gd name="connsiteY222" fmla="*/ 5095187 h 5236589"/>
                <a:gd name="connsiteX223" fmla="*/ 2564091 w 5649501"/>
                <a:gd name="connsiteY223" fmla="*/ 5099901 h 5236589"/>
                <a:gd name="connsiteX224" fmla="*/ 2578231 w 5649501"/>
                <a:gd name="connsiteY224" fmla="*/ 5109327 h 5236589"/>
                <a:gd name="connsiteX225" fmla="*/ 2601798 w 5649501"/>
                <a:gd name="connsiteY225" fmla="*/ 5104614 h 5236589"/>
                <a:gd name="connsiteX226" fmla="*/ 2634792 w 5649501"/>
                <a:gd name="connsiteY226" fmla="*/ 5085760 h 5236589"/>
                <a:gd name="connsiteX227" fmla="*/ 2663072 w 5649501"/>
                <a:gd name="connsiteY227" fmla="*/ 5076334 h 5236589"/>
                <a:gd name="connsiteX228" fmla="*/ 2677213 w 5649501"/>
                <a:gd name="connsiteY228" fmla="*/ 5071620 h 5236589"/>
                <a:gd name="connsiteX229" fmla="*/ 2691353 w 5649501"/>
                <a:gd name="connsiteY229" fmla="*/ 5066907 h 5236589"/>
                <a:gd name="connsiteX230" fmla="*/ 2705493 w 5649501"/>
                <a:gd name="connsiteY230" fmla="*/ 5057480 h 5236589"/>
                <a:gd name="connsiteX231" fmla="*/ 2724347 w 5649501"/>
                <a:gd name="connsiteY231" fmla="*/ 5029200 h 5236589"/>
                <a:gd name="connsiteX232" fmla="*/ 2771481 w 5649501"/>
                <a:gd name="connsiteY232" fmla="*/ 5015059 h 5236589"/>
                <a:gd name="connsiteX233" fmla="*/ 2804475 w 5649501"/>
                <a:gd name="connsiteY233" fmla="*/ 4996206 h 5236589"/>
                <a:gd name="connsiteX234" fmla="*/ 2832755 w 5649501"/>
                <a:gd name="connsiteY234" fmla="*/ 4972639 h 5236589"/>
                <a:gd name="connsiteX235" fmla="*/ 2870462 w 5649501"/>
                <a:gd name="connsiteY235" fmla="*/ 4982066 h 5236589"/>
                <a:gd name="connsiteX236" fmla="*/ 2993011 w 5649501"/>
                <a:gd name="connsiteY236" fmla="*/ 4986779 h 5236589"/>
                <a:gd name="connsiteX237" fmla="*/ 3026004 w 5649501"/>
                <a:gd name="connsiteY237" fmla="*/ 4991492 h 5236589"/>
                <a:gd name="connsiteX238" fmla="*/ 3035431 w 5649501"/>
                <a:gd name="connsiteY238" fmla="*/ 5005633 h 5236589"/>
                <a:gd name="connsiteX239" fmla="*/ 3087279 w 5649501"/>
                <a:gd name="connsiteY239" fmla="*/ 4996206 h 5236589"/>
                <a:gd name="connsiteX240" fmla="*/ 3124986 w 5649501"/>
                <a:gd name="connsiteY240" fmla="*/ 4986779 h 5236589"/>
                <a:gd name="connsiteX241" fmla="*/ 3139126 w 5649501"/>
                <a:gd name="connsiteY241" fmla="*/ 4958499 h 5236589"/>
                <a:gd name="connsiteX242" fmla="*/ 3172120 w 5649501"/>
                <a:gd name="connsiteY242" fmla="*/ 4944358 h 5236589"/>
                <a:gd name="connsiteX243" fmla="*/ 3219254 w 5649501"/>
                <a:gd name="connsiteY243" fmla="*/ 4949072 h 5236589"/>
                <a:gd name="connsiteX244" fmla="*/ 3247534 w 5649501"/>
                <a:gd name="connsiteY244" fmla="*/ 4958499 h 5236589"/>
                <a:gd name="connsiteX245" fmla="*/ 3285242 w 5649501"/>
                <a:gd name="connsiteY245" fmla="*/ 4963212 h 5236589"/>
                <a:gd name="connsiteX246" fmla="*/ 3318235 w 5649501"/>
                <a:gd name="connsiteY246" fmla="*/ 4972639 h 5236589"/>
                <a:gd name="connsiteX247" fmla="*/ 3346516 w 5649501"/>
                <a:gd name="connsiteY247" fmla="*/ 4982066 h 5236589"/>
                <a:gd name="connsiteX248" fmla="*/ 3360656 w 5649501"/>
                <a:gd name="connsiteY248" fmla="*/ 4986779 h 5236589"/>
                <a:gd name="connsiteX249" fmla="*/ 3407790 w 5649501"/>
                <a:gd name="connsiteY249" fmla="*/ 4996206 h 5236589"/>
                <a:gd name="connsiteX250" fmla="*/ 3426644 w 5649501"/>
                <a:gd name="connsiteY250" fmla="*/ 5005633 h 5236589"/>
                <a:gd name="connsiteX251" fmla="*/ 3511485 w 5649501"/>
                <a:gd name="connsiteY251" fmla="*/ 5005633 h 5236589"/>
                <a:gd name="connsiteX252" fmla="*/ 3525625 w 5649501"/>
                <a:gd name="connsiteY252" fmla="*/ 4991492 h 5236589"/>
                <a:gd name="connsiteX253" fmla="*/ 3539765 w 5649501"/>
                <a:gd name="connsiteY253" fmla="*/ 4958499 h 5236589"/>
                <a:gd name="connsiteX254" fmla="*/ 3553905 w 5649501"/>
                <a:gd name="connsiteY254" fmla="*/ 4953785 h 5236589"/>
                <a:gd name="connsiteX255" fmla="*/ 3624606 w 5649501"/>
                <a:gd name="connsiteY255" fmla="*/ 4958499 h 5236589"/>
                <a:gd name="connsiteX256" fmla="*/ 3643460 w 5649501"/>
                <a:gd name="connsiteY256" fmla="*/ 4967925 h 5236589"/>
                <a:gd name="connsiteX257" fmla="*/ 3657600 w 5649501"/>
                <a:gd name="connsiteY257" fmla="*/ 4972639 h 5236589"/>
                <a:gd name="connsiteX258" fmla="*/ 3723588 w 5649501"/>
                <a:gd name="connsiteY258" fmla="*/ 4967925 h 5236589"/>
                <a:gd name="connsiteX259" fmla="*/ 3733015 w 5649501"/>
                <a:gd name="connsiteY259" fmla="*/ 4953785 h 5236589"/>
                <a:gd name="connsiteX260" fmla="*/ 3737728 w 5649501"/>
                <a:gd name="connsiteY260" fmla="*/ 4873657 h 5236589"/>
                <a:gd name="connsiteX261" fmla="*/ 3784862 w 5649501"/>
                <a:gd name="connsiteY261" fmla="*/ 4868944 h 5236589"/>
                <a:gd name="connsiteX262" fmla="*/ 3822569 w 5649501"/>
                <a:gd name="connsiteY262" fmla="*/ 4864231 h 5236589"/>
                <a:gd name="connsiteX263" fmla="*/ 3879130 w 5649501"/>
                <a:gd name="connsiteY263" fmla="*/ 4868944 h 5236589"/>
                <a:gd name="connsiteX264" fmla="*/ 3893270 w 5649501"/>
                <a:gd name="connsiteY264" fmla="*/ 4873657 h 5236589"/>
                <a:gd name="connsiteX265" fmla="*/ 3921551 w 5649501"/>
                <a:gd name="connsiteY265" fmla="*/ 4868944 h 5236589"/>
                <a:gd name="connsiteX266" fmla="*/ 3935691 w 5649501"/>
                <a:gd name="connsiteY266" fmla="*/ 4873657 h 5236589"/>
                <a:gd name="connsiteX267" fmla="*/ 3982825 w 5649501"/>
                <a:gd name="connsiteY267" fmla="*/ 4864231 h 5236589"/>
                <a:gd name="connsiteX268" fmla="*/ 3996965 w 5649501"/>
                <a:gd name="connsiteY268" fmla="*/ 4854804 h 5236589"/>
                <a:gd name="connsiteX269" fmla="*/ 4011105 w 5649501"/>
                <a:gd name="connsiteY269" fmla="*/ 4840664 h 5236589"/>
                <a:gd name="connsiteX270" fmla="*/ 4029959 w 5649501"/>
                <a:gd name="connsiteY270" fmla="*/ 4831237 h 5236589"/>
                <a:gd name="connsiteX271" fmla="*/ 4058239 w 5649501"/>
                <a:gd name="connsiteY271" fmla="*/ 4812383 h 5236589"/>
                <a:gd name="connsiteX272" fmla="*/ 4077093 w 5649501"/>
                <a:gd name="connsiteY272" fmla="*/ 4802956 h 5236589"/>
                <a:gd name="connsiteX273" fmla="*/ 4091233 w 5649501"/>
                <a:gd name="connsiteY273" fmla="*/ 4793530 h 5236589"/>
                <a:gd name="connsiteX274" fmla="*/ 4119514 w 5649501"/>
                <a:gd name="connsiteY274" fmla="*/ 4784103 h 5236589"/>
                <a:gd name="connsiteX275" fmla="*/ 4133654 w 5649501"/>
                <a:gd name="connsiteY275" fmla="*/ 4779389 h 5236589"/>
                <a:gd name="connsiteX276" fmla="*/ 4161934 w 5649501"/>
                <a:gd name="connsiteY276" fmla="*/ 4765249 h 5236589"/>
                <a:gd name="connsiteX277" fmla="*/ 4190215 w 5649501"/>
                <a:gd name="connsiteY277" fmla="*/ 4741682 h 5236589"/>
                <a:gd name="connsiteX278" fmla="*/ 4204355 w 5649501"/>
                <a:gd name="connsiteY278" fmla="*/ 4727542 h 5236589"/>
                <a:gd name="connsiteX279" fmla="*/ 4218495 w 5649501"/>
                <a:gd name="connsiteY279" fmla="*/ 4718115 h 5236589"/>
                <a:gd name="connsiteX280" fmla="*/ 4232635 w 5649501"/>
                <a:gd name="connsiteY280" fmla="*/ 4703975 h 5236589"/>
                <a:gd name="connsiteX281" fmla="*/ 4251489 w 5649501"/>
                <a:gd name="connsiteY281" fmla="*/ 4689835 h 5236589"/>
                <a:gd name="connsiteX282" fmla="*/ 4270343 w 5649501"/>
                <a:gd name="connsiteY282" fmla="*/ 4661554 h 5236589"/>
                <a:gd name="connsiteX283" fmla="*/ 4279769 w 5649501"/>
                <a:gd name="connsiteY283" fmla="*/ 4647414 h 5236589"/>
                <a:gd name="connsiteX284" fmla="*/ 4298623 w 5649501"/>
                <a:gd name="connsiteY284" fmla="*/ 4633274 h 5236589"/>
                <a:gd name="connsiteX285" fmla="*/ 4308050 w 5649501"/>
                <a:gd name="connsiteY285" fmla="*/ 4619134 h 5236589"/>
                <a:gd name="connsiteX286" fmla="*/ 4322190 w 5649501"/>
                <a:gd name="connsiteY286" fmla="*/ 4614420 h 5236589"/>
                <a:gd name="connsiteX287" fmla="*/ 4336330 w 5649501"/>
                <a:gd name="connsiteY287" fmla="*/ 4604993 h 5236589"/>
                <a:gd name="connsiteX288" fmla="*/ 4369324 w 5649501"/>
                <a:gd name="connsiteY288" fmla="*/ 4581426 h 5236589"/>
                <a:gd name="connsiteX289" fmla="*/ 4383464 w 5649501"/>
                <a:gd name="connsiteY289" fmla="*/ 4576713 h 5236589"/>
                <a:gd name="connsiteX290" fmla="*/ 4397604 w 5649501"/>
                <a:gd name="connsiteY290" fmla="*/ 4562573 h 5236589"/>
                <a:gd name="connsiteX291" fmla="*/ 4421171 w 5649501"/>
                <a:gd name="connsiteY291" fmla="*/ 4553146 h 5236589"/>
                <a:gd name="connsiteX292" fmla="*/ 4449452 w 5649501"/>
                <a:gd name="connsiteY292" fmla="*/ 4529579 h 5236589"/>
                <a:gd name="connsiteX293" fmla="*/ 4458879 w 5649501"/>
                <a:gd name="connsiteY293" fmla="*/ 4515439 h 5236589"/>
                <a:gd name="connsiteX294" fmla="*/ 4473019 w 5649501"/>
                <a:gd name="connsiteY294" fmla="*/ 4496585 h 5236589"/>
                <a:gd name="connsiteX295" fmla="*/ 4482446 w 5649501"/>
                <a:gd name="connsiteY295" fmla="*/ 4482445 h 5236589"/>
                <a:gd name="connsiteX296" fmla="*/ 4496586 w 5649501"/>
                <a:gd name="connsiteY296" fmla="*/ 4468305 h 5236589"/>
                <a:gd name="connsiteX297" fmla="*/ 4520153 w 5649501"/>
                <a:gd name="connsiteY297" fmla="*/ 4449451 h 5236589"/>
                <a:gd name="connsiteX298" fmla="*/ 4539006 w 5649501"/>
                <a:gd name="connsiteY298" fmla="*/ 4416457 h 5236589"/>
                <a:gd name="connsiteX299" fmla="*/ 4553147 w 5649501"/>
                <a:gd name="connsiteY299" fmla="*/ 4407031 h 5236589"/>
                <a:gd name="connsiteX300" fmla="*/ 4562573 w 5649501"/>
                <a:gd name="connsiteY300" fmla="*/ 4388177 h 5236589"/>
                <a:gd name="connsiteX301" fmla="*/ 4595567 w 5649501"/>
                <a:gd name="connsiteY301" fmla="*/ 4369323 h 5236589"/>
                <a:gd name="connsiteX302" fmla="*/ 4619134 w 5649501"/>
                <a:gd name="connsiteY302" fmla="*/ 4336330 h 5236589"/>
                <a:gd name="connsiteX303" fmla="*/ 4628561 w 5649501"/>
                <a:gd name="connsiteY303" fmla="*/ 4322189 h 5236589"/>
                <a:gd name="connsiteX304" fmla="*/ 4642701 w 5649501"/>
                <a:gd name="connsiteY304" fmla="*/ 4312763 h 5236589"/>
                <a:gd name="connsiteX305" fmla="*/ 4661555 w 5649501"/>
                <a:gd name="connsiteY305" fmla="*/ 4298622 h 5236589"/>
                <a:gd name="connsiteX306" fmla="*/ 4713402 w 5649501"/>
                <a:gd name="connsiteY306" fmla="*/ 4246775 h 5236589"/>
                <a:gd name="connsiteX307" fmla="*/ 4727543 w 5649501"/>
                <a:gd name="connsiteY307" fmla="*/ 4232635 h 5236589"/>
                <a:gd name="connsiteX308" fmla="*/ 4736969 w 5649501"/>
                <a:gd name="connsiteY308" fmla="*/ 4218495 h 5236589"/>
                <a:gd name="connsiteX309" fmla="*/ 4741683 w 5649501"/>
                <a:gd name="connsiteY309" fmla="*/ 4204354 h 5236589"/>
                <a:gd name="connsiteX310" fmla="*/ 4760536 w 5649501"/>
                <a:gd name="connsiteY310" fmla="*/ 4194927 h 5236589"/>
                <a:gd name="connsiteX311" fmla="*/ 4774677 w 5649501"/>
                <a:gd name="connsiteY311" fmla="*/ 4180787 h 5236589"/>
                <a:gd name="connsiteX312" fmla="*/ 4779390 w 5649501"/>
                <a:gd name="connsiteY312" fmla="*/ 4161934 h 5236589"/>
                <a:gd name="connsiteX313" fmla="*/ 4807670 w 5649501"/>
                <a:gd name="connsiteY313" fmla="*/ 4138367 h 5236589"/>
                <a:gd name="connsiteX314" fmla="*/ 4831237 w 5649501"/>
                <a:gd name="connsiteY314" fmla="*/ 4119513 h 5236589"/>
                <a:gd name="connsiteX315" fmla="*/ 4840664 w 5649501"/>
                <a:gd name="connsiteY315" fmla="*/ 4105373 h 5236589"/>
                <a:gd name="connsiteX316" fmla="*/ 4854804 w 5649501"/>
                <a:gd name="connsiteY316" fmla="*/ 4095946 h 5236589"/>
                <a:gd name="connsiteX317" fmla="*/ 4864231 w 5649501"/>
                <a:gd name="connsiteY317" fmla="*/ 4081806 h 5236589"/>
                <a:gd name="connsiteX318" fmla="*/ 4883085 w 5649501"/>
                <a:gd name="connsiteY318" fmla="*/ 4072379 h 5236589"/>
                <a:gd name="connsiteX319" fmla="*/ 4897225 w 5649501"/>
                <a:gd name="connsiteY319" fmla="*/ 4062952 h 5236589"/>
                <a:gd name="connsiteX320" fmla="*/ 4920792 w 5649501"/>
                <a:gd name="connsiteY320" fmla="*/ 4039385 h 5236589"/>
                <a:gd name="connsiteX321" fmla="*/ 4930219 w 5649501"/>
                <a:gd name="connsiteY321" fmla="*/ 4025245 h 5236589"/>
                <a:gd name="connsiteX322" fmla="*/ 4944359 w 5649501"/>
                <a:gd name="connsiteY322" fmla="*/ 4011105 h 5236589"/>
                <a:gd name="connsiteX323" fmla="*/ 4967926 w 5649501"/>
                <a:gd name="connsiteY323" fmla="*/ 3982824 h 5236589"/>
                <a:gd name="connsiteX324" fmla="*/ 4982066 w 5649501"/>
                <a:gd name="connsiteY324" fmla="*/ 3949831 h 5236589"/>
                <a:gd name="connsiteX325" fmla="*/ 5000920 w 5649501"/>
                <a:gd name="connsiteY325" fmla="*/ 3921550 h 5236589"/>
                <a:gd name="connsiteX326" fmla="*/ 5015060 w 5649501"/>
                <a:gd name="connsiteY326" fmla="*/ 3907410 h 5236589"/>
                <a:gd name="connsiteX327" fmla="*/ 5019773 w 5649501"/>
                <a:gd name="connsiteY327" fmla="*/ 3860276 h 5236589"/>
                <a:gd name="connsiteX328" fmla="*/ 5038627 w 5649501"/>
                <a:gd name="connsiteY328" fmla="*/ 3831996 h 5236589"/>
                <a:gd name="connsiteX329" fmla="*/ 5052767 w 5649501"/>
                <a:gd name="connsiteY329" fmla="*/ 3775435 h 5236589"/>
                <a:gd name="connsiteX330" fmla="*/ 5066907 w 5649501"/>
                <a:gd name="connsiteY330" fmla="*/ 3761295 h 5236589"/>
                <a:gd name="connsiteX331" fmla="*/ 5081048 w 5649501"/>
                <a:gd name="connsiteY331" fmla="*/ 3737727 h 5236589"/>
                <a:gd name="connsiteX332" fmla="*/ 5109328 w 5649501"/>
                <a:gd name="connsiteY332" fmla="*/ 3709447 h 5236589"/>
                <a:gd name="connsiteX333" fmla="*/ 5123468 w 5649501"/>
                <a:gd name="connsiteY333" fmla="*/ 3695307 h 5236589"/>
                <a:gd name="connsiteX334" fmla="*/ 5161176 w 5649501"/>
                <a:gd name="connsiteY334" fmla="*/ 3652886 h 5236589"/>
                <a:gd name="connsiteX335" fmla="*/ 5175316 w 5649501"/>
                <a:gd name="connsiteY335" fmla="*/ 3638746 h 5236589"/>
                <a:gd name="connsiteX336" fmla="*/ 5180029 w 5649501"/>
                <a:gd name="connsiteY336" fmla="*/ 3624606 h 5236589"/>
                <a:gd name="connsiteX337" fmla="*/ 5189456 w 5649501"/>
                <a:gd name="connsiteY337" fmla="*/ 3610466 h 5236589"/>
                <a:gd name="connsiteX338" fmla="*/ 5194169 w 5649501"/>
                <a:gd name="connsiteY338" fmla="*/ 3586899 h 5236589"/>
                <a:gd name="connsiteX339" fmla="*/ 5203596 w 5649501"/>
                <a:gd name="connsiteY339" fmla="*/ 3568045 h 5236589"/>
                <a:gd name="connsiteX340" fmla="*/ 5208310 w 5649501"/>
                <a:gd name="connsiteY340" fmla="*/ 3549191 h 5236589"/>
                <a:gd name="connsiteX341" fmla="*/ 5222450 w 5649501"/>
                <a:gd name="connsiteY341" fmla="*/ 3539765 h 5236589"/>
                <a:gd name="connsiteX342" fmla="*/ 5231877 w 5649501"/>
                <a:gd name="connsiteY342" fmla="*/ 3525624 h 5236589"/>
                <a:gd name="connsiteX343" fmla="*/ 5250730 w 5649501"/>
                <a:gd name="connsiteY343" fmla="*/ 3516198 h 5236589"/>
                <a:gd name="connsiteX344" fmla="*/ 5264870 w 5649501"/>
                <a:gd name="connsiteY344" fmla="*/ 3506771 h 5236589"/>
                <a:gd name="connsiteX345" fmla="*/ 5274297 w 5649501"/>
                <a:gd name="connsiteY345" fmla="*/ 3492631 h 5236589"/>
                <a:gd name="connsiteX346" fmla="*/ 5293151 w 5649501"/>
                <a:gd name="connsiteY346" fmla="*/ 3478490 h 5236589"/>
                <a:gd name="connsiteX347" fmla="*/ 5312004 w 5649501"/>
                <a:gd name="connsiteY347" fmla="*/ 3454923 h 5236589"/>
                <a:gd name="connsiteX348" fmla="*/ 5316718 w 5649501"/>
                <a:gd name="connsiteY348" fmla="*/ 3440783 h 5236589"/>
                <a:gd name="connsiteX349" fmla="*/ 5335571 w 5649501"/>
                <a:gd name="connsiteY349" fmla="*/ 3398363 h 5236589"/>
                <a:gd name="connsiteX350" fmla="*/ 5340285 w 5649501"/>
                <a:gd name="connsiteY350" fmla="*/ 3374796 h 5236589"/>
                <a:gd name="connsiteX351" fmla="*/ 5354425 w 5649501"/>
                <a:gd name="connsiteY351" fmla="*/ 3370082 h 5236589"/>
                <a:gd name="connsiteX352" fmla="*/ 5382705 w 5649501"/>
                <a:gd name="connsiteY352" fmla="*/ 3365369 h 5236589"/>
                <a:gd name="connsiteX353" fmla="*/ 5396846 w 5649501"/>
                <a:gd name="connsiteY353" fmla="*/ 3360655 h 5236589"/>
                <a:gd name="connsiteX354" fmla="*/ 5415699 w 5649501"/>
                <a:gd name="connsiteY354" fmla="*/ 3355942 h 5236589"/>
                <a:gd name="connsiteX355" fmla="*/ 5425126 w 5649501"/>
                <a:gd name="connsiteY355" fmla="*/ 3341802 h 5236589"/>
                <a:gd name="connsiteX356" fmla="*/ 5439266 w 5649501"/>
                <a:gd name="connsiteY356" fmla="*/ 3308808 h 5236589"/>
                <a:gd name="connsiteX357" fmla="*/ 5453406 w 5649501"/>
                <a:gd name="connsiteY357" fmla="*/ 3304095 h 5236589"/>
                <a:gd name="connsiteX358" fmla="*/ 5476973 w 5649501"/>
                <a:gd name="connsiteY358" fmla="*/ 3280527 h 5236589"/>
                <a:gd name="connsiteX359" fmla="*/ 5505254 w 5649501"/>
                <a:gd name="connsiteY359" fmla="*/ 3261674 h 5236589"/>
                <a:gd name="connsiteX360" fmla="*/ 5514681 w 5649501"/>
                <a:gd name="connsiteY360" fmla="*/ 3233393 h 5236589"/>
                <a:gd name="connsiteX361" fmla="*/ 5524107 w 5649501"/>
                <a:gd name="connsiteY361" fmla="*/ 3200400 h 5236589"/>
                <a:gd name="connsiteX362" fmla="*/ 5533534 w 5649501"/>
                <a:gd name="connsiteY362" fmla="*/ 3181546 h 5236589"/>
                <a:gd name="connsiteX363" fmla="*/ 5566528 w 5649501"/>
                <a:gd name="connsiteY363" fmla="*/ 3148552 h 5236589"/>
                <a:gd name="connsiteX364" fmla="*/ 5580668 w 5649501"/>
                <a:gd name="connsiteY364" fmla="*/ 2993010 h 5236589"/>
                <a:gd name="connsiteX365" fmla="*/ 5594809 w 5649501"/>
                <a:gd name="connsiteY365" fmla="*/ 2964730 h 5236589"/>
                <a:gd name="connsiteX366" fmla="*/ 5599522 w 5649501"/>
                <a:gd name="connsiteY366" fmla="*/ 2950589 h 5236589"/>
                <a:gd name="connsiteX367" fmla="*/ 5608949 w 5649501"/>
                <a:gd name="connsiteY367" fmla="*/ 2927022 h 5236589"/>
                <a:gd name="connsiteX368" fmla="*/ 5627802 w 5649501"/>
                <a:gd name="connsiteY368" fmla="*/ 2846895 h 5236589"/>
                <a:gd name="connsiteX369" fmla="*/ 5637229 w 5649501"/>
                <a:gd name="connsiteY369" fmla="*/ 2813901 h 5236589"/>
                <a:gd name="connsiteX370" fmla="*/ 5646656 w 5649501"/>
                <a:gd name="connsiteY370" fmla="*/ 2785620 h 5236589"/>
                <a:gd name="connsiteX371" fmla="*/ 5641943 w 5649501"/>
                <a:gd name="connsiteY371" fmla="*/ 2738486 h 5236589"/>
                <a:gd name="connsiteX372" fmla="*/ 5524107 w 5649501"/>
                <a:gd name="connsiteY372" fmla="*/ 2747913 h 5236589"/>
                <a:gd name="connsiteX373" fmla="*/ 5458120 w 5649501"/>
                <a:gd name="connsiteY373" fmla="*/ 2743200 h 5236589"/>
                <a:gd name="connsiteX374" fmla="*/ 5453406 w 5649501"/>
                <a:gd name="connsiteY374" fmla="*/ 2729059 h 5236589"/>
                <a:gd name="connsiteX375" fmla="*/ 5448693 w 5649501"/>
                <a:gd name="connsiteY375" fmla="*/ 2658358 h 5236589"/>
                <a:gd name="connsiteX376" fmla="*/ 5429839 w 5649501"/>
                <a:gd name="connsiteY376" fmla="*/ 2615938 h 5236589"/>
                <a:gd name="connsiteX377" fmla="*/ 5429839 w 5649501"/>
                <a:gd name="connsiteY377" fmla="*/ 2545237 h 5236589"/>
                <a:gd name="connsiteX378" fmla="*/ 5425126 w 5649501"/>
                <a:gd name="connsiteY378" fmla="*/ 2507530 h 5236589"/>
                <a:gd name="connsiteX379" fmla="*/ 5415699 w 5649501"/>
                <a:gd name="connsiteY379" fmla="*/ 2493389 h 5236589"/>
                <a:gd name="connsiteX380" fmla="*/ 5410986 w 5649501"/>
                <a:gd name="connsiteY380" fmla="*/ 2479249 h 5236589"/>
                <a:gd name="connsiteX381" fmla="*/ 5392132 w 5649501"/>
                <a:gd name="connsiteY381" fmla="*/ 2455682 h 5236589"/>
                <a:gd name="connsiteX382" fmla="*/ 5396846 w 5649501"/>
                <a:gd name="connsiteY382" fmla="*/ 2384981 h 5236589"/>
                <a:gd name="connsiteX383" fmla="*/ 5406272 w 5649501"/>
                <a:gd name="connsiteY383" fmla="*/ 2356701 h 5236589"/>
                <a:gd name="connsiteX384" fmla="*/ 5410986 w 5649501"/>
                <a:gd name="connsiteY384" fmla="*/ 2318993 h 5236589"/>
                <a:gd name="connsiteX385" fmla="*/ 5415699 w 5649501"/>
                <a:gd name="connsiteY385" fmla="*/ 2286000 h 5236589"/>
                <a:gd name="connsiteX386" fmla="*/ 5410986 w 5649501"/>
                <a:gd name="connsiteY386" fmla="*/ 2224725 h 5236589"/>
                <a:gd name="connsiteX387" fmla="*/ 5406272 w 5649501"/>
                <a:gd name="connsiteY387" fmla="*/ 1956062 h 5236589"/>
                <a:gd name="connsiteX388" fmla="*/ 5387419 w 5649501"/>
                <a:gd name="connsiteY388" fmla="*/ 1937208 h 5236589"/>
                <a:gd name="connsiteX389" fmla="*/ 5382705 w 5649501"/>
                <a:gd name="connsiteY389" fmla="*/ 1923068 h 5236589"/>
                <a:gd name="connsiteX390" fmla="*/ 5368565 w 5649501"/>
                <a:gd name="connsiteY390" fmla="*/ 1890074 h 5236589"/>
                <a:gd name="connsiteX391" fmla="*/ 5359138 w 5649501"/>
                <a:gd name="connsiteY391" fmla="*/ 1847653 h 5236589"/>
                <a:gd name="connsiteX392" fmla="*/ 5349712 w 5649501"/>
                <a:gd name="connsiteY392" fmla="*/ 1828800 h 5236589"/>
                <a:gd name="connsiteX393" fmla="*/ 5335571 w 5649501"/>
                <a:gd name="connsiteY393" fmla="*/ 1824086 h 5236589"/>
                <a:gd name="connsiteX394" fmla="*/ 5307291 w 5649501"/>
                <a:gd name="connsiteY394" fmla="*/ 1809946 h 5236589"/>
                <a:gd name="connsiteX395" fmla="*/ 5293151 w 5649501"/>
                <a:gd name="connsiteY395" fmla="*/ 1725105 h 5236589"/>
                <a:gd name="connsiteX396" fmla="*/ 5279011 w 5649501"/>
                <a:gd name="connsiteY396" fmla="*/ 1677971 h 5236589"/>
                <a:gd name="connsiteX397" fmla="*/ 5264870 w 5649501"/>
                <a:gd name="connsiteY397" fmla="*/ 1564849 h 5236589"/>
                <a:gd name="connsiteX398" fmla="*/ 5260157 w 5649501"/>
                <a:gd name="connsiteY398" fmla="*/ 1536569 h 5236589"/>
                <a:gd name="connsiteX399" fmla="*/ 5255444 w 5649501"/>
                <a:gd name="connsiteY399" fmla="*/ 1522429 h 5236589"/>
                <a:gd name="connsiteX400" fmla="*/ 5236590 w 5649501"/>
                <a:gd name="connsiteY400" fmla="*/ 1494148 h 5236589"/>
                <a:gd name="connsiteX401" fmla="*/ 5222450 w 5649501"/>
                <a:gd name="connsiteY401" fmla="*/ 1465868 h 5236589"/>
                <a:gd name="connsiteX402" fmla="*/ 5180029 w 5649501"/>
                <a:gd name="connsiteY402" fmla="*/ 1428160 h 5236589"/>
                <a:gd name="connsiteX403" fmla="*/ 5156462 w 5649501"/>
                <a:gd name="connsiteY403" fmla="*/ 1423447 h 5236589"/>
                <a:gd name="connsiteX404" fmla="*/ 5081048 w 5649501"/>
                <a:gd name="connsiteY404" fmla="*/ 1418734 h 5236589"/>
                <a:gd name="connsiteX405" fmla="*/ 4897225 w 5649501"/>
                <a:gd name="connsiteY405" fmla="*/ 1418734 h 5236589"/>
                <a:gd name="connsiteX406" fmla="*/ 4845378 w 5649501"/>
                <a:gd name="connsiteY406" fmla="*/ 1404593 h 5236589"/>
                <a:gd name="connsiteX407" fmla="*/ 4826524 w 5649501"/>
                <a:gd name="connsiteY407" fmla="*/ 1399880 h 5236589"/>
                <a:gd name="connsiteX408" fmla="*/ 4807670 w 5649501"/>
                <a:gd name="connsiteY408" fmla="*/ 1390453 h 5236589"/>
                <a:gd name="connsiteX409" fmla="*/ 4779390 w 5649501"/>
                <a:gd name="connsiteY409" fmla="*/ 1381026 h 5236589"/>
                <a:gd name="connsiteX410" fmla="*/ 4765250 w 5649501"/>
                <a:gd name="connsiteY410" fmla="*/ 1371600 h 5236589"/>
                <a:gd name="connsiteX411" fmla="*/ 4685122 w 5649501"/>
                <a:gd name="connsiteY411" fmla="*/ 1376313 h 5236589"/>
                <a:gd name="connsiteX412" fmla="*/ 4661555 w 5649501"/>
                <a:gd name="connsiteY412" fmla="*/ 1381026 h 5236589"/>
                <a:gd name="connsiteX413" fmla="*/ 4647415 w 5649501"/>
                <a:gd name="connsiteY413" fmla="*/ 1390453 h 5236589"/>
                <a:gd name="connsiteX414" fmla="*/ 4633275 w 5649501"/>
                <a:gd name="connsiteY414" fmla="*/ 1395167 h 5236589"/>
                <a:gd name="connsiteX415" fmla="*/ 4619134 w 5649501"/>
                <a:gd name="connsiteY415" fmla="*/ 1409307 h 5236589"/>
                <a:gd name="connsiteX416" fmla="*/ 4604994 w 5649501"/>
                <a:gd name="connsiteY416" fmla="*/ 1414020 h 5236589"/>
                <a:gd name="connsiteX417" fmla="*/ 4581427 w 5649501"/>
                <a:gd name="connsiteY417" fmla="*/ 1442301 h 5236589"/>
                <a:gd name="connsiteX418" fmla="*/ 4572000 w 5649501"/>
                <a:gd name="connsiteY418" fmla="*/ 1456441 h 5236589"/>
                <a:gd name="connsiteX419" fmla="*/ 4543720 w 5649501"/>
                <a:gd name="connsiteY419" fmla="*/ 1465868 h 5236589"/>
                <a:gd name="connsiteX420" fmla="*/ 4529580 w 5649501"/>
                <a:gd name="connsiteY420" fmla="*/ 1470581 h 5236589"/>
                <a:gd name="connsiteX421" fmla="*/ 4515439 w 5649501"/>
                <a:gd name="connsiteY421" fmla="*/ 1475295 h 5236589"/>
                <a:gd name="connsiteX422" fmla="*/ 4496586 w 5649501"/>
                <a:gd name="connsiteY422" fmla="*/ 1480008 h 5236589"/>
                <a:gd name="connsiteX423" fmla="*/ 4454165 w 5649501"/>
                <a:gd name="connsiteY423" fmla="*/ 1484721 h 5236589"/>
                <a:gd name="connsiteX424" fmla="*/ 4435312 w 5649501"/>
                <a:gd name="connsiteY424" fmla="*/ 1489435 h 5236589"/>
                <a:gd name="connsiteX425" fmla="*/ 4411745 w 5649501"/>
                <a:gd name="connsiteY425" fmla="*/ 1494148 h 5236589"/>
                <a:gd name="connsiteX426" fmla="*/ 4402318 w 5649501"/>
                <a:gd name="connsiteY426" fmla="*/ 1508288 h 5236589"/>
                <a:gd name="connsiteX427" fmla="*/ 4388178 w 5649501"/>
                <a:gd name="connsiteY427" fmla="*/ 1522429 h 5236589"/>
                <a:gd name="connsiteX428" fmla="*/ 4369324 w 5649501"/>
                <a:gd name="connsiteY428" fmla="*/ 1541282 h 5236589"/>
                <a:gd name="connsiteX429" fmla="*/ 4364611 w 5649501"/>
                <a:gd name="connsiteY429" fmla="*/ 1555422 h 5236589"/>
                <a:gd name="connsiteX430" fmla="*/ 4355184 w 5649501"/>
                <a:gd name="connsiteY430" fmla="*/ 1588416 h 5236589"/>
                <a:gd name="connsiteX431" fmla="*/ 4341044 w 5649501"/>
                <a:gd name="connsiteY431" fmla="*/ 1597843 h 5236589"/>
                <a:gd name="connsiteX432" fmla="*/ 4331617 w 5649501"/>
                <a:gd name="connsiteY432" fmla="*/ 1611983 h 5236589"/>
                <a:gd name="connsiteX433" fmla="*/ 4317477 w 5649501"/>
                <a:gd name="connsiteY433" fmla="*/ 1640264 h 5236589"/>
                <a:gd name="connsiteX434" fmla="*/ 4275056 w 5649501"/>
                <a:gd name="connsiteY434" fmla="*/ 1663831 h 5236589"/>
                <a:gd name="connsiteX435" fmla="*/ 4260916 w 5649501"/>
                <a:gd name="connsiteY435" fmla="*/ 1677971 h 5236589"/>
                <a:gd name="connsiteX436" fmla="*/ 4256202 w 5649501"/>
                <a:gd name="connsiteY436" fmla="*/ 1692111 h 5236589"/>
                <a:gd name="connsiteX437" fmla="*/ 4204355 w 5649501"/>
                <a:gd name="connsiteY437" fmla="*/ 1696824 h 5236589"/>
                <a:gd name="connsiteX438" fmla="*/ 4185501 w 5649501"/>
                <a:gd name="connsiteY438" fmla="*/ 1725105 h 5236589"/>
                <a:gd name="connsiteX439" fmla="*/ 4152507 w 5649501"/>
                <a:gd name="connsiteY439" fmla="*/ 1734532 h 5236589"/>
                <a:gd name="connsiteX440" fmla="*/ 4138367 w 5649501"/>
                <a:gd name="connsiteY440" fmla="*/ 1743958 h 5236589"/>
                <a:gd name="connsiteX441" fmla="*/ 4128940 w 5649501"/>
                <a:gd name="connsiteY441" fmla="*/ 1772239 h 5236589"/>
                <a:gd name="connsiteX442" fmla="*/ 4086520 w 5649501"/>
                <a:gd name="connsiteY442" fmla="*/ 1791092 h 5236589"/>
                <a:gd name="connsiteX443" fmla="*/ 4072380 w 5649501"/>
                <a:gd name="connsiteY443" fmla="*/ 1819373 h 5236589"/>
                <a:gd name="connsiteX444" fmla="*/ 4062953 w 5649501"/>
                <a:gd name="connsiteY444" fmla="*/ 1847653 h 5236589"/>
                <a:gd name="connsiteX445" fmla="*/ 4058239 w 5649501"/>
                <a:gd name="connsiteY445" fmla="*/ 1861793 h 5236589"/>
                <a:gd name="connsiteX446" fmla="*/ 4053526 w 5649501"/>
                <a:gd name="connsiteY446" fmla="*/ 1875934 h 5236589"/>
                <a:gd name="connsiteX447" fmla="*/ 4044099 w 5649501"/>
                <a:gd name="connsiteY447" fmla="*/ 1890074 h 5236589"/>
                <a:gd name="connsiteX448" fmla="*/ 4039386 w 5649501"/>
                <a:gd name="connsiteY448" fmla="*/ 1908927 h 5236589"/>
                <a:gd name="connsiteX449" fmla="*/ 4029959 w 5649501"/>
                <a:gd name="connsiteY449" fmla="*/ 1923068 h 5236589"/>
                <a:gd name="connsiteX450" fmla="*/ 4025246 w 5649501"/>
                <a:gd name="connsiteY450" fmla="*/ 1937208 h 5236589"/>
                <a:gd name="connsiteX451" fmla="*/ 4006392 w 5649501"/>
                <a:gd name="connsiteY451" fmla="*/ 2007909 h 5236589"/>
                <a:gd name="connsiteX452" fmla="*/ 3992252 w 5649501"/>
                <a:gd name="connsiteY452" fmla="*/ 2012622 h 5236589"/>
                <a:gd name="connsiteX453" fmla="*/ 3963971 w 5649501"/>
                <a:gd name="connsiteY453" fmla="*/ 2036189 h 5236589"/>
                <a:gd name="connsiteX454" fmla="*/ 3954545 w 5649501"/>
                <a:gd name="connsiteY454" fmla="*/ 2050330 h 5236589"/>
                <a:gd name="connsiteX455" fmla="*/ 3940404 w 5649501"/>
                <a:gd name="connsiteY455" fmla="*/ 2055043 h 5236589"/>
                <a:gd name="connsiteX456" fmla="*/ 3926264 w 5649501"/>
                <a:gd name="connsiteY456" fmla="*/ 2069183 h 5236589"/>
                <a:gd name="connsiteX457" fmla="*/ 3897984 w 5649501"/>
                <a:gd name="connsiteY457" fmla="*/ 2088037 h 5236589"/>
                <a:gd name="connsiteX458" fmla="*/ 3893270 w 5649501"/>
                <a:gd name="connsiteY458" fmla="*/ 2102177 h 5236589"/>
                <a:gd name="connsiteX459" fmla="*/ 3869703 w 5649501"/>
                <a:gd name="connsiteY459" fmla="*/ 2111604 h 5236589"/>
                <a:gd name="connsiteX460" fmla="*/ 3780149 w 5649501"/>
                <a:gd name="connsiteY460" fmla="*/ 2116317 h 5236589"/>
                <a:gd name="connsiteX461" fmla="*/ 3766009 w 5649501"/>
                <a:gd name="connsiteY461" fmla="*/ 2121031 h 5236589"/>
                <a:gd name="connsiteX462" fmla="*/ 3751868 w 5649501"/>
                <a:gd name="connsiteY462" fmla="*/ 2149311 h 5236589"/>
                <a:gd name="connsiteX463" fmla="*/ 3756582 w 5649501"/>
                <a:gd name="connsiteY463" fmla="*/ 2172878 h 5236589"/>
                <a:gd name="connsiteX464" fmla="*/ 3761295 w 5649501"/>
                <a:gd name="connsiteY464" fmla="*/ 2187018 h 5236589"/>
                <a:gd name="connsiteX465" fmla="*/ 3756582 w 5649501"/>
                <a:gd name="connsiteY465" fmla="*/ 2205872 h 5236589"/>
                <a:gd name="connsiteX466" fmla="*/ 3737728 w 5649501"/>
                <a:gd name="connsiteY466" fmla="*/ 2253006 h 5236589"/>
                <a:gd name="connsiteX467" fmla="*/ 3728301 w 5649501"/>
                <a:gd name="connsiteY467" fmla="*/ 2267146 h 5236589"/>
                <a:gd name="connsiteX468" fmla="*/ 3714161 w 5649501"/>
                <a:gd name="connsiteY468" fmla="*/ 2276573 h 5236589"/>
                <a:gd name="connsiteX469" fmla="*/ 3700021 w 5649501"/>
                <a:gd name="connsiteY469" fmla="*/ 2318993 h 5236589"/>
                <a:gd name="connsiteX470" fmla="*/ 3690594 w 5649501"/>
                <a:gd name="connsiteY470" fmla="*/ 2347274 h 5236589"/>
                <a:gd name="connsiteX471" fmla="*/ 3676454 w 5649501"/>
                <a:gd name="connsiteY471" fmla="*/ 2356701 h 5236589"/>
                <a:gd name="connsiteX472" fmla="*/ 3671740 w 5649501"/>
                <a:gd name="connsiteY472" fmla="*/ 2370841 h 5236589"/>
                <a:gd name="connsiteX473" fmla="*/ 3643460 w 5649501"/>
                <a:gd name="connsiteY473" fmla="*/ 2384981 h 5236589"/>
                <a:gd name="connsiteX474" fmla="*/ 3634033 w 5649501"/>
                <a:gd name="connsiteY474" fmla="*/ 2399121 h 5236589"/>
                <a:gd name="connsiteX475" fmla="*/ 3497345 w 5649501"/>
                <a:gd name="connsiteY475" fmla="*/ 2413262 h 5236589"/>
                <a:gd name="connsiteX476" fmla="*/ 3393650 w 5649501"/>
                <a:gd name="connsiteY476" fmla="*/ 2413262 h 5236589"/>
                <a:gd name="connsiteX477" fmla="*/ 3374796 w 5649501"/>
                <a:gd name="connsiteY477" fmla="*/ 2399121 h 5236589"/>
                <a:gd name="connsiteX478" fmla="*/ 3327662 w 5649501"/>
                <a:gd name="connsiteY478" fmla="*/ 2389695 h 5236589"/>
                <a:gd name="connsiteX479" fmla="*/ 3299382 w 5649501"/>
                <a:gd name="connsiteY479" fmla="*/ 2380268 h 5236589"/>
                <a:gd name="connsiteX480" fmla="*/ 3242821 w 5649501"/>
                <a:gd name="connsiteY480" fmla="*/ 2366127 h 5236589"/>
                <a:gd name="connsiteX481" fmla="*/ 3223967 w 5649501"/>
                <a:gd name="connsiteY481" fmla="*/ 2347274 h 5236589"/>
                <a:gd name="connsiteX482" fmla="*/ 3214540 w 5649501"/>
                <a:gd name="connsiteY482" fmla="*/ 2333134 h 5236589"/>
                <a:gd name="connsiteX483" fmla="*/ 3200400 w 5649501"/>
                <a:gd name="connsiteY483" fmla="*/ 2323707 h 5236589"/>
                <a:gd name="connsiteX484" fmla="*/ 3195687 w 5649501"/>
                <a:gd name="connsiteY484" fmla="*/ 2309567 h 5236589"/>
                <a:gd name="connsiteX485" fmla="*/ 3167406 w 5649501"/>
                <a:gd name="connsiteY485" fmla="*/ 2290713 h 5236589"/>
                <a:gd name="connsiteX486" fmla="*/ 3148553 w 5649501"/>
                <a:gd name="connsiteY486" fmla="*/ 2276573 h 5236589"/>
                <a:gd name="connsiteX487" fmla="*/ 3134413 w 5649501"/>
                <a:gd name="connsiteY487" fmla="*/ 2271859 h 5236589"/>
                <a:gd name="connsiteX488" fmla="*/ 3021291 w 5649501"/>
                <a:gd name="connsiteY488" fmla="*/ 2276573 h 5236589"/>
                <a:gd name="connsiteX489" fmla="*/ 3007151 w 5649501"/>
                <a:gd name="connsiteY489" fmla="*/ 2286000 h 5236589"/>
                <a:gd name="connsiteX490" fmla="*/ 2993011 w 5649501"/>
                <a:gd name="connsiteY490" fmla="*/ 2290713 h 5236589"/>
                <a:gd name="connsiteX491" fmla="*/ 2978870 w 5649501"/>
                <a:gd name="connsiteY491" fmla="*/ 2300140 h 5236589"/>
                <a:gd name="connsiteX492" fmla="*/ 2960017 w 5649501"/>
                <a:gd name="connsiteY492" fmla="*/ 2342560 h 5236589"/>
                <a:gd name="connsiteX493" fmla="*/ 2955303 w 5649501"/>
                <a:gd name="connsiteY493" fmla="*/ 2356701 h 5236589"/>
                <a:gd name="connsiteX494" fmla="*/ 2941163 w 5649501"/>
                <a:gd name="connsiteY494" fmla="*/ 2408548 h 5236589"/>
                <a:gd name="connsiteX495" fmla="*/ 2931736 w 5649501"/>
                <a:gd name="connsiteY495" fmla="*/ 2427402 h 5236589"/>
                <a:gd name="connsiteX496" fmla="*/ 2912883 w 5649501"/>
                <a:gd name="connsiteY496" fmla="*/ 2441542 h 5236589"/>
                <a:gd name="connsiteX497" fmla="*/ 2908169 w 5649501"/>
                <a:gd name="connsiteY497" fmla="*/ 2460396 h 5236589"/>
                <a:gd name="connsiteX498" fmla="*/ 2898743 w 5649501"/>
                <a:gd name="connsiteY498" fmla="*/ 2512243 h 5236589"/>
                <a:gd name="connsiteX499" fmla="*/ 2884602 w 5649501"/>
                <a:gd name="connsiteY499" fmla="*/ 2516956 h 5236589"/>
                <a:gd name="connsiteX500" fmla="*/ 2870462 w 5649501"/>
                <a:gd name="connsiteY500" fmla="*/ 2526383 h 5236589"/>
                <a:gd name="connsiteX501" fmla="*/ 2842182 w 5649501"/>
                <a:gd name="connsiteY501" fmla="*/ 2535810 h 5236589"/>
                <a:gd name="connsiteX502" fmla="*/ 2828042 w 5649501"/>
                <a:gd name="connsiteY502" fmla="*/ 2549950 h 5236589"/>
                <a:gd name="connsiteX503" fmla="*/ 2799761 w 5649501"/>
                <a:gd name="connsiteY503" fmla="*/ 2568804 h 5236589"/>
                <a:gd name="connsiteX504" fmla="*/ 2795048 w 5649501"/>
                <a:gd name="connsiteY504" fmla="*/ 2582944 h 5236589"/>
                <a:gd name="connsiteX505" fmla="*/ 2785621 w 5649501"/>
                <a:gd name="connsiteY505" fmla="*/ 2597084 h 5236589"/>
                <a:gd name="connsiteX506" fmla="*/ 2790334 w 5649501"/>
                <a:gd name="connsiteY506" fmla="*/ 2611224 h 5236589"/>
                <a:gd name="connsiteX507" fmla="*/ 2780907 w 5649501"/>
                <a:gd name="connsiteY507" fmla="*/ 2644218 h 5236589"/>
                <a:gd name="connsiteX508" fmla="*/ 2752627 w 5649501"/>
                <a:gd name="connsiteY508" fmla="*/ 2663072 h 5236589"/>
                <a:gd name="connsiteX509" fmla="*/ 2747914 w 5649501"/>
                <a:gd name="connsiteY509" fmla="*/ 2677212 h 5236589"/>
                <a:gd name="connsiteX510" fmla="*/ 2714920 w 5649501"/>
                <a:gd name="connsiteY510" fmla="*/ 2681925 h 5236589"/>
                <a:gd name="connsiteX511" fmla="*/ 2696066 w 5649501"/>
                <a:gd name="connsiteY511" fmla="*/ 2686639 h 5236589"/>
                <a:gd name="connsiteX512" fmla="*/ 2677213 w 5649501"/>
                <a:gd name="connsiteY512" fmla="*/ 2700779 h 5236589"/>
                <a:gd name="connsiteX513" fmla="*/ 2667786 w 5649501"/>
                <a:gd name="connsiteY513" fmla="*/ 2714919 h 5236589"/>
                <a:gd name="connsiteX514" fmla="*/ 2663072 w 5649501"/>
                <a:gd name="connsiteY514" fmla="*/ 2729059 h 5236589"/>
                <a:gd name="connsiteX515" fmla="*/ 2648932 w 5649501"/>
                <a:gd name="connsiteY515" fmla="*/ 2733773 h 5236589"/>
                <a:gd name="connsiteX516" fmla="*/ 2422689 w 5649501"/>
                <a:gd name="connsiteY516" fmla="*/ 2738486 h 5236589"/>
                <a:gd name="connsiteX517" fmla="*/ 2408549 w 5649501"/>
                <a:gd name="connsiteY517" fmla="*/ 2743200 h 5236589"/>
                <a:gd name="connsiteX518" fmla="*/ 2384982 w 5649501"/>
                <a:gd name="connsiteY518" fmla="*/ 2747913 h 5236589"/>
                <a:gd name="connsiteX519" fmla="*/ 2389695 w 5649501"/>
                <a:gd name="connsiteY519" fmla="*/ 2606511 h 5236589"/>
                <a:gd name="connsiteX520" fmla="*/ 2394409 w 5649501"/>
                <a:gd name="connsiteY520" fmla="*/ 2587657 h 5236589"/>
                <a:gd name="connsiteX521" fmla="*/ 2422689 w 5649501"/>
                <a:gd name="connsiteY521" fmla="*/ 2578231 h 5236589"/>
                <a:gd name="connsiteX522" fmla="*/ 2441543 w 5649501"/>
                <a:gd name="connsiteY522" fmla="*/ 2568804 h 5236589"/>
                <a:gd name="connsiteX523" fmla="*/ 2450969 w 5649501"/>
                <a:gd name="connsiteY523" fmla="*/ 2554664 h 5236589"/>
                <a:gd name="connsiteX524" fmla="*/ 2450969 w 5649501"/>
                <a:gd name="connsiteY524" fmla="*/ 2483963 h 5236589"/>
                <a:gd name="connsiteX525" fmla="*/ 2441543 w 5649501"/>
                <a:gd name="connsiteY525" fmla="*/ 2469822 h 5236589"/>
                <a:gd name="connsiteX526" fmla="*/ 2427402 w 5649501"/>
                <a:gd name="connsiteY526" fmla="*/ 2465109 h 5236589"/>
                <a:gd name="connsiteX527" fmla="*/ 2399122 w 5649501"/>
                <a:gd name="connsiteY527" fmla="*/ 2446255 h 5236589"/>
                <a:gd name="connsiteX528" fmla="*/ 2394409 w 5649501"/>
                <a:gd name="connsiteY528" fmla="*/ 2375554 h 5236589"/>
                <a:gd name="connsiteX529" fmla="*/ 2389695 w 5649501"/>
                <a:gd name="connsiteY529" fmla="*/ 2361414 h 5236589"/>
                <a:gd name="connsiteX530" fmla="*/ 2370842 w 5649501"/>
                <a:gd name="connsiteY530" fmla="*/ 2333134 h 5236589"/>
                <a:gd name="connsiteX531" fmla="*/ 2366128 w 5649501"/>
                <a:gd name="connsiteY531" fmla="*/ 2318993 h 5236589"/>
                <a:gd name="connsiteX532" fmla="*/ 2342561 w 5649501"/>
                <a:gd name="connsiteY532" fmla="*/ 2286000 h 5236589"/>
                <a:gd name="connsiteX533" fmla="*/ 2337848 w 5649501"/>
                <a:gd name="connsiteY533" fmla="*/ 2271859 h 5236589"/>
                <a:gd name="connsiteX534" fmla="*/ 2328421 w 5649501"/>
                <a:gd name="connsiteY534" fmla="*/ 2257719 h 5236589"/>
                <a:gd name="connsiteX535" fmla="*/ 2318994 w 5649501"/>
                <a:gd name="connsiteY535" fmla="*/ 2229439 h 5236589"/>
                <a:gd name="connsiteX536" fmla="*/ 2314281 w 5649501"/>
                <a:gd name="connsiteY536" fmla="*/ 2215299 h 5236589"/>
                <a:gd name="connsiteX537" fmla="*/ 2300140 w 5649501"/>
                <a:gd name="connsiteY537" fmla="*/ 2210585 h 5236589"/>
                <a:gd name="connsiteX538" fmla="*/ 2286000 w 5649501"/>
                <a:gd name="connsiteY538" fmla="*/ 2196445 h 5236589"/>
                <a:gd name="connsiteX539" fmla="*/ 2267147 w 5649501"/>
                <a:gd name="connsiteY539" fmla="*/ 2172878 h 5236589"/>
                <a:gd name="connsiteX540" fmla="*/ 2253006 w 5649501"/>
                <a:gd name="connsiteY540" fmla="*/ 2163451 h 5236589"/>
                <a:gd name="connsiteX541" fmla="*/ 2238866 w 5649501"/>
                <a:gd name="connsiteY541" fmla="*/ 2158738 h 5236589"/>
                <a:gd name="connsiteX542" fmla="*/ 2229439 w 5649501"/>
                <a:gd name="connsiteY542" fmla="*/ 2144598 h 5236589"/>
                <a:gd name="connsiteX543" fmla="*/ 2215299 w 5649501"/>
                <a:gd name="connsiteY543" fmla="*/ 2139884 h 5236589"/>
                <a:gd name="connsiteX544" fmla="*/ 2205872 w 5649501"/>
                <a:gd name="connsiteY544" fmla="*/ 2135171 h 52365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  <a:cxn ang="0">
                  <a:pos x="connsiteX120" y="connsiteY120"/>
                </a:cxn>
                <a:cxn ang="0">
                  <a:pos x="connsiteX121" y="connsiteY121"/>
                </a:cxn>
                <a:cxn ang="0">
                  <a:pos x="connsiteX122" y="connsiteY122"/>
                </a:cxn>
                <a:cxn ang="0">
                  <a:pos x="connsiteX123" y="connsiteY123"/>
                </a:cxn>
                <a:cxn ang="0">
                  <a:pos x="connsiteX124" y="connsiteY124"/>
                </a:cxn>
                <a:cxn ang="0">
                  <a:pos x="connsiteX125" y="connsiteY125"/>
                </a:cxn>
                <a:cxn ang="0">
                  <a:pos x="connsiteX126" y="connsiteY126"/>
                </a:cxn>
                <a:cxn ang="0">
                  <a:pos x="connsiteX127" y="connsiteY127"/>
                </a:cxn>
                <a:cxn ang="0">
                  <a:pos x="connsiteX128" y="connsiteY128"/>
                </a:cxn>
                <a:cxn ang="0">
                  <a:pos x="connsiteX129" y="connsiteY129"/>
                </a:cxn>
                <a:cxn ang="0">
                  <a:pos x="connsiteX130" y="connsiteY130"/>
                </a:cxn>
                <a:cxn ang="0">
                  <a:pos x="connsiteX131" y="connsiteY131"/>
                </a:cxn>
                <a:cxn ang="0">
                  <a:pos x="connsiteX132" y="connsiteY132"/>
                </a:cxn>
                <a:cxn ang="0">
                  <a:pos x="connsiteX133" y="connsiteY133"/>
                </a:cxn>
                <a:cxn ang="0">
                  <a:pos x="connsiteX134" y="connsiteY134"/>
                </a:cxn>
                <a:cxn ang="0">
                  <a:pos x="connsiteX135" y="connsiteY135"/>
                </a:cxn>
                <a:cxn ang="0">
                  <a:pos x="connsiteX136" y="connsiteY136"/>
                </a:cxn>
                <a:cxn ang="0">
                  <a:pos x="connsiteX137" y="connsiteY137"/>
                </a:cxn>
                <a:cxn ang="0">
                  <a:pos x="connsiteX138" y="connsiteY138"/>
                </a:cxn>
                <a:cxn ang="0">
                  <a:pos x="connsiteX139" y="connsiteY139"/>
                </a:cxn>
                <a:cxn ang="0">
                  <a:pos x="connsiteX140" y="connsiteY140"/>
                </a:cxn>
                <a:cxn ang="0">
                  <a:pos x="connsiteX141" y="connsiteY141"/>
                </a:cxn>
                <a:cxn ang="0">
                  <a:pos x="connsiteX142" y="connsiteY142"/>
                </a:cxn>
                <a:cxn ang="0">
                  <a:pos x="connsiteX143" y="connsiteY143"/>
                </a:cxn>
                <a:cxn ang="0">
                  <a:pos x="connsiteX144" y="connsiteY144"/>
                </a:cxn>
                <a:cxn ang="0">
                  <a:pos x="connsiteX145" y="connsiteY145"/>
                </a:cxn>
                <a:cxn ang="0">
                  <a:pos x="connsiteX146" y="connsiteY146"/>
                </a:cxn>
                <a:cxn ang="0">
                  <a:pos x="connsiteX147" y="connsiteY147"/>
                </a:cxn>
                <a:cxn ang="0">
                  <a:pos x="connsiteX148" y="connsiteY148"/>
                </a:cxn>
                <a:cxn ang="0">
                  <a:pos x="connsiteX149" y="connsiteY149"/>
                </a:cxn>
                <a:cxn ang="0">
                  <a:pos x="connsiteX150" y="connsiteY150"/>
                </a:cxn>
                <a:cxn ang="0">
                  <a:pos x="connsiteX151" y="connsiteY151"/>
                </a:cxn>
                <a:cxn ang="0">
                  <a:pos x="connsiteX152" y="connsiteY152"/>
                </a:cxn>
                <a:cxn ang="0">
                  <a:pos x="connsiteX153" y="connsiteY153"/>
                </a:cxn>
                <a:cxn ang="0">
                  <a:pos x="connsiteX154" y="connsiteY154"/>
                </a:cxn>
                <a:cxn ang="0">
                  <a:pos x="connsiteX155" y="connsiteY155"/>
                </a:cxn>
                <a:cxn ang="0">
                  <a:pos x="connsiteX156" y="connsiteY156"/>
                </a:cxn>
                <a:cxn ang="0">
                  <a:pos x="connsiteX157" y="connsiteY157"/>
                </a:cxn>
                <a:cxn ang="0">
                  <a:pos x="connsiteX158" y="connsiteY158"/>
                </a:cxn>
                <a:cxn ang="0">
                  <a:pos x="connsiteX159" y="connsiteY159"/>
                </a:cxn>
                <a:cxn ang="0">
                  <a:pos x="connsiteX160" y="connsiteY160"/>
                </a:cxn>
                <a:cxn ang="0">
                  <a:pos x="connsiteX161" y="connsiteY161"/>
                </a:cxn>
                <a:cxn ang="0">
                  <a:pos x="connsiteX162" y="connsiteY162"/>
                </a:cxn>
                <a:cxn ang="0">
                  <a:pos x="connsiteX163" y="connsiteY163"/>
                </a:cxn>
                <a:cxn ang="0">
                  <a:pos x="connsiteX164" y="connsiteY164"/>
                </a:cxn>
                <a:cxn ang="0">
                  <a:pos x="connsiteX165" y="connsiteY165"/>
                </a:cxn>
                <a:cxn ang="0">
                  <a:pos x="connsiteX166" y="connsiteY166"/>
                </a:cxn>
                <a:cxn ang="0">
                  <a:pos x="connsiteX167" y="connsiteY167"/>
                </a:cxn>
                <a:cxn ang="0">
                  <a:pos x="connsiteX168" y="connsiteY168"/>
                </a:cxn>
                <a:cxn ang="0">
                  <a:pos x="connsiteX169" y="connsiteY169"/>
                </a:cxn>
                <a:cxn ang="0">
                  <a:pos x="connsiteX170" y="connsiteY170"/>
                </a:cxn>
                <a:cxn ang="0">
                  <a:pos x="connsiteX171" y="connsiteY171"/>
                </a:cxn>
                <a:cxn ang="0">
                  <a:pos x="connsiteX172" y="connsiteY172"/>
                </a:cxn>
                <a:cxn ang="0">
                  <a:pos x="connsiteX173" y="connsiteY173"/>
                </a:cxn>
                <a:cxn ang="0">
                  <a:pos x="connsiteX174" y="connsiteY174"/>
                </a:cxn>
                <a:cxn ang="0">
                  <a:pos x="connsiteX175" y="connsiteY175"/>
                </a:cxn>
                <a:cxn ang="0">
                  <a:pos x="connsiteX176" y="connsiteY176"/>
                </a:cxn>
                <a:cxn ang="0">
                  <a:pos x="connsiteX177" y="connsiteY177"/>
                </a:cxn>
                <a:cxn ang="0">
                  <a:pos x="connsiteX178" y="connsiteY178"/>
                </a:cxn>
                <a:cxn ang="0">
                  <a:pos x="connsiteX179" y="connsiteY179"/>
                </a:cxn>
                <a:cxn ang="0">
                  <a:pos x="connsiteX180" y="connsiteY180"/>
                </a:cxn>
                <a:cxn ang="0">
                  <a:pos x="connsiteX181" y="connsiteY181"/>
                </a:cxn>
                <a:cxn ang="0">
                  <a:pos x="connsiteX182" y="connsiteY182"/>
                </a:cxn>
                <a:cxn ang="0">
                  <a:pos x="connsiteX183" y="connsiteY183"/>
                </a:cxn>
                <a:cxn ang="0">
                  <a:pos x="connsiteX184" y="connsiteY184"/>
                </a:cxn>
                <a:cxn ang="0">
                  <a:pos x="connsiteX185" y="connsiteY185"/>
                </a:cxn>
                <a:cxn ang="0">
                  <a:pos x="connsiteX186" y="connsiteY186"/>
                </a:cxn>
                <a:cxn ang="0">
                  <a:pos x="connsiteX187" y="connsiteY187"/>
                </a:cxn>
                <a:cxn ang="0">
                  <a:pos x="connsiteX188" y="connsiteY188"/>
                </a:cxn>
                <a:cxn ang="0">
                  <a:pos x="connsiteX189" y="connsiteY189"/>
                </a:cxn>
                <a:cxn ang="0">
                  <a:pos x="connsiteX190" y="connsiteY190"/>
                </a:cxn>
                <a:cxn ang="0">
                  <a:pos x="connsiteX191" y="connsiteY191"/>
                </a:cxn>
                <a:cxn ang="0">
                  <a:pos x="connsiteX192" y="connsiteY192"/>
                </a:cxn>
                <a:cxn ang="0">
                  <a:pos x="connsiteX193" y="connsiteY193"/>
                </a:cxn>
                <a:cxn ang="0">
                  <a:pos x="connsiteX194" y="connsiteY194"/>
                </a:cxn>
                <a:cxn ang="0">
                  <a:pos x="connsiteX195" y="connsiteY195"/>
                </a:cxn>
                <a:cxn ang="0">
                  <a:pos x="connsiteX196" y="connsiteY196"/>
                </a:cxn>
                <a:cxn ang="0">
                  <a:pos x="connsiteX197" y="connsiteY197"/>
                </a:cxn>
                <a:cxn ang="0">
                  <a:pos x="connsiteX198" y="connsiteY198"/>
                </a:cxn>
                <a:cxn ang="0">
                  <a:pos x="connsiteX199" y="connsiteY199"/>
                </a:cxn>
                <a:cxn ang="0">
                  <a:pos x="connsiteX200" y="connsiteY200"/>
                </a:cxn>
                <a:cxn ang="0">
                  <a:pos x="connsiteX201" y="connsiteY201"/>
                </a:cxn>
                <a:cxn ang="0">
                  <a:pos x="connsiteX202" y="connsiteY202"/>
                </a:cxn>
                <a:cxn ang="0">
                  <a:pos x="connsiteX203" y="connsiteY203"/>
                </a:cxn>
                <a:cxn ang="0">
                  <a:pos x="connsiteX204" y="connsiteY204"/>
                </a:cxn>
                <a:cxn ang="0">
                  <a:pos x="connsiteX205" y="connsiteY205"/>
                </a:cxn>
                <a:cxn ang="0">
                  <a:pos x="connsiteX206" y="connsiteY206"/>
                </a:cxn>
                <a:cxn ang="0">
                  <a:pos x="connsiteX207" y="connsiteY207"/>
                </a:cxn>
                <a:cxn ang="0">
                  <a:pos x="connsiteX208" y="connsiteY208"/>
                </a:cxn>
                <a:cxn ang="0">
                  <a:pos x="connsiteX209" y="connsiteY209"/>
                </a:cxn>
                <a:cxn ang="0">
                  <a:pos x="connsiteX210" y="connsiteY210"/>
                </a:cxn>
                <a:cxn ang="0">
                  <a:pos x="connsiteX211" y="connsiteY211"/>
                </a:cxn>
                <a:cxn ang="0">
                  <a:pos x="connsiteX212" y="connsiteY212"/>
                </a:cxn>
                <a:cxn ang="0">
                  <a:pos x="connsiteX213" y="connsiteY213"/>
                </a:cxn>
                <a:cxn ang="0">
                  <a:pos x="connsiteX214" y="connsiteY214"/>
                </a:cxn>
                <a:cxn ang="0">
                  <a:pos x="connsiteX215" y="connsiteY215"/>
                </a:cxn>
                <a:cxn ang="0">
                  <a:pos x="connsiteX216" y="connsiteY216"/>
                </a:cxn>
                <a:cxn ang="0">
                  <a:pos x="connsiteX217" y="connsiteY217"/>
                </a:cxn>
                <a:cxn ang="0">
                  <a:pos x="connsiteX218" y="connsiteY218"/>
                </a:cxn>
                <a:cxn ang="0">
                  <a:pos x="connsiteX219" y="connsiteY219"/>
                </a:cxn>
                <a:cxn ang="0">
                  <a:pos x="connsiteX220" y="connsiteY220"/>
                </a:cxn>
                <a:cxn ang="0">
                  <a:pos x="connsiteX221" y="connsiteY221"/>
                </a:cxn>
                <a:cxn ang="0">
                  <a:pos x="connsiteX222" y="connsiteY222"/>
                </a:cxn>
                <a:cxn ang="0">
                  <a:pos x="connsiteX223" y="connsiteY223"/>
                </a:cxn>
                <a:cxn ang="0">
                  <a:pos x="connsiteX224" y="connsiteY224"/>
                </a:cxn>
                <a:cxn ang="0">
                  <a:pos x="connsiteX225" y="connsiteY225"/>
                </a:cxn>
                <a:cxn ang="0">
                  <a:pos x="connsiteX226" y="connsiteY226"/>
                </a:cxn>
                <a:cxn ang="0">
                  <a:pos x="connsiteX227" y="connsiteY227"/>
                </a:cxn>
                <a:cxn ang="0">
                  <a:pos x="connsiteX228" y="connsiteY228"/>
                </a:cxn>
                <a:cxn ang="0">
                  <a:pos x="connsiteX229" y="connsiteY229"/>
                </a:cxn>
                <a:cxn ang="0">
                  <a:pos x="connsiteX230" y="connsiteY230"/>
                </a:cxn>
                <a:cxn ang="0">
                  <a:pos x="connsiteX231" y="connsiteY231"/>
                </a:cxn>
                <a:cxn ang="0">
                  <a:pos x="connsiteX232" y="connsiteY232"/>
                </a:cxn>
                <a:cxn ang="0">
                  <a:pos x="connsiteX233" y="connsiteY233"/>
                </a:cxn>
                <a:cxn ang="0">
                  <a:pos x="connsiteX234" y="connsiteY234"/>
                </a:cxn>
                <a:cxn ang="0">
                  <a:pos x="connsiteX235" y="connsiteY235"/>
                </a:cxn>
                <a:cxn ang="0">
                  <a:pos x="connsiteX236" y="connsiteY236"/>
                </a:cxn>
                <a:cxn ang="0">
                  <a:pos x="connsiteX237" y="connsiteY237"/>
                </a:cxn>
                <a:cxn ang="0">
                  <a:pos x="connsiteX238" y="connsiteY238"/>
                </a:cxn>
                <a:cxn ang="0">
                  <a:pos x="connsiteX239" y="connsiteY239"/>
                </a:cxn>
                <a:cxn ang="0">
                  <a:pos x="connsiteX240" y="connsiteY240"/>
                </a:cxn>
                <a:cxn ang="0">
                  <a:pos x="connsiteX241" y="connsiteY241"/>
                </a:cxn>
                <a:cxn ang="0">
                  <a:pos x="connsiteX242" y="connsiteY242"/>
                </a:cxn>
                <a:cxn ang="0">
                  <a:pos x="connsiteX243" y="connsiteY243"/>
                </a:cxn>
                <a:cxn ang="0">
                  <a:pos x="connsiteX244" y="connsiteY244"/>
                </a:cxn>
                <a:cxn ang="0">
                  <a:pos x="connsiteX245" y="connsiteY245"/>
                </a:cxn>
                <a:cxn ang="0">
                  <a:pos x="connsiteX246" y="connsiteY246"/>
                </a:cxn>
                <a:cxn ang="0">
                  <a:pos x="connsiteX247" y="connsiteY247"/>
                </a:cxn>
                <a:cxn ang="0">
                  <a:pos x="connsiteX248" y="connsiteY248"/>
                </a:cxn>
                <a:cxn ang="0">
                  <a:pos x="connsiteX249" y="connsiteY249"/>
                </a:cxn>
                <a:cxn ang="0">
                  <a:pos x="connsiteX250" y="connsiteY250"/>
                </a:cxn>
                <a:cxn ang="0">
                  <a:pos x="connsiteX251" y="connsiteY251"/>
                </a:cxn>
                <a:cxn ang="0">
                  <a:pos x="connsiteX252" y="connsiteY252"/>
                </a:cxn>
                <a:cxn ang="0">
                  <a:pos x="connsiteX253" y="connsiteY253"/>
                </a:cxn>
                <a:cxn ang="0">
                  <a:pos x="connsiteX254" y="connsiteY254"/>
                </a:cxn>
                <a:cxn ang="0">
                  <a:pos x="connsiteX255" y="connsiteY255"/>
                </a:cxn>
                <a:cxn ang="0">
                  <a:pos x="connsiteX256" y="connsiteY256"/>
                </a:cxn>
                <a:cxn ang="0">
                  <a:pos x="connsiteX257" y="connsiteY257"/>
                </a:cxn>
                <a:cxn ang="0">
                  <a:pos x="connsiteX258" y="connsiteY258"/>
                </a:cxn>
                <a:cxn ang="0">
                  <a:pos x="connsiteX259" y="connsiteY259"/>
                </a:cxn>
                <a:cxn ang="0">
                  <a:pos x="connsiteX260" y="connsiteY260"/>
                </a:cxn>
                <a:cxn ang="0">
                  <a:pos x="connsiteX261" y="connsiteY261"/>
                </a:cxn>
                <a:cxn ang="0">
                  <a:pos x="connsiteX262" y="connsiteY262"/>
                </a:cxn>
                <a:cxn ang="0">
                  <a:pos x="connsiteX263" y="connsiteY263"/>
                </a:cxn>
                <a:cxn ang="0">
                  <a:pos x="connsiteX264" y="connsiteY264"/>
                </a:cxn>
                <a:cxn ang="0">
                  <a:pos x="connsiteX265" y="connsiteY265"/>
                </a:cxn>
                <a:cxn ang="0">
                  <a:pos x="connsiteX266" y="connsiteY266"/>
                </a:cxn>
                <a:cxn ang="0">
                  <a:pos x="connsiteX267" y="connsiteY267"/>
                </a:cxn>
                <a:cxn ang="0">
                  <a:pos x="connsiteX268" y="connsiteY268"/>
                </a:cxn>
                <a:cxn ang="0">
                  <a:pos x="connsiteX269" y="connsiteY269"/>
                </a:cxn>
                <a:cxn ang="0">
                  <a:pos x="connsiteX270" y="connsiteY270"/>
                </a:cxn>
                <a:cxn ang="0">
                  <a:pos x="connsiteX271" y="connsiteY271"/>
                </a:cxn>
                <a:cxn ang="0">
                  <a:pos x="connsiteX272" y="connsiteY272"/>
                </a:cxn>
                <a:cxn ang="0">
                  <a:pos x="connsiteX273" y="connsiteY273"/>
                </a:cxn>
                <a:cxn ang="0">
                  <a:pos x="connsiteX274" y="connsiteY274"/>
                </a:cxn>
                <a:cxn ang="0">
                  <a:pos x="connsiteX275" y="connsiteY275"/>
                </a:cxn>
                <a:cxn ang="0">
                  <a:pos x="connsiteX276" y="connsiteY276"/>
                </a:cxn>
                <a:cxn ang="0">
                  <a:pos x="connsiteX277" y="connsiteY277"/>
                </a:cxn>
                <a:cxn ang="0">
                  <a:pos x="connsiteX278" y="connsiteY278"/>
                </a:cxn>
                <a:cxn ang="0">
                  <a:pos x="connsiteX279" y="connsiteY279"/>
                </a:cxn>
                <a:cxn ang="0">
                  <a:pos x="connsiteX280" y="connsiteY280"/>
                </a:cxn>
                <a:cxn ang="0">
                  <a:pos x="connsiteX281" y="connsiteY281"/>
                </a:cxn>
                <a:cxn ang="0">
                  <a:pos x="connsiteX282" y="connsiteY282"/>
                </a:cxn>
                <a:cxn ang="0">
                  <a:pos x="connsiteX283" y="connsiteY283"/>
                </a:cxn>
                <a:cxn ang="0">
                  <a:pos x="connsiteX284" y="connsiteY284"/>
                </a:cxn>
                <a:cxn ang="0">
                  <a:pos x="connsiteX285" y="connsiteY285"/>
                </a:cxn>
                <a:cxn ang="0">
                  <a:pos x="connsiteX286" y="connsiteY286"/>
                </a:cxn>
                <a:cxn ang="0">
                  <a:pos x="connsiteX287" y="connsiteY287"/>
                </a:cxn>
                <a:cxn ang="0">
                  <a:pos x="connsiteX288" y="connsiteY288"/>
                </a:cxn>
                <a:cxn ang="0">
                  <a:pos x="connsiteX289" y="connsiteY289"/>
                </a:cxn>
                <a:cxn ang="0">
                  <a:pos x="connsiteX290" y="connsiteY290"/>
                </a:cxn>
                <a:cxn ang="0">
                  <a:pos x="connsiteX291" y="connsiteY291"/>
                </a:cxn>
                <a:cxn ang="0">
                  <a:pos x="connsiteX292" y="connsiteY292"/>
                </a:cxn>
                <a:cxn ang="0">
                  <a:pos x="connsiteX293" y="connsiteY293"/>
                </a:cxn>
                <a:cxn ang="0">
                  <a:pos x="connsiteX294" y="connsiteY294"/>
                </a:cxn>
                <a:cxn ang="0">
                  <a:pos x="connsiteX295" y="connsiteY295"/>
                </a:cxn>
                <a:cxn ang="0">
                  <a:pos x="connsiteX296" y="connsiteY296"/>
                </a:cxn>
                <a:cxn ang="0">
                  <a:pos x="connsiteX297" y="connsiteY297"/>
                </a:cxn>
                <a:cxn ang="0">
                  <a:pos x="connsiteX298" y="connsiteY298"/>
                </a:cxn>
                <a:cxn ang="0">
                  <a:pos x="connsiteX299" y="connsiteY299"/>
                </a:cxn>
                <a:cxn ang="0">
                  <a:pos x="connsiteX300" y="connsiteY300"/>
                </a:cxn>
                <a:cxn ang="0">
                  <a:pos x="connsiteX301" y="connsiteY301"/>
                </a:cxn>
                <a:cxn ang="0">
                  <a:pos x="connsiteX302" y="connsiteY302"/>
                </a:cxn>
                <a:cxn ang="0">
                  <a:pos x="connsiteX303" y="connsiteY303"/>
                </a:cxn>
                <a:cxn ang="0">
                  <a:pos x="connsiteX304" y="connsiteY304"/>
                </a:cxn>
                <a:cxn ang="0">
                  <a:pos x="connsiteX305" y="connsiteY305"/>
                </a:cxn>
                <a:cxn ang="0">
                  <a:pos x="connsiteX306" y="connsiteY306"/>
                </a:cxn>
                <a:cxn ang="0">
                  <a:pos x="connsiteX307" y="connsiteY307"/>
                </a:cxn>
                <a:cxn ang="0">
                  <a:pos x="connsiteX308" y="connsiteY308"/>
                </a:cxn>
                <a:cxn ang="0">
                  <a:pos x="connsiteX309" y="connsiteY309"/>
                </a:cxn>
                <a:cxn ang="0">
                  <a:pos x="connsiteX310" y="connsiteY310"/>
                </a:cxn>
                <a:cxn ang="0">
                  <a:pos x="connsiteX311" y="connsiteY311"/>
                </a:cxn>
                <a:cxn ang="0">
                  <a:pos x="connsiteX312" y="connsiteY312"/>
                </a:cxn>
                <a:cxn ang="0">
                  <a:pos x="connsiteX313" y="connsiteY313"/>
                </a:cxn>
                <a:cxn ang="0">
                  <a:pos x="connsiteX314" y="connsiteY314"/>
                </a:cxn>
                <a:cxn ang="0">
                  <a:pos x="connsiteX315" y="connsiteY315"/>
                </a:cxn>
                <a:cxn ang="0">
                  <a:pos x="connsiteX316" y="connsiteY316"/>
                </a:cxn>
                <a:cxn ang="0">
                  <a:pos x="connsiteX317" y="connsiteY317"/>
                </a:cxn>
                <a:cxn ang="0">
                  <a:pos x="connsiteX318" y="connsiteY318"/>
                </a:cxn>
                <a:cxn ang="0">
                  <a:pos x="connsiteX319" y="connsiteY319"/>
                </a:cxn>
                <a:cxn ang="0">
                  <a:pos x="connsiteX320" y="connsiteY320"/>
                </a:cxn>
                <a:cxn ang="0">
                  <a:pos x="connsiteX321" y="connsiteY321"/>
                </a:cxn>
                <a:cxn ang="0">
                  <a:pos x="connsiteX322" y="connsiteY322"/>
                </a:cxn>
                <a:cxn ang="0">
                  <a:pos x="connsiteX323" y="connsiteY323"/>
                </a:cxn>
                <a:cxn ang="0">
                  <a:pos x="connsiteX324" y="connsiteY324"/>
                </a:cxn>
                <a:cxn ang="0">
                  <a:pos x="connsiteX325" y="connsiteY325"/>
                </a:cxn>
                <a:cxn ang="0">
                  <a:pos x="connsiteX326" y="connsiteY326"/>
                </a:cxn>
                <a:cxn ang="0">
                  <a:pos x="connsiteX327" y="connsiteY327"/>
                </a:cxn>
                <a:cxn ang="0">
                  <a:pos x="connsiteX328" y="connsiteY328"/>
                </a:cxn>
                <a:cxn ang="0">
                  <a:pos x="connsiteX329" y="connsiteY329"/>
                </a:cxn>
                <a:cxn ang="0">
                  <a:pos x="connsiteX330" y="connsiteY330"/>
                </a:cxn>
                <a:cxn ang="0">
                  <a:pos x="connsiteX331" y="connsiteY331"/>
                </a:cxn>
                <a:cxn ang="0">
                  <a:pos x="connsiteX332" y="connsiteY332"/>
                </a:cxn>
                <a:cxn ang="0">
                  <a:pos x="connsiteX333" y="connsiteY333"/>
                </a:cxn>
                <a:cxn ang="0">
                  <a:pos x="connsiteX334" y="connsiteY334"/>
                </a:cxn>
                <a:cxn ang="0">
                  <a:pos x="connsiteX335" y="connsiteY335"/>
                </a:cxn>
                <a:cxn ang="0">
                  <a:pos x="connsiteX336" y="connsiteY336"/>
                </a:cxn>
                <a:cxn ang="0">
                  <a:pos x="connsiteX337" y="connsiteY337"/>
                </a:cxn>
                <a:cxn ang="0">
                  <a:pos x="connsiteX338" y="connsiteY338"/>
                </a:cxn>
                <a:cxn ang="0">
                  <a:pos x="connsiteX339" y="connsiteY339"/>
                </a:cxn>
                <a:cxn ang="0">
                  <a:pos x="connsiteX340" y="connsiteY340"/>
                </a:cxn>
                <a:cxn ang="0">
                  <a:pos x="connsiteX341" y="connsiteY341"/>
                </a:cxn>
                <a:cxn ang="0">
                  <a:pos x="connsiteX342" y="connsiteY342"/>
                </a:cxn>
                <a:cxn ang="0">
                  <a:pos x="connsiteX343" y="connsiteY343"/>
                </a:cxn>
                <a:cxn ang="0">
                  <a:pos x="connsiteX344" y="connsiteY344"/>
                </a:cxn>
                <a:cxn ang="0">
                  <a:pos x="connsiteX345" y="connsiteY345"/>
                </a:cxn>
                <a:cxn ang="0">
                  <a:pos x="connsiteX346" y="connsiteY346"/>
                </a:cxn>
                <a:cxn ang="0">
                  <a:pos x="connsiteX347" y="connsiteY347"/>
                </a:cxn>
                <a:cxn ang="0">
                  <a:pos x="connsiteX348" y="connsiteY348"/>
                </a:cxn>
                <a:cxn ang="0">
                  <a:pos x="connsiteX349" y="connsiteY349"/>
                </a:cxn>
                <a:cxn ang="0">
                  <a:pos x="connsiteX350" y="connsiteY350"/>
                </a:cxn>
                <a:cxn ang="0">
                  <a:pos x="connsiteX351" y="connsiteY351"/>
                </a:cxn>
                <a:cxn ang="0">
                  <a:pos x="connsiteX352" y="connsiteY352"/>
                </a:cxn>
                <a:cxn ang="0">
                  <a:pos x="connsiteX353" y="connsiteY353"/>
                </a:cxn>
                <a:cxn ang="0">
                  <a:pos x="connsiteX354" y="connsiteY354"/>
                </a:cxn>
                <a:cxn ang="0">
                  <a:pos x="connsiteX355" y="connsiteY355"/>
                </a:cxn>
                <a:cxn ang="0">
                  <a:pos x="connsiteX356" y="connsiteY356"/>
                </a:cxn>
                <a:cxn ang="0">
                  <a:pos x="connsiteX357" y="connsiteY357"/>
                </a:cxn>
                <a:cxn ang="0">
                  <a:pos x="connsiteX358" y="connsiteY358"/>
                </a:cxn>
                <a:cxn ang="0">
                  <a:pos x="connsiteX359" y="connsiteY359"/>
                </a:cxn>
                <a:cxn ang="0">
                  <a:pos x="connsiteX360" y="connsiteY360"/>
                </a:cxn>
                <a:cxn ang="0">
                  <a:pos x="connsiteX361" y="connsiteY361"/>
                </a:cxn>
                <a:cxn ang="0">
                  <a:pos x="connsiteX362" y="connsiteY362"/>
                </a:cxn>
                <a:cxn ang="0">
                  <a:pos x="connsiteX363" y="connsiteY363"/>
                </a:cxn>
                <a:cxn ang="0">
                  <a:pos x="connsiteX364" y="connsiteY364"/>
                </a:cxn>
                <a:cxn ang="0">
                  <a:pos x="connsiteX365" y="connsiteY365"/>
                </a:cxn>
                <a:cxn ang="0">
                  <a:pos x="connsiteX366" y="connsiteY366"/>
                </a:cxn>
                <a:cxn ang="0">
                  <a:pos x="connsiteX367" y="connsiteY367"/>
                </a:cxn>
                <a:cxn ang="0">
                  <a:pos x="connsiteX368" y="connsiteY368"/>
                </a:cxn>
                <a:cxn ang="0">
                  <a:pos x="connsiteX369" y="connsiteY369"/>
                </a:cxn>
                <a:cxn ang="0">
                  <a:pos x="connsiteX370" y="connsiteY370"/>
                </a:cxn>
                <a:cxn ang="0">
                  <a:pos x="connsiteX371" y="connsiteY371"/>
                </a:cxn>
                <a:cxn ang="0">
                  <a:pos x="connsiteX372" y="connsiteY372"/>
                </a:cxn>
                <a:cxn ang="0">
                  <a:pos x="connsiteX373" y="connsiteY373"/>
                </a:cxn>
                <a:cxn ang="0">
                  <a:pos x="connsiteX374" y="connsiteY374"/>
                </a:cxn>
                <a:cxn ang="0">
                  <a:pos x="connsiteX375" y="connsiteY375"/>
                </a:cxn>
                <a:cxn ang="0">
                  <a:pos x="connsiteX376" y="connsiteY376"/>
                </a:cxn>
                <a:cxn ang="0">
                  <a:pos x="connsiteX377" y="connsiteY377"/>
                </a:cxn>
                <a:cxn ang="0">
                  <a:pos x="connsiteX378" y="connsiteY378"/>
                </a:cxn>
                <a:cxn ang="0">
                  <a:pos x="connsiteX379" y="connsiteY379"/>
                </a:cxn>
                <a:cxn ang="0">
                  <a:pos x="connsiteX380" y="connsiteY380"/>
                </a:cxn>
                <a:cxn ang="0">
                  <a:pos x="connsiteX381" y="connsiteY381"/>
                </a:cxn>
                <a:cxn ang="0">
                  <a:pos x="connsiteX382" y="connsiteY382"/>
                </a:cxn>
                <a:cxn ang="0">
                  <a:pos x="connsiteX383" y="connsiteY383"/>
                </a:cxn>
                <a:cxn ang="0">
                  <a:pos x="connsiteX384" y="connsiteY384"/>
                </a:cxn>
                <a:cxn ang="0">
                  <a:pos x="connsiteX385" y="connsiteY385"/>
                </a:cxn>
                <a:cxn ang="0">
                  <a:pos x="connsiteX386" y="connsiteY386"/>
                </a:cxn>
                <a:cxn ang="0">
                  <a:pos x="connsiteX387" y="connsiteY387"/>
                </a:cxn>
                <a:cxn ang="0">
                  <a:pos x="connsiteX388" y="connsiteY388"/>
                </a:cxn>
                <a:cxn ang="0">
                  <a:pos x="connsiteX389" y="connsiteY389"/>
                </a:cxn>
                <a:cxn ang="0">
                  <a:pos x="connsiteX390" y="connsiteY390"/>
                </a:cxn>
                <a:cxn ang="0">
                  <a:pos x="connsiteX391" y="connsiteY391"/>
                </a:cxn>
                <a:cxn ang="0">
                  <a:pos x="connsiteX392" y="connsiteY392"/>
                </a:cxn>
                <a:cxn ang="0">
                  <a:pos x="connsiteX393" y="connsiteY393"/>
                </a:cxn>
                <a:cxn ang="0">
                  <a:pos x="connsiteX394" y="connsiteY394"/>
                </a:cxn>
                <a:cxn ang="0">
                  <a:pos x="connsiteX395" y="connsiteY395"/>
                </a:cxn>
                <a:cxn ang="0">
                  <a:pos x="connsiteX396" y="connsiteY396"/>
                </a:cxn>
                <a:cxn ang="0">
                  <a:pos x="connsiteX397" y="connsiteY397"/>
                </a:cxn>
                <a:cxn ang="0">
                  <a:pos x="connsiteX398" y="connsiteY398"/>
                </a:cxn>
                <a:cxn ang="0">
                  <a:pos x="connsiteX399" y="connsiteY399"/>
                </a:cxn>
                <a:cxn ang="0">
                  <a:pos x="connsiteX400" y="connsiteY400"/>
                </a:cxn>
                <a:cxn ang="0">
                  <a:pos x="connsiteX401" y="connsiteY401"/>
                </a:cxn>
                <a:cxn ang="0">
                  <a:pos x="connsiteX402" y="connsiteY402"/>
                </a:cxn>
                <a:cxn ang="0">
                  <a:pos x="connsiteX403" y="connsiteY403"/>
                </a:cxn>
                <a:cxn ang="0">
                  <a:pos x="connsiteX404" y="connsiteY404"/>
                </a:cxn>
                <a:cxn ang="0">
                  <a:pos x="connsiteX405" y="connsiteY405"/>
                </a:cxn>
                <a:cxn ang="0">
                  <a:pos x="connsiteX406" y="connsiteY406"/>
                </a:cxn>
                <a:cxn ang="0">
                  <a:pos x="connsiteX407" y="connsiteY407"/>
                </a:cxn>
                <a:cxn ang="0">
                  <a:pos x="connsiteX408" y="connsiteY408"/>
                </a:cxn>
                <a:cxn ang="0">
                  <a:pos x="connsiteX409" y="connsiteY409"/>
                </a:cxn>
                <a:cxn ang="0">
                  <a:pos x="connsiteX410" y="connsiteY410"/>
                </a:cxn>
                <a:cxn ang="0">
                  <a:pos x="connsiteX411" y="connsiteY411"/>
                </a:cxn>
                <a:cxn ang="0">
                  <a:pos x="connsiteX412" y="connsiteY412"/>
                </a:cxn>
                <a:cxn ang="0">
                  <a:pos x="connsiteX413" y="connsiteY413"/>
                </a:cxn>
                <a:cxn ang="0">
                  <a:pos x="connsiteX414" y="connsiteY414"/>
                </a:cxn>
                <a:cxn ang="0">
                  <a:pos x="connsiteX415" y="connsiteY415"/>
                </a:cxn>
                <a:cxn ang="0">
                  <a:pos x="connsiteX416" y="connsiteY416"/>
                </a:cxn>
                <a:cxn ang="0">
                  <a:pos x="connsiteX417" y="connsiteY417"/>
                </a:cxn>
                <a:cxn ang="0">
                  <a:pos x="connsiteX418" y="connsiteY418"/>
                </a:cxn>
                <a:cxn ang="0">
                  <a:pos x="connsiteX419" y="connsiteY419"/>
                </a:cxn>
                <a:cxn ang="0">
                  <a:pos x="connsiteX420" y="connsiteY420"/>
                </a:cxn>
                <a:cxn ang="0">
                  <a:pos x="connsiteX421" y="connsiteY421"/>
                </a:cxn>
                <a:cxn ang="0">
                  <a:pos x="connsiteX422" y="connsiteY422"/>
                </a:cxn>
                <a:cxn ang="0">
                  <a:pos x="connsiteX423" y="connsiteY423"/>
                </a:cxn>
                <a:cxn ang="0">
                  <a:pos x="connsiteX424" y="connsiteY424"/>
                </a:cxn>
                <a:cxn ang="0">
                  <a:pos x="connsiteX425" y="connsiteY425"/>
                </a:cxn>
                <a:cxn ang="0">
                  <a:pos x="connsiteX426" y="connsiteY426"/>
                </a:cxn>
                <a:cxn ang="0">
                  <a:pos x="connsiteX427" y="connsiteY427"/>
                </a:cxn>
                <a:cxn ang="0">
                  <a:pos x="connsiteX428" y="connsiteY428"/>
                </a:cxn>
                <a:cxn ang="0">
                  <a:pos x="connsiteX429" y="connsiteY429"/>
                </a:cxn>
                <a:cxn ang="0">
                  <a:pos x="connsiteX430" y="connsiteY430"/>
                </a:cxn>
                <a:cxn ang="0">
                  <a:pos x="connsiteX431" y="connsiteY431"/>
                </a:cxn>
                <a:cxn ang="0">
                  <a:pos x="connsiteX432" y="connsiteY432"/>
                </a:cxn>
                <a:cxn ang="0">
                  <a:pos x="connsiteX433" y="connsiteY433"/>
                </a:cxn>
                <a:cxn ang="0">
                  <a:pos x="connsiteX434" y="connsiteY434"/>
                </a:cxn>
                <a:cxn ang="0">
                  <a:pos x="connsiteX435" y="connsiteY435"/>
                </a:cxn>
                <a:cxn ang="0">
                  <a:pos x="connsiteX436" y="connsiteY436"/>
                </a:cxn>
                <a:cxn ang="0">
                  <a:pos x="connsiteX437" y="connsiteY437"/>
                </a:cxn>
                <a:cxn ang="0">
                  <a:pos x="connsiteX438" y="connsiteY438"/>
                </a:cxn>
                <a:cxn ang="0">
                  <a:pos x="connsiteX439" y="connsiteY439"/>
                </a:cxn>
                <a:cxn ang="0">
                  <a:pos x="connsiteX440" y="connsiteY440"/>
                </a:cxn>
                <a:cxn ang="0">
                  <a:pos x="connsiteX441" y="connsiteY441"/>
                </a:cxn>
                <a:cxn ang="0">
                  <a:pos x="connsiteX442" y="connsiteY442"/>
                </a:cxn>
                <a:cxn ang="0">
                  <a:pos x="connsiteX443" y="connsiteY443"/>
                </a:cxn>
                <a:cxn ang="0">
                  <a:pos x="connsiteX444" y="connsiteY444"/>
                </a:cxn>
                <a:cxn ang="0">
                  <a:pos x="connsiteX445" y="connsiteY445"/>
                </a:cxn>
                <a:cxn ang="0">
                  <a:pos x="connsiteX446" y="connsiteY446"/>
                </a:cxn>
                <a:cxn ang="0">
                  <a:pos x="connsiteX447" y="connsiteY447"/>
                </a:cxn>
                <a:cxn ang="0">
                  <a:pos x="connsiteX448" y="connsiteY448"/>
                </a:cxn>
                <a:cxn ang="0">
                  <a:pos x="connsiteX449" y="connsiteY449"/>
                </a:cxn>
                <a:cxn ang="0">
                  <a:pos x="connsiteX450" y="connsiteY450"/>
                </a:cxn>
                <a:cxn ang="0">
                  <a:pos x="connsiteX451" y="connsiteY451"/>
                </a:cxn>
                <a:cxn ang="0">
                  <a:pos x="connsiteX452" y="connsiteY452"/>
                </a:cxn>
                <a:cxn ang="0">
                  <a:pos x="connsiteX453" y="connsiteY453"/>
                </a:cxn>
                <a:cxn ang="0">
                  <a:pos x="connsiteX454" y="connsiteY454"/>
                </a:cxn>
                <a:cxn ang="0">
                  <a:pos x="connsiteX455" y="connsiteY455"/>
                </a:cxn>
                <a:cxn ang="0">
                  <a:pos x="connsiteX456" y="connsiteY456"/>
                </a:cxn>
                <a:cxn ang="0">
                  <a:pos x="connsiteX457" y="connsiteY457"/>
                </a:cxn>
                <a:cxn ang="0">
                  <a:pos x="connsiteX458" y="connsiteY458"/>
                </a:cxn>
                <a:cxn ang="0">
                  <a:pos x="connsiteX459" y="connsiteY459"/>
                </a:cxn>
                <a:cxn ang="0">
                  <a:pos x="connsiteX460" y="connsiteY460"/>
                </a:cxn>
                <a:cxn ang="0">
                  <a:pos x="connsiteX461" y="connsiteY461"/>
                </a:cxn>
                <a:cxn ang="0">
                  <a:pos x="connsiteX462" y="connsiteY462"/>
                </a:cxn>
                <a:cxn ang="0">
                  <a:pos x="connsiteX463" y="connsiteY463"/>
                </a:cxn>
                <a:cxn ang="0">
                  <a:pos x="connsiteX464" y="connsiteY464"/>
                </a:cxn>
                <a:cxn ang="0">
                  <a:pos x="connsiteX465" y="connsiteY465"/>
                </a:cxn>
                <a:cxn ang="0">
                  <a:pos x="connsiteX466" y="connsiteY466"/>
                </a:cxn>
                <a:cxn ang="0">
                  <a:pos x="connsiteX467" y="connsiteY467"/>
                </a:cxn>
                <a:cxn ang="0">
                  <a:pos x="connsiteX468" y="connsiteY468"/>
                </a:cxn>
                <a:cxn ang="0">
                  <a:pos x="connsiteX469" y="connsiteY469"/>
                </a:cxn>
                <a:cxn ang="0">
                  <a:pos x="connsiteX470" y="connsiteY470"/>
                </a:cxn>
                <a:cxn ang="0">
                  <a:pos x="connsiteX471" y="connsiteY471"/>
                </a:cxn>
                <a:cxn ang="0">
                  <a:pos x="connsiteX472" y="connsiteY472"/>
                </a:cxn>
                <a:cxn ang="0">
                  <a:pos x="connsiteX473" y="connsiteY473"/>
                </a:cxn>
                <a:cxn ang="0">
                  <a:pos x="connsiteX474" y="connsiteY474"/>
                </a:cxn>
                <a:cxn ang="0">
                  <a:pos x="connsiteX475" y="connsiteY475"/>
                </a:cxn>
                <a:cxn ang="0">
                  <a:pos x="connsiteX476" y="connsiteY476"/>
                </a:cxn>
                <a:cxn ang="0">
                  <a:pos x="connsiteX477" y="connsiteY477"/>
                </a:cxn>
                <a:cxn ang="0">
                  <a:pos x="connsiteX478" y="connsiteY478"/>
                </a:cxn>
                <a:cxn ang="0">
                  <a:pos x="connsiteX479" y="connsiteY479"/>
                </a:cxn>
                <a:cxn ang="0">
                  <a:pos x="connsiteX480" y="connsiteY480"/>
                </a:cxn>
                <a:cxn ang="0">
                  <a:pos x="connsiteX481" y="connsiteY481"/>
                </a:cxn>
                <a:cxn ang="0">
                  <a:pos x="connsiteX482" y="connsiteY482"/>
                </a:cxn>
                <a:cxn ang="0">
                  <a:pos x="connsiteX483" y="connsiteY483"/>
                </a:cxn>
                <a:cxn ang="0">
                  <a:pos x="connsiteX484" y="connsiteY484"/>
                </a:cxn>
                <a:cxn ang="0">
                  <a:pos x="connsiteX485" y="connsiteY485"/>
                </a:cxn>
                <a:cxn ang="0">
                  <a:pos x="connsiteX486" y="connsiteY486"/>
                </a:cxn>
                <a:cxn ang="0">
                  <a:pos x="connsiteX487" y="connsiteY487"/>
                </a:cxn>
                <a:cxn ang="0">
                  <a:pos x="connsiteX488" y="connsiteY488"/>
                </a:cxn>
                <a:cxn ang="0">
                  <a:pos x="connsiteX489" y="connsiteY489"/>
                </a:cxn>
                <a:cxn ang="0">
                  <a:pos x="connsiteX490" y="connsiteY490"/>
                </a:cxn>
                <a:cxn ang="0">
                  <a:pos x="connsiteX491" y="connsiteY491"/>
                </a:cxn>
                <a:cxn ang="0">
                  <a:pos x="connsiteX492" y="connsiteY492"/>
                </a:cxn>
                <a:cxn ang="0">
                  <a:pos x="connsiteX493" y="connsiteY493"/>
                </a:cxn>
                <a:cxn ang="0">
                  <a:pos x="connsiteX494" y="connsiteY494"/>
                </a:cxn>
                <a:cxn ang="0">
                  <a:pos x="connsiteX495" y="connsiteY495"/>
                </a:cxn>
                <a:cxn ang="0">
                  <a:pos x="connsiteX496" y="connsiteY496"/>
                </a:cxn>
                <a:cxn ang="0">
                  <a:pos x="connsiteX497" y="connsiteY497"/>
                </a:cxn>
                <a:cxn ang="0">
                  <a:pos x="connsiteX498" y="connsiteY498"/>
                </a:cxn>
                <a:cxn ang="0">
                  <a:pos x="connsiteX499" y="connsiteY499"/>
                </a:cxn>
                <a:cxn ang="0">
                  <a:pos x="connsiteX500" y="connsiteY500"/>
                </a:cxn>
                <a:cxn ang="0">
                  <a:pos x="connsiteX501" y="connsiteY501"/>
                </a:cxn>
                <a:cxn ang="0">
                  <a:pos x="connsiteX502" y="connsiteY502"/>
                </a:cxn>
                <a:cxn ang="0">
                  <a:pos x="connsiteX503" y="connsiteY503"/>
                </a:cxn>
                <a:cxn ang="0">
                  <a:pos x="connsiteX504" y="connsiteY504"/>
                </a:cxn>
                <a:cxn ang="0">
                  <a:pos x="connsiteX505" y="connsiteY505"/>
                </a:cxn>
                <a:cxn ang="0">
                  <a:pos x="connsiteX506" y="connsiteY506"/>
                </a:cxn>
                <a:cxn ang="0">
                  <a:pos x="connsiteX507" y="connsiteY507"/>
                </a:cxn>
                <a:cxn ang="0">
                  <a:pos x="connsiteX508" y="connsiteY508"/>
                </a:cxn>
                <a:cxn ang="0">
                  <a:pos x="connsiteX509" y="connsiteY509"/>
                </a:cxn>
                <a:cxn ang="0">
                  <a:pos x="connsiteX510" y="connsiteY510"/>
                </a:cxn>
                <a:cxn ang="0">
                  <a:pos x="connsiteX511" y="connsiteY511"/>
                </a:cxn>
                <a:cxn ang="0">
                  <a:pos x="connsiteX512" y="connsiteY512"/>
                </a:cxn>
                <a:cxn ang="0">
                  <a:pos x="connsiteX513" y="connsiteY513"/>
                </a:cxn>
                <a:cxn ang="0">
                  <a:pos x="connsiteX514" y="connsiteY514"/>
                </a:cxn>
                <a:cxn ang="0">
                  <a:pos x="connsiteX515" y="connsiteY515"/>
                </a:cxn>
                <a:cxn ang="0">
                  <a:pos x="connsiteX516" y="connsiteY516"/>
                </a:cxn>
                <a:cxn ang="0">
                  <a:pos x="connsiteX517" y="connsiteY517"/>
                </a:cxn>
                <a:cxn ang="0">
                  <a:pos x="connsiteX518" y="connsiteY518"/>
                </a:cxn>
                <a:cxn ang="0">
                  <a:pos x="connsiteX519" y="connsiteY519"/>
                </a:cxn>
                <a:cxn ang="0">
                  <a:pos x="connsiteX520" y="connsiteY520"/>
                </a:cxn>
                <a:cxn ang="0">
                  <a:pos x="connsiteX521" y="connsiteY521"/>
                </a:cxn>
                <a:cxn ang="0">
                  <a:pos x="connsiteX522" y="connsiteY522"/>
                </a:cxn>
                <a:cxn ang="0">
                  <a:pos x="connsiteX523" y="connsiteY523"/>
                </a:cxn>
                <a:cxn ang="0">
                  <a:pos x="connsiteX524" y="connsiteY524"/>
                </a:cxn>
                <a:cxn ang="0">
                  <a:pos x="connsiteX525" y="connsiteY525"/>
                </a:cxn>
                <a:cxn ang="0">
                  <a:pos x="connsiteX526" y="connsiteY526"/>
                </a:cxn>
                <a:cxn ang="0">
                  <a:pos x="connsiteX527" y="connsiteY527"/>
                </a:cxn>
                <a:cxn ang="0">
                  <a:pos x="connsiteX528" y="connsiteY528"/>
                </a:cxn>
                <a:cxn ang="0">
                  <a:pos x="connsiteX529" y="connsiteY529"/>
                </a:cxn>
                <a:cxn ang="0">
                  <a:pos x="connsiteX530" y="connsiteY530"/>
                </a:cxn>
                <a:cxn ang="0">
                  <a:pos x="connsiteX531" y="connsiteY531"/>
                </a:cxn>
                <a:cxn ang="0">
                  <a:pos x="connsiteX532" y="connsiteY532"/>
                </a:cxn>
                <a:cxn ang="0">
                  <a:pos x="connsiteX533" y="connsiteY533"/>
                </a:cxn>
                <a:cxn ang="0">
                  <a:pos x="connsiteX534" y="connsiteY534"/>
                </a:cxn>
                <a:cxn ang="0">
                  <a:pos x="connsiteX535" y="connsiteY535"/>
                </a:cxn>
                <a:cxn ang="0">
                  <a:pos x="connsiteX536" y="connsiteY536"/>
                </a:cxn>
                <a:cxn ang="0">
                  <a:pos x="connsiteX537" y="connsiteY537"/>
                </a:cxn>
                <a:cxn ang="0">
                  <a:pos x="connsiteX538" y="connsiteY538"/>
                </a:cxn>
                <a:cxn ang="0">
                  <a:pos x="connsiteX539" y="connsiteY539"/>
                </a:cxn>
                <a:cxn ang="0">
                  <a:pos x="connsiteX540" y="connsiteY540"/>
                </a:cxn>
                <a:cxn ang="0">
                  <a:pos x="connsiteX541" y="connsiteY541"/>
                </a:cxn>
                <a:cxn ang="0">
                  <a:pos x="connsiteX542" y="connsiteY542"/>
                </a:cxn>
                <a:cxn ang="0">
                  <a:pos x="connsiteX543" y="connsiteY543"/>
                </a:cxn>
                <a:cxn ang="0">
                  <a:pos x="connsiteX544" y="connsiteY544"/>
                </a:cxn>
              </a:cxnLst>
              <a:rect l="l" t="t" r="r" b="b"/>
              <a:pathLst>
                <a:path w="5649501" h="5236589">
                  <a:moveTo>
                    <a:pt x="14140" y="0"/>
                  </a:moveTo>
                  <a:cubicBezTo>
                    <a:pt x="12569" y="7856"/>
                    <a:pt x="11370" y="15795"/>
                    <a:pt x="9427" y="23567"/>
                  </a:cubicBezTo>
                  <a:cubicBezTo>
                    <a:pt x="8222" y="28387"/>
                    <a:pt x="6079" y="32930"/>
                    <a:pt x="4714" y="37707"/>
                  </a:cubicBezTo>
                  <a:cubicBezTo>
                    <a:pt x="2934" y="43936"/>
                    <a:pt x="1571" y="50276"/>
                    <a:pt x="0" y="56560"/>
                  </a:cubicBezTo>
                  <a:cubicBezTo>
                    <a:pt x="3142" y="84841"/>
                    <a:pt x="6165" y="113135"/>
                    <a:pt x="9427" y="141402"/>
                  </a:cubicBezTo>
                  <a:cubicBezTo>
                    <a:pt x="10879" y="153985"/>
                    <a:pt x="11874" y="166647"/>
                    <a:pt x="14140" y="179109"/>
                  </a:cubicBezTo>
                  <a:cubicBezTo>
                    <a:pt x="15902" y="188801"/>
                    <a:pt x="23949" y="204522"/>
                    <a:pt x="28281" y="212103"/>
                  </a:cubicBezTo>
                  <a:cubicBezTo>
                    <a:pt x="31091" y="217021"/>
                    <a:pt x="35174" y="221176"/>
                    <a:pt x="37707" y="226243"/>
                  </a:cubicBezTo>
                  <a:cubicBezTo>
                    <a:pt x="39929" y="230687"/>
                    <a:pt x="40199" y="235939"/>
                    <a:pt x="42421" y="240383"/>
                  </a:cubicBezTo>
                  <a:cubicBezTo>
                    <a:pt x="44955" y="245450"/>
                    <a:pt x="49037" y="249605"/>
                    <a:pt x="51848" y="254523"/>
                  </a:cubicBezTo>
                  <a:cubicBezTo>
                    <a:pt x="55334" y="260624"/>
                    <a:pt x="57789" y="267276"/>
                    <a:pt x="61275" y="273377"/>
                  </a:cubicBezTo>
                  <a:cubicBezTo>
                    <a:pt x="64085" y="278295"/>
                    <a:pt x="68168" y="282450"/>
                    <a:pt x="70701" y="287517"/>
                  </a:cubicBezTo>
                  <a:cubicBezTo>
                    <a:pt x="90214" y="326543"/>
                    <a:pt x="57828" y="275275"/>
                    <a:pt x="84842" y="315798"/>
                  </a:cubicBezTo>
                  <a:cubicBezTo>
                    <a:pt x="90220" y="331932"/>
                    <a:pt x="97457" y="361914"/>
                    <a:pt x="113122" y="372358"/>
                  </a:cubicBezTo>
                  <a:lnTo>
                    <a:pt x="127262" y="381785"/>
                  </a:lnTo>
                  <a:cubicBezTo>
                    <a:pt x="160948" y="432312"/>
                    <a:pt x="108489" y="355628"/>
                    <a:pt x="150829" y="410066"/>
                  </a:cubicBezTo>
                  <a:cubicBezTo>
                    <a:pt x="157785" y="419009"/>
                    <a:pt x="159164" y="434138"/>
                    <a:pt x="169683" y="438346"/>
                  </a:cubicBezTo>
                  <a:cubicBezTo>
                    <a:pt x="198510" y="449877"/>
                    <a:pt x="186210" y="443080"/>
                    <a:pt x="207390" y="457200"/>
                  </a:cubicBezTo>
                  <a:cubicBezTo>
                    <a:pt x="218441" y="490356"/>
                    <a:pt x="204060" y="449431"/>
                    <a:pt x="221530" y="490193"/>
                  </a:cubicBezTo>
                  <a:cubicBezTo>
                    <a:pt x="223487" y="494760"/>
                    <a:pt x="223140" y="500454"/>
                    <a:pt x="226244" y="504334"/>
                  </a:cubicBezTo>
                  <a:cubicBezTo>
                    <a:pt x="229783" y="508757"/>
                    <a:pt x="235671" y="510618"/>
                    <a:pt x="240384" y="513760"/>
                  </a:cubicBezTo>
                  <a:cubicBezTo>
                    <a:pt x="243526" y="523187"/>
                    <a:pt x="248406" y="532204"/>
                    <a:pt x="249811" y="542041"/>
                  </a:cubicBezTo>
                  <a:cubicBezTo>
                    <a:pt x="251382" y="553039"/>
                    <a:pt x="249927" y="564921"/>
                    <a:pt x="254524" y="575035"/>
                  </a:cubicBezTo>
                  <a:cubicBezTo>
                    <a:pt x="258202" y="583126"/>
                    <a:pt x="267826" y="586948"/>
                    <a:pt x="273378" y="593888"/>
                  </a:cubicBezTo>
                  <a:cubicBezTo>
                    <a:pt x="280456" y="602735"/>
                    <a:pt x="292231" y="622169"/>
                    <a:pt x="292231" y="622169"/>
                  </a:cubicBezTo>
                  <a:cubicBezTo>
                    <a:pt x="293802" y="628453"/>
                    <a:pt x="295588" y="634688"/>
                    <a:pt x="296945" y="641022"/>
                  </a:cubicBezTo>
                  <a:cubicBezTo>
                    <a:pt x="300302" y="656689"/>
                    <a:pt x="301304" y="672956"/>
                    <a:pt x="306371" y="688156"/>
                  </a:cubicBezTo>
                  <a:cubicBezTo>
                    <a:pt x="307942" y="692870"/>
                    <a:pt x="307981" y="698417"/>
                    <a:pt x="311085" y="702297"/>
                  </a:cubicBezTo>
                  <a:cubicBezTo>
                    <a:pt x="314624" y="706720"/>
                    <a:pt x="320512" y="708581"/>
                    <a:pt x="325225" y="711723"/>
                  </a:cubicBezTo>
                  <a:cubicBezTo>
                    <a:pt x="329938" y="718008"/>
                    <a:pt x="333330" y="725548"/>
                    <a:pt x="339365" y="730577"/>
                  </a:cubicBezTo>
                  <a:cubicBezTo>
                    <a:pt x="343182" y="733758"/>
                    <a:pt x="349625" y="732186"/>
                    <a:pt x="353505" y="735290"/>
                  </a:cubicBezTo>
                  <a:cubicBezTo>
                    <a:pt x="359056" y="739731"/>
                    <a:pt x="370040" y="763646"/>
                    <a:pt x="372359" y="768284"/>
                  </a:cubicBezTo>
                  <a:cubicBezTo>
                    <a:pt x="378304" y="815847"/>
                    <a:pt x="373067" y="793977"/>
                    <a:pt x="386499" y="834272"/>
                  </a:cubicBezTo>
                  <a:cubicBezTo>
                    <a:pt x="388070" y="838985"/>
                    <a:pt x="388457" y="844278"/>
                    <a:pt x="391213" y="848412"/>
                  </a:cubicBezTo>
                  <a:cubicBezTo>
                    <a:pt x="394355" y="853125"/>
                    <a:pt x="398106" y="857485"/>
                    <a:pt x="400639" y="862552"/>
                  </a:cubicBezTo>
                  <a:cubicBezTo>
                    <a:pt x="420152" y="901578"/>
                    <a:pt x="387766" y="850310"/>
                    <a:pt x="414780" y="890833"/>
                  </a:cubicBezTo>
                  <a:cubicBezTo>
                    <a:pt x="416351" y="897117"/>
                    <a:pt x="416596" y="903892"/>
                    <a:pt x="419493" y="909686"/>
                  </a:cubicBezTo>
                  <a:cubicBezTo>
                    <a:pt x="424560" y="919820"/>
                    <a:pt x="438347" y="937967"/>
                    <a:pt x="438347" y="937967"/>
                  </a:cubicBezTo>
                  <a:cubicBezTo>
                    <a:pt x="439918" y="942680"/>
                    <a:pt x="440647" y="947764"/>
                    <a:pt x="443060" y="952107"/>
                  </a:cubicBezTo>
                  <a:cubicBezTo>
                    <a:pt x="448562" y="962011"/>
                    <a:pt x="461914" y="980387"/>
                    <a:pt x="461914" y="980387"/>
                  </a:cubicBezTo>
                  <a:cubicBezTo>
                    <a:pt x="472197" y="1011237"/>
                    <a:pt x="457915" y="980959"/>
                    <a:pt x="480767" y="999241"/>
                  </a:cubicBezTo>
                  <a:cubicBezTo>
                    <a:pt x="485190" y="1002780"/>
                    <a:pt x="487052" y="1008668"/>
                    <a:pt x="490194" y="1013381"/>
                  </a:cubicBezTo>
                  <a:cubicBezTo>
                    <a:pt x="505473" y="1059219"/>
                    <a:pt x="496586" y="1025972"/>
                    <a:pt x="504334" y="1084082"/>
                  </a:cubicBezTo>
                  <a:cubicBezTo>
                    <a:pt x="504764" y="1087306"/>
                    <a:pt x="510356" y="1124406"/>
                    <a:pt x="513761" y="1131216"/>
                  </a:cubicBezTo>
                  <a:cubicBezTo>
                    <a:pt x="518828" y="1141350"/>
                    <a:pt x="526330" y="1150070"/>
                    <a:pt x="532615" y="1159497"/>
                  </a:cubicBezTo>
                  <a:lnTo>
                    <a:pt x="542042" y="1173637"/>
                  </a:lnTo>
                  <a:cubicBezTo>
                    <a:pt x="545184" y="1178350"/>
                    <a:pt x="547462" y="1183772"/>
                    <a:pt x="551468" y="1187777"/>
                  </a:cubicBezTo>
                  <a:lnTo>
                    <a:pt x="565609" y="1201917"/>
                  </a:lnTo>
                  <a:cubicBezTo>
                    <a:pt x="567180" y="1206630"/>
                    <a:pt x="567857" y="1211743"/>
                    <a:pt x="570322" y="1216057"/>
                  </a:cubicBezTo>
                  <a:cubicBezTo>
                    <a:pt x="586466" y="1244310"/>
                    <a:pt x="580600" y="1225906"/>
                    <a:pt x="598602" y="1249051"/>
                  </a:cubicBezTo>
                  <a:cubicBezTo>
                    <a:pt x="605558" y="1257994"/>
                    <a:pt x="611171" y="1267905"/>
                    <a:pt x="617456" y="1277332"/>
                  </a:cubicBezTo>
                  <a:cubicBezTo>
                    <a:pt x="620598" y="1282045"/>
                    <a:pt x="624350" y="1286405"/>
                    <a:pt x="626883" y="1291472"/>
                  </a:cubicBezTo>
                  <a:cubicBezTo>
                    <a:pt x="634255" y="1306215"/>
                    <a:pt x="636120" y="1314912"/>
                    <a:pt x="650450" y="1324466"/>
                  </a:cubicBezTo>
                  <a:cubicBezTo>
                    <a:pt x="654584" y="1327222"/>
                    <a:pt x="659877" y="1327608"/>
                    <a:pt x="664590" y="1329179"/>
                  </a:cubicBezTo>
                  <a:cubicBezTo>
                    <a:pt x="670875" y="1338606"/>
                    <a:pt x="679862" y="1346711"/>
                    <a:pt x="683444" y="1357459"/>
                  </a:cubicBezTo>
                  <a:cubicBezTo>
                    <a:pt x="685015" y="1362173"/>
                    <a:pt x="686200" y="1367033"/>
                    <a:pt x="688157" y="1371600"/>
                  </a:cubicBezTo>
                  <a:cubicBezTo>
                    <a:pt x="695332" y="1388341"/>
                    <a:pt x="697545" y="1390395"/>
                    <a:pt x="707011" y="1404593"/>
                  </a:cubicBezTo>
                  <a:cubicBezTo>
                    <a:pt x="718063" y="1437753"/>
                    <a:pt x="703680" y="1396821"/>
                    <a:pt x="721151" y="1437587"/>
                  </a:cubicBezTo>
                  <a:cubicBezTo>
                    <a:pt x="732861" y="1464910"/>
                    <a:pt x="717172" y="1438689"/>
                    <a:pt x="735291" y="1465868"/>
                  </a:cubicBezTo>
                  <a:cubicBezTo>
                    <a:pt x="736862" y="1472152"/>
                    <a:pt x="735957" y="1479663"/>
                    <a:pt x="740004" y="1484721"/>
                  </a:cubicBezTo>
                  <a:cubicBezTo>
                    <a:pt x="743108" y="1488601"/>
                    <a:pt x="753389" y="1484524"/>
                    <a:pt x="754145" y="1489435"/>
                  </a:cubicBezTo>
                  <a:cubicBezTo>
                    <a:pt x="757022" y="1508134"/>
                    <a:pt x="751002" y="1527142"/>
                    <a:pt x="749431" y="1545996"/>
                  </a:cubicBezTo>
                  <a:cubicBezTo>
                    <a:pt x="751002" y="1561707"/>
                    <a:pt x="752186" y="1577462"/>
                    <a:pt x="754145" y="1593130"/>
                  </a:cubicBezTo>
                  <a:cubicBezTo>
                    <a:pt x="755330" y="1602613"/>
                    <a:pt x="759360" y="1611867"/>
                    <a:pt x="758858" y="1621410"/>
                  </a:cubicBezTo>
                  <a:cubicBezTo>
                    <a:pt x="758074" y="1636299"/>
                    <a:pt x="751424" y="1679184"/>
                    <a:pt x="744718" y="1701538"/>
                  </a:cubicBezTo>
                  <a:cubicBezTo>
                    <a:pt x="741863" y="1711056"/>
                    <a:pt x="739735" y="1720930"/>
                    <a:pt x="735291" y="1729818"/>
                  </a:cubicBezTo>
                  <a:lnTo>
                    <a:pt x="725864" y="1748672"/>
                  </a:lnTo>
                  <a:cubicBezTo>
                    <a:pt x="729006" y="1827229"/>
                    <a:pt x="731009" y="1905839"/>
                    <a:pt x="735291" y="1984342"/>
                  </a:cubicBezTo>
                  <a:cubicBezTo>
                    <a:pt x="735343" y="1985290"/>
                    <a:pt x="740965" y="2017358"/>
                    <a:pt x="744718" y="2022049"/>
                  </a:cubicBezTo>
                  <a:cubicBezTo>
                    <a:pt x="748257" y="2026472"/>
                    <a:pt x="754145" y="2028334"/>
                    <a:pt x="758858" y="2031476"/>
                  </a:cubicBezTo>
                  <a:cubicBezTo>
                    <a:pt x="763652" y="2050655"/>
                    <a:pt x="762434" y="2051576"/>
                    <a:pt x="772998" y="2069183"/>
                  </a:cubicBezTo>
                  <a:cubicBezTo>
                    <a:pt x="778827" y="2078898"/>
                    <a:pt x="791852" y="2097464"/>
                    <a:pt x="791852" y="2097464"/>
                  </a:cubicBezTo>
                  <a:lnTo>
                    <a:pt x="801279" y="2125744"/>
                  </a:lnTo>
                  <a:cubicBezTo>
                    <a:pt x="802850" y="2130457"/>
                    <a:pt x="804787" y="2135064"/>
                    <a:pt x="805992" y="2139884"/>
                  </a:cubicBezTo>
                  <a:cubicBezTo>
                    <a:pt x="809134" y="2152453"/>
                    <a:pt x="811323" y="2165300"/>
                    <a:pt x="815419" y="2177591"/>
                  </a:cubicBezTo>
                  <a:cubicBezTo>
                    <a:pt x="816990" y="2182305"/>
                    <a:pt x="817910" y="2187288"/>
                    <a:pt x="820132" y="2191732"/>
                  </a:cubicBezTo>
                  <a:cubicBezTo>
                    <a:pt x="822665" y="2196799"/>
                    <a:pt x="826417" y="2201159"/>
                    <a:pt x="829559" y="2205872"/>
                  </a:cubicBezTo>
                  <a:cubicBezTo>
                    <a:pt x="842387" y="2244357"/>
                    <a:pt x="829559" y="2199854"/>
                    <a:pt x="829559" y="2286000"/>
                  </a:cubicBezTo>
                  <a:cubicBezTo>
                    <a:pt x="829559" y="2308052"/>
                    <a:pt x="831963" y="2330056"/>
                    <a:pt x="834272" y="2351987"/>
                  </a:cubicBezTo>
                  <a:cubicBezTo>
                    <a:pt x="835111" y="2359954"/>
                    <a:pt x="837553" y="2367672"/>
                    <a:pt x="838986" y="2375554"/>
                  </a:cubicBezTo>
                  <a:cubicBezTo>
                    <a:pt x="840696" y="2384957"/>
                    <a:pt x="842347" y="2394374"/>
                    <a:pt x="843699" y="2403835"/>
                  </a:cubicBezTo>
                  <a:cubicBezTo>
                    <a:pt x="845490" y="2416375"/>
                    <a:pt x="846739" y="2428986"/>
                    <a:pt x="848413" y="2441542"/>
                  </a:cubicBezTo>
                  <a:cubicBezTo>
                    <a:pt x="849881" y="2452554"/>
                    <a:pt x="852021" y="2463481"/>
                    <a:pt x="853126" y="2474536"/>
                  </a:cubicBezTo>
                  <a:cubicBezTo>
                    <a:pt x="855164" y="2494919"/>
                    <a:pt x="854471" y="2515604"/>
                    <a:pt x="857839" y="2535810"/>
                  </a:cubicBezTo>
                  <a:cubicBezTo>
                    <a:pt x="859230" y="2544156"/>
                    <a:pt x="864590" y="2551350"/>
                    <a:pt x="867266" y="2559377"/>
                  </a:cubicBezTo>
                  <a:cubicBezTo>
                    <a:pt x="869315" y="2565523"/>
                    <a:pt x="869083" y="2572437"/>
                    <a:pt x="871980" y="2578231"/>
                  </a:cubicBezTo>
                  <a:cubicBezTo>
                    <a:pt x="877047" y="2588364"/>
                    <a:pt x="887250" y="2595763"/>
                    <a:pt x="890833" y="2606511"/>
                  </a:cubicBezTo>
                  <a:cubicBezTo>
                    <a:pt x="897339" y="2626025"/>
                    <a:pt x="892791" y="2616517"/>
                    <a:pt x="904973" y="2634791"/>
                  </a:cubicBezTo>
                  <a:cubicBezTo>
                    <a:pt x="898273" y="2674993"/>
                    <a:pt x="885466" y="2697441"/>
                    <a:pt x="909687" y="2733773"/>
                  </a:cubicBezTo>
                  <a:cubicBezTo>
                    <a:pt x="915971" y="2743200"/>
                    <a:pt x="924957" y="2751305"/>
                    <a:pt x="928540" y="2762053"/>
                  </a:cubicBezTo>
                  <a:lnTo>
                    <a:pt x="937967" y="2790334"/>
                  </a:lnTo>
                  <a:cubicBezTo>
                    <a:pt x="941109" y="2812330"/>
                    <a:pt x="940369" y="2835242"/>
                    <a:pt x="947394" y="2856321"/>
                  </a:cubicBezTo>
                  <a:cubicBezTo>
                    <a:pt x="963246" y="2903884"/>
                    <a:pt x="939049" y="2830080"/>
                    <a:pt x="956821" y="2889315"/>
                  </a:cubicBezTo>
                  <a:cubicBezTo>
                    <a:pt x="959677" y="2898833"/>
                    <a:pt x="963106" y="2908169"/>
                    <a:pt x="966248" y="2917596"/>
                  </a:cubicBezTo>
                  <a:cubicBezTo>
                    <a:pt x="977543" y="2951482"/>
                    <a:pt x="963845" y="2909183"/>
                    <a:pt x="975675" y="2950589"/>
                  </a:cubicBezTo>
                  <a:cubicBezTo>
                    <a:pt x="977040" y="2955366"/>
                    <a:pt x="977632" y="2960596"/>
                    <a:pt x="980388" y="2964730"/>
                  </a:cubicBezTo>
                  <a:cubicBezTo>
                    <a:pt x="984085" y="2970276"/>
                    <a:pt x="989815" y="2974157"/>
                    <a:pt x="994528" y="2978870"/>
                  </a:cubicBezTo>
                  <a:cubicBezTo>
                    <a:pt x="997057" y="2991515"/>
                    <a:pt x="1001836" y="3020469"/>
                    <a:pt x="1008668" y="3030717"/>
                  </a:cubicBezTo>
                  <a:lnTo>
                    <a:pt x="1027522" y="3058998"/>
                  </a:lnTo>
                  <a:cubicBezTo>
                    <a:pt x="1037490" y="3098874"/>
                    <a:pt x="1023910" y="3058292"/>
                    <a:pt x="1046376" y="3091991"/>
                  </a:cubicBezTo>
                  <a:cubicBezTo>
                    <a:pt x="1060016" y="3112450"/>
                    <a:pt x="1034935" y="3119601"/>
                    <a:pt x="1079369" y="3134412"/>
                  </a:cubicBezTo>
                  <a:lnTo>
                    <a:pt x="1107650" y="3143839"/>
                  </a:lnTo>
                  <a:cubicBezTo>
                    <a:pt x="1130201" y="3177665"/>
                    <a:pt x="1118492" y="3164108"/>
                    <a:pt x="1140644" y="3186259"/>
                  </a:cubicBezTo>
                  <a:cubicBezTo>
                    <a:pt x="1144478" y="3197761"/>
                    <a:pt x="1145646" y="3205402"/>
                    <a:pt x="1154784" y="3214540"/>
                  </a:cubicBezTo>
                  <a:cubicBezTo>
                    <a:pt x="1158790" y="3218546"/>
                    <a:pt x="1164211" y="3220825"/>
                    <a:pt x="1168924" y="3223967"/>
                  </a:cubicBezTo>
                  <a:cubicBezTo>
                    <a:pt x="1181492" y="3261672"/>
                    <a:pt x="1162640" y="3217683"/>
                    <a:pt x="1187778" y="3242820"/>
                  </a:cubicBezTo>
                  <a:cubicBezTo>
                    <a:pt x="1191291" y="3246333"/>
                    <a:pt x="1189735" y="3252826"/>
                    <a:pt x="1192491" y="3256960"/>
                  </a:cubicBezTo>
                  <a:cubicBezTo>
                    <a:pt x="1202579" y="3272093"/>
                    <a:pt x="1205946" y="3270873"/>
                    <a:pt x="1220771" y="3275814"/>
                  </a:cubicBezTo>
                  <a:cubicBezTo>
                    <a:pt x="1260618" y="3315658"/>
                    <a:pt x="1204290" y="3264562"/>
                    <a:pt x="1258479" y="3294668"/>
                  </a:cubicBezTo>
                  <a:cubicBezTo>
                    <a:pt x="1266248" y="3298984"/>
                    <a:pt x="1270584" y="3307737"/>
                    <a:pt x="1277332" y="3313521"/>
                  </a:cubicBezTo>
                  <a:cubicBezTo>
                    <a:pt x="1281633" y="3317208"/>
                    <a:pt x="1286759" y="3319806"/>
                    <a:pt x="1291472" y="3322948"/>
                  </a:cubicBezTo>
                  <a:cubicBezTo>
                    <a:pt x="1294614" y="3329233"/>
                    <a:pt x="1298432" y="3335223"/>
                    <a:pt x="1300899" y="3341802"/>
                  </a:cubicBezTo>
                  <a:cubicBezTo>
                    <a:pt x="1303174" y="3347867"/>
                    <a:pt x="1302399" y="3355031"/>
                    <a:pt x="1305613" y="3360655"/>
                  </a:cubicBezTo>
                  <a:cubicBezTo>
                    <a:pt x="1308920" y="3366443"/>
                    <a:pt x="1315486" y="3369675"/>
                    <a:pt x="1319753" y="3374796"/>
                  </a:cubicBezTo>
                  <a:cubicBezTo>
                    <a:pt x="1323379" y="3379148"/>
                    <a:pt x="1326038" y="3384223"/>
                    <a:pt x="1329180" y="3388936"/>
                  </a:cubicBezTo>
                  <a:cubicBezTo>
                    <a:pt x="1340487" y="3422859"/>
                    <a:pt x="1326761" y="3380475"/>
                    <a:pt x="1338606" y="3421930"/>
                  </a:cubicBezTo>
                  <a:cubicBezTo>
                    <a:pt x="1339971" y="3426707"/>
                    <a:pt x="1341955" y="3431293"/>
                    <a:pt x="1343320" y="3436070"/>
                  </a:cubicBezTo>
                  <a:cubicBezTo>
                    <a:pt x="1345100" y="3442298"/>
                    <a:pt x="1345481" y="3448969"/>
                    <a:pt x="1348033" y="3454923"/>
                  </a:cubicBezTo>
                  <a:cubicBezTo>
                    <a:pt x="1350265" y="3460130"/>
                    <a:pt x="1354318" y="3464350"/>
                    <a:pt x="1357460" y="3469064"/>
                  </a:cubicBezTo>
                  <a:cubicBezTo>
                    <a:pt x="1360602" y="3478491"/>
                    <a:pt x="1364477" y="3487704"/>
                    <a:pt x="1366887" y="3497344"/>
                  </a:cubicBezTo>
                  <a:cubicBezTo>
                    <a:pt x="1368458" y="3503629"/>
                    <a:pt x="1368703" y="3510404"/>
                    <a:pt x="1371600" y="3516198"/>
                  </a:cubicBezTo>
                  <a:cubicBezTo>
                    <a:pt x="1375113" y="3523224"/>
                    <a:pt x="1381174" y="3528659"/>
                    <a:pt x="1385740" y="3535051"/>
                  </a:cubicBezTo>
                  <a:cubicBezTo>
                    <a:pt x="1389033" y="3539661"/>
                    <a:pt x="1392025" y="3544478"/>
                    <a:pt x="1395167" y="3549191"/>
                  </a:cubicBezTo>
                  <a:cubicBezTo>
                    <a:pt x="1396738" y="3555476"/>
                    <a:pt x="1396288" y="3562655"/>
                    <a:pt x="1399881" y="3568045"/>
                  </a:cubicBezTo>
                  <a:cubicBezTo>
                    <a:pt x="1403023" y="3572758"/>
                    <a:pt x="1411019" y="3572668"/>
                    <a:pt x="1414021" y="3577472"/>
                  </a:cubicBezTo>
                  <a:cubicBezTo>
                    <a:pt x="1419287" y="3585898"/>
                    <a:pt x="1420306" y="3596325"/>
                    <a:pt x="1423448" y="3605752"/>
                  </a:cubicBezTo>
                  <a:cubicBezTo>
                    <a:pt x="1425239" y="3611126"/>
                    <a:pt x="1429733" y="3615179"/>
                    <a:pt x="1432875" y="3619892"/>
                  </a:cubicBezTo>
                  <a:cubicBezTo>
                    <a:pt x="1434446" y="3624606"/>
                    <a:pt x="1436771" y="3629132"/>
                    <a:pt x="1437588" y="3634033"/>
                  </a:cubicBezTo>
                  <a:cubicBezTo>
                    <a:pt x="1439927" y="3648066"/>
                    <a:pt x="1438850" y="3662651"/>
                    <a:pt x="1442301" y="3676453"/>
                  </a:cubicBezTo>
                  <a:cubicBezTo>
                    <a:pt x="1443675" y="3681949"/>
                    <a:pt x="1448586" y="3685880"/>
                    <a:pt x="1451728" y="3690593"/>
                  </a:cubicBezTo>
                  <a:cubicBezTo>
                    <a:pt x="1454870" y="3703162"/>
                    <a:pt x="1459025" y="3715521"/>
                    <a:pt x="1461155" y="3728301"/>
                  </a:cubicBezTo>
                  <a:cubicBezTo>
                    <a:pt x="1462726" y="3737728"/>
                    <a:pt x="1463795" y="3747252"/>
                    <a:pt x="1465868" y="3756581"/>
                  </a:cubicBezTo>
                  <a:cubicBezTo>
                    <a:pt x="1466946" y="3761431"/>
                    <a:pt x="1467069" y="3767208"/>
                    <a:pt x="1470582" y="3770721"/>
                  </a:cubicBezTo>
                  <a:cubicBezTo>
                    <a:pt x="1474095" y="3774234"/>
                    <a:pt x="1480009" y="3773864"/>
                    <a:pt x="1484722" y="3775435"/>
                  </a:cubicBezTo>
                  <a:cubicBezTo>
                    <a:pt x="1494852" y="3805828"/>
                    <a:pt x="1486256" y="3776746"/>
                    <a:pt x="1494149" y="3831996"/>
                  </a:cubicBezTo>
                  <a:cubicBezTo>
                    <a:pt x="1495282" y="3839927"/>
                    <a:pt x="1497429" y="3847681"/>
                    <a:pt x="1498862" y="3855563"/>
                  </a:cubicBezTo>
                  <a:cubicBezTo>
                    <a:pt x="1500572" y="3864966"/>
                    <a:pt x="1501503" y="3874514"/>
                    <a:pt x="1503576" y="3883843"/>
                  </a:cubicBezTo>
                  <a:cubicBezTo>
                    <a:pt x="1504654" y="3888693"/>
                    <a:pt x="1506924" y="3893206"/>
                    <a:pt x="1508289" y="3897983"/>
                  </a:cubicBezTo>
                  <a:cubicBezTo>
                    <a:pt x="1510304" y="3905037"/>
                    <a:pt x="1513946" y="3923438"/>
                    <a:pt x="1517716" y="3930977"/>
                  </a:cubicBezTo>
                  <a:cubicBezTo>
                    <a:pt x="1520250" y="3936044"/>
                    <a:pt x="1522720" y="3941578"/>
                    <a:pt x="1527143" y="3945117"/>
                  </a:cubicBezTo>
                  <a:cubicBezTo>
                    <a:pt x="1531023" y="3948221"/>
                    <a:pt x="1536570" y="3948260"/>
                    <a:pt x="1541283" y="3949831"/>
                  </a:cubicBezTo>
                  <a:cubicBezTo>
                    <a:pt x="1550458" y="3977357"/>
                    <a:pt x="1538817" y="3952080"/>
                    <a:pt x="1560136" y="3973398"/>
                  </a:cubicBezTo>
                  <a:cubicBezTo>
                    <a:pt x="1565691" y="3978953"/>
                    <a:pt x="1569022" y="3986412"/>
                    <a:pt x="1574277" y="3992251"/>
                  </a:cubicBezTo>
                  <a:cubicBezTo>
                    <a:pt x="1583195" y="4002160"/>
                    <a:pt x="1602557" y="4020532"/>
                    <a:pt x="1602557" y="4020532"/>
                  </a:cubicBezTo>
                  <a:cubicBezTo>
                    <a:pt x="1609293" y="4037371"/>
                    <a:pt x="1612602" y="4047536"/>
                    <a:pt x="1621411" y="4062952"/>
                  </a:cubicBezTo>
                  <a:cubicBezTo>
                    <a:pt x="1624221" y="4067870"/>
                    <a:pt x="1628027" y="4072174"/>
                    <a:pt x="1630837" y="4077092"/>
                  </a:cubicBezTo>
                  <a:cubicBezTo>
                    <a:pt x="1634323" y="4083193"/>
                    <a:pt x="1637496" y="4089488"/>
                    <a:pt x="1640264" y="4095946"/>
                  </a:cubicBezTo>
                  <a:cubicBezTo>
                    <a:pt x="1642221" y="4100513"/>
                    <a:pt x="1642756" y="4105642"/>
                    <a:pt x="1644978" y="4110086"/>
                  </a:cubicBezTo>
                  <a:cubicBezTo>
                    <a:pt x="1647511" y="4115153"/>
                    <a:pt x="1651871" y="4119159"/>
                    <a:pt x="1654404" y="4124226"/>
                  </a:cubicBezTo>
                  <a:cubicBezTo>
                    <a:pt x="1656626" y="4128670"/>
                    <a:pt x="1655605" y="4134854"/>
                    <a:pt x="1659118" y="4138367"/>
                  </a:cubicBezTo>
                  <a:cubicBezTo>
                    <a:pt x="1667129" y="4146378"/>
                    <a:pt x="1687398" y="4157220"/>
                    <a:pt x="1687398" y="4157220"/>
                  </a:cubicBezTo>
                  <a:cubicBezTo>
                    <a:pt x="1697301" y="4172074"/>
                    <a:pt x="1697034" y="4168986"/>
                    <a:pt x="1701538" y="4185501"/>
                  </a:cubicBezTo>
                  <a:cubicBezTo>
                    <a:pt x="1704947" y="4198000"/>
                    <a:pt x="1710965" y="4223208"/>
                    <a:pt x="1710965" y="4223208"/>
                  </a:cubicBezTo>
                  <a:cubicBezTo>
                    <a:pt x="1718626" y="4292152"/>
                    <a:pt x="1710343" y="4244594"/>
                    <a:pt x="1720392" y="4279769"/>
                  </a:cubicBezTo>
                  <a:cubicBezTo>
                    <a:pt x="1723810" y="4291732"/>
                    <a:pt x="1724974" y="4301459"/>
                    <a:pt x="1729819" y="4312763"/>
                  </a:cubicBezTo>
                  <a:cubicBezTo>
                    <a:pt x="1732587" y="4319221"/>
                    <a:pt x="1735631" y="4325591"/>
                    <a:pt x="1739246" y="4331616"/>
                  </a:cubicBezTo>
                  <a:cubicBezTo>
                    <a:pt x="1745075" y="4341331"/>
                    <a:pt x="1758099" y="4359897"/>
                    <a:pt x="1758099" y="4359897"/>
                  </a:cubicBezTo>
                  <a:cubicBezTo>
                    <a:pt x="1759670" y="4366181"/>
                    <a:pt x="1760952" y="4372545"/>
                    <a:pt x="1762813" y="4378750"/>
                  </a:cubicBezTo>
                  <a:cubicBezTo>
                    <a:pt x="1765668" y="4388268"/>
                    <a:pt x="1771788" y="4397104"/>
                    <a:pt x="1772239" y="4407031"/>
                  </a:cubicBezTo>
                  <a:cubicBezTo>
                    <a:pt x="1773383" y="4432192"/>
                    <a:pt x="1771454" y="4457566"/>
                    <a:pt x="1767526" y="4482445"/>
                  </a:cubicBezTo>
                  <a:cubicBezTo>
                    <a:pt x="1766643" y="4488040"/>
                    <a:pt x="1761241" y="4491872"/>
                    <a:pt x="1758099" y="4496585"/>
                  </a:cubicBezTo>
                  <a:cubicBezTo>
                    <a:pt x="1747816" y="4527435"/>
                    <a:pt x="1762098" y="4497157"/>
                    <a:pt x="1739246" y="4515439"/>
                  </a:cubicBezTo>
                  <a:cubicBezTo>
                    <a:pt x="1734823" y="4518978"/>
                    <a:pt x="1733825" y="4525573"/>
                    <a:pt x="1729819" y="4529579"/>
                  </a:cubicBezTo>
                  <a:cubicBezTo>
                    <a:pt x="1725813" y="4533585"/>
                    <a:pt x="1720392" y="4535864"/>
                    <a:pt x="1715679" y="4539006"/>
                  </a:cubicBezTo>
                  <a:cubicBezTo>
                    <a:pt x="1712722" y="4543442"/>
                    <a:pt x="1701353" y="4564421"/>
                    <a:pt x="1692112" y="4562573"/>
                  </a:cubicBezTo>
                  <a:cubicBezTo>
                    <a:pt x="1686557" y="4561462"/>
                    <a:pt x="1687108" y="4551972"/>
                    <a:pt x="1682685" y="4548433"/>
                  </a:cubicBezTo>
                  <a:cubicBezTo>
                    <a:pt x="1678805" y="4545329"/>
                    <a:pt x="1672989" y="4545941"/>
                    <a:pt x="1668545" y="4543719"/>
                  </a:cubicBezTo>
                  <a:cubicBezTo>
                    <a:pt x="1663478" y="4541185"/>
                    <a:pt x="1659118" y="4537434"/>
                    <a:pt x="1654404" y="4534292"/>
                  </a:cubicBezTo>
                  <a:cubicBezTo>
                    <a:pt x="1652833" y="4539006"/>
                    <a:pt x="1651913" y="4543989"/>
                    <a:pt x="1649691" y="4548433"/>
                  </a:cubicBezTo>
                  <a:cubicBezTo>
                    <a:pt x="1647158" y="4553500"/>
                    <a:pt x="1640264" y="4556908"/>
                    <a:pt x="1640264" y="4562573"/>
                  </a:cubicBezTo>
                  <a:cubicBezTo>
                    <a:pt x="1640264" y="4592589"/>
                    <a:pt x="1645635" y="4622386"/>
                    <a:pt x="1649691" y="4652127"/>
                  </a:cubicBezTo>
                  <a:cubicBezTo>
                    <a:pt x="1650362" y="4657050"/>
                    <a:pt x="1650891" y="4662755"/>
                    <a:pt x="1654404" y="4666268"/>
                  </a:cubicBezTo>
                  <a:cubicBezTo>
                    <a:pt x="1657917" y="4669781"/>
                    <a:pt x="1663831" y="4669410"/>
                    <a:pt x="1668545" y="4670981"/>
                  </a:cubicBezTo>
                  <a:cubicBezTo>
                    <a:pt x="1673258" y="4666268"/>
                    <a:pt x="1676361" y="4658949"/>
                    <a:pt x="1682685" y="4656841"/>
                  </a:cubicBezTo>
                  <a:cubicBezTo>
                    <a:pt x="1687398" y="4655270"/>
                    <a:pt x="1694807" y="4657014"/>
                    <a:pt x="1696825" y="4661554"/>
                  </a:cubicBezTo>
                  <a:cubicBezTo>
                    <a:pt x="1700372" y="4669534"/>
                    <a:pt x="1701302" y="4730527"/>
                    <a:pt x="1710965" y="4736969"/>
                  </a:cubicBezTo>
                  <a:cubicBezTo>
                    <a:pt x="1744792" y="4759519"/>
                    <a:pt x="1731235" y="4747810"/>
                    <a:pt x="1753386" y="4769963"/>
                  </a:cubicBezTo>
                  <a:cubicBezTo>
                    <a:pt x="1763160" y="4809063"/>
                    <a:pt x="1748996" y="4774935"/>
                    <a:pt x="1772239" y="4793530"/>
                  </a:cubicBezTo>
                  <a:cubicBezTo>
                    <a:pt x="1788131" y="4806244"/>
                    <a:pt x="1776621" y="4807172"/>
                    <a:pt x="1786380" y="4821810"/>
                  </a:cubicBezTo>
                  <a:cubicBezTo>
                    <a:pt x="1790078" y="4827356"/>
                    <a:pt x="1795807" y="4831237"/>
                    <a:pt x="1800520" y="4835950"/>
                  </a:cubicBezTo>
                  <a:cubicBezTo>
                    <a:pt x="1808623" y="4860262"/>
                    <a:pt x="1807417" y="4849864"/>
                    <a:pt x="1800520" y="4887798"/>
                  </a:cubicBezTo>
                  <a:cubicBezTo>
                    <a:pt x="1799631" y="4892686"/>
                    <a:pt x="1798562" y="4897804"/>
                    <a:pt x="1795806" y="4901938"/>
                  </a:cubicBezTo>
                  <a:cubicBezTo>
                    <a:pt x="1792108" y="4907484"/>
                    <a:pt x="1786379" y="4911365"/>
                    <a:pt x="1781666" y="4916078"/>
                  </a:cubicBezTo>
                  <a:cubicBezTo>
                    <a:pt x="1780095" y="4920791"/>
                    <a:pt x="1778697" y="4925566"/>
                    <a:pt x="1776953" y="4930218"/>
                  </a:cubicBezTo>
                  <a:cubicBezTo>
                    <a:pt x="1773982" y="4938140"/>
                    <a:pt x="1767526" y="4945324"/>
                    <a:pt x="1767526" y="4953785"/>
                  </a:cubicBezTo>
                  <a:cubicBezTo>
                    <a:pt x="1767526" y="4986928"/>
                    <a:pt x="1772842" y="5019880"/>
                    <a:pt x="1776953" y="5052767"/>
                  </a:cubicBezTo>
                  <a:cubicBezTo>
                    <a:pt x="1777569" y="5057697"/>
                    <a:pt x="1778562" y="5063027"/>
                    <a:pt x="1781666" y="5066907"/>
                  </a:cubicBezTo>
                  <a:cubicBezTo>
                    <a:pt x="1785205" y="5071331"/>
                    <a:pt x="1791093" y="5073192"/>
                    <a:pt x="1795806" y="5076334"/>
                  </a:cubicBezTo>
                  <a:cubicBezTo>
                    <a:pt x="1800520" y="5074763"/>
                    <a:pt x="1806067" y="5074724"/>
                    <a:pt x="1809947" y="5071620"/>
                  </a:cubicBezTo>
                  <a:cubicBezTo>
                    <a:pt x="1814370" y="5068081"/>
                    <a:pt x="1817883" y="5062945"/>
                    <a:pt x="1819373" y="5057480"/>
                  </a:cubicBezTo>
                  <a:cubicBezTo>
                    <a:pt x="1820213" y="5054400"/>
                    <a:pt x="1824682" y="5005267"/>
                    <a:pt x="1828800" y="4996206"/>
                  </a:cubicBezTo>
                  <a:cubicBezTo>
                    <a:pt x="1833488" y="4985892"/>
                    <a:pt x="1847654" y="4967925"/>
                    <a:pt x="1847654" y="4967925"/>
                  </a:cubicBezTo>
                  <a:cubicBezTo>
                    <a:pt x="1852367" y="4969496"/>
                    <a:pt x="1857451" y="4970226"/>
                    <a:pt x="1861794" y="4972639"/>
                  </a:cubicBezTo>
                  <a:cubicBezTo>
                    <a:pt x="1871698" y="4978141"/>
                    <a:pt x="1890075" y="4991492"/>
                    <a:pt x="1890075" y="4991492"/>
                  </a:cubicBezTo>
                  <a:cubicBezTo>
                    <a:pt x="1901948" y="5038989"/>
                    <a:pt x="1885925" y="4971315"/>
                    <a:pt x="1899501" y="5052767"/>
                  </a:cubicBezTo>
                  <a:cubicBezTo>
                    <a:pt x="1900318" y="5057668"/>
                    <a:pt x="1899675" y="5064889"/>
                    <a:pt x="1904215" y="5066907"/>
                  </a:cubicBezTo>
                  <a:cubicBezTo>
                    <a:pt x="1915790" y="5072051"/>
                    <a:pt x="1929353" y="5070049"/>
                    <a:pt x="1941922" y="5071620"/>
                  </a:cubicBezTo>
                  <a:cubicBezTo>
                    <a:pt x="1946635" y="5073191"/>
                    <a:pt x="1951094" y="5076334"/>
                    <a:pt x="1956062" y="5076334"/>
                  </a:cubicBezTo>
                  <a:cubicBezTo>
                    <a:pt x="1962540" y="5076334"/>
                    <a:pt x="1969361" y="5068287"/>
                    <a:pt x="1974916" y="5071620"/>
                  </a:cubicBezTo>
                  <a:cubicBezTo>
                    <a:pt x="1980471" y="5074953"/>
                    <a:pt x="1976415" y="5084849"/>
                    <a:pt x="1979629" y="5090474"/>
                  </a:cubicBezTo>
                  <a:cubicBezTo>
                    <a:pt x="1991360" y="5111003"/>
                    <a:pt x="2004279" y="5106115"/>
                    <a:pt x="2026763" y="5109327"/>
                  </a:cubicBezTo>
                  <a:cubicBezTo>
                    <a:pt x="2029644" y="5117970"/>
                    <a:pt x="2035431" y="5143599"/>
                    <a:pt x="2045617" y="5151748"/>
                  </a:cubicBezTo>
                  <a:cubicBezTo>
                    <a:pt x="2049497" y="5154852"/>
                    <a:pt x="2055313" y="5154240"/>
                    <a:pt x="2059757" y="5156462"/>
                  </a:cubicBezTo>
                  <a:cubicBezTo>
                    <a:pt x="2064824" y="5158995"/>
                    <a:pt x="2069184" y="5162746"/>
                    <a:pt x="2073897" y="5165888"/>
                  </a:cubicBezTo>
                  <a:cubicBezTo>
                    <a:pt x="2077039" y="5170602"/>
                    <a:pt x="2079697" y="5175677"/>
                    <a:pt x="2083324" y="5180029"/>
                  </a:cubicBezTo>
                  <a:cubicBezTo>
                    <a:pt x="2090768" y="5188963"/>
                    <a:pt x="2101012" y="5198300"/>
                    <a:pt x="2111604" y="5203596"/>
                  </a:cubicBezTo>
                  <a:cubicBezTo>
                    <a:pt x="2121265" y="5208426"/>
                    <a:pt x="2140351" y="5211230"/>
                    <a:pt x="2149312" y="5213022"/>
                  </a:cubicBezTo>
                  <a:cubicBezTo>
                    <a:pt x="2157168" y="5216164"/>
                    <a:pt x="2164635" y="5220546"/>
                    <a:pt x="2172879" y="5222449"/>
                  </a:cubicBezTo>
                  <a:cubicBezTo>
                    <a:pt x="2226721" y="5234875"/>
                    <a:pt x="2195344" y="5217003"/>
                    <a:pt x="2224726" y="5236589"/>
                  </a:cubicBezTo>
                  <a:cubicBezTo>
                    <a:pt x="2231011" y="5233447"/>
                    <a:pt x="2237122" y="5229931"/>
                    <a:pt x="2243580" y="5227163"/>
                  </a:cubicBezTo>
                  <a:cubicBezTo>
                    <a:pt x="2248147" y="5225206"/>
                    <a:pt x="2254964" y="5226583"/>
                    <a:pt x="2257720" y="5222449"/>
                  </a:cubicBezTo>
                  <a:cubicBezTo>
                    <a:pt x="2262164" y="5215783"/>
                    <a:pt x="2260695" y="5206702"/>
                    <a:pt x="2262433" y="5198882"/>
                  </a:cubicBezTo>
                  <a:cubicBezTo>
                    <a:pt x="2265113" y="5186823"/>
                    <a:pt x="2266535" y="5174672"/>
                    <a:pt x="2276573" y="5165888"/>
                  </a:cubicBezTo>
                  <a:cubicBezTo>
                    <a:pt x="2298270" y="5146903"/>
                    <a:pt x="2302430" y="5149767"/>
                    <a:pt x="2323707" y="5137608"/>
                  </a:cubicBezTo>
                  <a:cubicBezTo>
                    <a:pt x="2328626" y="5134797"/>
                    <a:pt x="2333134" y="5131323"/>
                    <a:pt x="2337848" y="5128181"/>
                  </a:cubicBezTo>
                  <a:cubicBezTo>
                    <a:pt x="2339419" y="5123468"/>
                    <a:pt x="2339048" y="5117554"/>
                    <a:pt x="2342561" y="5114041"/>
                  </a:cubicBezTo>
                  <a:cubicBezTo>
                    <a:pt x="2346074" y="5110528"/>
                    <a:pt x="2351733" y="5109327"/>
                    <a:pt x="2356701" y="5109327"/>
                  </a:cubicBezTo>
                  <a:cubicBezTo>
                    <a:pt x="2374055" y="5109327"/>
                    <a:pt x="2391266" y="5112470"/>
                    <a:pt x="2408549" y="5114041"/>
                  </a:cubicBezTo>
                  <a:cubicBezTo>
                    <a:pt x="2419547" y="5112470"/>
                    <a:pt x="2431606" y="5114296"/>
                    <a:pt x="2441543" y="5109327"/>
                  </a:cubicBezTo>
                  <a:cubicBezTo>
                    <a:pt x="2445987" y="5107105"/>
                    <a:pt x="2444891" y="5099964"/>
                    <a:pt x="2446256" y="5095187"/>
                  </a:cubicBezTo>
                  <a:cubicBezTo>
                    <a:pt x="2448035" y="5088958"/>
                    <a:pt x="2449398" y="5082618"/>
                    <a:pt x="2450969" y="5076334"/>
                  </a:cubicBezTo>
                  <a:cubicBezTo>
                    <a:pt x="2482392" y="5077905"/>
                    <a:pt x="2514331" y="5075160"/>
                    <a:pt x="2545237" y="5081047"/>
                  </a:cubicBezTo>
                  <a:cubicBezTo>
                    <a:pt x="2550118" y="5081977"/>
                    <a:pt x="2546438" y="5091674"/>
                    <a:pt x="2549951" y="5095187"/>
                  </a:cubicBezTo>
                  <a:cubicBezTo>
                    <a:pt x="2553464" y="5098700"/>
                    <a:pt x="2559647" y="5097679"/>
                    <a:pt x="2564091" y="5099901"/>
                  </a:cubicBezTo>
                  <a:cubicBezTo>
                    <a:pt x="2569158" y="5102434"/>
                    <a:pt x="2573518" y="5106185"/>
                    <a:pt x="2578231" y="5109327"/>
                  </a:cubicBezTo>
                  <a:cubicBezTo>
                    <a:pt x="2586087" y="5107756"/>
                    <a:pt x="2594198" y="5107147"/>
                    <a:pt x="2601798" y="5104614"/>
                  </a:cubicBezTo>
                  <a:cubicBezTo>
                    <a:pt x="2639424" y="5092072"/>
                    <a:pt x="2603756" y="5099553"/>
                    <a:pt x="2634792" y="5085760"/>
                  </a:cubicBezTo>
                  <a:cubicBezTo>
                    <a:pt x="2643872" y="5081724"/>
                    <a:pt x="2653645" y="5079476"/>
                    <a:pt x="2663072" y="5076334"/>
                  </a:cubicBezTo>
                  <a:lnTo>
                    <a:pt x="2677213" y="5071620"/>
                  </a:lnTo>
                  <a:lnTo>
                    <a:pt x="2691353" y="5066907"/>
                  </a:lnTo>
                  <a:cubicBezTo>
                    <a:pt x="2696066" y="5063765"/>
                    <a:pt x="2701763" y="5061743"/>
                    <a:pt x="2705493" y="5057480"/>
                  </a:cubicBezTo>
                  <a:cubicBezTo>
                    <a:pt x="2712954" y="5048954"/>
                    <a:pt x="2713599" y="5032783"/>
                    <a:pt x="2724347" y="5029200"/>
                  </a:cubicBezTo>
                  <a:cubicBezTo>
                    <a:pt x="2758773" y="5017724"/>
                    <a:pt x="2742987" y="5022183"/>
                    <a:pt x="2771481" y="5015059"/>
                  </a:cubicBezTo>
                  <a:cubicBezTo>
                    <a:pt x="2817070" y="4980867"/>
                    <a:pt x="2768485" y="5014200"/>
                    <a:pt x="2804475" y="4996206"/>
                  </a:cubicBezTo>
                  <a:cubicBezTo>
                    <a:pt x="2817598" y="4989645"/>
                    <a:pt x="2822332" y="4983062"/>
                    <a:pt x="2832755" y="4972639"/>
                  </a:cubicBezTo>
                  <a:cubicBezTo>
                    <a:pt x="2845324" y="4975781"/>
                    <a:pt x="2857556" y="4980927"/>
                    <a:pt x="2870462" y="4982066"/>
                  </a:cubicBezTo>
                  <a:cubicBezTo>
                    <a:pt x="2911184" y="4985659"/>
                    <a:pt x="2952206" y="4984306"/>
                    <a:pt x="2993011" y="4986779"/>
                  </a:cubicBezTo>
                  <a:cubicBezTo>
                    <a:pt x="3004100" y="4987451"/>
                    <a:pt x="3015006" y="4989921"/>
                    <a:pt x="3026004" y="4991492"/>
                  </a:cubicBezTo>
                  <a:cubicBezTo>
                    <a:pt x="3029146" y="4996206"/>
                    <a:pt x="3029876" y="5004522"/>
                    <a:pt x="3035431" y="5005633"/>
                  </a:cubicBezTo>
                  <a:cubicBezTo>
                    <a:pt x="3059615" y="5010470"/>
                    <a:pt x="3068359" y="5000936"/>
                    <a:pt x="3087279" y="4996206"/>
                  </a:cubicBezTo>
                  <a:lnTo>
                    <a:pt x="3124986" y="4986779"/>
                  </a:lnTo>
                  <a:cubicBezTo>
                    <a:pt x="3128203" y="4977127"/>
                    <a:pt x="3130691" y="4965528"/>
                    <a:pt x="3139126" y="4958499"/>
                  </a:cubicBezTo>
                  <a:cubicBezTo>
                    <a:pt x="3146891" y="4952029"/>
                    <a:pt x="3162298" y="4947633"/>
                    <a:pt x="3172120" y="4944358"/>
                  </a:cubicBezTo>
                  <a:cubicBezTo>
                    <a:pt x="3187831" y="4945929"/>
                    <a:pt x="3203735" y="4946162"/>
                    <a:pt x="3219254" y="4949072"/>
                  </a:cubicBezTo>
                  <a:cubicBezTo>
                    <a:pt x="3229020" y="4950903"/>
                    <a:pt x="3237818" y="4956417"/>
                    <a:pt x="3247534" y="4958499"/>
                  </a:cubicBezTo>
                  <a:cubicBezTo>
                    <a:pt x="3259920" y="4961153"/>
                    <a:pt x="3272673" y="4961641"/>
                    <a:pt x="3285242" y="4963212"/>
                  </a:cubicBezTo>
                  <a:cubicBezTo>
                    <a:pt x="3332783" y="4979058"/>
                    <a:pt x="3259026" y="4954875"/>
                    <a:pt x="3318235" y="4972639"/>
                  </a:cubicBezTo>
                  <a:cubicBezTo>
                    <a:pt x="3327753" y="4975495"/>
                    <a:pt x="3337089" y="4978924"/>
                    <a:pt x="3346516" y="4982066"/>
                  </a:cubicBezTo>
                  <a:cubicBezTo>
                    <a:pt x="3351229" y="4983637"/>
                    <a:pt x="3355784" y="4985805"/>
                    <a:pt x="3360656" y="4986779"/>
                  </a:cubicBezTo>
                  <a:lnTo>
                    <a:pt x="3407790" y="4996206"/>
                  </a:lnTo>
                  <a:cubicBezTo>
                    <a:pt x="3414075" y="4999348"/>
                    <a:pt x="3420186" y="5002865"/>
                    <a:pt x="3426644" y="5005633"/>
                  </a:cubicBezTo>
                  <a:cubicBezTo>
                    <a:pt x="3456162" y="5018283"/>
                    <a:pt x="3469246" y="5008449"/>
                    <a:pt x="3511485" y="5005633"/>
                  </a:cubicBezTo>
                  <a:cubicBezTo>
                    <a:pt x="3516198" y="5000919"/>
                    <a:pt x="3522318" y="4997280"/>
                    <a:pt x="3525625" y="4991492"/>
                  </a:cubicBezTo>
                  <a:cubicBezTo>
                    <a:pt x="3535159" y="4974806"/>
                    <a:pt x="3523730" y="4971327"/>
                    <a:pt x="3539765" y="4958499"/>
                  </a:cubicBezTo>
                  <a:cubicBezTo>
                    <a:pt x="3543645" y="4955395"/>
                    <a:pt x="3549192" y="4955356"/>
                    <a:pt x="3553905" y="4953785"/>
                  </a:cubicBezTo>
                  <a:cubicBezTo>
                    <a:pt x="3577472" y="4955356"/>
                    <a:pt x="3601276" y="4954815"/>
                    <a:pt x="3624606" y="4958499"/>
                  </a:cubicBezTo>
                  <a:cubicBezTo>
                    <a:pt x="3631546" y="4959595"/>
                    <a:pt x="3637002" y="4965157"/>
                    <a:pt x="3643460" y="4967925"/>
                  </a:cubicBezTo>
                  <a:cubicBezTo>
                    <a:pt x="3648027" y="4969882"/>
                    <a:pt x="3652887" y="4971068"/>
                    <a:pt x="3657600" y="4972639"/>
                  </a:cubicBezTo>
                  <a:cubicBezTo>
                    <a:pt x="3679596" y="4971068"/>
                    <a:pt x="3702194" y="4973273"/>
                    <a:pt x="3723588" y="4967925"/>
                  </a:cubicBezTo>
                  <a:cubicBezTo>
                    <a:pt x="3729084" y="4966551"/>
                    <a:pt x="3732175" y="4959387"/>
                    <a:pt x="3733015" y="4953785"/>
                  </a:cubicBezTo>
                  <a:cubicBezTo>
                    <a:pt x="3736984" y="4927326"/>
                    <a:pt x="3723776" y="4896487"/>
                    <a:pt x="3737728" y="4873657"/>
                  </a:cubicBezTo>
                  <a:cubicBezTo>
                    <a:pt x="3745961" y="4860184"/>
                    <a:pt x="3769169" y="4870688"/>
                    <a:pt x="3784862" y="4868944"/>
                  </a:cubicBezTo>
                  <a:cubicBezTo>
                    <a:pt x="3797451" y="4867545"/>
                    <a:pt x="3810000" y="4865802"/>
                    <a:pt x="3822569" y="4864231"/>
                  </a:cubicBezTo>
                  <a:cubicBezTo>
                    <a:pt x="3841423" y="4865802"/>
                    <a:pt x="3860377" y="4866444"/>
                    <a:pt x="3879130" y="4868944"/>
                  </a:cubicBezTo>
                  <a:cubicBezTo>
                    <a:pt x="3884055" y="4869601"/>
                    <a:pt x="3888302" y="4873657"/>
                    <a:pt x="3893270" y="4873657"/>
                  </a:cubicBezTo>
                  <a:cubicBezTo>
                    <a:pt x="3902827" y="4873657"/>
                    <a:pt x="3912124" y="4870515"/>
                    <a:pt x="3921551" y="4868944"/>
                  </a:cubicBezTo>
                  <a:cubicBezTo>
                    <a:pt x="3926264" y="4870515"/>
                    <a:pt x="3930723" y="4873657"/>
                    <a:pt x="3935691" y="4873657"/>
                  </a:cubicBezTo>
                  <a:cubicBezTo>
                    <a:pt x="3947247" y="4873657"/>
                    <a:pt x="3970368" y="4867345"/>
                    <a:pt x="3982825" y="4864231"/>
                  </a:cubicBezTo>
                  <a:cubicBezTo>
                    <a:pt x="3987538" y="4861089"/>
                    <a:pt x="3992613" y="4858431"/>
                    <a:pt x="3996965" y="4854804"/>
                  </a:cubicBezTo>
                  <a:cubicBezTo>
                    <a:pt x="4002086" y="4850537"/>
                    <a:pt x="4005681" y="4844538"/>
                    <a:pt x="4011105" y="4840664"/>
                  </a:cubicBezTo>
                  <a:cubicBezTo>
                    <a:pt x="4016823" y="4836580"/>
                    <a:pt x="4023934" y="4834852"/>
                    <a:pt x="4029959" y="4831237"/>
                  </a:cubicBezTo>
                  <a:cubicBezTo>
                    <a:pt x="4039674" y="4825408"/>
                    <a:pt x="4048106" y="4817450"/>
                    <a:pt x="4058239" y="4812383"/>
                  </a:cubicBezTo>
                  <a:cubicBezTo>
                    <a:pt x="4064524" y="4809241"/>
                    <a:pt x="4070992" y="4806442"/>
                    <a:pt x="4077093" y="4802956"/>
                  </a:cubicBezTo>
                  <a:cubicBezTo>
                    <a:pt x="4082011" y="4800146"/>
                    <a:pt x="4086057" y="4795831"/>
                    <a:pt x="4091233" y="4793530"/>
                  </a:cubicBezTo>
                  <a:cubicBezTo>
                    <a:pt x="4100314" y="4789494"/>
                    <a:pt x="4110087" y="4787245"/>
                    <a:pt x="4119514" y="4784103"/>
                  </a:cubicBezTo>
                  <a:cubicBezTo>
                    <a:pt x="4124227" y="4782532"/>
                    <a:pt x="4129520" y="4782145"/>
                    <a:pt x="4133654" y="4779389"/>
                  </a:cubicBezTo>
                  <a:cubicBezTo>
                    <a:pt x="4151928" y="4767207"/>
                    <a:pt x="4142420" y="4771755"/>
                    <a:pt x="4161934" y="4765249"/>
                  </a:cubicBezTo>
                  <a:cubicBezTo>
                    <a:pt x="4180518" y="4737373"/>
                    <a:pt x="4159770" y="4763428"/>
                    <a:pt x="4190215" y="4741682"/>
                  </a:cubicBezTo>
                  <a:cubicBezTo>
                    <a:pt x="4195639" y="4737808"/>
                    <a:pt x="4199234" y="4731809"/>
                    <a:pt x="4204355" y="4727542"/>
                  </a:cubicBezTo>
                  <a:cubicBezTo>
                    <a:pt x="4208707" y="4723915"/>
                    <a:pt x="4214143" y="4721742"/>
                    <a:pt x="4218495" y="4718115"/>
                  </a:cubicBezTo>
                  <a:cubicBezTo>
                    <a:pt x="4223616" y="4713848"/>
                    <a:pt x="4227574" y="4708313"/>
                    <a:pt x="4232635" y="4703975"/>
                  </a:cubicBezTo>
                  <a:cubicBezTo>
                    <a:pt x="4238600" y="4698863"/>
                    <a:pt x="4245204" y="4694548"/>
                    <a:pt x="4251489" y="4689835"/>
                  </a:cubicBezTo>
                  <a:cubicBezTo>
                    <a:pt x="4259772" y="4664985"/>
                    <a:pt x="4250727" y="4685093"/>
                    <a:pt x="4270343" y="4661554"/>
                  </a:cubicBezTo>
                  <a:cubicBezTo>
                    <a:pt x="4273969" y="4657202"/>
                    <a:pt x="4275764" y="4651419"/>
                    <a:pt x="4279769" y="4647414"/>
                  </a:cubicBezTo>
                  <a:cubicBezTo>
                    <a:pt x="4285324" y="4641859"/>
                    <a:pt x="4293068" y="4638829"/>
                    <a:pt x="4298623" y="4633274"/>
                  </a:cubicBezTo>
                  <a:cubicBezTo>
                    <a:pt x="4302629" y="4629268"/>
                    <a:pt x="4303627" y="4622673"/>
                    <a:pt x="4308050" y="4619134"/>
                  </a:cubicBezTo>
                  <a:cubicBezTo>
                    <a:pt x="4311930" y="4616030"/>
                    <a:pt x="4317746" y="4616642"/>
                    <a:pt x="4322190" y="4614420"/>
                  </a:cubicBezTo>
                  <a:cubicBezTo>
                    <a:pt x="4327257" y="4611886"/>
                    <a:pt x="4331720" y="4608286"/>
                    <a:pt x="4336330" y="4604993"/>
                  </a:cubicBezTo>
                  <a:cubicBezTo>
                    <a:pt x="4341306" y="4601439"/>
                    <a:pt x="4361923" y="4585127"/>
                    <a:pt x="4369324" y="4581426"/>
                  </a:cubicBezTo>
                  <a:cubicBezTo>
                    <a:pt x="4373768" y="4579204"/>
                    <a:pt x="4378751" y="4578284"/>
                    <a:pt x="4383464" y="4576713"/>
                  </a:cubicBezTo>
                  <a:cubicBezTo>
                    <a:pt x="4388177" y="4572000"/>
                    <a:pt x="4391952" y="4566106"/>
                    <a:pt x="4397604" y="4562573"/>
                  </a:cubicBezTo>
                  <a:cubicBezTo>
                    <a:pt x="4404779" y="4558089"/>
                    <a:pt x="4413603" y="4556930"/>
                    <a:pt x="4421171" y="4553146"/>
                  </a:cubicBezTo>
                  <a:cubicBezTo>
                    <a:pt x="4431765" y="4547849"/>
                    <a:pt x="4442005" y="4538515"/>
                    <a:pt x="4449452" y="4529579"/>
                  </a:cubicBezTo>
                  <a:cubicBezTo>
                    <a:pt x="4453079" y="4525227"/>
                    <a:pt x="4455586" y="4520049"/>
                    <a:pt x="4458879" y="4515439"/>
                  </a:cubicBezTo>
                  <a:cubicBezTo>
                    <a:pt x="4463445" y="4509047"/>
                    <a:pt x="4468453" y="4502977"/>
                    <a:pt x="4473019" y="4496585"/>
                  </a:cubicBezTo>
                  <a:cubicBezTo>
                    <a:pt x="4476312" y="4491975"/>
                    <a:pt x="4478819" y="4486797"/>
                    <a:pt x="4482446" y="4482445"/>
                  </a:cubicBezTo>
                  <a:cubicBezTo>
                    <a:pt x="4486713" y="4477324"/>
                    <a:pt x="4492319" y="4473426"/>
                    <a:pt x="4496586" y="4468305"/>
                  </a:cubicBezTo>
                  <a:cubicBezTo>
                    <a:pt x="4512986" y="4448625"/>
                    <a:pt x="4496940" y="4457190"/>
                    <a:pt x="4520153" y="4449451"/>
                  </a:cubicBezTo>
                  <a:cubicBezTo>
                    <a:pt x="4525545" y="4433273"/>
                    <a:pt x="4524739" y="4430724"/>
                    <a:pt x="4539006" y="4416457"/>
                  </a:cubicBezTo>
                  <a:cubicBezTo>
                    <a:pt x="4543012" y="4412451"/>
                    <a:pt x="4548433" y="4410173"/>
                    <a:pt x="4553147" y="4407031"/>
                  </a:cubicBezTo>
                  <a:cubicBezTo>
                    <a:pt x="4556289" y="4400746"/>
                    <a:pt x="4558000" y="4393512"/>
                    <a:pt x="4562573" y="4388177"/>
                  </a:cubicBezTo>
                  <a:cubicBezTo>
                    <a:pt x="4573986" y="4374862"/>
                    <a:pt x="4581195" y="4374114"/>
                    <a:pt x="4595567" y="4369323"/>
                  </a:cubicBezTo>
                  <a:cubicBezTo>
                    <a:pt x="4613012" y="4334435"/>
                    <a:pt x="4595247" y="4364995"/>
                    <a:pt x="4619134" y="4336330"/>
                  </a:cubicBezTo>
                  <a:cubicBezTo>
                    <a:pt x="4622761" y="4331978"/>
                    <a:pt x="4624555" y="4326195"/>
                    <a:pt x="4628561" y="4322189"/>
                  </a:cubicBezTo>
                  <a:cubicBezTo>
                    <a:pt x="4632566" y="4318184"/>
                    <a:pt x="4638092" y="4316055"/>
                    <a:pt x="4642701" y="4312763"/>
                  </a:cubicBezTo>
                  <a:cubicBezTo>
                    <a:pt x="4649094" y="4308197"/>
                    <a:pt x="4655764" y="4303930"/>
                    <a:pt x="4661555" y="4298622"/>
                  </a:cubicBezTo>
                  <a:cubicBezTo>
                    <a:pt x="4661567" y="4298611"/>
                    <a:pt x="4702596" y="4257581"/>
                    <a:pt x="4713402" y="4246775"/>
                  </a:cubicBezTo>
                  <a:cubicBezTo>
                    <a:pt x="4718116" y="4242062"/>
                    <a:pt x="4723846" y="4238181"/>
                    <a:pt x="4727543" y="4232635"/>
                  </a:cubicBezTo>
                  <a:cubicBezTo>
                    <a:pt x="4730685" y="4227922"/>
                    <a:pt x="4734436" y="4223562"/>
                    <a:pt x="4736969" y="4218495"/>
                  </a:cubicBezTo>
                  <a:cubicBezTo>
                    <a:pt x="4739191" y="4214051"/>
                    <a:pt x="4738170" y="4207867"/>
                    <a:pt x="4741683" y="4204354"/>
                  </a:cubicBezTo>
                  <a:cubicBezTo>
                    <a:pt x="4746651" y="4199386"/>
                    <a:pt x="4754819" y="4199011"/>
                    <a:pt x="4760536" y="4194927"/>
                  </a:cubicBezTo>
                  <a:cubicBezTo>
                    <a:pt x="4765960" y="4191053"/>
                    <a:pt x="4769963" y="4185500"/>
                    <a:pt x="4774677" y="4180787"/>
                  </a:cubicBezTo>
                  <a:cubicBezTo>
                    <a:pt x="4776248" y="4174503"/>
                    <a:pt x="4776176" y="4167558"/>
                    <a:pt x="4779390" y="4161934"/>
                  </a:cubicBezTo>
                  <a:cubicBezTo>
                    <a:pt x="4784975" y="4152161"/>
                    <a:pt x="4798658" y="4144375"/>
                    <a:pt x="4807670" y="4138367"/>
                  </a:cubicBezTo>
                  <a:cubicBezTo>
                    <a:pt x="4834685" y="4097843"/>
                    <a:pt x="4798715" y="4145530"/>
                    <a:pt x="4831237" y="4119513"/>
                  </a:cubicBezTo>
                  <a:cubicBezTo>
                    <a:pt x="4835661" y="4115974"/>
                    <a:pt x="4836658" y="4109379"/>
                    <a:pt x="4840664" y="4105373"/>
                  </a:cubicBezTo>
                  <a:cubicBezTo>
                    <a:pt x="4844670" y="4101367"/>
                    <a:pt x="4850091" y="4099088"/>
                    <a:pt x="4854804" y="4095946"/>
                  </a:cubicBezTo>
                  <a:cubicBezTo>
                    <a:pt x="4857946" y="4091233"/>
                    <a:pt x="4859879" y="4085432"/>
                    <a:pt x="4864231" y="4081806"/>
                  </a:cubicBezTo>
                  <a:cubicBezTo>
                    <a:pt x="4869629" y="4077308"/>
                    <a:pt x="4876984" y="4075865"/>
                    <a:pt x="4883085" y="4072379"/>
                  </a:cubicBezTo>
                  <a:cubicBezTo>
                    <a:pt x="4888003" y="4069568"/>
                    <a:pt x="4892512" y="4066094"/>
                    <a:pt x="4897225" y="4062952"/>
                  </a:cubicBezTo>
                  <a:cubicBezTo>
                    <a:pt x="4922364" y="4025245"/>
                    <a:pt x="4889369" y="4070808"/>
                    <a:pt x="4920792" y="4039385"/>
                  </a:cubicBezTo>
                  <a:cubicBezTo>
                    <a:pt x="4924798" y="4035379"/>
                    <a:pt x="4926592" y="4029597"/>
                    <a:pt x="4930219" y="4025245"/>
                  </a:cubicBezTo>
                  <a:cubicBezTo>
                    <a:pt x="4934486" y="4020124"/>
                    <a:pt x="4940092" y="4016226"/>
                    <a:pt x="4944359" y="4011105"/>
                  </a:cubicBezTo>
                  <a:cubicBezTo>
                    <a:pt x="4977177" y="3971724"/>
                    <a:pt x="4926607" y="4024146"/>
                    <a:pt x="4967926" y="3982824"/>
                  </a:cubicBezTo>
                  <a:cubicBezTo>
                    <a:pt x="4972802" y="3968194"/>
                    <a:pt x="4973328" y="3964394"/>
                    <a:pt x="4982066" y="3949831"/>
                  </a:cubicBezTo>
                  <a:cubicBezTo>
                    <a:pt x="4987895" y="3940116"/>
                    <a:pt x="4992909" y="3929561"/>
                    <a:pt x="5000920" y="3921550"/>
                  </a:cubicBezTo>
                  <a:lnTo>
                    <a:pt x="5015060" y="3907410"/>
                  </a:lnTo>
                  <a:cubicBezTo>
                    <a:pt x="5016631" y="3891699"/>
                    <a:pt x="5015063" y="3875347"/>
                    <a:pt x="5019773" y="3860276"/>
                  </a:cubicBezTo>
                  <a:cubicBezTo>
                    <a:pt x="5023152" y="3849462"/>
                    <a:pt x="5038627" y="3831996"/>
                    <a:pt x="5038627" y="3831996"/>
                  </a:cubicBezTo>
                  <a:cubicBezTo>
                    <a:pt x="5040185" y="3822648"/>
                    <a:pt x="5045297" y="3782905"/>
                    <a:pt x="5052767" y="3775435"/>
                  </a:cubicBezTo>
                  <a:cubicBezTo>
                    <a:pt x="5057480" y="3770722"/>
                    <a:pt x="5062908" y="3766628"/>
                    <a:pt x="5066907" y="3761295"/>
                  </a:cubicBezTo>
                  <a:cubicBezTo>
                    <a:pt x="5072404" y="3753966"/>
                    <a:pt x="5075247" y="3744818"/>
                    <a:pt x="5081048" y="3737727"/>
                  </a:cubicBezTo>
                  <a:cubicBezTo>
                    <a:pt x="5089490" y="3727409"/>
                    <a:pt x="5099901" y="3718874"/>
                    <a:pt x="5109328" y="3709447"/>
                  </a:cubicBezTo>
                  <a:cubicBezTo>
                    <a:pt x="5114041" y="3704734"/>
                    <a:pt x="5119770" y="3700853"/>
                    <a:pt x="5123468" y="3695307"/>
                  </a:cubicBezTo>
                  <a:cubicBezTo>
                    <a:pt x="5140290" y="3670074"/>
                    <a:pt x="5128889" y="3685173"/>
                    <a:pt x="5161176" y="3652886"/>
                  </a:cubicBezTo>
                  <a:lnTo>
                    <a:pt x="5175316" y="3638746"/>
                  </a:lnTo>
                  <a:cubicBezTo>
                    <a:pt x="5176887" y="3634033"/>
                    <a:pt x="5177807" y="3629050"/>
                    <a:pt x="5180029" y="3624606"/>
                  </a:cubicBezTo>
                  <a:cubicBezTo>
                    <a:pt x="5182562" y="3619539"/>
                    <a:pt x="5187467" y="3615770"/>
                    <a:pt x="5189456" y="3610466"/>
                  </a:cubicBezTo>
                  <a:cubicBezTo>
                    <a:pt x="5192269" y="3602965"/>
                    <a:pt x="5191636" y="3594499"/>
                    <a:pt x="5194169" y="3586899"/>
                  </a:cubicBezTo>
                  <a:cubicBezTo>
                    <a:pt x="5196391" y="3580233"/>
                    <a:pt x="5201129" y="3574624"/>
                    <a:pt x="5203596" y="3568045"/>
                  </a:cubicBezTo>
                  <a:cubicBezTo>
                    <a:pt x="5205871" y="3561979"/>
                    <a:pt x="5204716" y="3554581"/>
                    <a:pt x="5208310" y="3549191"/>
                  </a:cubicBezTo>
                  <a:cubicBezTo>
                    <a:pt x="5211452" y="3544478"/>
                    <a:pt x="5217737" y="3542907"/>
                    <a:pt x="5222450" y="3539765"/>
                  </a:cubicBezTo>
                  <a:cubicBezTo>
                    <a:pt x="5225592" y="3535051"/>
                    <a:pt x="5227525" y="3529251"/>
                    <a:pt x="5231877" y="3525624"/>
                  </a:cubicBezTo>
                  <a:cubicBezTo>
                    <a:pt x="5237275" y="3521126"/>
                    <a:pt x="5244630" y="3519684"/>
                    <a:pt x="5250730" y="3516198"/>
                  </a:cubicBezTo>
                  <a:cubicBezTo>
                    <a:pt x="5255648" y="3513387"/>
                    <a:pt x="5260157" y="3509913"/>
                    <a:pt x="5264870" y="3506771"/>
                  </a:cubicBezTo>
                  <a:cubicBezTo>
                    <a:pt x="5268012" y="3502058"/>
                    <a:pt x="5270291" y="3496637"/>
                    <a:pt x="5274297" y="3492631"/>
                  </a:cubicBezTo>
                  <a:cubicBezTo>
                    <a:pt x="5279852" y="3487076"/>
                    <a:pt x="5288122" y="3484525"/>
                    <a:pt x="5293151" y="3478490"/>
                  </a:cubicBezTo>
                  <a:cubicBezTo>
                    <a:pt x="5321609" y="3444339"/>
                    <a:pt x="5268698" y="3483794"/>
                    <a:pt x="5312004" y="3454923"/>
                  </a:cubicBezTo>
                  <a:cubicBezTo>
                    <a:pt x="5313575" y="3450210"/>
                    <a:pt x="5314496" y="3445227"/>
                    <a:pt x="5316718" y="3440783"/>
                  </a:cubicBezTo>
                  <a:cubicBezTo>
                    <a:pt x="5329885" y="3414452"/>
                    <a:pt x="5327463" y="3438899"/>
                    <a:pt x="5335571" y="3398363"/>
                  </a:cubicBezTo>
                  <a:cubicBezTo>
                    <a:pt x="5337142" y="3390507"/>
                    <a:pt x="5335841" y="3381462"/>
                    <a:pt x="5340285" y="3374796"/>
                  </a:cubicBezTo>
                  <a:cubicBezTo>
                    <a:pt x="5343041" y="3370662"/>
                    <a:pt x="5349575" y="3371160"/>
                    <a:pt x="5354425" y="3370082"/>
                  </a:cubicBezTo>
                  <a:cubicBezTo>
                    <a:pt x="5363754" y="3368009"/>
                    <a:pt x="5373278" y="3366940"/>
                    <a:pt x="5382705" y="3365369"/>
                  </a:cubicBezTo>
                  <a:cubicBezTo>
                    <a:pt x="5387419" y="3363798"/>
                    <a:pt x="5392069" y="3362020"/>
                    <a:pt x="5396846" y="3360655"/>
                  </a:cubicBezTo>
                  <a:cubicBezTo>
                    <a:pt x="5403074" y="3358875"/>
                    <a:pt x="5410309" y="3359535"/>
                    <a:pt x="5415699" y="3355942"/>
                  </a:cubicBezTo>
                  <a:cubicBezTo>
                    <a:pt x="5420412" y="3352800"/>
                    <a:pt x="5421984" y="3346515"/>
                    <a:pt x="5425126" y="3341802"/>
                  </a:cubicBezTo>
                  <a:cubicBezTo>
                    <a:pt x="5427943" y="3333351"/>
                    <a:pt x="5433441" y="3314633"/>
                    <a:pt x="5439266" y="3308808"/>
                  </a:cubicBezTo>
                  <a:cubicBezTo>
                    <a:pt x="5442779" y="3305295"/>
                    <a:pt x="5448693" y="3305666"/>
                    <a:pt x="5453406" y="3304095"/>
                  </a:cubicBezTo>
                  <a:cubicBezTo>
                    <a:pt x="5469581" y="3271746"/>
                    <a:pt x="5452967" y="3293864"/>
                    <a:pt x="5476973" y="3280527"/>
                  </a:cubicBezTo>
                  <a:cubicBezTo>
                    <a:pt x="5486877" y="3275025"/>
                    <a:pt x="5505254" y="3261674"/>
                    <a:pt x="5505254" y="3261674"/>
                  </a:cubicBezTo>
                  <a:cubicBezTo>
                    <a:pt x="5508396" y="3252247"/>
                    <a:pt x="5512271" y="3243033"/>
                    <a:pt x="5514681" y="3233393"/>
                  </a:cubicBezTo>
                  <a:cubicBezTo>
                    <a:pt x="5517072" y="3223828"/>
                    <a:pt x="5520051" y="3209865"/>
                    <a:pt x="5524107" y="3200400"/>
                  </a:cubicBezTo>
                  <a:cubicBezTo>
                    <a:pt x="5526875" y="3193942"/>
                    <a:pt x="5529919" y="3187571"/>
                    <a:pt x="5533534" y="3181546"/>
                  </a:cubicBezTo>
                  <a:cubicBezTo>
                    <a:pt x="5552442" y="3150033"/>
                    <a:pt x="5542825" y="3156454"/>
                    <a:pt x="5566528" y="3148552"/>
                  </a:cubicBezTo>
                  <a:cubicBezTo>
                    <a:pt x="5602645" y="3094378"/>
                    <a:pt x="5571354" y="3146692"/>
                    <a:pt x="5580668" y="2993010"/>
                  </a:cubicBezTo>
                  <a:cubicBezTo>
                    <a:pt x="5581318" y="2982278"/>
                    <a:pt x="5589302" y="2972990"/>
                    <a:pt x="5594809" y="2964730"/>
                  </a:cubicBezTo>
                  <a:cubicBezTo>
                    <a:pt x="5596380" y="2960016"/>
                    <a:pt x="5597777" y="2955241"/>
                    <a:pt x="5599522" y="2950589"/>
                  </a:cubicBezTo>
                  <a:cubicBezTo>
                    <a:pt x="5602493" y="2942667"/>
                    <a:pt x="5606562" y="2935139"/>
                    <a:pt x="5608949" y="2927022"/>
                  </a:cubicBezTo>
                  <a:cubicBezTo>
                    <a:pt x="5643419" y="2809824"/>
                    <a:pt x="5611698" y="2911311"/>
                    <a:pt x="5627802" y="2846895"/>
                  </a:cubicBezTo>
                  <a:cubicBezTo>
                    <a:pt x="5630576" y="2835798"/>
                    <a:pt x="5633865" y="2824833"/>
                    <a:pt x="5637229" y="2813901"/>
                  </a:cubicBezTo>
                  <a:cubicBezTo>
                    <a:pt x="5640151" y="2804403"/>
                    <a:pt x="5646656" y="2785620"/>
                    <a:pt x="5646656" y="2785620"/>
                  </a:cubicBezTo>
                  <a:cubicBezTo>
                    <a:pt x="5645085" y="2769909"/>
                    <a:pt x="5656647" y="2744240"/>
                    <a:pt x="5641943" y="2738486"/>
                  </a:cubicBezTo>
                  <a:cubicBezTo>
                    <a:pt x="5598781" y="2721597"/>
                    <a:pt x="5561668" y="2735394"/>
                    <a:pt x="5524107" y="2747913"/>
                  </a:cubicBezTo>
                  <a:cubicBezTo>
                    <a:pt x="5502111" y="2746342"/>
                    <a:pt x="5479427" y="2748882"/>
                    <a:pt x="5458120" y="2743200"/>
                  </a:cubicBezTo>
                  <a:cubicBezTo>
                    <a:pt x="5453319" y="2741920"/>
                    <a:pt x="5453955" y="2733997"/>
                    <a:pt x="5453406" y="2729059"/>
                  </a:cubicBezTo>
                  <a:cubicBezTo>
                    <a:pt x="5450798" y="2705584"/>
                    <a:pt x="5452033" y="2681740"/>
                    <a:pt x="5448693" y="2658358"/>
                  </a:cubicBezTo>
                  <a:cubicBezTo>
                    <a:pt x="5445634" y="2636942"/>
                    <a:pt x="5440127" y="2631369"/>
                    <a:pt x="5429839" y="2615938"/>
                  </a:cubicBezTo>
                  <a:cubicBezTo>
                    <a:pt x="5417798" y="2579811"/>
                    <a:pt x="5429839" y="2622127"/>
                    <a:pt x="5429839" y="2545237"/>
                  </a:cubicBezTo>
                  <a:cubicBezTo>
                    <a:pt x="5429839" y="2532570"/>
                    <a:pt x="5428459" y="2519750"/>
                    <a:pt x="5425126" y="2507530"/>
                  </a:cubicBezTo>
                  <a:cubicBezTo>
                    <a:pt x="5423635" y="2502065"/>
                    <a:pt x="5418841" y="2498103"/>
                    <a:pt x="5415699" y="2493389"/>
                  </a:cubicBezTo>
                  <a:cubicBezTo>
                    <a:pt x="5414128" y="2488676"/>
                    <a:pt x="5414090" y="2483129"/>
                    <a:pt x="5410986" y="2479249"/>
                  </a:cubicBezTo>
                  <a:cubicBezTo>
                    <a:pt x="5386619" y="2448789"/>
                    <a:pt x="5403982" y="2491226"/>
                    <a:pt x="5392132" y="2455682"/>
                  </a:cubicBezTo>
                  <a:cubicBezTo>
                    <a:pt x="5393703" y="2432115"/>
                    <a:pt x="5393506" y="2408363"/>
                    <a:pt x="5396846" y="2384981"/>
                  </a:cubicBezTo>
                  <a:cubicBezTo>
                    <a:pt x="5398251" y="2375144"/>
                    <a:pt x="5406272" y="2356701"/>
                    <a:pt x="5406272" y="2356701"/>
                  </a:cubicBezTo>
                  <a:cubicBezTo>
                    <a:pt x="5407843" y="2344132"/>
                    <a:pt x="5409312" y="2331549"/>
                    <a:pt x="5410986" y="2318993"/>
                  </a:cubicBezTo>
                  <a:cubicBezTo>
                    <a:pt x="5412454" y="2307981"/>
                    <a:pt x="5415699" y="2297109"/>
                    <a:pt x="5415699" y="2286000"/>
                  </a:cubicBezTo>
                  <a:cubicBezTo>
                    <a:pt x="5415699" y="2265515"/>
                    <a:pt x="5412557" y="2245150"/>
                    <a:pt x="5410986" y="2224725"/>
                  </a:cubicBezTo>
                  <a:cubicBezTo>
                    <a:pt x="5409415" y="2135171"/>
                    <a:pt x="5409256" y="2045580"/>
                    <a:pt x="5406272" y="1956062"/>
                  </a:cubicBezTo>
                  <a:cubicBezTo>
                    <a:pt x="5405707" y="1939114"/>
                    <a:pt x="5400554" y="1941586"/>
                    <a:pt x="5387419" y="1937208"/>
                  </a:cubicBezTo>
                  <a:cubicBezTo>
                    <a:pt x="5385848" y="1932495"/>
                    <a:pt x="5384662" y="1927635"/>
                    <a:pt x="5382705" y="1923068"/>
                  </a:cubicBezTo>
                  <a:cubicBezTo>
                    <a:pt x="5374617" y="1904195"/>
                    <a:pt x="5372984" y="1907751"/>
                    <a:pt x="5368565" y="1890074"/>
                  </a:cubicBezTo>
                  <a:cubicBezTo>
                    <a:pt x="5366322" y="1881102"/>
                    <a:pt x="5362771" y="1857340"/>
                    <a:pt x="5359138" y="1847653"/>
                  </a:cubicBezTo>
                  <a:cubicBezTo>
                    <a:pt x="5356671" y="1841074"/>
                    <a:pt x="5354680" y="1833768"/>
                    <a:pt x="5349712" y="1828800"/>
                  </a:cubicBezTo>
                  <a:cubicBezTo>
                    <a:pt x="5346199" y="1825287"/>
                    <a:pt x="5340015" y="1826308"/>
                    <a:pt x="5335571" y="1824086"/>
                  </a:cubicBezTo>
                  <a:cubicBezTo>
                    <a:pt x="5299027" y="1805813"/>
                    <a:pt x="5342829" y="1821791"/>
                    <a:pt x="5307291" y="1809946"/>
                  </a:cubicBezTo>
                  <a:cubicBezTo>
                    <a:pt x="5283923" y="1774895"/>
                    <a:pt x="5301741" y="1806708"/>
                    <a:pt x="5293151" y="1725105"/>
                  </a:cubicBezTo>
                  <a:cubicBezTo>
                    <a:pt x="5292056" y="1714699"/>
                    <a:pt x="5281238" y="1684653"/>
                    <a:pt x="5279011" y="1677971"/>
                  </a:cubicBezTo>
                  <a:cubicBezTo>
                    <a:pt x="5273363" y="1627144"/>
                    <a:pt x="5273350" y="1624211"/>
                    <a:pt x="5264870" y="1564849"/>
                  </a:cubicBezTo>
                  <a:cubicBezTo>
                    <a:pt x="5263518" y="1555388"/>
                    <a:pt x="5262230" y="1545898"/>
                    <a:pt x="5260157" y="1536569"/>
                  </a:cubicBezTo>
                  <a:cubicBezTo>
                    <a:pt x="5259079" y="1531719"/>
                    <a:pt x="5257857" y="1526772"/>
                    <a:pt x="5255444" y="1522429"/>
                  </a:cubicBezTo>
                  <a:cubicBezTo>
                    <a:pt x="5249942" y="1512525"/>
                    <a:pt x="5236590" y="1494148"/>
                    <a:pt x="5236590" y="1494148"/>
                  </a:cubicBezTo>
                  <a:cubicBezTo>
                    <a:pt x="5232222" y="1481044"/>
                    <a:pt x="5232197" y="1476833"/>
                    <a:pt x="5222450" y="1465868"/>
                  </a:cubicBezTo>
                  <a:cubicBezTo>
                    <a:pt x="5218640" y="1461582"/>
                    <a:pt x="5193162" y="1433085"/>
                    <a:pt x="5180029" y="1428160"/>
                  </a:cubicBezTo>
                  <a:cubicBezTo>
                    <a:pt x="5172528" y="1425347"/>
                    <a:pt x="5164437" y="1424206"/>
                    <a:pt x="5156462" y="1423447"/>
                  </a:cubicBezTo>
                  <a:cubicBezTo>
                    <a:pt x="5131388" y="1421059"/>
                    <a:pt x="5106186" y="1420305"/>
                    <a:pt x="5081048" y="1418734"/>
                  </a:cubicBezTo>
                  <a:cubicBezTo>
                    <a:pt x="4983232" y="1422227"/>
                    <a:pt x="4972608" y="1428157"/>
                    <a:pt x="4897225" y="1418734"/>
                  </a:cubicBezTo>
                  <a:cubicBezTo>
                    <a:pt x="4864613" y="1414657"/>
                    <a:pt x="4880392" y="1413346"/>
                    <a:pt x="4845378" y="1404593"/>
                  </a:cubicBezTo>
                  <a:lnTo>
                    <a:pt x="4826524" y="1399880"/>
                  </a:lnTo>
                  <a:cubicBezTo>
                    <a:pt x="4820239" y="1396738"/>
                    <a:pt x="4814194" y="1393063"/>
                    <a:pt x="4807670" y="1390453"/>
                  </a:cubicBezTo>
                  <a:cubicBezTo>
                    <a:pt x="4798444" y="1386763"/>
                    <a:pt x="4787658" y="1386538"/>
                    <a:pt x="4779390" y="1381026"/>
                  </a:cubicBezTo>
                  <a:lnTo>
                    <a:pt x="4765250" y="1371600"/>
                  </a:lnTo>
                  <a:cubicBezTo>
                    <a:pt x="4738541" y="1373171"/>
                    <a:pt x="4711768" y="1373891"/>
                    <a:pt x="4685122" y="1376313"/>
                  </a:cubicBezTo>
                  <a:cubicBezTo>
                    <a:pt x="4677144" y="1377038"/>
                    <a:pt x="4669056" y="1378213"/>
                    <a:pt x="4661555" y="1381026"/>
                  </a:cubicBezTo>
                  <a:cubicBezTo>
                    <a:pt x="4656251" y="1383015"/>
                    <a:pt x="4652482" y="1387919"/>
                    <a:pt x="4647415" y="1390453"/>
                  </a:cubicBezTo>
                  <a:cubicBezTo>
                    <a:pt x="4642971" y="1392675"/>
                    <a:pt x="4637988" y="1393596"/>
                    <a:pt x="4633275" y="1395167"/>
                  </a:cubicBezTo>
                  <a:cubicBezTo>
                    <a:pt x="4628561" y="1399880"/>
                    <a:pt x="4624680" y="1405610"/>
                    <a:pt x="4619134" y="1409307"/>
                  </a:cubicBezTo>
                  <a:cubicBezTo>
                    <a:pt x="4615000" y="1412063"/>
                    <a:pt x="4608098" y="1410140"/>
                    <a:pt x="4604994" y="1414020"/>
                  </a:cubicBezTo>
                  <a:cubicBezTo>
                    <a:pt x="4575046" y="1451456"/>
                    <a:pt x="4631598" y="1417215"/>
                    <a:pt x="4581427" y="1442301"/>
                  </a:cubicBezTo>
                  <a:cubicBezTo>
                    <a:pt x="4578285" y="1447014"/>
                    <a:pt x="4576804" y="1453439"/>
                    <a:pt x="4572000" y="1456441"/>
                  </a:cubicBezTo>
                  <a:cubicBezTo>
                    <a:pt x="4563574" y="1461707"/>
                    <a:pt x="4553147" y="1462726"/>
                    <a:pt x="4543720" y="1465868"/>
                  </a:cubicBezTo>
                  <a:lnTo>
                    <a:pt x="4529580" y="1470581"/>
                  </a:lnTo>
                  <a:cubicBezTo>
                    <a:pt x="4524866" y="1472152"/>
                    <a:pt x="4520259" y="1474090"/>
                    <a:pt x="4515439" y="1475295"/>
                  </a:cubicBezTo>
                  <a:cubicBezTo>
                    <a:pt x="4509155" y="1476866"/>
                    <a:pt x="4502988" y="1479023"/>
                    <a:pt x="4496586" y="1480008"/>
                  </a:cubicBezTo>
                  <a:cubicBezTo>
                    <a:pt x="4482524" y="1482171"/>
                    <a:pt x="4468305" y="1483150"/>
                    <a:pt x="4454165" y="1484721"/>
                  </a:cubicBezTo>
                  <a:cubicBezTo>
                    <a:pt x="4447881" y="1486292"/>
                    <a:pt x="4441636" y="1488030"/>
                    <a:pt x="4435312" y="1489435"/>
                  </a:cubicBezTo>
                  <a:cubicBezTo>
                    <a:pt x="4427492" y="1491173"/>
                    <a:pt x="4418701" y="1490173"/>
                    <a:pt x="4411745" y="1494148"/>
                  </a:cubicBezTo>
                  <a:cubicBezTo>
                    <a:pt x="4406827" y="1496958"/>
                    <a:pt x="4405944" y="1503936"/>
                    <a:pt x="4402318" y="1508288"/>
                  </a:cubicBezTo>
                  <a:cubicBezTo>
                    <a:pt x="4398051" y="1513409"/>
                    <a:pt x="4392891" y="1517715"/>
                    <a:pt x="4388178" y="1522429"/>
                  </a:cubicBezTo>
                  <a:cubicBezTo>
                    <a:pt x="4375607" y="1560138"/>
                    <a:pt x="4394463" y="1516143"/>
                    <a:pt x="4369324" y="1541282"/>
                  </a:cubicBezTo>
                  <a:cubicBezTo>
                    <a:pt x="4365811" y="1544795"/>
                    <a:pt x="4365976" y="1550645"/>
                    <a:pt x="4364611" y="1555422"/>
                  </a:cubicBezTo>
                  <a:cubicBezTo>
                    <a:pt x="4364236" y="1556736"/>
                    <a:pt x="4357694" y="1585279"/>
                    <a:pt x="4355184" y="1588416"/>
                  </a:cubicBezTo>
                  <a:cubicBezTo>
                    <a:pt x="4351645" y="1592840"/>
                    <a:pt x="4345757" y="1594701"/>
                    <a:pt x="4341044" y="1597843"/>
                  </a:cubicBezTo>
                  <a:cubicBezTo>
                    <a:pt x="4337902" y="1602556"/>
                    <a:pt x="4334151" y="1606916"/>
                    <a:pt x="4331617" y="1611983"/>
                  </a:cubicBezTo>
                  <a:cubicBezTo>
                    <a:pt x="4325268" y="1624681"/>
                    <a:pt x="4329480" y="1629761"/>
                    <a:pt x="4317477" y="1640264"/>
                  </a:cubicBezTo>
                  <a:cubicBezTo>
                    <a:pt x="4297533" y="1657715"/>
                    <a:pt x="4294475" y="1657357"/>
                    <a:pt x="4275056" y="1663831"/>
                  </a:cubicBezTo>
                  <a:cubicBezTo>
                    <a:pt x="4270343" y="1668544"/>
                    <a:pt x="4264614" y="1672425"/>
                    <a:pt x="4260916" y="1677971"/>
                  </a:cubicBezTo>
                  <a:cubicBezTo>
                    <a:pt x="4258160" y="1682105"/>
                    <a:pt x="4260915" y="1690540"/>
                    <a:pt x="4256202" y="1692111"/>
                  </a:cubicBezTo>
                  <a:cubicBezTo>
                    <a:pt x="4239739" y="1697599"/>
                    <a:pt x="4221637" y="1695253"/>
                    <a:pt x="4204355" y="1696824"/>
                  </a:cubicBezTo>
                  <a:cubicBezTo>
                    <a:pt x="4198070" y="1706251"/>
                    <a:pt x="4196493" y="1722357"/>
                    <a:pt x="4185501" y="1725105"/>
                  </a:cubicBezTo>
                  <a:cubicBezTo>
                    <a:pt x="4179455" y="1726616"/>
                    <a:pt x="4159272" y="1731150"/>
                    <a:pt x="4152507" y="1734532"/>
                  </a:cubicBezTo>
                  <a:cubicBezTo>
                    <a:pt x="4147440" y="1737065"/>
                    <a:pt x="4143080" y="1740816"/>
                    <a:pt x="4138367" y="1743958"/>
                  </a:cubicBezTo>
                  <a:cubicBezTo>
                    <a:pt x="4135225" y="1753385"/>
                    <a:pt x="4138367" y="1769097"/>
                    <a:pt x="4128940" y="1772239"/>
                  </a:cubicBezTo>
                  <a:cubicBezTo>
                    <a:pt x="4095286" y="1783457"/>
                    <a:pt x="4108928" y="1776154"/>
                    <a:pt x="4086520" y="1791092"/>
                  </a:cubicBezTo>
                  <a:cubicBezTo>
                    <a:pt x="4069327" y="1842669"/>
                    <a:pt x="4096747" y="1764546"/>
                    <a:pt x="4072380" y="1819373"/>
                  </a:cubicBezTo>
                  <a:cubicBezTo>
                    <a:pt x="4068344" y="1828453"/>
                    <a:pt x="4066095" y="1838226"/>
                    <a:pt x="4062953" y="1847653"/>
                  </a:cubicBezTo>
                  <a:lnTo>
                    <a:pt x="4058239" y="1861793"/>
                  </a:lnTo>
                  <a:cubicBezTo>
                    <a:pt x="4056668" y="1866507"/>
                    <a:pt x="4056282" y="1871800"/>
                    <a:pt x="4053526" y="1875934"/>
                  </a:cubicBezTo>
                  <a:lnTo>
                    <a:pt x="4044099" y="1890074"/>
                  </a:lnTo>
                  <a:cubicBezTo>
                    <a:pt x="4042528" y="1896358"/>
                    <a:pt x="4041938" y="1902973"/>
                    <a:pt x="4039386" y="1908927"/>
                  </a:cubicBezTo>
                  <a:cubicBezTo>
                    <a:pt x="4037154" y="1914134"/>
                    <a:pt x="4032492" y="1918001"/>
                    <a:pt x="4029959" y="1923068"/>
                  </a:cubicBezTo>
                  <a:cubicBezTo>
                    <a:pt x="4027737" y="1927512"/>
                    <a:pt x="4026817" y="1932495"/>
                    <a:pt x="4025246" y="1937208"/>
                  </a:cubicBezTo>
                  <a:cubicBezTo>
                    <a:pt x="4021601" y="1984581"/>
                    <a:pt x="4037160" y="1992525"/>
                    <a:pt x="4006392" y="2007909"/>
                  </a:cubicBezTo>
                  <a:cubicBezTo>
                    <a:pt x="4001948" y="2010131"/>
                    <a:pt x="3996965" y="2011051"/>
                    <a:pt x="3992252" y="2012622"/>
                  </a:cubicBezTo>
                  <a:cubicBezTo>
                    <a:pt x="3978351" y="2021889"/>
                    <a:pt x="3975309" y="2022583"/>
                    <a:pt x="3963971" y="2036189"/>
                  </a:cubicBezTo>
                  <a:cubicBezTo>
                    <a:pt x="3960344" y="2040541"/>
                    <a:pt x="3958968" y="2046791"/>
                    <a:pt x="3954545" y="2050330"/>
                  </a:cubicBezTo>
                  <a:cubicBezTo>
                    <a:pt x="3950665" y="2053434"/>
                    <a:pt x="3945118" y="2053472"/>
                    <a:pt x="3940404" y="2055043"/>
                  </a:cubicBezTo>
                  <a:cubicBezTo>
                    <a:pt x="3935691" y="2059756"/>
                    <a:pt x="3931526" y="2065091"/>
                    <a:pt x="3926264" y="2069183"/>
                  </a:cubicBezTo>
                  <a:cubicBezTo>
                    <a:pt x="3917321" y="2076139"/>
                    <a:pt x="3897984" y="2088037"/>
                    <a:pt x="3897984" y="2088037"/>
                  </a:cubicBezTo>
                  <a:cubicBezTo>
                    <a:pt x="3896413" y="2092750"/>
                    <a:pt x="3897087" y="2098996"/>
                    <a:pt x="3893270" y="2102177"/>
                  </a:cubicBezTo>
                  <a:cubicBezTo>
                    <a:pt x="3886770" y="2107593"/>
                    <a:pt x="3878099" y="2110555"/>
                    <a:pt x="3869703" y="2111604"/>
                  </a:cubicBezTo>
                  <a:cubicBezTo>
                    <a:pt x="3840041" y="2115312"/>
                    <a:pt x="3810000" y="2114746"/>
                    <a:pt x="3780149" y="2116317"/>
                  </a:cubicBezTo>
                  <a:cubicBezTo>
                    <a:pt x="3775436" y="2117888"/>
                    <a:pt x="3769889" y="2117927"/>
                    <a:pt x="3766009" y="2121031"/>
                  </a:cubicBezTo>
                  <a:cubicBezTo>
                    <a:pt x="3757703" y="2127676"/>
                    <a:pt x="3754973" y="2139996"/>
                    <a:pt x="3751868" y="2149311"/>
                  </a:cubicBezTo>
                  <a:cubicBezTo>
                    <a:pt x="3753439" y="2157167"/>
                    <a:pt x="3754639" y="2165106"/>
                    <a:pt x="3756582" y="2172878"/>
                  </a:cubicBezTo>
                  <a:cubicBezTo>
                    <a:pt x="3757787" y="2177698"/>
                    <a:pt x="3761295" y="2182050"/>
                    <a:pt x="3761295" y="2187018"/>
                  </a:cubicBezTo>
                  <a:cubicBezTo>
                    <a:pt x="3761295" y="2193496"/>
                    <a:pt x="3758443" y="2199667"/>
                    <a:pt x="3756582" y="2205872"/>
                  </a:cubicBezTo>
                  <a:cubicBezTo>
                    <a:pt x="3750484" y="2226200"/>
                    <a:pt x="3747674" y="2235601"/>
                    <a:pt x="3737728" y="2253006"/>
                  </a:cubicBezTo>
                  <a:cubicBezTo>
                    <a:pt x="3734917" y="2257924"/>
                    <a:pt x="3732307" y="2263140"/>
                    <a:pt x="3728301" y="2267146"/>
                  </a:cubicBezTo>
                  <a:cubicBezTo>
                    <a:pt x="3724295" y="2271152"/>
                    <a:pt x="3718874" y="2273431"/>
                    <a:pt x="3714161" y="2276573"/>
                  </a:cubicBezTo>
                  <a:cubicBezTo>
                    <a:pt x="3696877" y="2311139"/>
                    <a:pt x="3710985" y="2278790"/>
                    <a:pt x="3700021" y="2318993"/>
                  </a:cubicBezTo>
                  <a:cubicBezTo>
                    <a:pt x="3697406" y="2328580"/>
                    <a:pt x="3698862" y="2341762"/>
                    <a:pt x="3690594" y="2347274"/>
                  </a:cubicBezTo>
                  <a:lnTo>
                    <a:pt x="3676454" y="2356701"/>
                  </a:lnTo>
                  <a:cubicBezTo>
                    <a:pt x="3674883" y="2361414"/>
                    <a:pt x="3674844" y="2366961"/>
                    <a:pt x="3671740" y="2370841"/>
                  </a:cubicBezTo>
                  <a:cubicBezTo>
                    <a:pt x="3665094" y="2379148"/>
                    <a:pt x="3652776" y="2381876"/>
                    <a:pt x="3643460" y="2384981"/>
                  </a:cubicBezTo>
                  <a:cubicBezTo>
                    <a:pt x="3640318" y="2389694"/>
                    <a:pt x="3638837" y="2396119"/>
                    <a:pt x="3634033" y="2399121"/>
                  </a:cubicBezTo>
                  <a:cubicBezTo>
                    <a:pt x="3602833" y="2418621"/>
                    <a:pt x="3501405" y="2413085"/>
                    <a:pt x="3497345" y="2413262"/>
                  </a:cubicBezTo>
                  <a:cubicBezTo>
                    <a:pt x="3458602" y="2426175"/>
                    <a:pt x="3465564" y="2425769"/>
                    <a:pt x="3393650" y="2413262"/>
                  </a:cubicBezTo>
                  <a:cubicBezTo>
                    <a:pt x="3385910" y="2411916"/>
                    <a:pt x="3381617" y="2403019"/>
                    <a:pt x="3374796" y="2399121"/>
                  </a:cubicBezTo>
                  <a:cubicBezTo>
                    <a:pt x="3363828" y="2392854"/>
                    <a:pt x="3334912" y="2390731"/>
                    <a:pt x="3327662" y="2389695"/>
                  </a:cubicBezTo>
                  <a:cubicBezTo>
                    <a:pt x="3318235" y="2386553"/>
                    <a:pt x="3309082" y="2382424"/>
                    <a:pt x="3299382" y="2380268"/>
                  </a:cubicBezTo>
                  <a:cubicBezTo>
                    <a:pt x="3252111" y="2369763"/>
                    <a:pt x="3270703" y="2375422"/>
                    <a:pt x="3242821" y="2366127"/>
                  </a:cubicBezTo>
                  <a:cubicBezTo>
                    <a:pt x="3232536" y="2335275"/>
                    <a:pt x="3246820" y="2365556"/>
                    <a:pt x="3223967" y="2347274"/>
                  </a:cubicBezTo>
                  <a:cubicBezTo>
                    <a:pt x="3219543" y="2343735"/>
                    <a:pt x="3218546" y="2337140"/>
                    <a:pt x="3214540" y="2333134"/>
                  </a:cubicBezTo>
                  <a:cubicBezTo>
                    <a:pt x="3210534" y="2329128"/>
                    <a:pt x="3205113" y="2326849"/>
                    <a:pt x="3200400" y="2323707"/>
                  </a:cubicBezTo>
                  <a:cubicBezTo>
                    <a:pt x="3198829" y="2318994"/>
                    <a:pt x="3199200" y="2313080"/>
                    <a:pt x="3195687" y="2309567"/>
                  </a:cubicBezTo>
                  <a:cubicBezTo>
                    <a:pt x="3187676" y="2301556"/>
                    <a:pt x="3176470" y="2297511"/>
                    <a:pt x="3167406" y="2290713"/>
                  </a:cubicBezTo>
                  <a:cubicBezTo>
                    <a:pt x="3161122" y="2286000"/>
                    <a:pt x="3155373" y="2280471"/>
                    <a:pt x="3148553" y="2276573"/>
                  </a:cubicBezTo>
                  <a:cubicBezTo>
                    <a:pt x="3144239" y="2274108"/>
                    <a:pt x="3139126" y="2273430"/>
                    <a:pt x="3134413" y="2271859"/>
                  </a:cubicBezTo>
                  <a:cubicBezTo>
                    <a:pt x="3096706" y="2273430"/>
                    <a:pt x="3058800" y="2272405"/>
                    <a:pt x="3021291" y="2276573"/>
                  </a:cubicBezTo>
                  <a:cubicBezTo>
                    <a:pt x="3015661" y="2277199"/>
                    <a:pt x="3012218" y="2283467"/>
                    <a:pt x="3007151" y="2286000"/>
                  </a:cubicBezTo>
                  <a:cubicBezTo>
                    <a:pt x="3002707" y="2288222"/>
                    <a:pt x="2997724" y="2289142"/>
                    <a:pt x="2993011" y="2290713"/>
                  </a:cubicBezTo>
                  <a:cubicBezTo>
                    <a:pt x="2988297" y="2293855"/>
                    <a:pt x="2982876" y="2296134"/>
                    <a:pt x="2978870" y="2300140"/>
                  </a:cubicBezTo>
                  <a:cubicBezTo>
                    <a:pt x="2967668" y="2311342"/>
                    <a:pt x="2964683" y="2328563"/>
                    <a:pt x="2960017" y="2342560"/>
                  </a:cubicBezTo>
                  <a:cubicBezTo>
                    <a:pt x="2958446" y="2347274"/>
                    <a:pt x="2956277" y="2351829"/>
                    <a:pt x="2955303" y="2356701"/>
                  </a:cubicBezTo>
                  <a:cubicBezTo>
                    <a:pt x="2951855" y="2373943"/>
                    <a:pt x="2949138" y="2392599"/>
                    <a:pt x="2941163" y="2408548"/>
                  </a:cubicBezTo>
                  <a:cubicBezTo>
                    <a:pt x="2938021" y="2414833"/>
                    <a:pt x="2936309" y="2422067"/>
                    <a:pt x="2931736" y="2427402"/>
                  </a:cubicBezTo>
                  <a:cubicBezTo>
                    <a:pt x="2926624" y="2433366"/>
                    <a:pt x="2919167" y="2436829"/>
                    <a:pt x="2912883" y="2441542"/>
                  </a:cubicBezTo>
                  <a:cubicBezTo>
                    <a:pt x="2911312" y="2447827"/>
                    <a:pt x="2909439" y="2454044"/>
                    <a:pt x="2908169" y="2460396"/>
                  </a:cubicBezTo>
                  <a:cubicBezTo>
                    <a:pt x="2904724" y="2477621"/>
                    <a:pt x="2905499" y="2496029"/>
                    <a:pt x="2898743" y="2512243"/>
                  </a:cubicBezTo>
                  <a:cubicBezTo>
                    <a:pt x="2896832" y="2516829"/>
                    <a:pt x="2889316" y="2515385"/>
                    <a:pt x="2884602" y="2516956"/>
                  </a:cubicBezTo>
                  <a:cubicBezTo>
                    <a:pt x="2879889" y="2520098"/>
                    <a:pt x="2875639" y="2524082"/>
                    <a:pt x="2870462" y="2526383"/>
                  </a:cubicBezTo>
                  <a:cubicBezTo>
                    <a:pt x="2861382" y="2530419"/>
                    <a:pt x="2842182" y="2535810"/>
                    <a:pt x="2842182" y="2535810"/>
                  </a:cubicBezTo>
                  <a:cubicBezTo>
                    <a:pt x="2837469" y="2540523"/>
                    <a:pt x="2833829" y="2546643"/>
                    <a:pt x="2828042" y="2549950"/>
                  </a:cubicBezTo>
                  <a:cubicBezTo>
                    <a:pt x="2795264" y="2568681"/>
                    <a:pt x="2820152" y="2538218"/>
                    <a:pt x="2799761" y="2568804"/>
                  </a:cubicBezTo>
                  <a:cubicBezTo>
                    <a:pt x="2798190" y="2573517"/>
                    <a:pt x="2797270" y="2578500"/>
                    <a:pt x="2795048" y="2582944"/>
                  </a:cubicBezTo>
                  <a:cubicBezTo>
                    <a:pt x="2792515" y="2588011"/>
                    <a:pt x="2786552" y="2591496"/>
                    <a:pt x="2785621" y="2597084"/>
                  </a:cubicBezTo>
                  <a:cubicBezTo>
                    <a:pt x="2784804" y="2601985"/>
                    <a:pt x="2788763" y="2606511"/>
                    <a:pt x="2790334" y="2611224"/>
                  </a:cubicBezTo>
                  <a:cubicBezTo>
                    <a:pt x="2790293" y="2611390"/>
                    <a:pt x="2783163" y="2641962"/>
                    <a:pt x="2780907" y="2644218"/>
                  </a:cubicBezTo>
                  <a:cubicBezTo>
                    <a:pt x="2772896" y="2652229"/>
                    <a:pt x="2752627" y="2663072"/>
                    <a:pt x="2752627" y="2663072"/>
                  </a:cubicBezTo>
                  <a:cubicBezTo>
                    <a:pt x="2751056" y="2667785"/>
                    <a:pt x="2752358" y="2674990"/>
                    <a:pt x="2747914" y="2677212"/>
                  </a:cubicBezTo>
                  <a:cubicBezTo>
                    <a:pt x="2737977" y="2682180"/>
                    <a:pt x="2725850" y="2679938"/>
                    <a:pt x="2714920" y="2681925"/>
                  </a:cubicBezTo>
                  <a:cubicBezTo>
                    <a:pt x="2708546" y="2683084"/>
                    <a:pt x="2702351" y="2685068"/>
                    <a:pt x="2696066" y="2686639"/>
                  </a:cubicBezTo>
                  <a:cubicBezTo>
                    <a:pt x="2689782" y="2691352"/>
                    <a:pt x="2682768" y="2695224"/>
                    <a:pt x="2677213" y="2700779"/>
                  </a:cubicBezTo>
                  <a:cubicBezTo>
                    <a:pt x="2673207" y="2704785"/>
                    <a:pt x="2670320" y="2709852"/>
                    <a:pt x="2667786" y="2714919"/>
                  </a:cubicBezTo>
                  <a:cubicBezTo>
                    <a:pt x="2665564" y="2719363"/>
                    <a:pt x="2666585" y="2725546"/>
                    <a:pt x="2663072" y="2729059"/>
                  </a:cubicBezTo>
                  <a:cubicBezTo>
                    <a:pt x="2659559" y="2732572"/>
                    <a:pt x="2653645" y="2732202"/>
                    <a:pt x="2648932" y="2733773"/>
                  </a:cubicBezTo>
                  <a:cubicBezTo>
                    <a:pt x="2544316" y="2725054"/>
                    <a:pt x="2586116" y="2725914"/>
                    <a:pt x="2422689" y="2738486"/>
                  </a:cubicBezTo>
                  <a:cubicBezTo>
                    <a:pt x="2417735" y="2738867"/>
                    <a:pt x="2413369" y="2741995"/>
                    <a:pt x="2408549" y="2743200"/>
                  </a:cubicBezTo>
                  <a:cubicBezTo>
                    <a:pt x="2400777" y="2745143"/>
                    <a:pt x="2392838" y="2746342"/>
                    <a:pt x="2384982" y="2747913"/>
                  </a:cubicBezTo>
                  <a:cubicBezTo>
                    <a:pt x="2386553" y="2700779"/>
                    <a:pt x="2386926" y="2653590"/>
                    <a:pt x="2389695" y="2606511"/>
                  </a:cubicBezTo>
                  <a:cubicBezTo>
                    <a:pt x="2390075" y="2600044"/>
                    <a:pt x="2389490" y="2591873"/>
                    <a:pt x="2394409" y="2587657"/>
                  </a:cubicBezTo>
                  <a:cubicBezTo>
                    <a:pt x="2401953" y="2581190"/>
                    <a:pt x="2413802" y="2582675"/>
                    <a:pt x="2422689" y="2578231"/>
                  </a:cubicBezTo>
                  <a:lnTo>
                    <a:pt x="2441543" y="2568804"/>
                  </a:lnTo>
                  <a:cubicBezTo>
                    <a:pt x="2444685" y="2564091"/>
                    <a:pt x="2448436" y="2559731"/>
                    <a:pt x="2450969" y="2554664"/>
                  </a:cubicBezTo>
                  <a:cubicBezTo>
                    <a:pt x="2461848" y="2532906"/>
                    <a:pt x="2455404" y="2506139"/>
                    <a:pt x="2450969" y="2483963"/>
                  </a:cubicBezTo>
                  <a:cubicBezTo>
                    <a:pt x="2449858" y="2478408"/>
                    <a:pt x="2445966" y="2473361"/>
                    <a:pt x="2441543" y="2469822"/>
                  </a:cubicBezTo>
                  <a:cubicBezTo>
                    <a:pt x="2437663" y="2466718"/>
                    <a:pt x="2432116" y="2466680"/>
                    <a:pt x="2427402" y="2465109"/>
                  </a:cubicBezTo>
                  <a:cubicBezTo>
                    <a:pt x="2417975" y="2458824"/>
                    <a:pt x="2399876" y="2457559"/>
                    <a:pt x="2399122" y="2446255"/>
                  </a:cubicBezTo>
                  <a:cubicBezTo>
                    <a:pt x="2397551" y="2422688"/>
                    <a:pt x="2397017" y="2399029"/>
                    <a:pt x="2394409" y="2375554"/>
                  </a:cubicBezTo>
                  <a:cubicBezTo>
                    <a:pt x="2393860" y="2370616"/>
                    <a:pt x="2392108" y="2365757"/>
                    <a:pt x="2389695" y="2361414"/>
                  </a:cubicBezTo>
                  <a:cubicBezTo>
                    <a:pt x="2384193" y="2351510"/>
                    <a:pt x="2374425" y="2343882"/>
                    <a:pt x="2370842" y="2333134"/>
                  </a:cubicBezTo>
                  <a:cubicBezTo>
                    <a:pt x="2369271" y="2328420"/>
                    <a:pt x="2368884" y="2323127"/>
                    <a:pt x="2366128" y="2318993"/>
                  </a:cubicBezTo>
                  <a:cubicBezTo>
                    <a:pt x="2340266" y="2280200"/>
                    <a:pt x="2362088" y="2331564"/>
                    <a:pt x="2342561" y="2286000"/>
                  </a:cubicBezTo>
                  <a:cubicBezTo>
                    <a:pt x="2340604" y="2281433"/>
                    <a:pt x="2340070" y="2276303"/>
                    <a:pt x="2337848" y="2271859"/>
                  </a:cubicBezTo>
                  <a:cubicBezTo>
                    <a:pt x="2335315" y="2266792"/>
                    <a:pt x="2330722" y="2262896"/>
                    <a:pt x="2328421" y="2257719"/>
                  </a:cubicBezTo>
                  <a:cubicBezTo>
                    <a:pt x="2324385" y="2248639"/>
                    <a:pt x="2322136" y="2238866"/>
                    <a:pt x="2318994" y="2229439"/>
                  </a:cubicBezTo>
                  <a:cubicBezTo>
                    <a:pt x="2317423" y="2224726"/>
                    <a:pt x="2318994" y="2216870"/>
                    <a:pt x="2314281" y="2215299"/>
                  </a:cubicBezTo>
                  <a:lnTo>
                    <a:pt x="2300140" y="2210585"/>
                  </a:lnTo>
                  <a:cubicBezTo>
                    <a:pt x="2295427" y="2205872"/>
                    <a:pt x="2289307" y="2202232"/>
                    <a:pt x="2286000" y="2196445"/>
                  </a:cubicBezTo>
                  <a:cubicBezTo>
                    <a:pt x="2270682" y="2169638"/>
                    <a:pt x="2294642" y="2182042"/>
                    <a:pt x="2267147" y="2172878"/>
                  </a:cubicBezTo>
                  <a:cubicBezTo>
                    <a:pt x="2262433" y="2169736"/>
                    <a:pt x="2258073" y="2165984"/>
                    <a:pt x="2253006" y="2163451"/>
                  </a:cubicBezTo>
                  <a:cubicBezTo>
                    <a:pt x="2248562" y="2161229"/>
                    <a:pt x="2242746" y="2161842"/>
                    <a:pt x="2238866" y="2158738"/>
                  </a:cubicBezTo>
                  <a:cubicBezTo>
                    <a:pt x="2234442" y="2155199"/>
                    <a:pt x="2233862" y="2148137"/>
                    <a:pt x="2229439" y="2144598"/>
                  </a:cubicBezTo>
                  <a:cubicBezTo>
                    <a:pt x="2225559" y="2141494"/>
                    <a:pt x="2219912" y="2141729"/>
                    <a:pt x="2215299" y="2139884"/>
                  </a:cubicBezTo>
                  <a:cubicBezTo>
                    <a:pt x="2212037" y="2138579"/>
                    <a:pt x="2209014" y="2136742"/>
                    <a:pt x="2205872" y="2135171"/>
                  </a:cubicBezTo>
                </a:path>
              </a:pathLst>
            </a:cu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81" name="Freeform 180"/>
            <p:cNvSpPr/>
            <p:nvPr/>
          </p:nvSpPr>
          <p:spPr>
            <a:xfrm>
              <a:off x="1018440" y="7739452"/>
              <a:ext cx="618870" cy="189486"/>
            </a:xfrm>
            <a:custGeom>
              <a:avLst/>
              <a:gdLst>
                <a:gd name="connsiteX0" fmla="*/ 0 w 952107"/>
                <a:gd name="connsiteY0" fmla="*/ 207390 h 287518"/>
                <a:gd name="connsiteX1" fmla="*/ 18853 w 952107"/>
                <a:gd name="connsiteY1" fmla="*/ 193250 h 287518"/>
                <a:gd name="connsiteX2" fmla="*/ 32993 w 952107"/>
                <a:gd name="connsiteY2" fmla="*/ 164969 h 287518"/>
                <a:gd name="connsiteX3" fmla="*/ 51847 w 952107"/>
                <a:gd name="connsiteY3" fmla="*/ 160256 h 287518"/>
                <a:gd name="connsiteX4" fmla="*/ 94268 w 952107"/>
                <a:gd name="connsiteY4" fmla="*/ 155543 h 287518"/>
                <a:gd name="connsiteX5" fmla="*/ 98981 w 952107"/>
                <a:gd name="connsiteY5" fmla="*/ 141402 h 287518"/>
                <a:gd name="connsiteX6" fmla="*/ 108408 w 952107"/>
                <a:gd name="connsiteY6" fmla="*/ 122549 h 287518"/>
                <a:gd name="connsiteX7" fmla="*/ 113121 w 952107"/>
                <a:gd name="connsiteY7" fmla="*/ 103695 h 287518"/>
                <a:gd name="connsiteX8" fmla="*/ 117835 w 952107"/>
                <a:gd name="connsiteY8" fmla="*/ 32994 h 287518"/>
                <a:gd name="connsiteX9" fmla="*/ 131975 w 952107"/>
                <a:gd name="connsiteY9" fmla="*/ 23567 h 287518"/>
                <a:gd name="connsiteX10" fmla="*/ 136688 w 952107"/>
                <a:gd name="connsiteY10" fmla="*/ 9427 h 287518"/>
                <a:gd name="connsiteX11" fmla="*/ 164969 w 952107"/>
                <a:gd name="connsiteY11" fmla="*/ 0 h 287518"/>
                <a:gd name="connsiteX12" fmla="*/ 183822 w 952107"/>
                <a:gd name="connsiteY12" fmla="*/ 4714 h 287518"/>
                <a:gd name="connsiteX13" fmla="*/ 188536 w 952107"/>
                <a:gd name="connsiteY13" fmla="*/ 18854 h 287518"/>
                <a:gd name="connsiteX14" fmla="*/ 207389 w 952107"/>
                <a:gd name="connsiteY14" fmla="*/ 51848 h 287518"/>
                <a:gd name="connsiteX15" fmla="*/ 235670 w 952107"/>
                <a:gd name="connsiteY15" fmla="*/ 61275 h 287518"/>
                <a:gd name="connsiteX16" fmla="*/ 249810 w 952107"/>
                <a:gd name="connsiteY16" fmla="*/ 89555 h 287518"/>
                <a:gd name="connsiteX17" fmla="*/ 268664 w 952107"/>
                <a:gd name="connsiteY17" fmla="*/ 155543 h 287518"/>
                <a:gd name="connsiteX18" fmla="*/ 273377 w 952107"/>
                <a:gd name="connsiteY18" fmla="*/ 169683 h 287518"/>
                <a:gd name="connsiteX19" fmla="*/ 278090 w 952107"/>
                <a:gd name="connsiteY19" fmla="*/ 212104 h 287518"/>
                <a:gd name="connsiteX20" fmla="*/ 320511 w 952107"/>
                <a:gd name="connsiteY20" fmla="*/ 221530 h 287518"/>
                <a:gd name="connsiteX21" fmla="*/ 367645 w 952107"/>
                <a:gd name="connsiteY21" fmla="*/ 245097 h 287518"/>
                <a:gd name="connsiteX22" fmla="*/ 381785 w 952107"/>
                <a:gd name="connsiteY22" fmla="*/ 235671 h 287518"/>
                <a:gd name="connsiteX23" fmla="*/ 428919 w 952107"/>
                <a:gd name="connsiteY23" fmla="*/ 245097 h 287518"/>
                <a:gd name="connsiteX24" fmla="*/ 447773 w 952107"/>
                <a:gd name="connsiteY24" fmla="*/ 249811 h 287518"/>
                <a:gd name="connsiteX25" fmla="*/ 476053 w 952107"/>
                <a:gd name="connsiteY25" fmla="*/ 259238 h 287518"/>
                <a:gd name="connsiteX26" fmla="*/ 485480 w 952107"/>
                <a:gd name="connsiteY26" fmla="*/ 273378 h 287518"/>
                <a:gd name="connsiteX27" fmla="*/ 499620 w 952107"/>
                <a:gd name="connsiteY27" fmla="*/ 278091 h 287518"/>
                <a:gd name="connsiteX28" fmla="*/ 589175 w 952107"/>
                <a:gd name="connsiteY28" fmla="*/ 273378 h 287518"/>
                <a:gd name="connsiteX29" fmla="*/ 622169 w 952107"/>
                <a:gd name="connsiteY29" fmla="*/ 268664 h 287518"/>
                <a:gd name="connsiteX30" fmla="*/ 645736 w 952107"/>
                <a:gd name="connsiteY30" fmla="*/ 263951 h 287518"/>
                <a:gd name="connsiteX31" fmla="*/ 692870 w 952107"/>
                <a:gd name="connsiteY31" fmla="*/ 268664 h 287518"/>
                <a:gd name="connsiteX32" fmla="*/ 711723 w 952107"/>
                <a:gd name="connsiteY32" fmla="*/ 278091 h 287518"/>
                <a:gd name="connsiteX33" fmla="*/ 740004 w 952107"/>
                <a:gd name="connsiteY33" fmla="*/ 287518 h 287518"/>
                <a:gd name="connsiteX34" fmla="*/ 754144 w 952107"/>
                <a:gd name="connsiteY34" fmla="*/ 278091 h 287518"/>
                <a:gd name="connsiteX35" fmla="*/ 758857 w 952107"/>
                <a:gd name="connsiteY35" fmla="*/ 263951 h 287518"/>
                <a:gd name="connsiteX36" fmla="*/ 777711 w 952107"/>
                <a:gd name="connsiteY36" fmla="*/ 230957 h 287518"/>
                <a:gd name="connsiteX37" fmla="*/ 791851 w 952107"/>
                <a:gd name="connsiteY37" fmla="*/ 226244 h 287518"/>
                <a:gd name="connsiteX38" fmla="*/ 805991 w 952107"/>
                <a:gd name="connsiteY38" fmla="*/ 212104 h 287518"/>
                <a:gd name="connsiteX39" fmla="*/ 810705 w 952107"/>
                <a:gd name="connsiteY39" fmla="*/ 197963 h 287518"/>
                <a:gd name="connsiteX40" fmla="*/ 829558 w 952107"/>
                <a:gd name="connsiteY40" fmla="*/ 169683 h 287518"/>
                <a:gd name="connsiteX41" fmla="*/ 857839 w 952107"/>
                <a:gd name="connsiteY41" fmla="*/ 146116 h 287518"/>
                <a:gd name="connsiteX42" fmla="*/ 942680 w 952107"/>
                <a:gd name="connsiteY42" fmla="*/ 141402 h 287518"/>
                <a:gd name="connsiteX43" fmla="*/ 952107 w 952107"/>
                <a:gd name="connsiteY43" fmla="*/ 127262 h 2875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</a:cxnLst>
              <a:rect l="l" t="t" r="r" b="b"/>
              <a:pathLst>
                <a:path w="952107" h="287518">
                  <a:moveTo>
                    <a:pt x="0" y="207390"/>
                  </a:moveTo>
                  <a:cubicBezTo>
                    <a:pt x="6284" y="202677"/>
                    <a:pt x="13824" y="199285"/>
                    <a:pt x="18853" y="193250"/>
                  </a:cubicBezTo>
                  <a:cubicBezTo>
                    <a:pt x="30613" y="179138"/>
                    <a:pt x="14820" y="177085"/>
                    <a:pt x="32993" y="164969"/>
                  </a:cubicBezTo>
                  <a:cubicBezTo>
                    <a:pt x="38383" y="161376"/>
                    <a:pt x="45444" y="161241"/>
                    <a:pt x="51847" y="160256"/>
                  </a:cubicBezTo>
                  <a:cubicBezTo>
                    <a:pt x="65909" y="158093"/>
                    <a:pt x="80128" y="157114"/>
                    <a:pt x="94268" y="155543"/>
                  </a:cubicBezTo>
                  <a:cubicBezTo>
                    <a:pt x="95839" y="150829"/>
                    <a:pt x="97024" y="145969"/>
                    <a:pt x="98981" y="141402"/>
                  </a:cubicBezTo>
                  <a:cubicBezTo>
                    <a:pt x="101749" y="134944"/>
                    <a:pt x="105941" y="129128"/>
                    <a:pt x="108408" y="122549"/>
                  </a:cubicBezTo>
                  <a:cubicBezTo>
                    <a:pt x="110683" y="116483"/>
                    <a:pt x="111550" y="109980"/>
                    <a:pt x="113121" y="103695"/>
                  </a:cubicBezTo>
                  <a:cubicBezTo>
                    <a:pt x="114692" y="80128"/>
                    <a:pt x="112425" y="55985"/>
                    <a:pt x="117835" y="32994"/>
                  </a:cubicBezTo>
                  <a:cubicBezTo>
                    <a:pt x="119132" y="27480"/>
                    <a:pt x="128436" y="27991"/>
                    <a:pt x="131975" y="23567"/>
                  </a:cubicBezTo>
                  <a:cubicBezTo>
                    <a:pt x="135079" y="19687"/>
                    <a:pt x="132645" y="12315"/>
                    <a:pt x="136688" y="9427"/>
                  </a:cubicBezTo>
                  <a:cubicBezTo>
                    <a:pt x="144774" y="3651"/>
                    <a:pt x="164969" y="0"/>
                    <a:pt x="164969" y="0"/>
                  </a:cubicBezTo>
                  <a:cubicBezTo>
                    <a:pt x="171253" y="1571"/>
                    <a:pt x="178764" y="667"/>
                    <a:pt x="183822" y="4714"/>
                  </a:cubicBezTo>
                  <a:cubicBezTo>
                    <a:pt x="187702" y="7818"/>
                    <a:pt x="186579" y="14287"/>
                    <a:pt x="188536" y="18854"/>
                  </a:cubicBezTo>
                  <a:cubicBezTo>
                    <a:pt x="189697" y="21562"/>
                    <a:pt x="202772" y="48962"/>
                    <a:pt x="207389" y="51848"/>
                  </a:cubicBezTo>
                  <a:cubicBezTo>
                    <a:pt x="215815" y="57115"/>
                    <a:pt x="235670" y="61275"/>
                    <a:pt x="235670" y="61275"/>
                  </a:cubicBezTo>
                  <a:cubicBezTo>
                    <a:pt x="242148" y="70992"/>
                    <a:pt x="248309" y="77545"/>
                    <a:pt x="249810" y="89555"/>
                  </a:cubicBezTo>
                  <a:cubicBezTo>
                    <a:pt x="258226" y="156891"/>
                    <a:pt x="234284" y="144082"/>
                    <a:pt x="268664" y="155543"/>
                  </a:cubicBezTo>
                  <a:cubicBezTo>
                    <a:pt x="270235" y="160256"/>
                    <a:pt x="272560" y="164782"/>
                    <a:pt x="273377" y="169683"/>
                  </a:cubicBezTo>
                  <a:cubicBezTo>
                    <a:pt x="275716" y="183717"/>
                    <a:pt x="268520" y="201577"/>
                    <a:pt x="278090" y="212104"/>
                  </a:cubicBezTo>
                  <a:cubicBezTo>
                    <a:pt x="287834" y="222822"/>
                    <a:pt x="306371" y="218388"/>
                    <a:pt x="320511" y="221530"/>
                  </a:cubicBezTo>
                  <a:cubicBezTo>
                    <a:pt x="333944" y="261828"/>
                    <a:pt x="320078" y="251044"/>
                    <a:pt x="367645" y="245097"/>
                  </a:cubicBezTo>
                  <a:cubicBezTo>
                    <a:pt x="372358" y="241955"/>
                    <a:pt x="376149" y="236235"/>
                    <a:pt x="381785" y="235671"/>
                  </a:cubicBezTo>
                  <a:cubicBezTo>
                    <a:pt x="402638" y="233586"/>
                    <a:pt x="411868" y="240225"/>
                    <a:pt x="428919" y="245097"/>
                  </a:cubicBezTo>
                  <a:cubicBezTo>
                    <a:pt x="435148" y="246877"/>
                    <a:pt x="441568" y="247949"/>
                    <a:pt x="447773" y="249811"/>
                  </a:cubicBezTo>
                  <a:cubicBezTo>
                    <a:pt x="457291" y="252666"/>
                    <a:pt x="476053" y="259238"/>
                    <a:pt x="476053" y="259238"/>
                  </a:cubicBezTo>
                  <a:cubicBezTo>
                    <a:pt x="479195" y="263951"/>
                    <a:pt x="481056" y="269839"/>
                    <a:pt x="485480" y="273378"/>
                  </a:cubicBezTo>
                  <a:cubicBezTo>
                    <a:pt x="489360" y="276482"/>
                    <a:pt x="494652" y="278091"/>
                    <a:pt x="499620" y="278091"/>
                  </a:cubicBezTo>
                  <a:cubicBezTo>
                    <a:pt x="529513" y="278091"/>
                    <a:pt x="559323" y="274949"/>
                    <a:pt x="589175" y="273378"/>
                  </a:cubicBezTo>
                  <a:cubicBezTo>
                    <a:pt x="600173" y="271807"/>
                    <a:pt x="611210" y="270490"/>
                    <a:pt x="622169" y="268664"/>
                  </a:cubicBezTo>
                  <a:cubicBezTo>
                    <a:pt x="630071" y="267347"/>
                    <a:pt x="637725" y="263951"/>
                    <a:pt x="645736" y="263951"/>
                  </a:cubicBezTo>
                  <a:cubicBezTo>
                    <a:pt x="661526" y="263951"/>
                    <a:pt x="677159" y="267093"/>
                    <a:pt x="692870" y="268664"/>
                  </a:cubicBezTo>
                  <a:cubicBezTo>
                    <a:pt x="699154" y="271806"/>
                    <a:pt x="705199" y="275481"/>
                    <a:pt x="711723" y="278091"/>
                  </a:cubicBezTo>
                  <a:cubicBezTo>
                    <a:pt x="720949" y="281782"/>
                    <a:pt x="740004" y="287518"/>
                    <a:pt x="740004" y="287518"/>
                  </a:cubicBezTo>
                  <a:cubicBezTo>
                    <a:pt x="744717" y="284376"/>
                    <a:pt x="750605" y="282515"/>
                    <a:pt x="754144" y="278091"/>
                  </a:cubicBezTo>
                  <a:cubicBezTo>
                    <a:pt x="757248" y="274211"/>
                    <a:pt x="756900" y="268518"/>
                    <a:pt x="758857" y="263951"/>
                  </a:cubicBezTo>
                  <a:cubicBezTo>
                    <a:pt x="760672" y="259715"/>
                    <a:pt x="772565" y="235074"/>
                    <a:pt x="777711" y="230957"/>
                  </a:cubicBezTo>
                  <a:cubicBezTo>
                    <a:pt x="781591" y="227853"/>
                    <a:pt x="787138" y="227815"/>
                    <a:pt x="791851" y="226244"/>
                  </a:cubicBezTo>
                  <a:cubicBezTo>
                    <a:pt x="796564" y="221531"/>
                    <a:pt x="802294" y="217650"/>
                    <a:pt x="805991" y="212104"/>
                  </a:cubicBezTo>
                  <a:cubicBezTo>
                    <a:pt x="808747" y="207970"/>
                    <a:pt x="808292" y="202306"/>
                    <a:pt x="810705" y="197963"/>
                  </a:cubicBezTo>
                  <a:cubicBezTo>
                    <a:pt x="816207" y="188059"/>
                    <a:pt x="822760" y="178746"/>
                    <a:pt x="829558" y="169683"/>
                  </a:cubicBezTo>
                  <a:cubicBezTo>
                    <a:pt x="840114" y="155608"/>
                    <a:pt x="840398" y="147777"/>
                    <a:pt x="857839" y="146116"/>
                  </a:cubicBezTo>
                  <a:cubicBezTo>
                    <a:pt x="886035" y="143431"/>
                    <a:pt x="914400" y="142973"/>
                    <a:pt x="942680" y="141402"/>
                  </a:cubicBezTo>
                  <a:lnTo>
                    <a:pt x="952107" y="127262"/>
                  </a:lnTo>
                </a:path>
              </a:pathLst>
            </a:cu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cxnSp>
          <p:nvCxnSpPr>
            <p:cNvPr id="182" name="Straight Connector 181"/>
            <p:cNvCxnSpPr>
              <a:endCxn id="186" idx="42"/>
            </p:cNvCxnSpPr>
            <p:nvPr/>
          </p:nvCxnSpPr>
          <p:spPr>
            <a:xfrm flipH="1">
              <a:off x="1631183" y="6571474"/>
              <a:ext cx="9191" cy="1261167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3" name="Straight Connector 182"/>
            <p:cNvCxnSpPr/>
            <p:nvPr/>
          </p:nvCxnSpPr>
          <p:spPr>
            <a:xfrm flipH="1">
              <a:off x="1635778" y="6571474"/>
              <a:ext cx="183823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4" name="Straight Connector 183"/>
            <p:cNvCxnSpPr/>
            <p:nvPr/>
          </p:nvCxnSpPr>
          <p:spPr>
            <a:xfrm>
              <a:off x="1811942" y="5888084"/>
              <a:ext cx="3063" cy="683391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85" name="Straight Connector 184"/>
            <p:cNvCxnSpPr/>
            <p:nvPr/>
          </p:nvCxnSpPr>
          <p:spPr>
            <a:xfrm>
              <a:off x="645348" y="5718336"/>
              <a:ext cx="714058" cy="4185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186" name="Freeform 185"/>
            <p:cNvSpPr/>
            <p:nvPr/>
          </p:nvSpPr>
          <p:spPr>
            <a:xfrm>
              <a:off x="209897" y="5640915"/>
              <a:ext cx="433388" cy="89976"/>
            </a:xfrm>
            <a:custGeom>
              <a:avLst/>
              <a:gdLst>
                <a:gd name="connsiteX0" fmla="*/ 0 w 666750"/>
                <a:gd name="connsiteY0" fmla="*/ 95250 h 136525"/>
                <a:gd name="connsiteX1" fmla="*/ 9525 w 666750"/>
                <a:gd name="connsiteY1" fmla="*/ 76200 h 136525"/>
                <a:gd name="connsiteX2" fmla="*/ 19050 w 666750"/>
                <a:gd name="connsiteY2" fmla="*/ 73025 h 136525"/>
                <a:gd name="connsiteX3" fmla="*/ 28575 w 666750"/>
                <a:gd name="connsiteY3" fmla="*/ 66675 h 136525"/>
                <a:gd name="connsiteX4" fmla="*/ 88900 w 666750"/>
                <a:gd name="connsiteY4" fmla="*/ 63500 h 136525"/>
                <a:gd name="connsiteX5" fmla="*/ 139700 w 666750"/>
                <a:gd name="connsiteY5" fmla="*/ 66675 h 136525"/>
                <a:gd name="connsiteX6" fmla="*/ 149225 w 666750"/>
                <a:gd name="connsiteY6" fmla="*/ 73025 h 136525"/>
                <a:gd name="connsiteX7" fmla="*/ 158750 w 666750"/>
                <a:gd name="connsiteY7" fmla="*/ 76200 h 136525"/>
                <a:gd name="connsiteX8" fmla="*/ 180975 w 666750"/>
                <a:gd name="connsiteY8" fmla="*/ 82550 h 136525"/>
                <a:gd name="connsiteX9" fmla="*/ 231775 w 666750"/>
                <a:gd name="connsiteY9" fmla="*/ 76200 h 136525"/>
                <a:gd name="connsiteX10" fmla="*/ 241300 w 666750"/>
                <a:gd name="connsiteY10" fmla="*/ 66675 h 136525"/>
                <a:gd name="connsiteX11" fmla="*/ 260350 w 666750"/>
                <a:gd name="connsiteY11" fmla="*/ 53975 h 136525"/>
                <a:gd name="connsiteX12" fmla="*/ 269875 w 666750"/>
                <a:gd name="connsiteY12" fmla="*/ 47625 h 136525"/>
                <a:gd name="connsiteX13" fmla="*/ 288925 w 666750"/>
                <a:gd name="connsiteY13" fmla="*/ 41275 h 136525"/>
                <a:gd name="connsiteX14" fmla="*/ 298450 w 666750"/>
                <a:gd name="connsiteY14" fmla="*/ 38100 h 136525"/>
                <a:gd name="connsiteX15" fmla="*/ 330200 w 666750"/>
                <a:gd name="connsiteY15" fmla="*/ 28575 h 136525"/>
                <a:gd name="connsiteX16" fmla="*/ 339725 w 666750"/>
                <a:gd name="connsiteY16" fmla="*/ 25400 h 136525"/>
                <a:gd name="connsiteX17" fmla="*/ 361950 w 666750"/>
                <a:gd name="connsiteY17" fmla="*/ 12700 h 136525"/>
                <a:gd name="connsiteX18" fmla="*/ 371475 w 666750"/>
                <a:gd name="connsiteY18" fmla="*/ 9525 h 136525"/>
                <a:gd name="connsiteX19" fmla="*/ 390525 w 666750"/>
                <a:gd name="connsiteY19" fmla="*/ 0 h 136525"/>
                <a:gd name="connsiteX20" fmla="*/ 444500 w 666750"/>
                <a:gd name="connsiteY20" fmla="*/ 3175 h 136525"/>
                <a:gd name="connsiteX21" fmla="*/ 463550 w 666750"/>
                <a:gd name="connsiteY21" fmla="*/ 9525 h 136525"/>
                <a:gd name="connsiteX22" fmla="*/ 473075 w 666750"/>
                <a:gd name="connsiteY22" fmla="*/ 12700 h 136525"/>
                <a:gd name="connsiteX23" fmla="*/ 482600 w 666750"/>
                <a:gd name="connsiteY23" fmla="*/ 15875 h 136525"/>
                <a:gd name="connsiteX24" fmla="*/ 492125 w 666750"/>
                <a:gd name="connsiteY24" fmla="*/ 38100 h 136525"/>
                <a:gd name="connsiteX25" fmla="*/ 495300 w 666750"/>
                <a:gd name="connsiteY25" fmla="*/ 47625 h 136525"/>
                <a:gd name="connsiteX26" fmla="*/ 504825 w 666750"/>
                <a:gd name="connsiteY26" fmla="*/ 50800 h 136525"/>
                <a:gd name="connsiteX27" fmla="*/ 514350 w 666750"/>
                <a:gd name="connsiteY27" fmla="*/ 57150 h 136525"/>
                <a:gd name="connsiteX28" fmla="*/ 523875 w 666750"/>
                <a:gd name="connsiteY28" fmla="*/ 69850 h 136525"/>
                <a:gd name="connsiteX29" fmla="*/ 542925 w 666750"/>
                <a:gd name="connsiteY29" fmla="*/ 82550 h 136525"/>
                <a:gd name="connsiteX30" fmla="*/ 552450 w 666750"/>
                <a:gd name="connsiteY30" fmla="*/ 101600 h 136525"/>
                <a:gd name="connsiteX31" fmla="*/ 561975 w 666750"/>
                <a:gd name="connsiteY31" fmla="*/ 104775 h 136525"/>
                <a:gd name="connsiteX32" fmla="*/ 571500 w 666750"/>
                <a:gd name="connsiteY32" fmla="*/ 114300 h 136525"/>
                <a:gd name="connsiteX33" fmla="*/ 581025 w 666750"/>
                <a:gd name="connsiteY33" fmla="*/ 117475 h 136525"/>
                <a:gd name="connsiteX34" fmla="*/ 587375 w 666750"/>
                <a:gd name="connsiteY34" fmla="*/ 127000 h 136525"/>
                <a:gd name="connsiteX35" fmla="*/ 606425 w 666750"/>
                <a:gd name="connsiteY35" fmla="*/ 133350 h 136525"/>
                <a:gd name="connsiteX36" fmla="*/ 615950 w 666750"/>
                <a:gd name="connsiteY36" fmla="*/ 136525 h 136525"/>
                <a:gd name="connsiteX37" fmla="*/ 654050 w 666750"/>
                <a:gd name="connsiteY37" fmla="*/ 127000 h 136525"/>
                <a:gd name="connsiteX38" fmla="*/ 666750 w 666750"/>
                <a:gd name="connsiteY38" fmla="*/ 117475 h 1365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</a:cxnLst>
              <a:rect l="l" t="t" r="r" b="b"/>
              <a:pathLst>
                <a:path w="666750" h="136525">
                  <a:moveTo>
                    <a:pt x="0" y="95250"/>
                  </a:moveTo>
                  <a:cubicBezTo>
                    <a:pt x="3175" y="88900"/>
                    <a:pt x="4905" y="81590"/>
                    <a:pt x="9525" y="76200"/>
                  </a:cubicBezTo>
                  <a:cubicBezTo>
                    <a:pt x="11703" y="73659"/>
                    <a:pt x="16057" y="74522"/>
                    <a:pt x="19050" y="73025"/>
                  </a:cubicBezTo>
                  <a:cubicBezTo>
                    <a:pt x="22463" y="71318"/>
                    <a:pt x="24794" y="67191"/>
                    <a:pt x="28575" y="66675"/>
                  </a:cubicBezTo>
                  <a:cubicBezTo>
                    <a:pt x="48527" y="63954"/>
                    <a:pt x="68792" y="64558"/>
                    <a:pt x="88900" y="63500"/>
                  </a:cubicBezTo>
                  <a:cubicBezTo>
                    <a:pt x="105833" y="64558"/>
                    <a:pt x="122941" y="64029"/>
                    <a:pt x="139700" y="66675"/>
                  </a:cubicBezTo>
                  <a:cubicBezTo>
                    <a:pt x="143469" y="67270"/>
                    <a:pt x="145812" y="71318"/>
                    <a:pt x="149225" y="73025"/>
                  </a:cubicBezTo>
                  <a:cubicBezTo>
                    <a:pt x="152218" y="74522"/>
                    <a:pt x="155544" y="75238"/>
                    <a:pt x="158750" y="76200"/>
                  </a:cubicBezTo>
                  <a:cubicBezTo>
                    <a:pt x="166130" y="78414"/>
                    <a:pt x="173567" y="80433"/>
                    <a:pt x="180975" y="82550"/>
                  </a:cubicBezTo>
                  <a:cubicBezTo>
                    <a:pt x="197908" y="80433"/>
                    <a:pt x="215272" y="80543"/>
                    <a:pt x="231775" y="76200"/>
                  </a:cubicBezTo>
                  <a:cubicBezTo>
                    <a:pt x="236117" y="75057"/>
                    <a:pt x="237756" y="69432"/>
                    <a:pt x="241300" y="66675"/>
                  </a:cubicBezTo>
                  <a:cubicBezTo>
                    <a:pt x="247324" y="61990"/>
                    <a:pt x="254000" y="58208"/>
                    <a:pt x="260350" y="53975"/>
                  </a:cubicBezTo>
                  <a:cubicBezTo>
                    <a:pt x="263525" y="51858"/>
                    <a:pt x="266255" y="48832"/>
                    <a:pt x="269875" y="47625"/>
                  </a:cubicBezTo>
                  <a:lnTo>
                    <a:pt x="288925" y="41275"/>
                  </a:lnTo>
                  <a:cubicBezTo>
                    <a:pt x="292100" y="40217"/>
                    <a:pt x="295168" y="38756"/>
                    <a:pt x="298450" y="38100"/>
                  </a:cubicBezTo>
                  <a:cubicBezTo>
                    <a:pt x="322739" y="33242"/>
                    <a:pt x="306331" y="37526"/>
                    <a:pt x="330200" y="28575"/>
                  </a:cubicBezTo>
                  <a:cubicBezTo>
                    <a:pt x="333334" y="27400"/>
                    <a:pt x="336732" y="26897"/>
                    <a:pt x="339725" y="25400"/>
                  </a:cubicBezTo>
                  <a:cubicBezTo>
                    <a:pt x="371611" y="9457"/>
                    <a:pt x="322986" y="29399"/>
                    <a:pt x="361950" y="12700"/>
                  </a:cubicBezTo>
                  <a:cubicBezTo>
                    <a:pt x="365026" y="11382"/>
                    <a:pt x="368482" y="11022"/>
                    <a:pt x="371475" y="9525"/>
                  </a:cubicBezTo>
                  <a:cubicBezTo>
                    <a:pt x="396094" y="-2785"/>
                    <a:pt x="366584" y="7980"/>
                    <a:pt x="390525" y="0"/>
                  </a:cubicBezTo>
                  <a:cubicBezTo>
                    <a:pt x="408517" y="1058"/>
                    <a:pt x="426629" y="844"/>
                    <a:pt x="444500" y="3175"/>
                  </a:cubicBezTo>
                  <a:cubicBezTo>
                    <a:pt x="451137" y="4041"/>
                    <a:pt x="457200" y="7408"/>
                    <a:pt x="463550" y="9525"/>
                  </a:cubicBezTo>
                  <a:lnTo>
                    <a:pt x="473075" y="12700"/>
                  </a:lnTo>
                  <a:lnTo>
                    <a:pt x="482600" y="15875"/>
                  </a:lnTo>
                  <a:cubicBezTo>
                    <a:pt x="490046" y="38213"/>
                    <a:pt x="480355" y="10637"/>
                    <a:pt x="492125" y="38100"/>
                  </a:cubicBezTo>
                  <a:cubicBezTo>
                    <a:pt x="493443" y="41176"/>
                    <a:pt x="492933" y="45258"/>
                    <a:pt x="495300" y="47625"/>
                  </a:cubicBezTo>
                  <a:cubicBezTo>
                    <a:pt x="497667" y="49992"/>
                    <a:pt x="501832" y="49303"/>
                    <a:pt x="504825" y="50800"/>
                  </a:cubicBezTo>
                  <a:cubicBezTo>
                    <a:pt x="508238" y="52507"/>
                    <a:pt x="511652" y="54452"/>
                    <a:pt x="514350" y="57150"/>
                  </a:cubicBezTo>
                  <a:cubicBezTo>
                    <a:pt x="518092" y="60892"/>
                    <a:pt x="519920" y="66334"/>
                    <a:pt x="523875" y="69850"/>
                  </a:cubicBezTo>
                  <a:cubicBezTo>
                    <a:pt x="529579" y="74920"/>
                    <a:pt x="542925" y="82550"/>
                    <a:pt x="542925" y="82550"/>
                  </a:cubicBezTo>
                  <a:cubicBezTo>
                    <a:pt x="545017" y="88825"/>
                    <a:pt x="546855" y="97124"/>
                    <a:pt x="552450" y="101600"/>
                  </a:cubicBezTo>
                  <a:cubicBezTo>
                    <a:pt x="555063" y="103691"/>
                    <a:pt x="558800" y="103717"/>
                    <a:pt x="561975" y="104775"/>
                  </a:cubicBezTo>
                  <a:cubicBezTo>
                    <a:pt x="565150" y="107950"/>
                    <a:pt x="567764" y="111809"/>
                    <a:pt x="571500" y="114300"/>
                  </a:cubicBezTo>
                  <a:cubicBezTo>
                    <a:pt x="574285" y="116156"/>
                    <a:pt x="578412" y="115384"/>
                    <a:pt x="581025" y="117475"/>
                  </a:cubicBezTo>
                  <a:cubicBezTo>
                    <a:pt x="584005" y="119859"/>
                    <a:pt x="584139" y="124978"/>
                    <a:pt x="587375" y="127000"/>
                  </a:cubicBezTo>
                  <a:cubicBezTo>
                    <a:pt x="593051" y="130548"/>
                    <a:pt x="600075" y="131233"/>
                    <a:pt x="606425" y="133350"/>
                  </a:cubicBezTo>
                  <a:lnTo>
                    <a:pt x="615950" y="136525"/>
                  </a:lnTo>
                  <a:cubicBezTo>
                    <a:pt x="625472" y="134938"/>
                    <a:pt x="645664" y="132590"/>
                    <a:pt x="654050" y="127000"/>
                  </a:cubicBezTo>
                  <a:cubicBezTo>
                    <a:pt x="664820" y="119820"/>
                    <a:pt x="660877" y="123348"/>
                    <a:pt x="666750" y="117475"/>
                  </a:cubicBezTo>
                </a:path>
              </a:pathLst>
            </a:cu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803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87" name="Freeform 186"/>
            <p:cNvSpPr/>
            <p:nvPr/>
          </p:nvSpPr>
          <p:spPr>
            <a:xfrm>
              <a:off x="1359406" y="5726706"/>
              <a:ext cx="1190784" cy="182043"/>
            </a:xfrm>
            <a:custGeom>
              <a:avLst/>
              <a:gdLst>
                <a:gd name="connsiteX0" fmla="*/ 0 w 1831975"/>
                <a:gd name="connsiteY0" fmla="*/ 0 h 276225"/>
                <a:gd name="connsiteX1" fmla="*/ 31750 w 1831975"/>
                <a:gd name="connsiteY1" fmla="*/ 22225 h 276225"/>
                <a:gd name="connsiteX2" fmla="*/ 63500 w 1831975"/>
                <a:gd name="connsiteY2" fmla="*/ 44450 h 276225"/>
                <a:gd name="connsiteX3" fmla="*/ 66675 w 1831975"/>
                <a:gd name="connsiteY3" fmla="*/ 53975 h 276225"/>
                <a:gd name="connsiteX4" fmla="*/ 76200 w 1831975"/>
                <a:gd name="connsiteY4" fmla="*/ 60325 h 276225"/>
                <a:gd name="connsiteX5" fmla="*/ 85725 w 1831975"/>
                <a:gd name="connsiteY5" fmla="*/ 69850 h 276225"/>
                <a:gd name="connsiteX6" fmla="*/ 95250 w 1831975"/>
                <a:gd name="connsiteY6" fmla="*/ 76200 h 276225"/>
                <a:gd name="connsiteX7" fmla="*/ 111125 w 1831975"/>
                <a:gd name="connsiteY7" fmla="*/ 95250 h 276225"/>
                <a:gd name="connsiteX8" fmla="*/ 130175 w 1831975"/>
                <a:gd name="connsiteY8" fmla="*/ 104775 h 276225"/>
                <a:gd name="connsiteX9" fmla="*/ 139700 w 1831975"/>
                <a:gd name="connsiteY9" fmla="*/ 114300 h 276225"/>
                <a:gd name="connsiteX10" fmla="*/ 165100 w 1831975"/>
                <a:gd name="connsiteY10" fmla="*/ 123825 h 276225"/>
                <a:gd name="connsiteX11" fmla="*/ 206375 w 1831975"/>
                <a:gd name="connsiteY11" fmla="*/ 117475 h 276225"/>
                <a:gd name="connsiteX12" fmla="*/ 225425 w 1831975"/>
                <a:gd name="connsiteY12" fmla="*/ 111125 h 276225"/>
                <a:gd name="connsiteX13" fmla="*/ 234950 w 1831975"/>
                <a:gd name="connsiteY13" fmla="*/ 107950 h 276225"/>
                <a:gd name="connsiteX14" fmla="*/ 269875 w 1831975"/>
                <a:gd name="connsiteY14" fmla="*/ 111125 h 276225"/>
                <a:gd name="connsiteX15" fmla="*/ 282575 w 1831975"/>
                <a:gd name="connsiteY15" fmla="*/ 114300 h 276225"/>
                <a:gd name="connsiteX16" fmla="*/ 346075 w 1831975"/>
                <a:gd name="connsiteY16" fmla="*/ 117475 h 276225"/>
                <a:gd name="connsiteX17" fmla="*/ 371475 w 1831975"/>
                <a:gd name="connsiteY17" fmla="*/ 120650 h 276225"/>
                <a:gd name="connsiteX18" fmla="*/ 384175 w 1831975"/>
                <a:gd name="connsiteY18" fmla="*/ 130175 h 276225"/>
                <a:gd name="connsiteX19" fmla="*/ 479425 w 1831975"/>
                <a:gd name="connsiteY19" fmla="*/ 120650 h 276225"/>
                <a:gd name="connsiteX20" fmla="*/ 501650 w 1831975"/>
                <a:gd name="connsiteY20" fmla="*/ 120650 h 276225"/>
                <a:gd name="connsiteX21" fmla="*/ 555625 w 1831975"/>
                <a:gd name="connsiteY21" fmla="*/ 123825 h 276225"/>
                <a:gd name="connsiteX22" fmla="*/ 577850 w 1831975"/>
                <a:gd name="connsiteY22" fmla="*/ 139700 h 276225"/>
                <a:gd name="connsiteX23" fmla="*/ 584200 w 1831975"/>
                <a:gd name="connsiteY23" fmla="*/ 149225 h 276225"/>
                <a:gd name="connsiteX24" fmla="*/ 593725 w 1831975"/>
                <a:gd name="connsiteY24" fmla="*/ 155575 h 276225"/>
                <a:gd name="connsiteX25" fmla="*/ 669925 w 1831975"/>
                <a:gd name="connsiteY25" fmla="*/ 165100 h 276225"/>
                <a:gd name="connsiteX26" fmla="*/ 692150 w 1831975"/>
                <a:gd name="connsiteY26" fmla="*/ 161925 h 276225"/>
                <a:gd name="connsiteX27" fmla="*/ 701675 w 1831975"/>
                <a:gd name="connsiteY27" fmla="*/ 155575 h 276225"/>
                <a:gd name="connsiteX28" fmla="*/ 714375 w 1831975"/>
                <a:gd name="connsiteY28" fmla="*/ 152400 h 276225"/>
                <a:gd name="connsiteX29" fmla="*/ 803275 w 1831975"/>
                <a:gd name="connsiteY29" fmla="*/ 158750 h 276225"/>
                <a:gd name="connsiteX30" fmla="*/ 822325 w 1831975"/>
                <a:gd name="connsiteY30" fmla="*/ 165100 h 276225"/>
                <a:gd name="connsiteX31" fmla="*/ 841375 w 1831975"/>
                <a:gd name="connsiteY31" fmla="*/ 168275 h 276225"/>
                <a:gd name="connsiteX32" fmla="*/ 882650 w 1831975"/>
                <a:gd name="connsiteY32" fmla="*/ 158750 h 276225"/>
                <a:gd name="connsiteX33" fmla="*/ 904875 w 1831975"/>
                <a:gd name="connsiteY33" fmla="*/ 146050 h 276225"/>
                <a:gd name="connsiteX34" fmla="*/ 917575 w 1831975"/>
                <a:gd name="connsiteY34" fmla="*/ 142875 h 276225"/>
                <a:gd name="connsiteX35" fmla="*/ 939800 w 1831975"/>
                <a:gd name="connsiteY35" fmla="*/ 133350 h 276225"/>
                <a:gd name="connsiteX36" fmla="*/ 974725 w 1831975"/>
                <a:gd name="connsiteY36" fmla="*/ 127000 h 276225"/>
                <a:gd name="connsiteX37" fmla="*/ 1028700 w 1831975"/>
                <a:gd name="connsiteY37" fmla="*/ 123825 h 276225"/>
                <a:gd name="connsiteX38" fmla="*/ 1054100 w 1831975"/>
                <a:gd name="connsiteY38" fmla="*/ 117475 h 276225"/>
                <a:gd name="connsiteX39" fmla="*/ 1143000 w 1831975"/>
                <a:gd name="connsiteY39" fmla="*/ 107950 h 276225"/>
                <a:gd name="connsiteX40" fmla="*/ 1187450 w 1831975"/>
                <a:gd name="connsiteY40" fmla="*/ 101600 h 276225"/>
                <a:gd name="connsiteX41" fmla="*/ 1206500 w 1831975"/>
                <a:gd name="connsiteY41" fmla="*/ 98425 h 276225"/>
                <a:gd name="connsiteX42" fmla="*/ 1263650 w 1831975"/>
                <a:gd name="connsiteY42" fmla="*/ 92075 h 276225"/>
                <a:gd name="connsiteX43" fmla="*/ 1273175 w 1831975"/>
                <a:gd name="connsiteY43" fmla="*/ 88900 h 276225"/>
                <a:gd name="connsiteX44" fmla="*/ 1282700 w 1831975"/>
                <a:gd name="connsiteY44" fmla="*/ 82550 h 276225"/>
                <a:gd name="connsiteX45" fmla="*/ 1298575 w 1831975"/>
                <a:gd name="connsiteY45" fmla="*/ 79375 h 276225"/>
                <a:gd name="connsiteX46" fmla="*/ 1327150 w 1831975"/>
                <a:gd name="connsiteY46" fmla="*/ 69850 h 276225"/>
                <a:gd name="connsiteX47" fmla="*/ 1362075 w 1831975"/>
                <a:gd name="connsiteY47" fmla="*/ 63500 h 276225"/>
                <a:gd name="connsiteX48" fmla="*/ 1377950 w 1831975"/>
                <a:gd name="connsiteY48" fmla="*/ 60325 h 276225"/>
                <a:gd name="connsiteX49" fmla="*/ 1397000 w 1831975"/>
                <a:gd name="connsiteY49" fmla="*/ 57150 h 276225"/>
                <a:gd name="connsiteX50" fmla="*/ 1406525 w 1831975"/>
                <a:gd name="connsiteY50" fmla="*/ 53975 h 276225"/>
                <a:gd name="connsiteX51" fmla="*/ 1422400 w 1831975"/>
                <a:gd name="connsiteY51" fmla="*/ 50800 h 276225"/>
                <a:gd name="connsiteX52" fmla="*/ 1454150 w 1831975"/>
                <a:gd name="connsiteY52" fmla="*/ 41275 h 276225"/>
                <a:gd name="connsiteX53" fmla="*/ 1489075 w 1831975"/>
                <a:gd name="connsiteY53" fmla="*/ 38100 h 276225"/>
                <a:gd name="connsiteX54" fmla="*/ 1501775 w 1831975"/>
                <a:gd name="connsiteY54" fmla="*/ 34925 h 276225"/>
                <a:gd name="connsiteX55" fmla="*/ 1511300 w 1831975"/>
                <a:gd name="connsiteY55" fmla="*/ 31750 h 276225"/>
                <a:gd name="connsiteX56" fmla="*/ 1533525 w 1831975"/>
                <a:gd name="connsiteY56" fmla="*/ 28575 h 276225"/>
                <a:gd name="connsiteX57" fmla="*/ 1555750 w 1831975"/>
                <a:gd name="connsiteY57" fmla="*/ 19050 h 276225"/>
                <a:gd name="connsiteX58" fmla="*/ 1590675 w 1831975"/>
                <a:gd name="connsiteY58" fmla="*/ 12700 h 276225"/>
                <a:gd name="connsiteX59" fmla="*/ 1612900 w 1831975"/>
                <a:gd name="connsiteY59" fmla="*/ 6350 h 276225"/>
                <a:gd name="connsiteX60" fmla="*/ 1641475 w 1831975"/>
                <a:gd name="connsiteY60" fmla="*/ 19050 h 276225"/>
                <a:gd name="connsiteX61" fmla="*/ 1660525 w 1831975"/>
                <a:gd name="connsiteY61" fmla="*/ 31750 h 276225"/>
                <a:gd name="connsiteX62" fmla="*/ 1679575 w 1831975"/>
                <a:gd name="connsiteY62" fmla="*/ 28575 h 276225"/>
                <a:gd name="connsiteX63" fmla="*/ 1692275 w 1831975"/>
                <a:gd name="connsiteY63" fmla="*/ 22225 h 276225"/>
                <a:gd name="connsiteX64" fmla="*/ 1701800 w 1831975"/>
                <a:gd name="connsiteY64" fmla="*/ 19050 h 276225"/>
                <a:gd name="connsiteX65" fmla="*/ 1771650 w 1831975"/>
                <a:gd name="connsiteY65" fmla="*/ 31750 h 276225"/>
                <a:gd name="connsiteX66" fmla="*/ 1781175 w 1831975"/>
                <a:gd name="connsiteY66" fmla="*/ 38100 h 276225"/>
                <a:gd name="connsiteX67" fmla="*/ 1793875 w 1831975"/>
                <a:gd name="connsiteY67" fmla="*/ 57150 h 276225"/>
                <a:gd name="connsiteX68" fmla="*/ 1800225 w 1831975"/>
                <a:gd name="connsiteY68" fmla="*/ 66675 h 276225"/>
                <a:gd name="connsiteX69" fmla="*/ 1809750 w 1831975"/>
                <a:gd name="connsiteY69" fmla="*/ 73025 h 276225"/>
                <a:gd name="connsiteX70" fmla="*/ 1831975 w 1831975"/>
                <a:gd name="connsiteY70" fmla="*/ 98425 h 276225"/>
                <a:gd name="connsiteX71" fmla="*/ 1822450 w 1831975"/>
                <a:gd name="connsiteY71" fmla="*/ 104775 h 276225"/>
                <a:gd name="connsiteX72" fmla="*/ 1762125 w 1831975"/>
                <a:gd name="connsiteY72" fmla="*/ 111125 h 276225"/>
                <a:gd name="connsiteX73" fmla="*/ 1711325 w 1831975"/>
                <a:gd name="connsiteY73" fmla="*/ 117475 h 276225"/>
                <a:gd name="connsiteX74" fmla="*/ 1698625 w 1831975"/>
                <a:gd name="connsiteY74" fmla="*/ 123825 h 276225"/>
                <a:gd name="connsiteX75" fmla="*/ 1692275 w 1831975"/>
                <a:gd name="connsiteY75" fmla="*/ 142875 h 276225"/>
                <a:gd name="connsiteX76" fmla="*/ 1679575 w 1831975"/>
                <a:gd name="connsiteY76" fmla="*/ 165100 h 276225"/>
                <a:gd name="connsiteX77" fmla="*/ 1670050 w 1831975"/>
                <a:gd name="connsiteY77" fmla="*/ 174625 h 276225"/>
                <a:gd name="connsiteX78" fmla="*/ 1638300 w 1831975"/>
                <a:gd name="connsiteY78" fmla="*/ 180975 h 276225"/>
                <a:gd name="connsiteX79" fmla="*/ 1619250 w 1831975"/>
                <a:gd name="connsiteY79" fmla="*/ 168275 h 276225"/>
                <a:gd name="connsiteX80" fmla="*/ 1606550 w 1831975"/>
                <a:gd name="connsiteY80" fmla="*/ 152400 h 276225"/>
                <a:gd name="connsiteX81" fmla="*/ 1590675 w 1831975"/>
                <a:gd name="connsiteY81" fmla="*/ 155575 h 276225"/>
                <a:gd name="connsiteX82" fmla="*/ 1562100 w 1831975"/>
                <a:gd name="connsiteY82" fmla="*/ 168275 h 276225"/>
                <a:gd name="connsiteX83" fmla="*/ 1533525 w 1831975"/>
                <a:gd name="connsiteY83" fmla="*/ 171450 h 276225"/>
                <a:gd name="connsiteX84" fmla="*/ 1524000 w 1831975"/>
                <a:gd name="connsiteY84" fmla="*/ 190500 h 276225"/>
                <a:gd name="connsiteX85" fmla="*/ 1498600 w 1831975"/>
                <a:gd name="connsiteY85" fmla="*/ 196850 h 276225"/>
                <a:gd name="connsiteX86" fmla="*/ 1489075 w 1831975"/>
                <a:gd name="connsiteY86" fmla="*/ 203200 h 276225"/>
                <a:gd name="connsiteX87" fmla="*/ 1479550 w 1831975"/>
                <a:gd name="connsiteY87" fmla="*/ 222250 h 276225"/>
                <a:gd name="connsiteX88" fmla="*/ 1470025 w 1831975"/>
                <a:gd name="connsiteY88" fmla="*/ 225425 h 276225"/>
                <a:gd name="connsiteX89" fmla="*/ 1457325 w 1831975"/>
                <a:gd name="connsiteY89" fmla="*/ 241300 h 276225"/>
                <a:gd name="connsiteX90" fmla="*/ 1447800 w 1831975"/>
                <a:gd name="connsiteY90" fmla="*/ 250825 h 276225"/>
                <a:gd name="connsiteX91" fmla="*/ 1438275 w 1831975"/>
                <a:gd name="connsiteY91" fmla="*/ 254000 h 276225"/>
                <a:gd name="connsiteX92" fmla="*/ 1419225 w 1831975"/>
                <a:gd name="connsiteY92" fmla="*/ 266700 h 276225"/>
                <a:gd name="connsiteX93" fmla="*/ 1384300 w 1831975"/>
                <a:gd name="connsiteY93" fmla="*/ 276225 h 276225"/>
                <a:gd name="connsiteX94" fmla="*/ 1365250 w 1831975"/>
                <a:gd name="connsiteY94" fmla="*/ 231775 h 276225"/>
                <a:gd name="connsiteX95" fmla="*/ 1355725 w 1831975"/>
                <a:gd name="connsiteY95" fmla="*/ 228600 h 276225"/>
                <a:gd name="connsiteX96" fmla="*/ 1346200 w 1831975"/>
                <a:gd name="connsiteY96" fmla="*/ 222250 h 276225"/>
                <a:gd name="connsiteX97" fmla="*/ 1323975 w 1831975"/>
                <a:gd name="connsiteY97" fmla="*/ 212725 h 276225"/>
                <a:gd name="connsiteX98" fmla="*/ 1314450 w 1831975"/>
                <a:gd name="connsiteY98" fmla="*/ 190500 h 276225"/>
                <a:gd name="connsiteX99" fmla="*/ 1311275 w 1831975"/>
                <a:gd name="connsiteY99" fmla="*/ 180975 h 276225"/>
                <a:gd name="connsiteX100" fmla="*/ 1301750 w 1831975"/>
                <a:gd name="connsiteY100" fmla="*/ 171450 h 276225"/>
                <a:gd name="connsiteX101" fmla="*/ 1285875 w 1831975"/>
                <a:gd name="connsiteY101" fmla="*/ 158750 h 276225"/>
                <a:gd name="connsiteX102" fmla="*/ 1241425 w 1831975"/>
                <a:gd name="connsiteY102" fmla="*/ 161925 h 276225"/>
                <a:gd name="connsiteX103" fmla="*/ 1225550 w 1831975"/>
                <a:gd name="connsiteY103" fmla="*/ 165100 h 276225"/>
                <a:gd name="connsiteX104" fmla="*/ 1162050 w 1831975"/>
                <a:gd name="connsiteY104" fmla="*/ 174625 h 276225"/>
                <a:gd name="connsiteX105" fmla="*/ 1111250 w 1831975"/>
                <a:gd name="connsiteY105" fmla="*/ 184150 h 276225"/>
                <a:gd name="connsiteX106" fmla="*/ 1073150 w 1831975"/>
                <a:gd name="connsiteY106" fmla="*/ 187325 h 276225"/>
                <a:gd name="connsiteX107" fmla="*/ 1050925 w 1831975"/>
                <a:gd name="connsiteY107" fmla="*/ 193675 h 276225"/>
                <a:gd name="connsiteX108" fmla="*/ 1028700 w 1831975"/>
                <a:gd name="connsiteY108" fmla="*/ 203200 h 276225"/>
                <a:gd name="connsiteX109" fmla="*/ 1006475 w 1831975"/>
                <a:gd name="connsiteY109" fmla="*/ 209550 h 276225"/>
                <a:gd name="connsiteX110" fmla="*/ 996950 w 1831975"/>
                <a:gd name="connsiteY110" fmla="*/ 212725 h 276225"/>
                <a:gd name="connsiteX111" fmla="*/ 984250 w 1831975"/>
                <a:gd name="connsiteY111" fmla="*/ 215900 h 276225"/>
                <a:gd name="connsiteX112" fmla="*/ 974725 w 1831975"/>
                <a:gd name="connsiteY112" fmla="*/ 219075 h 276225"/>
                <a:gd name="connsiteX113" fmla="*/ 942975 w 1831975"/>
                <a:gd name="connsiteY113" fmla="*/ 222250 h 276225"/>
                <a:gd name="connsiteX114" fmla="*/ 930275 w 1831975"/>
                <a:gd name="connsiteY114" fmla="*/ 225425 h 276225"/>
                <a:gd name="connsiteX115" fmla="*/ 873125 w 1831975"/>
                <a:gd name="connsiteY115" fmla="*/ 231775 h 276225"/>
                <a:gd name="connsiteX116" fmla="*/ 857250 w 1831975"/>
                <a:gd name="connsiteY116" fmla="*/ 238125 h 276225"/>
                <a:gd name="connsiteX117" fmla="*/ 815975 w 1831975"/>
                <a:gd name="connsiteY117" fmla="*/ 244475 h 276225"/>
                <a:gd name="connsiteX118" fmla="*/ 708025 w 1831975"/>
                <a:gd name="connsiteY118" fmla="*/ 241300 h 276225"/>
                <a:gd name="connsiteX119" fmla="*/ 695325 w 1831975"/>
                <a:gd name="connsiteY119" fmla="*/ 241300 h 2762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  <a:cxn ang="0">
                  <a:pos x="connsiteX92" y="connsiteY92"/>
                </a:cxn>
                <a:cxn ang="0">
                  <a:pos x="connsiteX93" y="connsiteY93"/>
                </a:cxn>
                <a:cxn ang="0">
                  <a:pos x="connsiteX94" y="connsiteY94"/>
                </a:cxn>
                <a:cxn ang="0">
                  <a:pos x="connsiteX95" y="connsiteY95"/>
                </a:cxn>
                <a:cxn ang="0">
                  <a:pos x="connsiteX96" y="connsiteY96"/>
                </a:cxn>
                <a:cxn ang="0">
                  <a:pos x="connsiteX97" y="connsiteY97"/>
                </a:cxn>
                <a:cxn ang="0">
                  <a:pos x="connsiteX98" y="connsiteY98"/>
                </a:cxn>
                <a:cxn ang="0">
                  <a:pos x="connsiteX99" y="connsiteY99"/>
                </a:cxn>
                <a:cxn ang="0">
                  <a:pos x="connsiteX100" y="connsiteY100"/>
                </a:cxn>
                <a:cxn ang="0">
                  <a:pos x="connsiteX101" y="connsiteY101"/>
                </a:cxn>
                <a:cxn ang="0">
                  <a:pos x="connsiteX102" y="connsiteY102"/>
                </a:cxn>
                <a:cxn ang="0">
                  <a:pos x="connsiteX103" y="connsiteY103"/>
                </a:cxn>
                <a:cxn ang="0">
                  <a:pos x="connsiteX104" y="connsiteY104"/>
                </a:cxn>
                <a:cxn ang="0">
                  <a:pos x="connsiteX105" y="connsiteY105"/>
                </a:cxn>
                <a:cxn ang="0">
                  <a:pos x="connsiteX106" y="connsiteY106"/>
                </a:cxn>
                <a:cxn ang="0">
                  <a:pos x="connsiteX107" y="connsiteY107"/>
                </a:cxn>
                <a:cxn ang="0">
                  <a:pos x="connsiteX108" y="connsiteY108"/>
                </a:cxn>
                <a:cxn ang="0">
                  <a:pos x="connsiteX109" y="connsiteY109"/>
                </a:cxn>
                <a:cxn ang="0">
                  <a:pos x="connsiteX110" y="connsiteY110"/>
                </a:cxn>
                <a:cxn ang="0">
                  <a:pos x="connsiteX111" y="connsiteY111"/>
                </a:cxn>
                <a:cxn ang="0">
                  <a:pos x="connsiteX112" y="connsiteY112"/>
                </a:cxn>
                <a:cxn ang="0">
                  <a:pos x="connsiteX113" y="connsiteY113"/>
                </a:cxn>
                <a:cxn ang="0">
                  <a:pos x="connsiteX114" y="connsiteY114"/>
                </a:cxn>
                <a:cxn ang="0">
                  <a:pos x="connsiteX115" y="connsiteY115"/>
                </a:cxn>
                <a:cxn ang="0">
                  <a:pos x="connsiteX116" y="connsiteY116"/>
                </a:cxn>
                <a:cxn ang="0">
                  <a:pos x="connsiteX117" y="connsiteY117"/>
                </a:cxn>
                <a:cxn ang="0">
                  <a:pos x="connsiteX118" y="connsiteY118"/>
                </a:cxn>
                <a:cxn ang="0">
                  <a:pos x="connsiteX119" y="connsiteY119"/>
                </a:cxn>
              </a:cxnLst>
              <a:rect l="l" t="t" r="r" b="b"/>
              <a:pathLst>
                <a:path w="1831975" h="276225">
                  <a:moveTo>
                    <a:pt x="0" y="0"/>
                  </a:moveTo>
                  <a:cubicBezTo>
                    <a:pt x="17495" y="8748"/>
                    <a:pt x="13601" y="5589"/>
                    <a:pt x="31750" y="22225"/>
                  </a:cubicBezTo>
                  <a:cubicBezTo>
                    <a:pt x="56652" y="45052"/>
                    <a:pt x="40743" y="38761"/>
                    <a:pt x="63500" y="44450"/>
                  </a:cubicBezTo>
                  <a:cubicBezTo>
                    <a:pt x="64558" y="47625"/>
                    <a:pt x="64584" y="51362"/>
                    <a:pt x="66675" y="53975"/>
                  </a:cubicBezTo>
                  <a:cubicBezTo>
                    <a:pt x="69059" y="56955"/>
                    <a:pt x="73269" y="57882"/>
                    <a:pt x="76200" y="60325"/>
                  </a:cubicBezTo>
                  <a:cubicBezTo>
                    <a:pt x="79649" y="63200"/>
                    <a:pt x="82276" y="66975"/>
                    <a:pt x="85725" y="69850"/>
                  </a:cubicBezTo>
                  <a:cubicBezTo>
                    <a:pt x="88656" y="72293"/>
                    <a:pt x="92319" y="73757"/>
                    <a:pt x="95250" y="76200"/>
                  </a:cubicBezTo>
                  <a:cubicBezTo>
                    <a:pt x="126458" y="102207"/>
                    <a:pt x="86150" y="70275"/>
                    <a:pt x="111125" y="95250"/>
                  </a:cubicBezTo>
                  <a:cubicBezTo>
                    <a:pt x="117280" y="101405"/>
                    <a:pt x="122428" y="102193"/>
                    <a:pt x="130175" y="104775"/>
                  </a:cubicBezTo>
                  <a:cubicBezTo>
                    <a:pt x="133350" y="107950"/>
                    <a:pt x="136046" y="111690"/>
                    <a:pt x="139700" y="114300"/>
                  </a:cubicBezTo>
                  <a:cubicBezTo>
                    <a:pt x="148640" y="120686"/>
                    <a:pt x="154873" y="121268"/>
                    <a:pt x="165100" y="123825"/>
                  </a:cubicBezTo>
                  <a:cubicBezTo>
                    <a:pt x="178858" y="121708"/>
                    <a:pt x="192753" y="120343"/>
                    <a:pt x="206375" y="117475"/>
                  </a:cubicBezTo>
                  <a:cubicBezTo>
                    <a:pt x="212925" y="116096"/>
                    <a:pt x="219075" y="113242"/>
                    <a:pt x="225425" y="111125"/>
                  </a:cubicBezTo>
                  <a:lnTo>
                    <a:pt x="234950" y="107950"/>
                  </a:lnTo>
                  <a:cubicBezTo>
                    <a:pt x="246592" y="109008"/>
                    <a:pt x="258288" y="109580"/>
                    <a:pt x="269875" y="111125"/>
                  </a:cubicBezTo>
                  <a:cubicBezTo>
                    <a:pt x="274200" y="111702"/>
                    <a:pt x="278226" y="113938"/>
                    <a:pt x="282575" y="114300"/>
                  </a:cubicBezTo>
                  <a:cubicBezTo>
                    <a:pt x="303695" y="116060"/>
                    <a:pt x="324908" y="116417"/>
                    <a:pt x="346075" y="117475"/>
                  </a:cubicBezTo>
                  <a:cubicBezTo>
                    <a:pt x="354542" y="118533"/>
                    <a:pt x="363380" y="117952"/>
                    <a:pt x="371475" y="120650"/>
                  </a:cubicBezTo>
                  <a:cubicBezTo>
                    <a:pt x="376495" y="122323"/>
                    <a:pt x="378920" y="129557"/>
                    <a:pt x="384175" y="130175"/>
                  </a:cubicBezTo>
                  <a:cubicBezTo>
                    <a:pt x="394445" y="131383"/>
                    <a:pt x="476163" y="121034"/>
                    <a:pt x="479425" y="120650"/>
                  </a:cubicBezTo>
                  <a:cubicBezTo>
                    <a:pt x="497506" y="114623"/>
                    <a:pt x="479945" y="118583"/>
                    <a:pt x="501650" y="120650"/>
                  </a:cubicBezTo>
                  <a:cubicBezTo>
                    <a:pt x="519592" y="122359"/>
                    <a:pt x="537633" y="122767"/>
                    <a:pt x="555625" y="123825"/>
                  </a:cubicBezTo>
                  <a:cubicBezTo>
                    <a:pt x="568465" y="130245"/>
                    <a:pt x="568656" y="128667"/>
                    <a:pt x="577850" y="139700"/>
                  </a:cubicBezTo>
                  <a:cubicBezTo>
                    <a:pt x="580293" y="142631"/>
                    <a:pt x="581502" y="146527"/>
                    <a:pt x="584200" y="149225"/>
                  </a:cubicBezTo>
                  <a:cubicBezTo>
                    <a:pt x="586898" y="151923"/>
                    <a:pt x="590238" y="154025"/>
                    <a:pt x="593725" y="155575"/>
                  </a:cubicBezTo>
                  <a:cubicBezTo>
                    <a:pt x="620261" y="167369"/>
                    <a:pt x="636347" y="163235"/>
                    <a:pt x="669925" y="165100"/>
                  </a:cubicBezTo>
                  <a:cubicBezTo>
                    <a:pt x="677333" y="164042"/>
                    <a:pt x="684982" y="164075"/>
                    <a:pt x="692150" y="161925"/>
                  </a:cubicBezTo>
                  <a:cubicBezTo>
                    <a:pt x="695805" y="160829"/>
                    <a:pt x="698168" y="157078"/>
                    <a:pt x="701675" y="155575"/>
                  </a:cubicBezTo>
                  <a:cubicBezTo>
                    <a:pt x="705686" y="153856"/>
                    <a:pt x="710142" y="153458"/>
                    <a:pt x="714375" y="152400"/>
                  </a:cubicBezTo>
                  <a:cubicBezTo>
                    <a:pt x="723722" y="152867"/>
                    <a:pt x="782079" y="154208"/>
                    <a:pt x="803275" y="158750"/>
                  </a:cubicBezTo>
                  <a:cubicBezTo>
                    <a:pt x="809820" y="160152"/>
                    <a:pt x="815723" y="164000"/>
                    <a:pt x="822325" y="165100"/>
                  </a:cubicBezTo>
                  <a:lnTo>
                    <a:pt x="841375" y="168275"/>
                  </a:lnTo>
                  <a:cubicBezTo>
                    <a:pt x="851621" y="166811"/>
                    <a:pt x="873141" y="165089"/>
                    <a:pt x="882650" y="158750"/>
                  </a:cubicBezTo>
                  <a:cubicBezTo>
                    <a:pt x="890546" y="153486"/>
                    <a:pt x="895668" y="149503"/>
                    <a:pt x="904875" y="146050"/>
                  </a:cubicBezTo>
                  <a:cubicBezTo>
                    <a:pt x="908961" y="144518"/>
                    <a:pt x="913489" y="144407"/>
                    <a:pt x="917575" y="142875"/>
                  </a:cubicBezTo>
                  <a:cubicBezTo>
                    <a:pt x="935748" y="136060"/>
                    <a:pt x="924031" y="137292"/>
                    <a:pt x="939800" y="133350"/>
                  </a:cubicBezTo>
                  <a:cubicBezTo>
                    <a:pt x="945195" y="132001"/>
                    <a:pt x="970385" y="127377"/>
                    <a:pt x="974725" y="127000"/>
                  </a:cubicBezTo>
                  <a:cubicBezTo>
                    <a:pt x="992680" y="125439"/>
                    <a:pt x="1010708" y="124883"/>
                    <a:pt x="1028700" y="123825"/>
                  </a:cubicBezTo>
                  <a:cubicBezTo>
                    <a:pt x="1037167" y="121708"/>
                    <a:pt x="1045482" y="118854"/>
                    <a:pt x="1054100" y="117475"/>
                  </a:cubicBezTo>
                  <a:cubicBezTo>
                    <a:pt x="1109939" y="108541"/>
                    <a:pt x="1096322" y="113551"/>
                    <a:pt x="1143000" y="107950"/>
                  </a:cubicBezTo>
                  <a:cubicBezTo>
                    <a:pt x="1157860" y="106167"/>
                    <a:pt x="1172687" y="104061"/>
                    <a:pt x="1187450" y="101600"/>
                  </a:cubicBezTo>
                  <a:cubicBezTo>
                    <a:pt x="1193800" y="100542"/>
                    <a:pt x="1200107" y="99177"/>
                    <a:pt x="1206500" y="98425"/>
                  </a:cubicBezTo>
                  <a:cubicBezTo>
                    <a:pt x="1293824" y="88152"/>
                    <a:pt x="1201079" y="101014"/>
                    <a:pt x="1263650" y="92075"/>
                  </a:cubicBezTo>
                  <a:cubicBezTo>
                    <a:pt x="1266825" y="91017"/>
                    <a:pt x="1270182" y="90397"/>
                    <a:pt x="1273175" y="88900"/>
                  </a:cubicBezTo>
                  <a:cubicBezTo>
                    <a:pt x="1276588" y="87193"/>
                    <a:pt x="1279127" y="83890"/>
                    <a:pt x="1282700" y="82550"/>
                  </a:cubicBezTo>
                  <a:cubicBezTo>
                    <a:pt x="1287753" y="80655"/>
                    <a:pt x="1293386" y="80858"/>
                    <a:pt x="1298575" y="79375"/>
                  </a:cubicBezTo>
                  <a:cubicBezTo>
                    <a:pt x="1308229" y="76617"/>
                    <a:pt x="1317410" y="72285"/>
                    <a:pt x="1327150" y="69850"/>
                  </a:cubicBezTo>
                  <a:cubicBezTo>
                    <a:pt x="1351532" y="63754"/>
                    <a:pt x="1327946" y="69188"/>
                    <a:pt x="1362075" y="63500"/>
                  </a:cubicBezTo>
                  <a:cubicBezTo>
                    <a:pt x="1367398" y="62613"/>
                    <a:pt x="1372641" y="61290"/>
                    <a:pt x="1377950" y="60325"/>
                  </a:cubicBezTo>
                  <a:cubicBezTo>
                    <a:pt x="1384284" y="59173"/>
                    <a:pt x="1390716" y="58547"/>
                    <a:pt x="1397000" y="57150"/>
                  </a:cubicBezTo>
                  <a:cubicBezTo>
                    <a:pt x="1400267" y="56424"/>
                    <a:pt x="1403278" y="54787"/>
                    <a:pt x="1406525" y="53975"/>
                  </a:cubicBezTo>
                  <a:cubicBezTo>
                    <a:pt x="1411760" y="52666"/>
                    <a:pt x="1417194" y="52220"/>
                    <a:pt x="1422400" y="50800"/>
                  </a:cubicBezTo>
                  <a:cubicBezTo>
                    <a:pt x="1431031" y="48446"/>
                    <a:pt x="1444448" y="42569"/>
                    <a:pt x="1454150" y="41275"/>
                  </a:cubicBezTo>
                  <a:cubicBezTo>
                    <a:pt x="1465737" y="39730"/>
                    <a:pt x="1477433" y="39158"/>
                    <a:pt x="1489075" y="38100"/>
                  </a:cubicBezTo>
                  <a:cubicBezTo>
                    <a:pt x="1493308" y="37042"/>
                    <a:pt x="1497579" y="36124"/>
                    <a:pt x="1501775" y="34925"/>
                  </a:cubicBezTo>
                  <a:cubicBezTo>
                    <a:pt x="1504993" y="34006"/>
                    <a:pt x="1508018" y="32406"/>
                    <a:pt x="1511300" y="31750"/>
                  </a:cubicBezTo>
                  <a:cubicBezTo>
                    <a:pt x="1518638" y="30282"/>
                    <a:pt x="1526117" y="29633"/>
                    <a:pt x="1533525" y="28575"/>
                  </a:cubicBezTo>
                  <a:cubicBezTo>
                    <a:pt x="1542612" y="24032"/>
                    <a:pt x="1546407" y="21386"/>
                    <a:pt x="1555750" y="19050"/>
                  </a:cubicBezTo>
                  <a:cubicBezTo>
                    <a:pt x="1569371" y="15645"/>
                    <a:pt x="1576521" y="15531"/>
                    <a:pt x="1590675" y="12700"/>
                  </a:cubicBezTo>
                  <a:cubicBezTo>
                    <a:pt x="1600642" y="10707"/>
                    <a:pt x="1603822" y="9376"/>
                    <a:pt x="1612900" y="6350"/>
                  </a:cubicBezTo>
                  <a:cubicBezTo>
                    <a:pt x="1643718" y="11486"/>
                    <a:pt x="1622279" y="4120"/>
                    <a:pt x="1641475" y="19050"/>
                  </a:cubicBezTo>
                  <a:cubicBezTo>
                    <a:pt x="1647499" y="23735"/>
                    <a:pt x="1660525" y="31750"/>
                    <a:pt x="1660525" y="31750"/>
                  </a:cubicBezTo>
                  <a:cubicBezTo>
                    <a:pt x="1666875" y="30692"/>
                    <a:pt x="1673409" y="30425"/>
                    <a:pt x="1679575" y="28575"/>
                  </a:cubicBezTo>
                  <a:cubicBezTo>
                    <a:pt x="1684108" y="27215"/>
                    <a:pt x="1687925" y="24089"/>
                    <a:pt x="1692275" y="22225"/>
                  </a:cubicBezTo>
                  <a:cubicBezTo>
                    <a:pt x="1695351" y="20907"/>
                    <a:pt x="1698625" y="20108"/>
                    <a:pt x="1701800" y="19050"/>
                  </a:cubicBezTo>
                  <a:cubicBezTo>
                    <a:pt x="1703954" y="19319"/>
                    <a:pt x="1758096" y="22714"/>
                    <a:pt x="1771650" y="31750"/>
                  </a:cubicBezTo>
                  <a:lnTo>
                    <a:pt x="1781175" y="38100"/>
                  </a:lnTo>
                  <a:lnTo>
                    <a:pt x="1793875" y="57150"/>
                  </a:lnTo>
                  <a:cubicBezTo>
                    <a:pt x="1795992" y="60325"/>
                    <a:pt x="1797050" y="64558"/>
                    <a:pt x="1800225" y="66675"/>
                  </a:cubicBezTo>
                  <a:lnTo>
                    <a:pt x="1809750" y="73025"/>
                  </a:lnTo>
                  <a:cubicBezTo>
                    <a:pt x="1824567" y="95250"/>
                    <a:pt x="1816100" y="87842"/>
                    <a:pt x="1831975" y="98425"/>
                  </a:cubicBezTo>
                  <a:cubicBezTo>
                    <a:pt x="1828800" y="100542"/>
                    <a:pt x="1825863" y="103068"/>
                    <a:pt x="1822450" y="104775"/>
                  </a:cubicBezTo>
                  <a:cubicBezTo>
                    <a:pt x="1806519" y="112741"/>
                    <a:pt x="1767144" y="110654"/>
                    <a:pt x="1762125" y="111125"/>
                  </a:cubicBezTo>
                  <a:cubicBezTo>
                    <a:pt x="1745134" y="112718"/>
                    <a:pt x="1728258" y="115358"/>
                    <a:pt x="1711325" y="117475"/>
                  </a:cubicBezTo>
                  <a:cubicBezTo>
                    <a:pt x="1707092" y="119592"/>
                    <a:pt x="1701465" y="120039"/>
                    <a:pt x="1698625" y="123825"/>
                  </a:cubicBezTo>
                  <a:cubicBezTo>
                    <a:pt x="1694609" y="129180"/>
                    <a:pt x="1695268" y="136888"/>
                    <a:pt x="1692275" y="142875"/>
                  </a:cubicBezTo>
                  <a:cubicBezTo>
                    <a:pt x="1688393" y="150639"/>
                    <a:pt x="1685185" y="158368"/>
                    <a:pt x="1679575" y="165100"/>
                  </a:cubicBezTo>
                  <a:cubicBezTo>
                    <a:pt x="1676700" y="168549"/>
                    <a:pt x="1673786" y="172134"/>
                    <a:pt x="1670050" y="174625"/>
                  </a:cubicBezTo>
                  <a:cubicBezTo>
                    <a:pt x="1664005" y="178655"/>
                    <a:pt x="1640182" y="180706"/>
                    <a:pt x="1638300" y="180975"/>
                  </a:cubicBezTo>
                  <a:cubicBezTo>
                    <a:pt x="1631950" y="176742"/>
                    <a:pt x="1621663" y="175515"/>
                    <a:pt x="1619250" y="168275"/>
                  </a:cubicBezTo>
                  <a:cubicBezTo>
                    <a:pt x="1614868" y="155130"/>
                    <a:pt x="1618860" y="160606"/>
                    <a:pt x="1606550" y="152400"/>
                  </a:cubicBezTo>
                  <a:cubicBezTo>
                    <a:pt x="1601258" y="153458"/>
                    <a:pt x="1595728" y="153680"/>
                    <a:pt x="1590675" y="155575"/>
                  </a:cubicBezTo>
                  <a:cubicBezTo>
                    <a:pt x="1569781" y="163410"/>
                    <a:pt x="1594944" y="164626"/>
                    <a:pt x="1562100" y="168275"/>
                  </a:cubicBezTo>
                  <a:lnTo>
                    <a:pt x="1533525" y="171450"/>
                  </a:lnTo>
                  <a:cubicBezTo>
                    <a:pt x="1531433" y="177725"/>
                    <a:pt x="1529595" y="186024"/>
                    <a:pt x="1524000" y="190500"/>
                  </a:cubicBezTo>
                  <a:cubicBezTo>
                    <a:pt x="1520746" y="193103"/>
                    <a:pt x="1499391" y="196692"/>
                    <a:pt x="1498600" y="196850"/>
                  </a:cubicBezTo>
                  <a:cubicBezTo>
                    <a:pt x="1495425" y="198967"/>
                    <a:pt x="1491459" y="200220"/>
                    <a:pt x="1489075" y="203200"/>
                  </a:cubicBezTo>
                  <a:cubicBezTo>
                    <a:pt x="1478850" y="215982"/>
                    <a:pt x="1494419" y="210355"/>
                    <a:pt x="1479550" y="222250"/>
                  </a:cubicBezTo>
                  <a:cubicBezTo>
                    <a:pt x="1476937" y="224341"/>
                    <a:pt x="1473200" y="224367"/>
                    <a:pt x="1470025" y="225425"/>
                  </a:cubicBezTo>
                  <a:cubicBezTo>
                    <a:pt x="1464813" y="241062"/>
                    <a:pt x="1470582" y="230253"/>
                    <a:pt x="1457325" y="241300"/>
                  </a:cubicBezTo>
                  <a:cubicBezTo>
                    <a:pt x="1453876" y="244175"/>
                    <a:pt x="1451536" y="248334"/>
                    <a:pt x="1447800" y="250825"/>
                  </a:cubicBezTo>
                  <a:cubicBezTo>
                    <a:pt x="1445015" y="252681"/>
                    <a:pt x="1441201" y="252375"/>
                    <a:pt x="1438275" y="254000"/>
                  </a:cubicBezTo>
                  <a:cubicBezTo>
                    <a:pt x="1431604" y="257706"/>
                    <a:pt x="1426629" y="264849"/>
                    <a:pt x="1419225" y="266700"/>
                  </a:cubicBezTo>
                  <a:cubicBezTo>
                    <a:pt x="1390578" y="273862"/>
                    <a:pt x="1402104" y="270290"/>
                    <a:pt x="1384300" y="276225"/>
                  </a:cubicBezTo>
                  <a:cubicBezTo>
                    <a:pt x="1350854" y="269536"/>
                    <a:pt x="1379171" y="280497"/>
                    <a:pt x="1365250" y="231775"/>
                  </a:cubicBezTo>
                  <a:cubicBezTo>
                    <a:pt x="1364331" y="228557"/>
                    <a:pt x="1358718" y="230097"/>
                    <a:pt x="1355725" y="228600"/>
                  </a:cubicBezTo>
                  <a:cubicBezTo>
                    <a:pt x="1352312" y="226893"/>
                    <a:pt x="1349513" y="224143"/>
                    <a:pt x="1346200" y="222250"/>
                  </a:cubicBezTo>
                  <a:cubicBezTo>
                    <a:pt x="1335215" y="215973"/>
                    <a:pt x="1334661" y="216287"/>
                    <a:pt x="1323975" y="212725"/>
                  </a:cubicBezTo>
                  <a:cubicBezTo>
                    <a:pt x="1316529" y="190387"/>
                    <a:pt x="1326220" y="217963"/>
                    <a:pt x="1314450" y="190500"/>
                  </a:cubicBezTo>
                  <a:cubicBezTo>
                    <a:pt x="1313132" y="187424"/>
                    <a:pt x="1313131" y="183760"/>
                    <a:pt x="1311275" y="180975"/>
                  </a:cubicBezTo>
                  <a:cubicBezTo>
                    <a:pt x="1308784" y="177239"/>
                    <a:pt x="1304625" y="174899"/>
                    <a:pt x="1301750" y="171450"/>
                  </a:cubicBezTo>
                  <a:cubicBezTo>
                    <a:pt x="1290703" y="158193"/>
                    <a:pt x="1301512" y="163962"/>
                    <a:pt x="1285875" y="158750"/>
                  </a:cubicBezTo>
                  <a:cubicBezTo>
                    <a:pt x="1271058" y="159808"/>
                    <a:pt x="1256198" y="160370"/>
                    <a:pt x="1241425" y="161925"/>
                  </a:cubicBezTo>
                  <a:cubicBezTo>
                    <a:pt x="1236058" y="162490"/>
                    <a:pt x="1230884" y="164279"/>
                    <a:pt x="1225550" y="165100"/>
                  </a:cubicBezTo>
                  <a:cubicBezTo>
                    <a:pt x="1173736" y="173071"/>
                    <a:pt x="1229146" y="162044"/>
                    <a:pt x="1162050" y="174625"/>
                  </a:cubicBezTo>
                  <a:cubicBezTo>
                    <a:pt x="1145117" y="177800"/>
                    <a:pt x="1128419" y="182719"/>
                    <a:pt x="1111250" y="184150"/>
                  </a:cubicBezTo>
                  <a:lnTo>
                    <a:pt x="1073150" y="187325"/>
                  </a:lnTo>
                  <a:cubicBezTo>
                    <a:pt x="1066705" y="188936"/>
                    <a:pt x="1057302" y="190942"/>
                    <a:pt x="1050925" y="193675"/>
                  </a:cubicBezTo>
                  <a:cubicBezTo>
                    <a:pt x="1031652" y="201935"/>
                    <a:pt x="1045247" y="198236"/>
                    <a:pt x="1028700" y="203200"/>
                  </a:cubicBezTo>
                  <a:cubicBezTo>
                    <a:pt x="1021320" y="205414"/>
                    <a:pt x="1013855" y="207336"/>
                    <a:pt x="1006475" y="209550"/>
                  </a:cubicBezTo>
                  <a:cubicBezTo>
                    <a:pt x="1003269" y="210512"/>
                    <a:pt x="1000168" y="211806"/>
                    <a:pt x="996950" y="212725"/>
                  </a:cubicBezTo>
                  <a:cubicBezTo>
                    <a:pt x="992754" y="213924"/>
                    <a:pt x="988446" y="214701"/>
                    <a:pt x="984250" y="215900"/>
                  </a:cubicBezTo>
                  <a:cubicBezTo>
                    <a:pt x="981032" y="216819"/>
                    <a:pt x="978033" y="218566"/>
                    <a:pt x="974725" y="219075"/>
                  </a:cubicBezTo>
                  <a:cubicBezTo>
                    <a:pt x="964213" y="220692"/>
                    <a:pt x="953558" y="221192"/>
                    <a:pt x="942975" y="222250"/>
                  </a:cubicBezTo>
                  <a:cubicBezTo>
                    <a:pt x="938742" y="223308"/>
                    <a:pt x="934568" y="224644"/>
                    <a:pt x="930275" y="225425"/>
                  </a:cubicBezTo>
                  <a:cubicBezTo>
                    <a:pt x="910962" y="228936"/>
                    <a:pt x="892877" y="229979"/>
                    <a:pt x="873125" y="231775"/>
                  </a:cubicBezTo>
                  <a:cubicBezTo>
                    <a:pt x="867833" y="233892"/>
                    <a:pt x="862839" y="237007"/>
                    <a:pt x="857250" y="238125"/>
                  </a:cubicBezTo>
                  <a:cubicBezTo>
                    <a:pt x="795860" y="250403"/>
                    <a:pt x="843869" y="235177"/>
                    <a:pt x="815975" y="244475"/>
                  </a:cubicBezTo>
                  <a:cubicBezTo>
                    <a:pt x="779992" y="243417"/>
                    <a:pt x="743974" y="243192"/>
                    <a:pt x="708025" y="241300"/>
                  </a:cubicBezTo>
                  <a:cubicBezTo>
                    <a:pt x="694298" y="240578"/>
                    <a:pt x="695325" y="233104"/>
                    <a:pt x="695325" y="241300"/>
                  </a:cubicBezTo>
                </a:path>
              </a:pathLst>
            </a:cu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803">
                <a:ln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88" name="Freeform 187"/>
            <p:cNvSpPr/>
            <p:nvPr/>
          </p:nvSpPr>
          <p:spPr>
            <a:xfrm>
              <a:off x="3497606" y="7300265"/>
              <a:ext cx="247915" cy="309370"/>
            </a:xfrm>
            <a:custGeom>
              <a:avLst/>
              <a:gdLst>
                <a:gd name="connsiteX0" fmla="*/ 322729 w 381407"/>
                <a:gd name="connsiteY0" fmla="*/ 58678 h 469425"/>
                <a:gd name="connsiteX1" fmla="*/ 303170 w 381407"/>
                <a:gd name="connsiteY1" fmla="*/ 73348 h 469425"/>
                <a:gd name="connsiteX2" fmla="*/ 273831 w 381407"/>
                <a:gd name="connsiteY2" fmla="*/ 63568 h 469425"/>
                <a:gd name="connsiteX3" fmla="*/ 264051 w 381407"/>
                <a:gd name="connsiteY3" fmla="*/ 48898 h 469425"/>
                <a:gd name="connsiteX4" fmla="*/ 234712 w 381407"/>
                <a:gd name="connsiteY4" fmla="*/ 39119 h 469425"/>
                <a:gd name="connsiteX5" fmla="*/ 220042 w 381407"/>
                <a:gd name="connsiteY5" fmla="*/ 29339 h 469425"/>
                <a:gd name="connsiteX6" fmla="*/ 210263 w 381407"/>
                <a:gd name="connsiteY6" fmla="*/ 9780 h 469425"/>
                <a:gd name="connsiteX7" fmla="*/ 180924 w 381407"/>
                <a:gd name="connsiteY7" fmla="*/ 0 h 469425"/>
                <a:gd name="connsiteX8" fmla="*/ 156475 w 381407"/>
                <a:gd name="connsiteY8" fmla="*/ 4890 h 469425"/>
                <a:gd name="connsiteX9" fmla="*/ 151585 w 381407"/>
                <a:gd name="connsiteY9" fmla="*/ 19559 h 469425"/>
                <a:gd name="connsiteX10" fmla="*/ 122246 w 381407"/>
                <a:gd name="connsiteY10" fmla="*/ 44008 h 469425"/>
                <a:gd name="connsiteX11" fmla="*/ 117356 w 381407"/>
                <a:gd name="connsiteY11" fmla="*/ 58678 h 469425"/>
                <a:gd name="connsiteX12" fmla="*/ 97796 w 381407"/>
                <a:gd name="connsiteY12" fmla="*/ 88017 h 469425"/>
                <a:gd name="connsiteX13" fmla="*/ 92907 w 381407"/>
                <a:gd name="connsiteY13" fmla="*/ 102687 h 469425"/>
                <a:gd name="connsiteX14" fmla="*/ 68457 w 381407"/>
                <a:gd name="connsiteY14" fmla="*/ 132026 h 469425"/>
                <a:gd name="connsiteX15" fmla="*/ 53788 w 381407"/>
                <a:gd name="connsiteY15" fmla="*/ 141805 h 469425"/>
                <a:gd name="connsiteX16" fmla="*/ 39118 w 381407"/>
                <a:gd name="connsiteY16" fmla="*/ 171144 h 469425"/>
                <a:gd name="connsiteX17" fmla="*/ 24449 w 381407"/>
                <a:gd name="connsiteY17" fmla="*/ 176034 h 469425"/>
                <a:gd name="connsiteX18" fmla="*/ 9779 w 381407"/>
                <a:gd name="connsiteY18" fmla="*/ 190704 h 469425"/>
                <a:gd name="connsiteX19" fmla="*/ 0 w 381407"/>
                <a:gd name="connsiteY19" fmla="*/ 220043 h 469425"/>
                <a:gd name="connsiteX20" fmla="*/ 4890 w 381407"/>
                <a:gd name="connsiteY20" fmla="*/ 259161 h 469425"/>
                <a:gd name="connsiteX21" fmla="*/ 9779 w 381407"/>
                <a:gd name="connsiteY21" fmla="*/ 273831 h 469425"/>
                <a:gd name="connsiteX22" fmla="*/ 14669 w 381407"/>
                <a:gd name="connsiteY22" fmla="*/ 312950 h 469425"/>
                <a:gd name="connsiteX23" fmla="*/ 34229 w 381407"/>
                <a:gd name="connsiteY23" fmla="*/ 308060 h 469425"/>
                <a:gd name="connsiteX24" fmla="*/ 48898 w 381407"/>
                <a:gd name="connsiteY24" fmla="*/ 312950 h 469425"/>
                <a:gd name="connsiteX25" fmla="*/ 63568 w 381407"/>
                <a:gd name="connsiteY25" fmla="*/ 371628 h 469425"/>
                <a:gd name="connsiteX26" fmla="*/ 68457 w 381407"/>
                <a:gd name="connsiteY26" fmla="*/ 386297 h 469425"/>
                <a:gd name="connsiteX27" fmla="*/ 102686 w 381407"/>
                <a:gd name="connsiteY27" fmla="*/ 400967 h 469425"/>
                <a:gd name="connsiteX28" fmla="*/ 112466 w 381407"/>
                <a:gd name="connsiteY28" fmla="*/ 415636 h 469425"/>
                <a:gd name="connsiteX29" fmla="*/ 141805 w 381407"/>
                <a:gd name="connsiteY29" fmla="*/ 430306 h 469425"/>
                <a:gd name="connsiteX30" fmla="*/ 156475 w 381407"/>
                <a:gd name="connsiteY30" fmla="*/ 440085 h 469425"/>
                <a:gd name="connsiteX31" fmla="*/ 210263 w 381407"/>
                <a:gd name="connsiteY31" fmla="*/ 454755 h 469425"/>
                <a:gd name="connsiteX32" fmla="*/ 239602 w 381407"/>
                <a:gd name="connsiteY32" fmla="*/ 464535 h 469425"/>
                <a:gd name="connsiteX33" fmla="*/ 259161 w 381407"/>
                <a:gd name="connsiteY33" fmla="*/ 469425 h 469425"/>
                <a:gd name="connsiteX34" fmla="*/ 322729 w 381407"/>
                <a:gd name="connsiteY34" fmla="*/ 464535 h 469425"/>
                <a:gd name="connsiteX35" fmla="*/ 327619 w 381407"/>
                <a:gd name="connsiteY35" fmla="*/ 449865 h 469425"/>
                <a:gd name="connsiteX36" fmla="*/ 337399 w 381407"/>
                <a:gd name="connsiteY36" fmla="*/ 391187 h 469425"/>
                <a:gd name="connsiteX37" fmla="*/ 347178 w 381407"/>
                <a:gd name="connsiteY37" fmla="*/ 317840 h 469425"/>
                <a:gd name="connsiteX38" fmla="*/ 356958 w 381407"/>
                <a:gd name="connsiteY38" fmla="*/ 303170 h 469425"/>
                <a:gd name="connsiteX39" fmla="*/ 361848 w 381407"/>
                <a:gd name="connsiteY39" fmla="*/ 288500 h 469425"/>
                <a:gd name="connsiteX40" fmla="*/ 376517 w 381407"/>
                <a:gd name="connsiteY40" fmla="*/ 293390 h 469425"/>
                <a:gd name="connsiteX41" fmla="*/ 381407 w 381407"/>
                <a:gd name="connsiteY41" fmla="*/ 308060 h 4694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</a:cxnLst>
              <a:rect l="l" t="t" r="r" b="b"/>
              <a:pathLst>
                <a:path w="381407" h="469425">
                  <a:moveTo>
                    <a:pt x="322729" y="58678"/>
                  </a:moveTo>
                  <a:cubicBezTo>
                    <a:pt x="316209" y="63568"/>
                    <a:pt x="311279" y="72537"/>
                    <a:pt x="303170" y="73348"/>
                  </a:cubicBezTo>
                  <a:cubicBezTo>
                    <a:pt x="292912" y="74374"/>
                    <a:pt x="273831" y="63568"/>
                    <a:pt x="273831" y="63568"/>
                  </a:cubicBezTo>
                  <a:cubicBezTo>
                    <a:pt x="270571" y="58678"/>
                    <a:pt x="269035" y="52013"/>
                    <a:pt x="264051" y="48898"/>
                  </a:cubicBezTo>
                  <a:cubicBezTo>
                    <a:pt x="255309" y="43435"/>
                    <a:pt x="234712" y="39119"/>
                    <a:pt x="234712" y="39119"/>
                  </a:cubicBezTo>
                  <a:cubicBezTo>
                    <a:pt x="229822" y="35859"/>
                    <a:pt x="223804" y="33854"/>
                    <a:pt x="220042" y="29339"/>
                  </a:cubicBezTo>
                  <a:cubicBezTo>
                    <a:pt x="215376" y="23739"/>
                    <a:pt x="216094" y="14154"/>
                    <a:pt x="210263" y="9780"/>
                  </a:cubicBezTo>
                  <a:cubicBezTo>
                    <a:pt x="202016" y="3595"/>
                    <a:pt x="180924" y="0"/>
                    <a:pt x="180924" y="0"/>
                  </a:cubicBezTo>
                  <a:cubicBezTo>
                    <a:pt x="172774" y="1630"/>
                    <a:pt x="163390" y="280"/>
                    <a:pt x="156475" y="4890"/>
                  </a:cubicBezTo>
                  <a:cubicBezTo>
                    <a:pt x="152186" y="7749"/>
                    <a:pt x="154444" y="15270"/>
                    <a:pt x="151585" y="19559"/>
                  </a:cubicBezTo>
                  <a:cubicBezTo>
                    <a:pt x="144054" y="30855"/>
                    <a:pt x="133071" y="36791"/>
                    <a:pt x="122246" y="44008"/>
                  </a:cubicBezTo>
                  <a:cubicBezTo>
                    <a:pt x="120616" y="48898"/>
                    <a:pt x="119859" y="54172"/>
                    <a:pt x="117356" y="58678"/>
                  </a:cubicBezTo>
                  <a:cubicBezTo>
                    <a:pt x="111648" y="68953"/>
                    <a:pt x="97796" y="88017"/>
                    <a:pt x="97796" y="88017"/>
                  </a:cubicBezTo>
                  <a:cubicBezTo>
                    <a:pt x="96166" y="92907"/>
                    <a:pt x="95212" y="98077"/>
                    <a:pt x="92907" y="102687"/>
                  </a:cubicBezTo>
                  <a:cubicBezTo>
                    <a:pt x="87413" y="113675"/>
                    <a:pt x="77724" y="124303"/>
                    <a:pt x="68457" y="132026"/>
                  </a:cubicBezTo>
                  <a:cubicBezTo>
                    <a:pt x="63942" y="135788"/>
                    <a:pt x="58678" y="138545"/>
                    <a:pt x="53788" y="141805"/>
                  </a:cubicBezTo>
                  <a:cubicBezTo>
                    <a:pt x="50566" y="151470"/>
                    <a:pt x="47736" y="164249"/>
                    <a:pt x="39118" y="171144"/>
                  </a:cubicBezTo>
                  <a:cubicBezTo>
                    <a:pt x="35093" y="174364"/>
                    <a:pt x="29339" y="174404"/>
                    <a:pt x="24449" y="176034"/>
                  </a:cubicBezTo>
                  <a:cubicBezTo>
                    <a:pt x="19559" y="180924"/>
                    <a:pt x="13137" y="184659"/>
                    <a:pt x="9779" y="190704"/>
                  </a:cubicBezTo>
                  <a:cubicBezTo>
                    <a:pt x="4773" y="199715"/>
                    <a:pt x="0" y="220043"/>
                    <a:pt x="0" y="220043"/>
                  </a:cubicBezTo>
                  <a:cubicBezTo>
                    <a:pt x="1630" y="233082"/>
                    <a:pt x="2539" y="246232"/>
                    <a:pt x="4890" y="259161"/>
                  </a:cubicBezTo>
                  <a:cubicBezTo>
                    <a:pt x="5812" y="264232"/>
                    <a:pt x="8857" y="268760"/>
                    <a:pt x="9779" y="273831"/>
                  </a:cubicBezTo>
                  <a:cubicBezTo>
                    <a:pt x="12130" y="286760"/>
                    <a:pt x="13039" y="299910"/>
                    <a:pt x="14669" y="312950"/>
                  </a:cubicBezTo>
                  <a:cubicBezTo>
                    <a:pt x="21189" y="311320"/>
                    <a:pt x="27508" y="308060"/>
                    <a:pt x="34229" y="308060"/>
                  </a:cubicBezTo>
                  <a:cubicBezTo>
                    <a:pt x="39383" y="308060"/>
                    <a:pt x="45902" y="308756"/>
                    <a:pt x="48898" y="312950"/>
                  </a:cubicBezTo>
                  <a:cubicBezTo>
                    <a:pt x="58460" y="326337"/>
                    <a:pt x="60208" y="356509"/>
                    <a:pt x="63568" y="371628"/>
                  </a:cubicBezTo>
                  <a:cubicBezTo>
                    <a:pt x="64686" y="376659"/>
                    <a:pt x="64813" y="382653"/>
                    <a:pt x="68457" y="386297"/>
                  </a:cubicBezTo>
                  <a:cubicBezTo>
                    <a:pt x="74499" y="392339"/>
                    <a:pt x="93919" y="398045"/>
                    <a:pt x="102686" y="400967"/>
                  </a:cubicBezTo>
                  <a:cubicBezTo>
                    <a:pt x="105946" y="405857"/>
                    <a:pt x="108310" y="411481"/>
                    <a:pt x="112466" y="415636"/>
                  </a:cubicBezTo>
                  <a:cubicBezTo>
                    <a:pt x="126480" y="429649"/>
                    <a:pt x="125897" y="422352"/>
                    <a:pt x="141805" y="430306"/>
                  </a:cubicBezTo>
                  <a:cubicBezTo>
                    <a:pt x="147061" y="432934"/>
                    <a:pt x="151105" y="437698"/>
                    <a:pt x="156475" y="440085"/>
                  </a:cubicBezTo>
                  <a:cubicBezTo>
                    <a:pt x="187772" y="453994"/>
                    <a:pt x="180484" y="446633"/>
                    <a:pt x="210263" y="454755"/>
                  </a:cubicBezTo>
                  <a:cubicBezTo>
                    <a:pt x="220208" y="457467"/>
                    <a:pt x="229601" y="462035"/>
                    <a:pt x="239602" y="464535"/>
                  </a:cubicBezTo>
                  <a:lnTo>
                    <a:pt x="259161" y="469425"/>
                  </a:lnTo>
                  <a:cubicBezTo>
                    <a:pt x="280350" y="467795"/>
                    <a:pt x="302295" y="470374"/>
                    <a:pt x="322729" y="464535"/>
                  </a:cubicBezTo>
                  <a:cubicBezTo>
                    <a:pt x="327685" y="463119"/>
                    <a:pt x="326608" y="454919"/>
                    <a:pt x="327619" y="449865"/>
                  </a:cubicBezTo>
                  <a:cubicBezTo>
                    <a:pt x="331508" y="430421"/>
                    <a:pt x="334458" y="410797"/>
                    <a:pt x="337399" y="391187"/>
                  </a:cubicBezTo>
                  <a:cubicBezTo>
                    <a:pt x="337784" y="388621"/>
                    <a:pt x="345633" y="322989"/>
                    <a:pt x="347178" y="317840"/>
                  </a:cubicBezTo>
                  <a:cubicBezTo>
                    <a:pt x="348867" y="312211"/>
                    <a:pt x="354330" y="308427"/>
                    <a:pt x="356958" y="303170"/>
                  </a:cubicBezTo>
                  <a:cubicBezTo>
                    <a:pt x="359263" y="298560"/>
                    <a:pt x="360218" y="293390"/>
                    <a:pt x="361848" y="288500"/>
                  </a:cubicBezTo>
                  <a:cubicBezTo>
                    <a:pt x="366738" y="290130"/>
                    <a:pt x="372873" y="289745"/>
                    <a:pt x="376517" y="293390"/>
                  </a:cubicBezTo>
                  <a:cubicBezTo>
                    <a:pt x="380162" y="297035"/>
                    <a:pt x="381407" y="308060"/>
                    <a:pt x="381407" y="308060"/>
                  </a:cubicBezTo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89" name="Freeform 188"/>
            <p:cNvSpPr/>
            <p:nvPr/>
          </p:nvSpPr>
          <p:spPr>
            <a:xfrm>
              <a:off x="2852391" y="7854055"/>
              <a:ext cx="425905" cy="422658"/>
            </a:xfrm>
            <a:custGeom>
              <a:avLst/>
              <a:gdLst>
                <a:gd name="connsiteX0" fmla="*/ 425416 w 655239"/>
                <a:gd name="connsiteY0" fmla="*/ 754 h 641323"/>
                <a:gd name="connsiteX1" fmla="*/ 449866 w 655239"/>
                <a:gd name="connsiteY1" fmla="*/ 34983 h 641323"/>
                <a:gd name="connsiteX2" fmla="*/ 454755 w 655239"/>
                <a:gd name="connsiteY2" fmla="*/ 49653 h 641323"/>
                <a:gd name="connsiteX3" fmla="*/ 469425 w 655239"/>
                <a:gd name="connsiteY3" fmla="*/ 59432 h 641323"/>
                <a:gd name="connsiteX4" fmla="*/ 508544 w 655239"/>
                <a:gd name="connsiteY4" fmla="*/ 69212 h 641323"/>
                <a:gd name="connsiteX5" fmla="*/ 528103 w 655239"/>
                <a:gd name="connsiteY5" fmla="*/ 98551 h 641323"/>
                <a:gd name="connsiteX6" fmla="*/ 537883 w 655239"/>
                <a:gd name="connsiteY6" fmla="*/ 113221 h 641323"/>
                <a:gd name="connsiteX7" fmla="*/ 567222 w 655239"/>
                <a:gd name="connsiteY7" fmla="*/ 127890 h 641323"/>
                <a:gd name="connsiteX8" fmla="*/ 581891 w 655239"/>
                <a:gd name="connsiteY8" fmla="*/ 157229 h 641323"/>
                <a:gd name="connsiteX9" fmla="*/ 596561 w 655239"/>
                <a:gd name="connsiteY9" fmla="*/ 162119 h 641323"/>
                <a:gd name="connsiteX10" fmla="*/ 630790 w 655239"/>
                <a:gd name="connsiteY10" fmla="*/ 181678 h 641323"/>
                <a:gd name="connsiteX11" fmla="*/ 635679 w 655239"/>
                <a:gd name="connsiteY11" fmla="*/ 196348 h 641323"/>
                <a:gd name="connsiteX12" fmla="*/ 655239 w 655239"/>
                <a:gd name="connsiteY12" fmla="*/ 225687 h 641323"/>
                <a:gd name="connsiteX13" fmla="*/ 621010 w 655239"/>
                <a:gd name="connsiteY13" fmla="*/ 264806 h 641323"/>
                <a:gd name="connsiteX14" fmla="*/ 611230 w 655239"/>
                <a:gd name="connsiteY14" fmla="*/ 279475 h 641323"/>
                <a:gd name="connsiteX15" fmla="*/ 591671 w 655239"/>
                <a:gd name="connsiteY15" fmla="*/ 323484 h 641323"/>
                <a:gd name="connsiteX16" fmla="*/ 577001 w 655239"/>
                <a:gd name="connsiteY16" fmla="*/ 328374 h 641323"/>
                <a:gd name="connsiteX17" fmla="*/ 562332 w 655239"/>
                <a:gd name="connsiteY17" fmla="*/ 338153 h 641323"/>
                <a:gd name="connsiteX18" fmla="*/ 552552 w 655239"/>
                <a:gd name="connsiteY18" fmla="*/ 372382 h 641323"/>
                <a:gd name="connsiteX19" fmla="*/ 557442 w 655239"/>
                <a:gd name="connsiteY19" fmla="*/ 387052 h 641323"/>
                <a:gd name="connsiteX20" fmla="*/ 572111 w 655239"/>
                <a:gd name="connsiteY20" fmla="*/ 391942 h 641323"/>
                <a:gd name="connsiteX21" fmla="*/ 547662 w 655239"/>
                <a:gd name="connsiteY21" fmla="*/ 416391 h 641323"/>
                <a:gd name="connsiteX22" fmla="*/ 518323 w 655239"/>
                <a:gd name="connsiteY22" fmla="*/ 445730 h 641323"/>
                <a:gd name="connsiteX23" fmla="*/ 513433 w 655239"/>
                <a:gd name="connsiteY23" fmla="*/ 460399 h 641323"/>
                <a:gd name="connsiteX24" fmla="*/ 479205 w 655239"/>
                <a:gd name="connsiteY24" fmla="*/ 470179 h 641323"/>
                <a:gd name="connsiteX25" fmla="*/ 459645 w 655239"/>
                <a:gd name="connsiteY25" fmla="*/ 479959 h 641323"/>
                <a:gd name="connsiteX26" fmla="*/ 371628 w 655239"/>
                <a:gd name="connsiteY26" fmla="*/ 489738 h 641323"/>
                <a:gd name="connsiteX27" fmla="*/ 356959 w 655239"/>
                <a:gd name="connsiteY27" fmla="*/ 499518 h 641323"/>
                <a:gd name="connsiteX28" fmla="*/ 342289 w 655239"/>
                <a:gd name="connsiteY28" fmla="*/ 504408 h 641323"/>
                <a:gd name="connsiteX29" fmla="*/ 327620 w 655239"/>
                <a:gd name="connsiteY29" fmla="*/ 519077 h 641323"/>
                <a:gd name="connsiteX30" fmla="*/ 322730 w 655239"/>
                <a:gd name="connsiteY30" fmla="*/ 533747 h 641323"/>
                <a:gd name="connsiteX31" fmla="*/ 337399 w 655239"/>
                <a:gd name="connsiteY31" fmla="*/ 567976 h 641323"/>
                <a:gd name="connsiteX32" fmla="*/ 308060 w 655239"/>
                <a:gd name="connsiteY32" fmla="*/ 577755 h 641323"/>
                <a:gd name="connsiteX33" fmla="*/ 293391 w 655239"/>
                <a:gd name="connsiteY33" fmla="*/ 636433 h 641323"/>
                <a:gd name="connsiteX34" fmla="*/ 278721 w 655239"/>
                <a:gd name="connsiteY34" fmla="*/ 641323 h 641323"/>
                <a:gd name="connsiteX35" fmla="*/ 244492 w 655239"/>
                <a:gd name="connsiteY35" fmla="*/ 626654 h 641323"/>
                <a:gd name="connsiteX36" fmla="*/ 220043 w 655239"/>
                <a:gd name="connsiteY36" fmla="*/ 602205 h 641323"/>
                <a:gd name="connsiteX37" fmla="*/ 190704 w 655239"/>
                <a:gd name="connsiteY37" fmla="*/ 597315 h 641323"/>
                <a:gd name="connsiteX38" fmla="*/ 176034 w 655239"/>
                <a:gd name="connsiteY38" fmla="*/ 582645 h 641323"/>
                <a:gd name="connsiteX39" fmla="*/ 171145 w 655239"/>
                <a:gd name="connsiteY39" fmla="*/ 567976 h 641323"/>
                <a:gd name="connsiteX40" fmla="*/ 156475 w 655239"/>
                <a:gd name="connsiteY40" fmla="*/ 563086 h 641323"/>
                <a:gd name="connsiteX41" fmla="*/ 136916 w 655239"/>
                <a:gd name="connsiteY41" fmla="*/ 538637 h 641323"/>
                <a:gd name="connsiteX42" fmla="*/ 112467 w 655239"/>
                <a:gd name="connsiteY42" fmla="*/ 519077 h 641323"/>
                <a:gd name="connsiteX43" fmla="*/ 102687 w 655239"/>
                <a:gd name="connsiteY43" fmla="*/ 504408 h 641323"/>
                <a:gd name="connsiteX44" fmla="*/ 97797 w 655239"/>
                <a:gd name="connsiteY44" fmla="*/ 479959 h 641323"/>
                <a:gd name="connsiteX45" fmla="*/ 83128 w 655239"/>
                <a:gd name="connsiteY45" fmla="*/ 450620 h 641323"/>
                <a:gd name="connsiteX46" fmla="*/ 68458 w 655239"/>
                <a:gd name="connsiteY46" fmla="*/ 440840 h 641323"/>
                <a:gd name="connsiteX47" fmla="*/ 44009 w 655239"/>
                <a:gd name="connsiteY47" fmla="*/ 416391 h 641323"/>
                <a:gd name="connsiteX48" fmla="*/ 29339 w 655239"/>
                <a:gd name="connsiteY48" fmla="*/ 382162 h 641323"/>
                <a:gd name="connsiteX49" fmla="*/ 14670 w 655239"/>
                <a:gd name="connsiteY49" fmla="*/ 367492 h 641323"/>
                <a:gd name="connsiteX50" fmla="*/ 4890 w 655239"/>
                <a:gd name="connsiteY50" fmla="*/ 352823 h 641323"/>
                <a:gd name="connsiteX51" fmla="*/ 0 w 655239"/>
                <a:gd name="connsiteY51" fmla="*/ 338153 h 641323"/>
                <a:gd name="connsiteX52" fmla="*/ 4890 w 655239"/>
                <a:gd name="connsiteY52" fmla="*/ 323484 h 641323"/>
                <a:gd name="connsiteX53" fmla="*/ 19560 w 655239"/>
                <a:gd name="connsiteY53" fmla="*/ 318594 h 641323"/>
                <a:gd name="connsiteX54" fmla="*/ 58678 w 655239"/>
                <a:gd name="connsiteY54" fmla="*/ 308814 h 641323"/>
                <a:gd name="connsiteX55" fmla="*/ 73348 w 655239"/>
                <a:gd name="connsiteY55" fmla="*/ 299035 h 641323"/>
                <a:gd name="connsiteX56" fmla="*/ 83128 w 655239"/>
                <a:gd name="connsiteY56" fmla="*/ 284365 h 641323"/>
                <a:gd name="connsiteX57" fmla="*/ 97797 w 655239"/>
                <a:gd name="connsiteY57" fmla="*/ 235467 h 641323"/>
                <a:gd name="connsiteX58" fmla="*/ 107577 w 655239"/>
                <a:gd name="connsiteY58" fmla="*/ 206128 h 641323"/>
                <a:gd name="connsiteX59" fmla="*/ 112467 w 655239"/>
                <a:gd name="connsiteY59" fmla="*/ 191458 h 641323"/>
                <a:gd name="connsiteX60" fmla="*/ 127136 w 655239"/>
                <a:gd name="connsiteY60" fmla="*/ 186568 h 641323"/>
                <a:gd name="connsiteX61" fmla="*/ 136916 w 655239"/>
                <a:gd name="connsiteY61" fmla="*/ 171899 h 641323"/>
                <a:gd name="connsiteX62" fmla="*/ 151585 w 655239"/>
                <a:gd name="connsiteY62" fmla="*/ 167009 h 641323"/>
                <a:gd name="connsiteX63" fmla="*/ 180924 w 655239"/>
                <a:gd name="connsiteY63" fmla="*/ 118110 h 641323"/>
                <a:gd name="connsiteX64" fmla="*/ 195594 w 655239"/>
                <a:gd name="connsiteY64" fmla="*/ 103441 h 641323"/>
                <a:gd name="connsiteX65" fmla="*/ 224933 w 655239"/>
                <a:gd name="connsiteY65" fmla="*/ 88771 h 641323"/>
                <a:gd name="connsiteX66" fmla="*/ 288501 w 655239"/>
                <a:gd name="connsiteY66" fmla="*/ 83882 h 641323"/>
                <a:gd name="connsiteX67" fmla="*/ 322730 w 655239"/>
                <a:gd name="connsiteY67" fmla="*/ 69212 h 641323"/>
                <a:gd name="connsiteX68" fmla="*/ 327620 w 655239"/>
                <a:gd name="connsiteY68" fmla="*/ 54543 h 641323"/>
                <a:gd name="connsiteX69" fmla="*/ 337399 w 655239"/>
                <a:gd name="connsiteY69" fmla="*/ 34983 h 641323"/>
                <a:gd name="connsiteX70" fmla="*/ 371628 w 655239"/>
                <a:gd name="connsiteY70" fmla="*/ 20314 h 641323"/>
                <a:gd name="connsiteX71" fmla="*/ 386298 w 655239"/>
                <a:gd name="connsiteY71" fmla="*/ 15424 h 641323"/>
                <a:gd name="connsiteX72" fmla="*/ 425416 w 655239"/>
                <a:gd name="connsiteY72" fmla="*/ 754 h 64132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</a:cxnLst>
              <a:rect l="l" t="t" r="r" b="b"/>
              <a:pathLst>
                <a:path w="655239" h="641323">
                  <a:moveTo>
                    <a:pt x="425416" y="754"/>
                  </a:moveTo>
                  <a:cubicBezTo>
                    <a:pt x="436011" y="4014"/>
                    <a:pt x="446293" y="27837"/>
                    <a:pt x="449866" y="34983"/>
                  </a:cubicBezTo>
                  <a:cubicBezTo>
                    <a:pt x="452171" y="39593"/>
                    <a:pt x="451535" y="45628"/>
                    <a:pt x="454755" y="49653"/>
                  </a:cubicBezTo>
                  <a:cubicBezTo>
                    <a:pt x="458426" y="54242"/>
                    <a:pt x="464169" y="56804"/>
                    <a:pt x="469425" y="59432"/>
                  </a:cubicBezTo>
                  <a:cubicBezTo>
                    <a:pt x="479451" y="64445"/>
                    <a:pt x="499241" y="67351"/>
                    <a:pt x="508544" y="69212"/>
                  </a:cubicBezTo>
                  <a:lnTo>
                    <a:pt x="528103" y="98551"/>
                  </a:lnTo>
                  <a:cubicBezTo>
                    <a:pt x="531363" y="103441"/>
                    <a:pt x="532626" y="110593"/>
                    <a:pt x="537883" y="113221"/>
                  </a:cubicBezTo>
                  <a:lnTo>
                    <a:pt x="567222" y="127890"/>
                  </a:lnTo>
                  <a:cubicBezTo>
                    <a:pt x="570443" y="137555"/>
                    <a:pt x="573272" y="150334"/>
                    <a:pt x="581891" y="157229"/>
                  </a:cubicBezTo>
                  <a:cubicBezTo>
                    <a:pt x="585916" y="160449"/>
                    <a:pt x="591823" y="160088"/>
                    <a:pt x="596561" y="162119"/>
                  </a:cubicBezTo>
                  <a:cubicBezTo>
                    <a:pt x="613928" y="169562"/>
                    <a:pt x="616060" y="171859"/>
                    <a:pt x="630790" y="181678"/>
                  </a:cubicBezTo>
                  <a:cubicBezTo>
                    <a:pt x="632420" y="186568"/>
                    <a:pt x="632820" y="192059"/>
                    <a:pt x="635679" y="196348"/>
                  </a:cubicBezTo>
                  <a:cubicBezTo>
                    <a:pt x="660100" y="232980"/>
                    <a:pt x="643611" y="190802"/>
                    <a:pt x="655239" y="225687"/>
                  </a:cubicBezTo>
                  <a:cubicBezTo>
                    <a:pt x="632419" y="259916"/>
                    <a:pt x="645459" y="248506"/>
                    <a:pt x="621010" y="264806"/>
                  </a:cubicBezTo>
                  <a:cubicBezTo>
                    <a:pt x="617750" y="269696"/>
                    <a:pt x="613617" y="274105"/>
                    <a:pt x="611230" y="279475"/>
                  </a:cubicBezTo>
                  <a:cubicBezTo>
                    <a:pt x="606695" y="289678"/>
                    <a:pt x="603120" y="314325"/>
                    <a:pt x="591671" y="323484"/>
                  </a:cubicBezTo>
                  <a:cubicBezTo>
                    <a:pt x="587646" y="326704"/>
                    <a:pt x="581611" y="326069"/>
                    <a:pt x="577001" y="328374"/>
                  </a:cubicBezTo>
                  <a:cubicBezTo>
                    <a:pt x="571745" y="331002"/>
                    <a:pt x="567222" y="334893"/>
                    <a:pt x="562332" y="338153"/>
                  </a:cubicBezTo>
                  <a:cubicBezTo>
                    <a:pt x="560026" y="345070"/>
                    <a:pt x="552552" y="366243"/>
                    <a:pt x="552552" y="372382"/>
                  </a:cubicBezTo>
                  <a:cubicBezTo>
                    <a:pt x="552552" y="377537"/>
                    <a:pt x="553797" y="383407"/>
                    <a:pt x="557442" y="387052"/>
                  </a:cubicBezTo>
                  <a:cubicBezTo>
                    <a:pt x="561086" y="390697"/>
                    <a:pt x="567221" y="390312"/>
                    <a:pt x="572111" y="391942"/>
                  </a:cubicBezTo>
                  <a:cubicBezTo>
                    <a:pt x="562037" y="432245"/>
                    <a:pt x="577297" y="395647"/>
                    <a:pt x="547662" y="416391"/>
                  </a:cubicBezTo>
                  <a:cubicBezTo>
                    <a:pt x="536332" y="424322"/>
                    <a:pt x="518323" y="445730"/>
                    <a:pt x="518323" y="445730"/>
                  </a:cubicBezTo>
                  <a:cubicBezTo>
                    <a:pt x="516693" y="450620"/>
                    <a:pt x="517078" y="456754"/>
                    <a:pt x="513433" y="460399"/>
                  </a:cubicBezTo>
                  <a:cubicBezTo>
                    <a:pt x="511068" y="462764"/>
                    <a:pt x="479408" y="470103"/>
                    <a:pt x="479205" y="470179"/>
                  </a:cubicBezTo>
                  <a:cubicBezTo>
                    <a:pt x="472380" y="472739"/>
                    <a:pt x="466345" y="477088"/>
                    <a:pt x="459645" y="479959"/>
                  </a:cubicBezTo>
                  <a:cubicBezTo>
                    <a:pt x="431711" y="491930"/>
                    <a:pt x="402666" y="487669"/>
                    <a:pt x="371628" y="489738"/>
                  </a:cubicBezTo>
                  <a:cubicBezTo>
                    <a:pt x="366738" y="492998"/>
                    <a:pt x="362215" y="496890"/>
                    <a:pt x="356959" y="499518"/>
                  </a:cubicBezTo>
                  <a:cubicBezTo>
                    <a:pt x="352349" y="501823"/>
                    <a:pt x="346578" y="501549"/>
                    <a:pt x="342289" y="504408"/>
                  </a:cubicBezTo>
                  <a:cubicBezTo>
                    <a:pt x="336535" y="508244"/>
                    <a:pt x="332510" y="514187"/>
                    <a:pt x="327620" y="519077"/>
                  </a:cubicBezTo>
                  <a:cubicBezTo>
                    <a:pt x="325990" y="523967"/>
                    <a:pt x="322730" y="528592"/>
                    <a:pt x="322730" y="533747"/>
                  </a:cubicBezTo>
                  <a:cubicBezTo>
                    <a:pt x="322730" y="549533"/>
                    <a:pt x="329415" y="555999"/>
                    <a:pt x="337399" y="567976"/>
                  </a:cubicBezTo>
                  <a:cubicBezTo>
                    <a:pt x="327619" y="571236"/>
                    <a:pt x="309198" y="567509"/>
                    <a:pt x="308060" y="577755"/>
                  </a:cubicBezTo>
                  <a:cubicBezTo>
                    <a:pt x="306374" y="592933"/>
                    <a:pt x="309823" y="623287"/>
                    <a:pt x="293391" y="636433"/>
                  </a:cubicBezTo>
                  <a:cubicBezTo>
                    <a:pt x="289366" y="639653"/>
                    <a:pt x="283611" y="639693"/>
                    <a:pt x="278721" y="641323"/>
                  </a:cubicBezTo>
                  <a:cubicBezTo>
                    <a:pt x="263761" y="637583"/>
                    <a:pt x="255747" y="637909"/>
                    <a:pt x="244492" y="626654"/>
                  </a:cubicBezTo>
                  <a:cubicBezTo>
                    <a:pt x="231450" y="613612"/>
                    <a:pt x="239607" y="608726"/>
                    <a:pt x="220043" y="602205"/>
                  </a:cubicBezTo>
                  <a:cubicBezTo>
                    <a:pt x="210637" y="599070"/>
                    <a:pt x="200484" y="598945"/>
                    <a:pt x="190704" y="597315"/>
                  </a:cubicBezTo>
                  <a:cubicBezTo>
                    <a:pt x="185814" y="592425"/>
                    <a:pt x="179870" y="588399"/>
                    <a:pt x="176034" y="582645"/>
                  </a:cubicBezTo>
                  <a:cubicBezTo>
                    <a:pt x="173175" y="578357"/>
                    <a:pt x="174789" y="571620"/>
                    <a:pt x="171145" y="567976"/>
                  </a:cubicBezTo>
                  <a:cubicBezTo>
                    <a:pt x="167500" y="564331"/>
                    <a:pt x="161365" y="564716"/>
                    <a:pt x="156475" y="563086"/>
                  </a:cubicBezTo>
                  <a:cubicBezTo>
                    <a:pt x="146955" y="534526"/>
                    <a:pt x="159034" y="560755"/>
                    <a:pt x="136916" y="538637"/>
                  </a:cubicBezTo>
                  <a:cubicBezTo>
                    <a:pt x="114797" y="516518"/>
                    <a:pt x="141025" y="528597"/>
                    <a:pt x="112467" y="519077"/>
                  </a:cubicBezTo>
                  <a:cubicBezTo>
                    <a:pt x="109207" y="514187"/>
                    <a:pt x="104751" y="509911"/>
                    <a:pt x="102687" y="504408"/>
                  </a:cubicBezTo>
                  <a:cubicBezTo>
                    <a:pt x="99769" y="496626"/>
                    <a:pt x="99813" y="488022"/>
                    <a:pt x="97797" y="479959"/>
                  </a:cubicBezTo>
                  <a:cubicBezTo>
                    <a:pt x="95146" y="469354"/>
                    <a:pt x="91095" y="458587"/>
                    <a:pt x="83128" y="450620"/>
                  </a:cubicBezTo>
                  <a:cubicBezTo>
                    <a:pt x="78972" y="446464"/>
                    <a:pt x="73348" y="444100"/>
                    <a:pt x="68458" y="440840"/>
                  </a:cubicBezTo>
                  <a:cubicBezTo>
                    <a:pt x="56990" y="406436"/>
                    <a:pt x="74221" y="446603"/>
                    <a:pt x="44009" y="416391"/>
                  </a:cubicBezTo>
                  <a:cubicBezTo>
                    <a:pt x="25570" y="397952"/>
                    <a:pt x="41027" y="399694"/>
                    <a:pt x="29339" y="382162"/>
                  </a:cubicBezTo>
                  <a:cubicBezTo>
                    <a:pt x="25503" y="376408"/>
                    <a:pt x="19097" y="372804"/>
                    <a:pt x="14670" y="367492"/>
                  </a:cubicBezTo>
                  <a:cubicBezTo>
                    <a:pt x="10908" y="362977"/>
                    <a:pt x="8150" y="357713"/>
                    <a:pt x="4890" y="352823"/>
                  </a:cubicBezTo>
                  <a:cubicBezTo>
                    <a:pt x="3260" y="347933"/>
                    <a:pt x="0" y="343308"/>
                    <a:pt x="0" y="338153"/>
                  </a:cubicBezTo>
                  <a:cubicBezTo>
                    <a:pt x="0" y="332999"/>
                    <a:pt x="1245" y="327128"/>
                    <a:pt x="4890" y="323484"/>
                  </a:cubicBezTo>
                  <a:cubicBezTo>
                    <a:pt x="8535" y="319839"/>
                    <a:pt x="14587" y="319950"/>
                    <a:pt x="19560" y="318594"/>
                  </a:cubicBezTo>
                  <a:cubicBezTo>
                    <a:pt x="32527" y="315057"/>
                    <a:pt x="45639" y="312074"/>
                    <a:pt x="58678" y="308814"/>
                  </a:cubicBezTo>
                  <a:cubicBezTo>
                    <a:pt x="63568" y="305554"/>
                    <a:pt x="69192" y="303190"/>
                    <a:pt x="73348" y="299035"/>
                  </a:cubicBezTo>
                  <a:cubicBezTo>
                    <a:pt x="77504" y="294879"/>
                    <a:pt x="80741" y="289736"/>
                    <a:pt x="83128" y="284365"/>
                  </a:cubicBezTo>
                  <a:cubicBezTo>
                    <a:pt x="93764" y="260432"/>
                    <a:pt x="91233" y="257346"/>
                    <a:pt x="97797" y="235467"/>
                  </a:cubicBezTo>
                  <a:cubicBezTo>
                    <a:pt x="100759" y="225593"/>
                    <a:pt x="104317" y="215908"/>
                    <a:pt x="107577" y="206128"/>
                  </a:cubicBezTo>
                  <a:cubicBezTo>
                    <a:pt x="109207" y="201238"/>
                    <a:pt x="107577" y="193088"/>
                    <a:pt x="112467" y="191458"/>
                  </a:cubicBezTo>
                  <a:lnTo>
                    <a:pt x="127136" y="186568"/>
                  </a:lnTo>
                  <a:cubicBezTo>
                    <a:pt x="130396" y="181678"/>
                    <a:pt x="132327" y="175570"/>
                    <a:pt x="136916" y="171899"/>
                  </a:cubicBezTo>
                  <a:cubicBezTo>
                    <a:pt x="140941" y="168679"/>
                    <a:pt x="147940" y="170654"/>
                    <a:pt x="151585" y="167009"/>
                  </a:cubicBezTo>
                  <a:cubicBezTo>
                    <a:pt x="182063" y="136531"/>
                    <a:pt x="161626" y="145128"/>
                    <a:pt x="180924" y="118110"/>
                  </a:cubicBezTo>
                  <a:cubicBezTo>
                    <a:pt x="184943" y="112483"/>
                    <a:pt x="190282" y="107868"/>
                    <a:pt x="195594" y="103441"/>
                  </a:cubicBezTo>
                  <a:cubicBezTo>
                    <a:pt x="203303" y="97017"/>
                    <a:pt x="214554" y="90068"/>
                    <a:pt x="224933" y="88771"/>
                  </a:cubicBezTo>
                  <a:cubicBezTo>
                    <a:pt x="246021" y="86135"/>
                    <a:pt x="267312" y="85512"/>
                    <a:pt x="288501" y="83882"/>
                  </a:cubicBezTo>
                  <a:cubicBezTo>
                    <a:pt x="300247" y="80945"/>
                    <a:pt x="314287" y="79765"/>
                    <a:pt x="322730" y="69212"/>
                  </a:cubicBezTo>
                  <a:cubicBezTo>
                    <a:pt x="325950" y="65187"/>
                    <a:pt x="325590" y="59280"/>
                    <a:pt x="327620" y="54543"/>
                  </a:cubicBezTo>
                  <a:cubicBezTo>
                    <a:pt x="330491" y="47843"/>
                    <a:pt x="332732" y="40583"/>
                    <a:pt x="337399" y="34983"/>
                  </a:cubicBezTo>
                  <a:cubicBezTo>
                    <a:pt x="346703" y="23819"/>
                    <a:pt x="358899" y="23951"/>
                    <a:pt x="371628" y="20314"/>
                  </a:cubicBezTo>
                  <a:cubicBezTo>
                    <a:pt x="376584" y="18898"/>
                    <a:pt x="381325" y="16780"/>
                    <a:pt x="386298" y="15424"/>
                  </a:cubicBezTo>
                  <a:cubicBezTo>
                    <a:pt x="423606" y="5249"/>
                    <a:pt x="414821" y="-2506"/>
                    <a:pt x="425416" y="754"/>
                  </a:cubicBezTo>
                  <a:close/>
                </a:path>
              </a:pathLst>
            </a:cu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90" name="Oval 189"/>
            <p:cNvSpPr/>
            <p:nvPr/>
          </p:nvSpPr>
          <p:spPr>
            <a:xfrm>
              <a:off x="2723596" y="8594104"/>
              <a:ext cx="86108" cy="92807"/>
            </a:xfrm>
            <a:prstGeom prst="ellipse">
              <a:avLst/>
            </a:prstGeom>
            <a:solidFill>
              <a:schemeClr val="accent2"/>
            </a:solidFill>
            <a:ln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2984121" y="8674933"/>
              <a:ext cx="697991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/>
                <a:t>East London</a:t>
              </a: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2770576" y="8364090"/>
              <a:ext cx="585723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Hogsback</a:t>
              </a:r>
              <a:endParaRPr lang="en-US" sz="802" dirty="0"/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2092723" y="8581787"/>
              <a:ext cx="746106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/>
                <a:t>Fort Beaufort</a:t>
              </a:r>
              <a:endParaRPr lang="en-US" sz="802" dirty="0"/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3383972" y="8237427"/>
              <a:ext cx="667518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Oribi</a:t>
              </a:r>
              <a:r>
                <a:rPr lang="en-US" sz="802" dirty="0"/>
                <a:t> Gorge</a:t>
              </a: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3458593" y="8116003"/>
              <a:ext cx="845544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/>
                <a:t>Vernon </a:t>
              </a:r>
              <a:r>
                <a:rPr lang="en-US" sz="802" dirty="0" err="1"/>
                <a:t>Croocks</a:t>
              </a:r>
              <a:endParaRPr lang="en-US" sz="802" dirty="0"/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1770317" y="7732073"/>
              <a:ext cx="606573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Rooipoort</a:t>
              </a:r>
              <a:endParaRPr lang="en-US" sz="802" dirty="0"/>
            </a:p>
          </p:txBody>
        </p:sp>
        <p:sp>
          <p:nvSpPr>
            <p:cNvPr id="198" name="TextBox 197"/>
            <p:cNvSpPr txBox="1"/>
            <p:nvPr/>
          </p:nvSpPr>
          <p:spPr>
            <a:xfrm>
              <a:off x="2928581" y="7374350"/>
              <a:ext cx="579307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/>
                <a:t>Kaalplaas</a:t>
              </a:r>
              <a:endParaRPr lang="en-US" sz="802" dirty="0"/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2994134" y="7164505"/>
              <a:ext cx="495908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/>
                <a:t>Rietvlei</a:t>
              </a:r>
              <a:endParaRPr lang="en-US" sz="802" dirty="0"/>
            </a:p>
          </p:txBody>
        </p:sp>
        <p:sp>
          <p:nvSpPr>
            <p:cNvPr id="201" name="Pie 200"/>
            <p:cNvSpPr/>
            <p:nvPr/>
          </p:nvSpPr>
          <p:spPr>
            <a:xfrm>
              <a:off x="2823814" y="8557937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02" name="Pie 201"/>
            <p:cNvSpPr/>
            <p:nvPr/>
          </p:nvSpPr>
          <p:spPr>
            <a:xfrm>
              <a:off x="2950022" y="8643520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C000"/>
            </a:solidFill>
            <a:ln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3260027" y="7814239"/>
              <a:ext cx="484681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Inkunzi</a:t>
              </a:r>
              <a:endParaRPr lang="en-US" sz="802" dirty="0"/>
            </a:p>
          </p:txBody>
        </p:sp>
        <p:sp>
          <p:nvSpPr>
            <p:cNvPr id="204" name="Oval 203"/>
            <p:cNvSpPr/>
            <p:nvPr/>
          </p:nvSpPr>
          <p:spPr>
            <a:xfrm>
              <a:off x="3360263" y="7775914"/>
              <a:ext cx="86108" cy="92807"/>
            </a:xfrm>
            <a:prstGeom prst="ellipse">
              <a:avLst/>
            </a:prstGeom>
            <a:pattFill prst="dkDnDiag">
              <a:fgClr>
                <a:srgbClr val="C34FFF"/>
              </a:fgClr>
              <a:bgClr>
                <a:schemeClr val="bg1"/>
              </a:bgClr>
            </a:pattFill>
            <a:ln>
              <a:solidFill>
                <a:srgbClr val="C34F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05" name="Oval 204"/>
            <p:cNvSpPr/>
            <p:nvPr/>
          </p:nvSpPr>
          <p:spPr>
            <a:xfrm>
              <a:off x="3319102" y="7631266"/>
              <a:ext cx="86108" cy="92807"/>
            </a:xfrm>
            <a:prstGeom prst="ellipse">
              <a:avLst/>
            </a:prstGeom>
            <a:pattFill prst="dkDnDiag">
              <a:fgClr>
                <a:srgbClr val="00B0F0"/>
              </a:fgClr>
              <a:bgClr>
                <a:schemeClr val="bg1"/>
              </a:bgClr>
            </a:patt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06" name="Pie 205"/>
            <p:cNvSpPr/>
            <p:nvPr/>
          </p:nvSpPr>
          <p:spPr>
            <a:xfrm>
              <a:off x="3352717" y="8212331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FF55F8"/>
            </a:solidFill>
            <a:ln>
              <a:solidFill>
                <a:srgbClr val="FF55F8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07" name="Pie 206"/>
            <p:cNvSpPr/>
            <p:nvPr/>
          </p:nvSpPr>
          <p:spPr>
            <a:xfrm>
              <a:off x="3409833" y="8101361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7030A0"/>
            </a:solidFill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08" name="Pie 207"/>
            <p:cNvSpPr/>
            <p:nvPr/>
          </p:nvSpPr>
          <p:spPr>
            <a:xfrm>
              <a:off x="2917136" y="7431454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0070C0"/>
            </a:solidFill>
            <a:ln>
              <a:solidFill>
                <a:schemeClr val="accent1">
                  <a:shade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09" name="Pie 208"/>
            <p:cNvSpPr/>
            <p:nvPr/>
          </p:nvSpPr>
          <p:spPr>
            <a:xfrm>
              <a:off x="2984152" y="7225821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00FDFF"/>
            </a:solidFill>
            <a:ln>
              <a:solidFill>
                <a:srgbClr val="00FD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10" name="Pie 209"/>
            <p:cNvSpPr/>
            <p:nvPr/>
          </p:nvSpPr>
          <p:spPr>
            <a:xfrm>
              <a:off x="2329954" y="7811117"/>
              <a:ext cx="87565" cy="88366"/>
            </a:xfrm>
            <a:prstGeom prst="pie">
              <a:avLst>
                <a:gd name="adj1" fmla="val 5423228"/>
                <a:gd name="adj2" fmla="val 5400000"/>
              </a:avLst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>
                <a:solidFill>
                  <a:schemeClr val="tx1"/>
                </a:solidFill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1945221" y="7476861"/>
              <a:ext cx="577704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Dronfield</a:t>
              </a:r>
              <a:endParaRPr lang="en-US" sz="802" dirty="0"/>
            </a:p>
          </p:txBody>
        </p:sp>
        <p:sp>
          <p:nvSpPr>
            <p:cNvPr id="212" name="Oval 211"/>
            <p:cNvSpPr/>
            <p:nvPr/>
          </p:nvSpPr>
          <p:spPr>
            <a:xfrm>
              <a:off x="2426192" y="7687662"/>
              <a:ext cx="86108" cy="92807"/>
            </a:xfrm>
            <a:prstGeom prst="ellipse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6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14" name="Oval 213"/>
            <p:cNvSpPr/>
            <p:nvPr/>
          </p:nvSpPr>
          <p:spPr>
            <a:xfrm>
              <a:off x="1225755" y="7013678"/>
              <a:ext cx="86108" cy="92807"/>
            </a:xfrm>
            <a:prstGeom prst="ellipse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15" name="Oval 214"/>
            <p:cNvSpPr/>
            <p:nvPr/>
          </p:nvSpPr>
          <p:spPr>
            <a:xfrm>
              <a:off x="1067977" y="6600849"/>
              <a:ext cx="86108" cy="9280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16" name="TextBox 215"/>
            <p:cNvSpPr txBox="1"/>
            <p:nvPr/>
          </p:nvSpPr>
          <p:spPr>
            <a:xfrm>
              <a:off x="857743" y="6660202"/>
              <a:ext cx="616196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/>
                <a:t>Windhoek</a:t>
              </a:r>
            </a:p>
          </p:txBody>
        </p:sp>
        <p:sp>
          <p:nvSpPr>
            <p:cNvPr id="217" name="TextBox 216"/>
            <p:cNvSpPr txBox="1"/>
            <p:nvPr/>
          </p:nvSpPr>
          <p:spPr>
            <a:xfrm>
              <a:off x="1022491" y="7069512"/>
              <a:ext cx="595346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 dirty="0" err="1"/>
                <a:t>Mariental</a:t>
              </a:r>
              <a:endParaRPr lang="en-US" sz="802" dirty="0"/>
            </a:p>
          </p:txBody>
        </p:sp>
        <p:sp>
          <p:nvSpPr>
            <p:cNvPr id="219" name="TextBox 218"/>
            <p:cNvSpPr txBox="1"/>
            <p:nvPr/>
          </p:nvSpPr>
          <p:spPr>
            <a:xfrm>
              <a:off x="1515569" y="8134980"/>
              <a:ext cx="1232647" cy="395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2" b="1" dirty="0"/>
                <a:t>South Africa</a:t>
              </a:r>
            </a:p>
          </p:txBody>
        </p:sp>
        <p:sp>
          <p:nvSpPr>
            <p:cNvPr id="220" name="TextBox 219"/>
            <p:cNvSpPr txBox="1"/>
            <p:nvPr/>
          </p:nvSpPr>
          <p:spPr>
            <a:xfrm>
              <a:off x="702285" y="6009432"/>
              <a:ext cx="898472" cy="395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2" b="1" dirty="0"/>
                <a:t>Namibia</a:t>
              </a:r>
            </a:p>
          </p:txBody>
        </p:sp>
        <p:sp>
          <p:nvSpPr>
            <p:cNvPr id="221" name="Oval 220"/>
            <p:cNvSpPr/>
            <p:nvPr/>
          </p:nvSpPr>
          <p:spPr>
            <a:xfrm>
              <a:off x="2677487" y="8184110"/>
              <a:ext cx="86108" cy="92807"/>
            </a:xfrm>
            <a:prstGeom prst="ellipse">
              <a:avLst/>
            </a:prstGeom>
            <a:solidFill>
              <a:srgbClr val="FFFF00"/>
            </a:solidFill>
            <a:ln>
              <a:solidFill>
                <a:srgbClr val="FFFF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803"/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2676530" y="8213471"/>
              <a:ext cx="483076" cy="2517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2"/>
                <a:t>Bethuli</a:t>
              </a:r>
              <a:endParaRPr lang="en-US" sz="802" dirty="0"/>
            </a:p>
          </p:txBody>
        </p:sp>
      </p:grpSp>
      <p:sp>
        <p:nvSpPr>
          <p:cNvPr id="223" name="TextBox 222"/>
          <p:cNvSpPr txBox="1"/>
          <p:nvPr/>
        </p:nvSpPr>
        <p:spPr>
          <a:xfrm>
            <a:off x="1060058" y="1156835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224" name="Freeform 223"/>
          <p:cNvSpPr/>
          <p:nvPr/>
        </p:nvSpPr>
        <p:spPr>
          <a:xfrm>
            <a:off x="1926565" y="1932492"/>
            <a:ext cx="1829859" cy="1440634"/>
          </a:xfrm>
          <a:custGeom>
            <a:avLst/>
            <a:gdLst>
              <a:gd name="connsiteX0" fmla="*/ 204067 w 1829859"/>
              <a:gd name="connsiteY0" fmla="*/ 37042 h 1440634"/>
              <a:gd name="connsiteX1" fmla="*/ 602100 w 1829859"/>
              <a:gd name="connsiteY1" fmla="*/ 144618 h 1440634"/>
              <a:gd name="connsiteX2" fmla="*/ 1828472 w 1829859"/>
              <a:gd name="connsiteY2" fmla="*/ 1026745 h 1440634"/>
              <a:gd name="connsiteX3" fmla="*/ 828011 w 1829859"/>
              <a:gd name="connsiteY3" fmla="*/ 1424778 h 1440634"/>
              <a:gd name="connsiteX4" fmla="*/ 31945 w 1829859"/>
              <a:gd name="connsiteY4" fmla="*/ 521136 h 1440634"/>
              <a:gd name="connsiteX5" fmla="*/ 204067 w 1829859"/>
              <a:gd name="connsiteY5" fmla="*/ 37042 h 144063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829859" h="1440634">
                <a:moveTo>
                  <a:pt x="204067" y="37042"/>
                </a:moveTo>
                <a:cubicBezTo>
                  <a:pt x="299093" y="-25711"/>
                  <a:pt x="331366" y="-20332"/>
                  <a:pt x="602100" y="144618"/>
                </a:cubicBezTo>
                <a:cubicBezTo>
                  <a:pt x="872834" y="309568"/>
                  <a:pt x="1790820" y="813385"/>
                  <a:pt x="1828472" y="1026745"/>
                </a:cubicBezTo>
                <a:cubicBezTo>
                  <a:pt x="1866124" y="1240105"/>
                  <a:pt x="1127432" y="1509046"/>
                  <a:pt x="828011" y="1424778"/>
                </a:cubicBezTo>
                <a:cubicBezTo>
                  <a:pt x="528590" y="1340510"/>
                  <a:pt x="137729" y="752425"/>
                  <a:pt x="31945" y="521136"/>
                </a:cubicBezTo>
                <a:cubicBezTo>
                  <a:pt x="-73839" y="289847"/>
                  <a:pt x="109041" y="99795"/>
                  <a:pt x="204067" y="37042"/>
                </a:cubicBezTo>
                <a:close/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5" name="Freeform 224"/>
          <p:cNvSpPr/>
          <p:nvPr/>
        </p:nvSpPr>
        <p:spPr>
          <a:xfrm>
            <a:off x="3706700" y="2331111"/>
            <a:ext cx="1031462" cy="1714838"/>
          </a:xfrm>
          <a:custGeom>
            <a:avLst/>
            <a:gdLst>
              <a:gd name="connsiteX0" fmla="*/ 499517 w 1031462"/>
              <a:gd name="connsiteY0" fmla="*/ 88511 h 1714838"/>
              <a:gd name="connsiteX1" fmla="*/ 15423 w 1031462"/>
              <a:gd name="connsiteY1" fmla="*/ 959881 h 1714838"/>
              <a:gd name="connsiteX2" fmla="*/ 198303 w 1031462"/>
              <a:gd name="connsiteY2" fmla="*/ 1712916 h 1714838"/>
              <a:gd name="connsiteX3" fmla="*/ 962095 w 1031462"/>
              <a:gd name="connsiteY3" fmla="*/ 1153518 h 1714838"/>
              <a:gd name="connsiteX4" fmla="*/ 972853 w 1031462"/>
              <a:gd name="connsiteY4" fmla="*/ 454271 h 1714838"/>
              <a:gd name="connsiteX5" fmla="*/ 757700 w 1031462"/>
              <a:gd name="connsiteY5" fmla="*/ 66996 h 1714838"/>
              <a:gd name="connsiteX6" fmla="*/ 499517 w 1031462"/>
              <a:gd name="connsiteY6" fmla="*/ 88511 h 17148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1031462" h="1714838">
                <a:moveTo>
                  <a:pt x="499517" y="88511"/>
                </a:moveTo>
                <a:cubicBezTo>
                  <a:pt x="375804" y="237325"/>
                  <a:pt x="65625" y="689147"/>
                  <a:pt x="15423" y="959881"/>
                </a:cubicBezTo>
                <a:cubicBezTo>
                  <a:pt x="-34779" y="1230615"/>
                  <a:pt x="40524" y="1680643"/>
                  <a:pt x="198303" y="1712916"/>
                </a:cubicBezTo>
                <a:cubicBezTo>
                  <a:pt x="356082" y="1745189"/>
                  <a:pt x="833003" y="1363292"/>
                  <a:pt x="962095" y="1153518"/>
                </a:cubicBezTo>
                <a:cubicBezTo>
                  <a:pt x="1091187" y="943744"/>
                  <a:pt x="1006919" y="635358"/>
                  <a:pt x="972853" y="454271"/>
                </a:cubicBezTo>
                <a:cubicBezTo>
                  <a:pt x="938787" y="273184"/>
                  <a:pt x="836589" y="122577"/>
                  <a:pt x="757700" y="66996"/>
                </a:cubicBezTo>
                <a:cubicBezTo>
                  <a:pt x="678811" y="11415"/>
                  <a:pt x="623230" y="-60303"/>
                  <a:pt x="499517" y="88511"/>
                </a:cubicBezTo>
                <a:close/>
              </a:path>
            </a:pathLst>
          </a:cu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6" name="TextBox 225"/>
          <p:cNvSpPr txBox="1"/>
          <p:nvPr/>
        </p:nvSpPr>
        <p:spPr>
          <a:xfrm>
            <a:off x="2782041" y="2060067"/>
            <a:ext cx="13965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Rhabdomys bechuanae</a:t>
            </a:r>
            <a:endParaRPr lang="en-GB" sz="1000" i="1" dirty="0"/>
          </a:p>
        </p:txBody>
      </p:sp>
      <p:sp>
        <p:nvSpPr>
          <p:cNvPr id="227" name="TextBox 226"/>
          <p:cNvSpPr txBox="1"/>
          <p:nvPr/>
        </p:nvSpPr>
        <p:spPr>
          <a:xfrm>
            <a:off x="4346191" y="2191152"/>
            <a:ext cx="121539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smtClean="0"/>
              <a:t>Rhabdomys dilectus</a:t>
            </a:r>
            <a:endParaRPr lang="en-GB" sz="1000" i="1" dirty="0"/>
          </a:p>
        </p:txBody>
      </p:sp>
      <p:sp>
        <p:nvSpPr>
          <p:cNvPr id="228" name="TextBox 227"/>
          <p:cNvSpPr txBox="1"/>
          <p:nvPr/>
        </p:nvSpPr>
        <p:spPr>
          <a:xfrm>
            <a:off x="1111182" y="5343707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648961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45</Words>
  <Application>Microsoft Macintosh PowerPoint</Application>
  <PresentationFormat>A4 Paper (210x297 mm)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ee, Conrad, Prof &lt;cam@sun.ac.za&gt;</dc:creator>
  <cp:lastModifiedBy>Matthee, Conrad, Prof &lt;cam@sun.ac.za&gt;</cp:lastModifiedBy>
  <cp:revision>1</cp:revision>
  <dcterms:created xsi:type="dcterms:W3CDTF">2017-11-09T08:58:17Z</dcterms:created>
  <dcterms:modified xsi:type="dcterms:W3CDTF">2017-11-09T09:02:11Z</dcterms:modified>
</cp:coreProperties>
</file>